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61" r:id="rId3"/>
  </p:sldIdLst>
  <p:sldSz cx="6858000" cy="9144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429" autoAdjust="0"/>
  </p:normalViewPr>
  <p:slideViewPr>
    <p:cSldViewPr>
      <p:cViewPr>
        <p:scale>
          <a:sx n="100" d="100"/>
          <a:sy n="100" d="100"/>
        </p:scale>
        <p:origin x="-1152" y="2550"/>
      </p:cViewPr>
      <p:guideLst>
        <p:guide orient="horz" pos="2880"/>
        <p:guide pos="2160"/>
      </p:guideLst>
    </p:cSldViewPr>
  </p:slideViewPr>
  <p:notesTextViewPr>
    <p:cViewPr>
      <p:scale>
        <a:sx n="125" d="100"/>
        <a:sy n="125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DF20B9-79F6-48D0-BE3F-70D78AB18340}" type="datetimeFigureOut">
              <a:rPr lang="zh-TW" altLang="en-US" smtClean="0"/>
              <a:pPr/>
              <a:t>2015/10/11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6F288A-49DB-4B78-8948-623F227C542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34719820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C0C89-7CE1-4B56-9C1D-AFA05E1FA365}" type="datetimeFigureOut">
              <a:rPr lang="zh-TW" altLang="en-US" smtClean="0"/>
              <a:pPr/>
              <a:t>2015/10/1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D6D857-68CE-4392-955F-A7FBC9B5FA2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2078995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C0C89-7CE1-4B56-9C1D-AFA05E1FA365}" type="datetimeFigureOut">
              <a:rPr lang="zh-TW" altLang="en-US" smtClean="0"/>
              <a:pPr/>
              <a:t>2015/10/1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D6D857-68CE-4392-955F-A7FBC9B5FA2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3711400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C0C89-7CE1-4B56-9C1D-AFA05E1FA365}" type="datetimeFigureOut">
              <a:rPr lang="zh-TW" altLang="en-US" smtClean="0"/>
              <a:pPr/>
              <a:t>2015/10/1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D6D857-68CE-4392-955F-A7FBC9B5FA2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39458973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C0C89-7CE1-4B56-9C1D-AFA05E1FA365}" type="datetimeFigureOut">
              <a:rPr lang="zh-TW" altLang="en-US" smtClean="0"/>
              <a:pPr/>
              <a:t>2015/10/1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D6D857-68CE-4392-955F-A7FBC9B5FA2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37092190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C0C89-7CE1-4B56-9C1D-AFA05E1FA365}" type="datetimeFigureOut">
              <a:rPr lang="zh-TW" altLang="en-US" smtClean="0"/>
              <a:pPr/>
              <a:t>2015/10/1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D6D857-68CE-4392-955F-A7FBC9B5FA2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1348891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C0C89-7CE1-4B56-9C1D-AFA05E1FA365}" type="datetimeFigureOut">
              <a:rPr lang="zh-TW" altLang="en-US" smtClean="0"/>
              <a:pPr/>
              <a:t>2015/10/1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D6D857-68CE-4392-955F-A7FBC9B5FA2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18534683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C0C89-7CE1-4B56-9C1D-AFA05E1FA365}" type="datetimeFigureOut">
              <a:rPr lang="zh-TW" altLang="en-US" smtClean="0"/>
              <a:pPr/>
              <a:t>2015/10/11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D6D857-68CE-4392-955F-A7FBC9B5FA2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531154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C0C89-7CE1-4B56-9C1D-AFA05E1FA365}" type="datetimeFigureOut">
              <a:rPr lang="zh-TW" altLang="en-US" smtClean="0"/>
              <a:pPr/>
              <a:t>2015/10/11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D6D857-68CE-4392-955F-A7FBC9B5FA2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17413635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C0C89-7CE1-4B56-9C1D-AFA05E1FA365}" type="datetimeFigureOut">
              <a:rPr lang="zh-TW" altLang="en-US" smtClean="0"/>
              <a:pPr/>
              <a:t>2015/10/11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D6D857-68CE-4392-955F-A7FBC9B5FA2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35780912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C0C89-7CE1-4B56-9C1D-AFA05E1FA365}" type="datetimeFigureOut">
              <a:rPr lang="zh-TW" altLang="en-US" smtClean="0"/>
              <a:pPr/>
              <a:t>2015/10/1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D6D857-68CE-4392-955F-A7FBC9B5FA2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2615959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C0C89-7CE1-4B56-9C1D-AFA05E1FA365}" type="datetimeFigureOut">
              <a:rPr lang="zh-TW" altLang="en-US" smtClean="0"/>
              <a:pPr/>
              <a:t>2015/10/1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D6D857-68CE-4392-955F-A7FBC9B5FA2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678683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BC0C89-7CE1-4B56-9C1D-AFA05E1FA365}" type="datetimeFigureOut">
              <a:rPr lang="zh-TW" altLang="en-US" smtClean="0"/>
              <a:pPr/>
              <a:t>2015/10/1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D6D857-68CE-4392-955F-A7FBC9B5FA2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30211690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7" name="Rectangle 1"/>
          <p:cNvSpPr>
            <a:spLocks noChangeArrowheads="1"/>
          </p:cNvSpPr>
          <p:nvPr/>
        </p:nvSpPr>
        <p:spPr bwMode="auto">
          <a:xfrm>
            <a:off x="620688" y="6300192"/>
            <a:ext cx="5944761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zh-TW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標楷體" pitchFamily="65" charset="-120"/>
                <a:cs typeface="Times New Roman" pitchFamily="18" charset="0"/>
              </a:rPr>
              <a:t>Sup. Fig. 1. 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Transverse sections of the spinal cord obtained from wild-type mice are </a:t>
            </a:r>
            <a:r>
              <a:rPr lang="en-US" altLang="zh-TW" sz="1200" dirty="0" err="1" smtClean="0">
                <a:latin typeface="Times New Roman" pitchFamily="18" charset="0"/>
                <a:cs typeface="Times New Roman" pitchFamily="18" charset="0"/>
              </a:rPr>
              <a:t>immunostained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 with anti-GFAP and -C/</a:t>
            </a:r>
            <a:r>
              <a:rPr lang="en-US" altLang="zh-TW" sz="1200" dirty="0" err="1" smtClean="0">
                <a:latin typeface="Times New Roman" pitchFamily="18" charset="0"/>
                <a:cs typeface="Times New Roman" pitchFamily="18" charset="0"/>
              </a:rPr>
              <a:t>EBPδ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 antibodies at Day 0, 7, 14, and 28 post-injury (P). Co-localization of GFAP and C/</a:t>
            </a:r>
            <a:r>
              <a:rPr lang="en-US" altLang="zh-TW" sz="1200" dirty="0" err="1" smtClean="0">
                <a:latin typeface="Times New Roman" pitchFamily="18" charset="0"/>
                <a:cs typeface="Times New Roman" pitchFamily="18" charset="0"/>
              </a:rPr>
              <a:t>EBPδ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TW" sz="1200" dirty="0" err="1" smtClean="0">
                <a:latin typeface="Times New Roman" pitchFamily="18" charset="0"/>
                <a:cs typeface="Times New Roman" pitchFamily="18" charset="0"/>
              </a:rPr>
              <a:t>immunoreactivity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 is evident in the residual cord tissue (dotted lines) </a:t>
            </a:r>
            <a:r>
              <a:rPr lang="en-US" altLang="zh-TW" sz="1200" dirty="0" err="1" smtClean="0">
                <a:latin typeface="Times New Roman" pitchFamily="18" charset="0"/>
                <a:cs typeface="Times New Roman" pitchFamily="18" charset="0"/>
              </a:rPr>
              <a:t>ventrolateral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 to the lesion epicenter particularly along the lesion border. </a:t>
            </a:r>
            <a:endParaRPr lang="zh-TW" altLang="zh-TW" sz="1200" dirty="0" smtClean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88" name="Picture 2" descr="C:\Users\User\Desktop\全景spinal cord\GFAP\2014-01-14 14-17-Region 002.jpg"/>
          <p:cNvPicPr preferRelativeResize="0">
            <a:picLocks noChangeArrowheads="1"/>
          </p:cNvPicPr>
          <p:nvPr/>
        </p:nvPicPr>
        <p:blipFill>
          <a:blip r:embed="rId2" cstate="print">
            <a:lum bright="48000" contrast="70000"/>
          </a:blip>
          <a:srcRect l="12204" t="4193" r="16475" b="18181"/>
          <a:stretch>
            <a:fillRect/>
          </a:stretch>
        </p:blipFill>
        <p:spPr bwMode="auto">
          <a:xfrm rot="16200000">
            <a:off x="1154521" y="1329354"/>
            <a:ext cx="874306" cy="1329777"/>
          </a:xfrm>
          <a:prstGeom prst="rect">
            <a:avLst/>
          </a:prstGeom>
          <a:noFill/>
          <a:ln w="25400">
            <a:solidFill>
              <a:schemeClr val="bg1"/>
            </a:solidFill>
          </a:ln>
        </p:spPr>
      </p:pic>
      <p:pic>
        <p:nvPicPr>
          <p:cNvPr id="89" name="Picture 3" descr="C:\Users\User\Desktop\全景spinal cord\cy3\2014-01-14 14-17-Region 002.jpg"/>
          <p:cNvPicPr preferRelativeResize="0">
            <a:picLocks noChangeArrowheads="1"/>
          </p:cNvPicPr>
          <p:nvPr/>
        </p:nvPicPr>
        <p:blipFill>
          <a:blip r:embed="rId3" cstate="print">
            <a:lum bright="48000" contrast="70000"/>
          </a:blip>
          <a:srcRect l="10629" t="2810" r="16492" b="18200"/>
          <a:stretch>
            <a:fillRect/>
          </a:stretch>
        </p:blipFill>
        <p:spPr bwMode="auto">
          <a:xfrm rot="16200000">
            <a:off x="1155081" y="2238577"/>
            <a:ext cx="874306" cy="1330897"/>
          </a:xfrm>
          <a:prstGeom prst="rect">
            <a:avLst/>
          </a:prstGeom>
          <a:noFill/>
          <a:ln w="25400">
            <a:solidFill>
              <a:schemeClr val="bg1"/>
            </a:solidFill>
          </a:ln>
        </p:spPr>
      </p:pic>
      <p:pic>
        <p:nvPicPr>
          <p:cNvPr id="92" name="Picture 5" descr="C:\Users\User\Desktop\全景spinal cord\marge\2014-01-14 14-17-Region 002.jpg"/>
          <p:cNvPicPr preferRelativeResize="0">
            <a:picLocks noChangeArrowheads="1"/>
          </p:cNvPicPr>
          <p:nvPr/>
        </p:nvPicPr>
        <p:blipFill>
          <a:blip r:embed="rId4" cstate="print">
            <a:lum bright="48000" contrast="70000"/>
          </a:blip>
          <a:srcRect l="11226" t="4737" r="19918" b="16273"/>
          <a:stretch>
            <a:fillRect/>
          </a:stretch>
        </p:blipFill>
        <p:spPr bwMode="auto">
          <a:xfrm rot="16200000">
            <a:off x="1155254" y="3119398"/>
            <a:ext cx="874326" cy="1331263"/>
          </a:xfrm>
          <a:prstGeom prst="rect">
            <a:avLst/>
          </a:prstGeom>
          <a:noFill/>
          <a:ln w="25400">
            <a:solidFill>
              <a:schemeClr val="bg1"/>
            </a:solidFill>
          </a:ln>
        </p:spPr>
      </p:pic>
      <p:pic>
        <p:nvPicPr>
          <p:cNvPr id="94" name="Picture 9" descr="C:\Users\User\Desktop\全景spinal cord\cy3\2014-01-14 14-17-Region 003.jpg"/>
          <p:cNvPicPr preferRelativeResize="0">
            <a:picLocks noChangeArrowheads="1"/>
          </p:cNvPicPr>
          <p:nvPr/>
        </p:nvPicPr>
        <p:blipFill>
          <a:blip r:embed="rId5" cstate="print">
            <a:lum bright="30000" contrast="50000"/>
          </a:blip>
          <a:stretch>
            <a:fillRect/>
          </a:stretch>
        </p:blipFill>
        <p:spPr bwMode="auto">
          <a:xfrm rot="16200000">
            <a:off x="2508653" y="2242839"/>
            <a:ext cx="874800" cy="1331263"/>
          </a:xfrm>
          <a:prstGeom prst="rect">
            <a:avLst/>
          </a:prstGeom>
          <a:noFill/>
          <a:ln w="25400">
            <a:solidFill>
              <a:schemeClr val="bg1"/>
            </a:solidFill>
          </a:ln>
        </p:spPr>
      </p:pic>
      <p:pic>
        <p:nvPicPr>
          <p:cNvPr id="95" name="Picture 6" descr="C:\Users\User\Desktop\全景spinal cord\GFAP\2014-01-14 14-17-Region 003.jpg"/>
          <p:cNvPicPr preferRelativeResize="0">
            <a:picLocks noChangeArrowheads="1"/>
          </p:cNvPicPr>
          <p:nvPr/>
        </p:nvPicPr>
        <p:blipFill>
          <a:blip r:embed="rId6" cstate="print">
            <a:lum bright="10000" contrast="40000"/>
          </a:blip>
          <a:stretch>
            <a:fillRect/>
          </a:stretch>
        </p:blipFill>
        <p:spPr bwMode="auto">
          <a:xfrm rot="16200000">
            <a:off x="2508654" y="1327029"/>
            <a:ext cx="874800" cy="1331263"/>
          </a:xfrm>
          <a:prstGeom prst="rect">
            <a:avLst/>
          </a:prstGeom>
          <a:noFill/>
          <a:ln w="25400">
            <a:solidFill>
              <a:schemeClr val="bg1"/>
            </a:solidFill>
          </a:ln>
        </p:spPr>
      </p:pic>
      <p:pic>
        <p:nvPicPr>
          <p:cNvPr id="100" name="Picture 11" descr="C:\Users\User\Desktop\全景spinal cord\marge\2014-01-14 14-17-Region 003.jpg"/>
          <p:cNvPicPr preferRelativeResize="0">
            <a:picLocks noChangeArrowheads="1"/>
          </p:cNvPicPr>
          <p:nvPr/>
        </p:nvPicPr>
        <p:blipFill>
          <a:blip r:embed="rId7" cstate="print">
            <a:lum bright="20000" contrast="50000"/>
          </a:blip>
          <a:stretch>
            <a:fillRect/>
          </a:stretch>
        </p:blipFill>
        <p:spPr bwMode="auto">
          <a:xfrm rot="16200000">
            <a:off x="2508656" y="3122523"/>
            <a:ext cx="874800" cy="1331263"/>
          </a:xfrm>
          <a:prstGeom prst="rect">
            <a:avLst/>
          </a:prstGeom>
          <a:noFill/>
          <a:ln w="25400">
            <a:solidFill>
              <a:schemeClr val="bg1"/>
            </a:solidFill>
          </a:ln>
        </p:spPr>
      </p:pic>
      <p:pic>
        <p:nvPicPr>
          <p:cNvPr id="105" name="Picture 17" descr="C:\Users\User\Desktop\全景spinal cord\cy3\2014-01-14 14-17-Region 014.jpg"/>
          <p:cNvPicPr preferRelativeResize="0">
            <a:picLocks noChangeArrowheads="1"/>
          </p:cNvPicPr>
          <p:nvPr/>
        </p:nvPicPr>
        <p:blipFill>
          <a:blip r:embed="rId8" cstate="print">
            <a:lum bright="40000" contrast="60000"/>
          </a:blip>
          <a:stretch>
            <a:fillRect/>
          </a:stretch>
        </p:blipFill>
        <p:spPr bwMode="auto">
          <a:xfrm rot="16200000">
            <a:off x="5245248" y="2238036"/>
            <a:ext cx="874326" cy="1332000"/>
          </a:xfrm>
          <a:prstGeom prst="rect">
            <a:avLst/>
          </a:prstGeom>
          <a:noFill/>
          <a:ln w="25400">
            <a:solidFill>
              <a:schemeClr val="bg1"/>
            </a:solidFill>
          </a:ln>
        </p:spPr>
      </p:pic>
      <p:pic>
        <p:nvPicPr>
          <p:cNvPr id="106" name="Picture 16" descr="C:\Users\User\Desktop\全景spinal cord\GFAP\2014-01-14 14-17-Region 014.jpg"/>
          <p:cNvPicPr preferRelativeResize="0">
            <a:picLocks noChangeArrowheads="1"/>
          </p:cNvPicPr>
          <p:nvPr/>
        </p:nvPicPr>
        <p:blipFill>
          <a:blip r:embed="rId9" cstate="print">
            <a:lum bright="26000" contrast="48000"/>
          </a:blip>
          <a:stretch>
            <a:fillRect/>
          </a:stretch>
        </p:blipFill>
        <p:spPr bwMode="auto">
          <a:xfrm rot="16200000">
            <a:off x="5252058" y="1328253"/>
            <a:ext cx="874326" cy="1332000"/>
          </a:xfrm>
          <a:prstGeom prst="rect">
            <a:avLst/>
          </a:prstGeom>
          <a:noFill/>
          <a:ln w="25400">
            <a:solidFill>
              <a:schemeClr val="bg1"/>
            </a:solidFill>
          </a:ln>
        </p:spPr>
      </p:pic>
      <p:pic>
        <p:nvPicPr>
          <p:cNvPr id="107" name="Picture 19" descr="C:\Users\User\Desktop\全景spinal cord\marge\2014-01-14 14-17-Region 014.jpg"/>
          <p:cNvPicPr preferRelativeResize="0">
            <a:picLocks noChangeArrowheads="1"/>
          </p:cNvPicPr>
          <p:nvPr/>
        </p:nvPicPr>
        <p:blipFill>
          <a:blip r:embed="rId10" cstate="print">
            <a:lum bright="30000" contrast="52000"/>
          </a:blip>
          <a:stretch>
            <a:fillRect/>
          </a:stretch>
        </p:blipFill>
        <p:spPr bwMode="auto">
          <a:xfrm rot="16200000">
            <a:off x="5259987" y="3118202"/>
            <a:ext cx="850901" cy="1345496"/>
          </a:xfrm>
          <a:prstGeom prst="rect">
            <a:avLst/>
          </a:prstGeom>
          <a:noFill/>
          <a:ln w="25400">
            <a:solidFill>
              <a:schemeClr val="bg1"/>
            </a:solidFill>
          </a:ln>
        </p:spPr>
      </p:pic>
      <p:sp>
        <p:nvSpPr>
          <p:cNvPr id="108" name="文字方塊 107"/>
          <p:cNvSpPr txBox="1"/>
          <p:nvPr/>
        </p:nvSpPr>
        <p:spPr>
          <a:xfrm rot="16200000">
            <a:off x="320527" y="1857401"/>
            <a:ext cx="859917" cy="27961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 smtClean="0">
                <a:solidFill>
                  <a:srgbClr val="00B050"/>
                </a:solidFill>
                <a:latin typeface="+mj-lt"/>
                <a:cs typeface="Times New Roman" pitchFamily="18" charset="0"/>
              </a:rPr>
              <a:t>GFAP</a:t>
            </a:r>
            <a:endParaRPr lang="zh-TW" altLang="en-US" sz="1200" b="1" dirty="0">
              <a:solidFill>
                <a:srgbClr val="00B050"/>
              </a:solidFill>
              <a:latin typeface="+mj-lt"/>
              <a:cs typeface="Times New Roman" pitchFamily="18" charset="0"/>
            </a:endParaRPr>
          </a:p>
        </p:txBody>
      </p:sp>
      <p:sp>
        <p:nvSpPr>
          <p:cNvPr id="109" name="文字方塊 108"/>
          <p:cNvSpPr txBox="1"/>
          <p:nvPr/>
        </p:nvSpPr>
        <p:spPr>
          <a:xfrm rot="16200000">
            <a:off x="320528" y="2761174"/>
            <a:ext cx="859917" cy="27961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 err="1" smtClean="0">
                <a:solidFill>
                  <a:srgbClr val="FF0000"/>
                </a:solidFill>
                <a:latin typeface="+mj-lt"/>
                <a:cs typeface="Times New Roman" pitchFamily="18" charset="0"/>
              </a:rPr>
              <a:t>Cebpd</a:t>
            </a:r>
            <a:endParaRPr lang="zh-TW" altLang="en-US" sz="1200" b="1" dirty="0">
              <a:solidFill>
                <a:srgbClr val="FF0000"/>
              </a:solidFill>
              <a:latin typeface="+mj-lt"/>
              <a:cs typeface="Times New Roman" pitchFamily="18" charset="0"/>
            </a:endParaRPr>
          </a:p>
        </p:txBody>
      </p:sp>
      <p:sp>
        <p:nvSpPr>
          <p:cNvPr id="110" name="文字方塊 109"/>
          <p:cNvSpPr txBox="1"/>
          <p:nvPr/>
        </p:nvSpPr>
        <p:spPr>
          <a:xfrm rot="16200000">
            <a:off x="-134164" y="4104560"/>
            <a:ext cx="1769301" cy="27961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 smtClean="0">
                <a:solidFill>
                  <a:schemeClr val="bg1"/>
                </a:solidFill>
                <a:latin typeface="+mj-lt"/>
                <a:cs typeface="Times New Roman" pitchFamily="18" charset="0"/>
              </a:rPr>
              <a:t>Merged</a:t>
            </a:r>
            <a:endParaRPr lang="zh-TW" altLang="en-US" sz="1200" b="1" dirty="0">
              <a:solidFill>
                <a:schemeClr val="bg1"/>
              </a:solidFill>
              <a:latin typeface="+mj-lt"/>
              <a:cs typeface="Times New Roman" pitchFamily="18" charset="0"/>
            </a:endParaRPr>
          </a:p>
        </p:txBody>
      </p:sp>
      <p:sp>
        <p:nvSpPr>
          <p:cNvPr id="111" name="文字方塊 110"/>
          <p:cNvSpPr txBox="1"/>
          <p:nvPr/>
        </p:nvSpPr>
        <p:spPr>
          <a:xfrm>
            <a:off x="947288" y="1238653"/>
            <a:ext cx="1295061" cy="27699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 smtClean="0">
                <a:solidFill>
                  <a:schemeClr val="bg1"/>
                </a:solidFill>
                <a:latin typeface="+mj-lt"/>
                <a:cs typeface="Times New Roman" pitchFamily="18" charset="0"/>
              </a:rPr>
              <a:t>P0</a:t>
            </a:r>
            <a:endParaRPr lang="zh-TW" altLang="en-US" sz="1200" b="1" dirty="0">
              <a:solidFill>
                <a:schemeClr val="bg1"/>
              </a:solidFill>
              <a:latin typeface="+mj-lt"/>
              <a:cs typeface="Times New Roman" pitchFamily="18" charset="0"/>
            </a:endParaRPr>
          </a:p>
        </p:txBody>
      </p:sp>
      <p:sp>
        <p:nvSpPr>
          <p:cNvPr id="112" name="文字方塊 111"/>
          <p:cNvSpPr txBox="1"/>
          <p:nvPr/>
        </p:nvSpPr>
        <p:spPr>
          <a:xfrm>
            <a:off x="2290966" y="1238653"/>
            <a:ext cx="1316694" cy="27699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 smtClean="0">
                <a:solidFill>
                  <a:schemeClr val="bg1"/>
                </a:solidFill>
                <a:latin typeface="+mj-lt"/>
                <a:cs typeface="Times New Roman" pitchFamily="18" charset="0"/>
              </a:rPr>
              <a:t>P7</a:t>
            </a:r>
            <a:endParaRPr lang="zh-TW" altLang="en-US" sz="1200" b="1" dirty="0">
              <a:solidFill>
                <a:schemeClr val="bg1"/>
              </a:solidFill>
              <a:latin typeface="+mj-lt"/>
              <a:cs typeface="Times New Roman" pitchFamily="18" charset="0"/>
            </a:endParaRPr>
          </a:p>
        </p:txBody>
      </p:sp>
      <p:sp>
        <p:nvSpPr>
          <p:cNvPr id="113" name="文字方塊 112"/>
          <p:cNvSpPr txBox="1"/>
          <p:nvPr/>
        </p:nvSpPr>
        <p:spPr>
          <a:xfrm>
            <a:off x="3671411" y="1238653"/>
            <a:ext cx="1302291" cy="27699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 smtClean="0">
                <a:solidFill>
                  <a:schemeClr val="bg1"/>
                </a:solidFill>
                <a:latin typeface="+mj-lt"/>
                <a:cs typeface="Times New Roman" pitchFamily="18" charset="0"/>
              </a:rPr>
              <a:t>P14</a:t>
            </a:r>
            <a:endParaRPr lang="zh-TW" altLang="en-US" sz="1200" b="1" dirty="0">
              <a:solidFill>
                <a:schemeClr val="bg1"/>
              </a:solidFill>
              <a:latin typeface="+mj-lt"/>
              <a:cs typeface="Times New Roman" pitchFamily="18" charset="0"/>
            </a:endParaRPr>
          </a:p>
        </p:txBody>
      </p:sp>
      <p:sp>
        <p:nvSpPr>
          <p:cNvPr id="114" name="文字方塊 113"/>
          <p:cNvSpPr txBox="1"/>
          <p:nvPr/>
        </p:nvSpPr>
        <p:spPr>
          <a:xfrm>
            <a:off x="5027354" y="1238653"/>
            <a:ext cx="1326850" cy="27699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 smtClean="0">
                <a:solidFill>
                  <a:schemeClr val="bg1"/>
                </a:solidFill>
                <a:latin typeface="+mj-lt"/>
                <a:cs typeface="Times New Roman" pitchFamily="18" charset="0"/>
              </a:rPr>
              <a:t>P28</a:t>
            </a:r>
            <a:endParaRPr lang="zh-TW" altLang="en-US" sz="1200" b="1" dirty="0">
              <a:solidFill>
                <a:schemeClr val="bg1"/>
              </a:solidFill>
              <a:latin typeface="+mj-lt"/>
              <a:cs typeface="Times New Roman" pitchFamily="18" charset="0"/>
            </a:endParaRPr>
          </a:p>
        </p:txBody>
      </p:sp>
      <p:pic>
        <p:nvPicPr>
          <p:cNvPr id="115" name="Picture 15" descr="C:\Users\User\Desktop\全景spinal cord\marge\2014-01-14 14-17-Region 006.jpg"/>
          <p:cNvPicPr preferRelativeResize="0">
            <a:picLocks noChangeArrowheads="1"/>
          </p:cNvPicPr>
          <p:nvPr/>
        </p:nvPicPr>
        <p:blipFill>
          <a:blip r:embed="rId11" cstate="print">
            <a:lum bright="16000" contrast="24000"/>
          </a:blip>
          <a:stretch>
            <a:fillRect/>
          </a:stretch>
        </p:blipFill>
        <p:spPr bwMode="auto">
          <a:xfrm rot="16200000">
            <a:off x="3879540" y="3119029"/>
            <a:ext cx="874326" cy="1332000"/>
          </a:xfrm>
          <a:prstGeom prst="rect">
            <a:avLst/>
          </a:prstGeom>
          <a:noFill/>
          <a:ln w="25400">
            <a:solidFill>
              <a:schemeClr val="bg1"/>
            </a:solidFill>
          </a:ln>
        </p:spPr>
      </p:pic>
      <p:pic>
        <p:nvPicPr>
          <p:cNvPr id="116" name="Picture 13" descr="C:\Users\User\Desktop\全景spinal cord\cy3\2014-01-14 14-17-Region 006.jpg"/>
          <p:cNvPicPr preferRelativeResize="0">
            <a:picLocks noChangeArrowheads="1"/>
          </p:cNvPicPr>
          <p:nvPr/>
        </p:nvPicPr>
        <p:blipFill>
          <a:blip r:embed="rId12" cstate="print">
            <a:lum bright="40000" contrast="60000"/>
          </a:blip>
          <a:stretch>
            <a:fillRect/>
          </a:stretch>
        </p:blipFill>
        <p:spPr bwMode="auto">
          <a:xfrm rot="16200000">
            <a:off x="3881580" y="2238036"/>
            <a:ext cx="874326" cy="1332000"/>
          </a:xfrm>
          <a:prstGeom prst="rect">
            <a:avLst/>
          </a:prstGeom>
          <a:noFill/>
          <a:ln w="25400">
            <a:solidFill>
              <a:schemeClr val="bg1"/>
            </a:solidFill>
          </a:ln>
        </p:spPr>
      </p:pic>
      <p:pic>
        <p:nvPicPr>
          <p:cNvPr id="117" name="Picture 12" descr="C:\Users\User\Desktop\全景spinal cord\GFAP\2014-01-14 14-17-Region 006.jpg"/>
          <p:cNvPicPr preferRelativeResize="0">
            <a:picLocks noChangeArrowheads="1"/>
          </p:cNvPicPr>
          <p:nvPr/>
        </p:nvPicPr>
        <p:blipFill>
          <a:blip r:embed="rId13" cstate="print">
            <a:lum bright="26000" contrast="48000"/>
          </a:blip>
          <a:stretch>
            <a:fillRect/>
          </a:stretch>
        </p:blipFill>
        <p:spPr bwMode="auto">
          <a:xfrm rot="16200000">
            <a:off x="3882853" y="1328253"/>
            <a:ext cx="874326" cy="1332000"/>
          </a:xfrm>
          <a:prstGeom prst="rect">
            <a:avLst/>
          </a:prstGeom>
          <a:noFill/>
          <a:ln w="25400">
            <a:solidFill>
              <a:schemeClr val="bg1"/>
            </a:solidFill>
          </a:ln>
        </p:spPr>
      </p:pic>
      <p:sp>
        <p:nvSpPr>
          <p:cNvPr id="118" name="手繪多邊形 117"/>
          <p:cNvSpPr/>
          <p:nvPr/>
        </p:nvSpPr>
        <p:spPr>
          <a:xfrm>
            <a:off x="3676905" y="1692530"/>
            <a:ext cx="1307139" cy="741653"/>
          </a:xfrm>
          <a:custGeom>
            <a:avLst/>
            <a:gdLst>
              <a:gd name="connsiteX0" fmla="*/ 340352 w 1307139"/>
              <a:gd name="connsiteY0" fmla="*/ 794 h 741653"/>
              <a:gd name="connsiteX1" fmla="*/ 349877 w 1307139"/>
              <a:gd name="connsiteY1" fmla="*/ 15081 h 741653"/>
              <a:gd name="connsiteX2" fmla="*/ 416552 w 1307139"/>
              <a:gd name="connsiteY2" fmla="*/ 29369 h 741653"/>
              <a:gd name="connsiteX3" fmla="*/ 449889 w 1307139"/>
              <a:gd name="connsiteY3" fmla="*/ 43656 h 741653"/>
              <a:gd name="connsiteX4" fmla="*/ 454652 w 1307139"/>
              <a:gd name="connsiteY4" fmla="*/ 62706 h 741653"/>
              <a:gd name="connsiteX5" fmla="*/ 449889 w 1307139"/>
              <a:gd name="connsiteY5" fmla="*/ 86519 h 741653"/>
              <a:gd name="connsiteX6" fmla="*/ 421314 w 1307139"/>
              <a:gd name="connsiteY6" fmla="*/ 110331 h 741653"/>
              <a:gd name="connsiteX7" fmla="*/ 373689 w 1307139"/>
              <a:gd name="connsiteY7" fmla="*/ 129381 h 741653"/>
              <a:gd name="connsiteX8" fmla="*/ 349877 w 1307139"/>
              <a:gd name="connsiteY8" fmla="*/ 134144 h 741653"/>
              <a:gd name="connsiteX9" fmla="*/ 330827 w 1307139"/>
              <a:gd name="connsiteY9" fmla="*/ 138906 h 741653"/>
              <a:gd name="connsiteX10" fmla="*/ 302252 w 1307139"/>
              <a:gd name="connsiteY10" fmla="*/ 143669 h 741653"/>
              <a:gd name="connsiteX11" fmla="*/ 283202 w 1307139"/>
              <a:gd name="connsiteY11" fmla="*/ 148431 h 741653"/>
              <a:gd name="connsiteX12" fmla="*/ 268914 w 1307139"/>
              <a:gd name="connsiteY12" fmla="*/ 153194 h 741653"/>
              <a:gd name="connsiteX13" fmla="*/ 221289 w 1307139"/>
              <a:gd name="connsiteY13" fmla="*/ 157956 h 741653"/>
              <a:gd name="connsiteX14" fmla="*/ 226052 w 1307139"/>
              <a:gd name="connsiteY14" fmla="*/ 177006 h 741653"/>
              <a:gd name="connsiteX15" fmla="*/ 235577 w 1307139"/>
              <a:gd name="connsiteY15" fmla="*/ 205581 h 741653"/>
              <a:gd name="connsiteX16" fmla="*/ 230814 w 1307139"/>
              <a:gd name="connsiteY16" fmla="*/ 248444 h 741653"/>
              <a:gd name="connsiteX17" fmla="*/ 221289 w 1307139"/>
              <a:gd name="connsiteY17" fmla="*/ 277019 h 741653"/>
              <a:gd name="connsiteX18" fmla="*/ 235577 w 1307139"/>
              <a:gd name="connsiteY18" fmla="*/ 362744 h 741653"/>
              <a:gd name="connsiteX19" fmla="*/ 249864 w 1307139"/>
              <a:gd name="connsiteY19" fmla="*/ 372269 h 741653"/>
              <a:gd name="connsiteX20" fmla="*/ 273677 w 1307139"/>
              <a:gd name="connsiteY20" fmla="*/ 410369 h 741653"/>
              <a:gd name="connsiteX21" fmla="*/ 283202 w 1307139"/>
              <a:gd name="connsiteY21" fmla="*/ 424656 h 741653"/>
              <a:gd name="connsiteX22" fmla="*/ 297489 w 1307139"/>
              <a:gd name="connsiteY22" fmla="*/ 438944 h 741653"/>
              <a:gd name="connsiteX23" fmla="*/ 302252 w 1307139"/>
              <a:gd name="connsiteY23" fmla="*/ 457994 h 741653"/>
              <a:gd name="connsiteX24" fmla="*/ 335589 w 1307139"/>
              <a:gd name="connsiteY24" fmla="*/ 477044 h 741653"/>
              <a:gd name="connsiteX25" fmla="*/ 397502 w 1307139"/>
              <a:gd name="connsiteY25" fmla="*/ 467519 h 741653"/>
              <a:gd name="connsiteX26" fmla="*/ 416552 w 1307139"/>
              <a:gd name="connsiteY26" fmla="*/ 438944 h 741653"/>
              <a:gd name="connsiteX27" fmla="*/ 426077 w 1307139"/>
              <a:gd name="connsiteY27" fmla="*/ 419894 h 741653"/>
              <a:gd name="connsiteX28" fmla="*/ 421314 w 1307139"/>
              <a:gd name="connsiteY28" fmla="*/ 405606 h 741653"/>
              <a:gd name="connsiteX29" fmla="*/ 473702 w 1307139"/>
              <a:gd name="connsiteY29" fmla="*/ 386556 h 741653"/>
              <a:gd name="connsiteX30" fmla="*/ 516564 w 1307139"/>
              <a:gd name="connsiteY30" fmla="*/ 381794 h 741653"/>
              <a:gd name="connsiteX31" fmla="*/ 530852 w 1307139"/>
              <a:gd name="connsiteY31" fmla="*/ 396081 h 741653"/>
              <a:gd name="connsiteX32" fmla="*/ 545139 w 1307139"/>
              <a:gd name="connsiteY32" fmla="*/ 467519 h 741653"/>
              <a:gd name="connsiteX33" fmla="*/ 559427 w 1307139"/>
              <a:gd name="connsiteY33" fmla="*/ 500856 h 741653"/>
              <a:gd name="connsiteX34" fmla="*/ 568952 w 1307139"/>
              <a:gd name="connsiteY34" fmla="*/ 519906 h 741653"/>
              <a:gd name="connsiteX35" fmla="*/ 588002 w 1307139"/>
              <a:gd name="connsiteY35" fmla="*/ 534194 h 741653"/>
              <a:gd name="connsiteX36" fmla="*/ 592764 w 1307139"/>
              <a:gd name="connsiteY36" fmla="*/ 548481 h 741653"/>
              <a:gd name="connsiteX37" fmla="*/ 640389 w 1307139"/>
              <a:gd name="connsiteY37" fmla="*/ 548481 h 741653"/>
              <a:gd name="connsiteX38" fmla="*/ 654677 w 1307139"/>
              <a:gd name="connsiteY38" fmla="*/ 538956 h 741653"/>
              <a:gd name="connsiteX39" fmla="*/ 664202 w 1307139"/>
              <a:gd name="connsiteY39" fmla="*/ 524669 h 741653"/>
              <a:gd name="connsiteX40" fmla="*/ 683252 w 1307139"/>
              <a:gd name="connsiteY40" fmla="*/ 519906 h 741653"/>
              <a:gd name="connsiteX41" fmla="*/ 697539 w 1307139"/>
              <a:gd name="connsiteY41" fmla="*/ 510381 h 741653"/>
              <a:gd name="connsiteX42" fmla="*/ 711827 w 1307139"/>
              <a:gd name="connsiteY42" fmla="*/ 496094 h 741653"/>
              <a:gd name="connsiteX43" fmla="*/ 730877 w 1307139"/>
              <a:gd name="connsiteY43" fmla="*/ 486569 h 741653"/>
              <a:gd name="connsiteX44" fmla="*/ 740402 w 1307139"/>
              <a:gd name="connsiteY44" fmla="*/ 467519 h 741653"/>
              <a:gd name="connsiteX45" fmla="*/ 754689 w 1307139"/>
              <a:gd name="connsiteY45" fmla="*/ 453231 h 741653"/>
              <a:gd name="connsiteX46" fmla="*/ 759452 w 1307139"/>
              <a:gd name="connsiteY46" fmla="*/ 396081 h 741653"/>
              <a:gd name="connsiteX47" fmla="*/ 864227 w 1307139"/>
              <a:gd name="connsiteY47" fmla="*/ 400844 h 741653"/>
              <a:gd name="connsiteX48" fmla="*/ 883277 w 1307139"/>
              <a:gd name="connsiteY48" fmla="*/ 429419 h 741653"/>
              <a:gd name="connsiteX49" fmla="*/ 911852 w 1307139"/>
              <a:gd name="connsiteY49" fmla="*/ 443706 h 741653"/>
              <a:gd name="connsiteX50" fmla="*/ 949952 w 1307139"/>
              <a:gd name="connsiteY50" fmla="*/ 467519 h 741653"/>
              <a:gd name="connsiteX51" fmla="*/ 978527 w 1307139"/>
              <a:gd name="connsiteY51" fmla="*/ 453231 h 741653"/>
              <a:gd name="connsiteX52" fmla="*/ 1002339 w 1307139"/>
              <a:gd name="connsiteY52" fmla="*/ 419894 h 741653"/>
              <a:gd name="connsiteX53" fmla="*/ 1007102 w 1307139"/>
              <a:gd name="connsiteY53" fmla="*/ 405606 h 741653"/>
              <a:gd name="connsiteX54" fmla="*/ 1026152 w 1307139"/>
              <a:gd name="connsiteY54" fmla="*/ 377031 h 741653"/>
              <a:gd name="connsiteX55" fmla="*/ 1035677 w 1307139"/>
              <a:gd name="connsiteY55" fmla="*/ 357981 h 741653"/>
              <a:gd name="connsiteX56" fmla="*/ 1049964 w 1307139"/>
              <a:gd name="connsiteY56" fmla="*/ 348456 h 741653"/>
              <a:gd name="connsiteX57" fmla="*/ 1064252 w 1307139"/>
              <a:gd name="connsiteY57" fmla="*/ 319881 h 741653"/>
              <a:gd name="connsiteX58" fmla="*/ 1078539 w 1307139"/>
              <a:gd name="connsiteY58" fmla="*/ 310356 h 741653"/>
              <a:gd name="connsiteX59" fmla="*/ 1121402 w 1307139"/>
              <a:gd name="connsiteY59" fmla="*/ 334169 h 741653"/>
              <a:gd name="connsiteX60" fmla="*/ 1135689 w 1307139"/>
              <a:gd name="connsiteY60" fmla="*/ 343694 h 741653"/>
              <a:gd name="connsiteX61" fmla="*/ 1173789 w 1307139"/>
              <a:gd name="connsiteY61" fmla="*/ 338931 h 741653"/>
              <a:gd name="connsiteX62" fmla="*/ 1202364 w 1307139"/>
              <a:gd name="connsiteY62" fmla="*/ 329406 h 741653"/>
              <a:gd name="connsiteX63" fmla="*/ 1216652 w 1307139"/>
              <a:gd name="connsiteY63" fmla="*/ 319881 h 741653"/>
              <a:gd name="connsiteX64" fmla="*/ 1245227 w 1307139"/>
              <a:gd name="connsiteY64" fmla="*/ 315119 h 741653"/>
              <a:gd name="connsiteX65" fmla="*/ 1264277 w 1307139"/>
              <a:gd name="connsiteY65" fmla="*/ 277019 h 741653"/>
              <a:gd name="connsiteX66" fmla="*/ 1283327 w 1307139"/>
              <a:gd name="connsiteY66" fmla="*/ 234156 h 741653"/>
              <a:gd name="connsiteX67" fmla="*/ 1292852 w 1307139"/>
              <a:gd name="connsiteY67" fmla="*/ 253206 h 741653"/>
              <a:gd name="connsiteX68" fmla="*/ 1297614 w 1307139"/>
              <a:gd name="connsiteY68" fmla="*/ 300831 h 741653"/>
              <a:gd name="connsiteX69" fmla="*/ 1302377 w 1307139"/>
              <a:gd name="connsiteY69" fmla="*/ 343694 h 741653"/>
              <a:gd name="connsiteX70" fmla="*/ 1307139 w 1307139"/>
              <a:gd name="connsiteY70" fmla="*/ 357981 h 741653"/>
              <a:gd name="connsiteX71" fmla="*/ 1302377 w 1307139"/>
              <a:gd name="connsiteY71" fmla="*/ 443706 h 741653"/>
              <a:gd name="connsiteX72" fmla="*/ 1297614 w 1307139"/>
              <a:gd name="connsiteY72" fmla="*/ 457994 h 741653"/>
              <a:gd name="connsiteX73" fmla="*/ 1264277 w 1307139"/>
              <a:gd name="connsiteY73" fmla="*/ 505619 h 741653"/>
              <a:gd name="connsiteX74" fmla="*/ 1245227 w 1307139"/>
              <a:gd name="connsiteY74" fmla="*/ 538956 h 741653"/>
              <a:gd name="connsiteX75" fmla="*/ 1226177 w 1307139"/>
              <a:gd name="connsiteY75" fmla="*/ 567531 h 741653"/>
              <a:gd name="connsiteX76" fmla="*/ 1202364 w 1307139"/>
              <a:gd name="connsiteY76" fmla="*/ 596106 h 741653"/>
              <a:gd name="connsiteX77" fmla="*/ 1188077 w 1307139"/>
              <a:gd name="connsiteY77" fmla="*/ 605631 h 741653"/>
              <a:gd name="connsiteX78" fmla="*/ 1159502 w 1307139"/>
              <a:gd name="connsiteY78" fmla="*/ 624681 h 741653"/>
              <a:gd name="connsiteX79" fmla="*/ 1130927 w 1307139"/>
              <a:gd name="connsiteY79" fmla="*/ 643731 h 741653"/>
              <a:gd name="connsiteX80" fmla="*/ 1088064 w 1307139"/>
              <a:gd name="connsiteY80" fmla="*/ 658019 h 741653"/>
              <a:gd name="connsiteX81" fmla="*/ 1073777 w 1307139"/>
              <a:gd name="connsiteY81" fmla="*/ 662781 h 741653"/>
              <a:gd name="connsiteX82" fmla="*/ 1045202 w 1307139"/>
              <a:gd name="connsiteY82" fmla="*/ 677069 h 741653"/>
              <a:gd name="connsiteX83" fmla="*/ 1011864 w 1307139"/>
              <a:gd name="connsiteY83" fmla="*/ 696119 h 741653"/>
              <a:gd name="connsiteX84" fmla="*/ 973764 w 1307139"/>
              <a:gd name="connsiteY84" fmla="*/ 705644 h 741653"/>
              <a:gd name="connsiteX85" fmla="*/ 935664 w 1307139"/>
              <a:gd name="connsiteY85" fmla="*/ 719931 h 741653"/>
              <a:gd name="connsiteX86" fmla="*/ 721352 w 1307139"/>
              <a:gd name="connsiteY86" fmla="*/ 715169 h 741653"/>
              <a:gd name="connsiteX87" fmla="*/ 668964 w 1307139"/>
              <a:gd name="connsiteY87" fmla="*/ 715169 h 741653"/>
              <a:gd name="connsiteX88" fmla="*/ 654677 w 1307139"/>
              <a:gd name="connsiteY88" fmla="*/ 724694 h 741653"/>
              <a:gd name="connsiteX89" fmla="*/ 635627 w 1307139"/>
              <a:gd name="connsiteY89" fmla="*/ 729456 h 741653"/>
              <a:gd name="connsiteX90" fmla="*/ 507039 w 1307139"/>
              <a:gd name="connsiteY90" fmla="*/ 724694 h 741653"/>
              <a:gd name="connsiteX91" fmla="*/ 397502 w 1307139"/>
              <a:gd name="connsiteY91" fmla="*/ 729456 h 741653"/>
              <a:gd name="connsiteX92" fmla="*/ 349877 w 1307139"/>
              <a:gd name="connsiteY92" fmla="*/ 729456 h 741653"/>
              <a:gd name="connsiteX93" fmla="*/ 307014 w 1307139"/>
              <a:gd name="connsiteY93" fmla="*/ 710406 h 741653"/>
              <a:gd name="connsiteX94" fmla="*/ 287964 w 1307139"/>
              <a:gd name="connsiteY94" fmla="*/ 696119 h 741653"/>
              <a:gd name="connsiteX95" fmla="*/ 240339 w 1307139"/>
              <a:gd name="connsiteY95" fmla="*/ 677069 h 741653"/>
              <a:gd name="connsiteX96" fmla="*/ 226052 w 1307139"/>
              <a:gd name="connsiteY96" fmla="*/ 667544 h 741653"/>
              <a:gd name="connsiteX97" fmla="*/ 211764 w 1307139"/>
              <a:gd name="connsiteY97" fmla="*/ 653256 h 741653"/>
              <a:gd name="connsiteX98" fmla="*/ 183189 w 1307139"/>
              <a:gd name="connsiteY98" fmla="*/ 643731 h 741653"/>
              <a:gd name="connsiteX99" fmla="*/ 149852 w 1307139"/>
              <a:gd name="connsiteY99" fmla="*/ 629444 h 741653"/>
              <a:gd name="connsiteX100" fmla="*/ 135564 w 1307139"/>
              <a:gd name="connsiteY100" fmla="*/ 615156 h 741653"/>
              <a:gd name="connsiteX101" fmla="*/ 121277 w 1307139"/>
              <a:gd name="connsiteY101" fmla="*/ 605631 h 741653"/>
              <a:gd name="connsiteX102" fmla="*/ 92702 w 1307139"/>
              <a:gd name="connsiteY102" fmla="*/ 572294 h 741653"/>
              <a:gd name="connsiteX103" fmla="*/ 78414 w 1307139"/>
              <a:gd name="connsiteY103" fmla="*/ 567531 h 741653"/>
              <a:gd name="connsiteX104" fmla="*/ 45077 w 1307139"/>
              <a:gd name="connsiteY104" fmla="*/ 558006 h 741653"/>
              <a:gd name="connsiteX105" fmla="*/ 26027 w 1307139"/>
              <a:gd name="connsiteY105" fmla="*/ 529431 h 741653"/>
              <a:gd name="connsiteX106" fmla="*/ 16502 w 1307139"/>
              <a:gd name="connsiteY106" fmla="*/ 491331 h 741653"/>
              <a:gd name="connsiteX107" fmla="*/ 11739 w 1307139"/>
              <a:gd name="connsiteY107" fmla="*/ 457994 h 741653"/>
              <a:gd name="connsiteX108" fmla="*/ 6977 w 1307139"/>
              <a:gd name="connsiteY108" fmla="*/ 438944 h 741653"/>
              <a:gd name="connsiteX109" fmla="*/ 6977 w 1307139"/>
              <a:gd name="connsiteY109" fmla="*/ 329406 h 741653"/>
              <a:gd name="connsiteX110" fmla="*/ 21264 w 1307139"/>
              <a:gd name="connsiteY110" fmla="*/ 277019 h 741653"/>
              <a:gd name="connsiteX111" fmla="*/ 40314 w 1307139"/>
              <a:gd name="connsiteY111" fmla="*/ 262731 h 741653"/>
              <a:gd name="connsiteX112" fmla="*/ 59364 w 1307139"/>
              <a:gd name="connsiteY112" fmla="*/ 238919 h 741653"/>
              <a:gd name="connsiteX113" fmla="*/ 78414 w 1307139"/>
              <a:gd name="connsiteY113" fmla="*/ 205581 h 741653"/>
              <a:gd name="connsiteX114" fmla="*/ 87939 w 1307139"/>
              <a:gd name="connsiteY114" fmla="*/ 177006 h 741653"/>
              <a:gd name="connsiteX115" fmla="*/ 97464 w 1307139"/>
              <a:gd name="connsiteY115" fmla="*/ 157956 h 741653"/>
              <a:gd name="connsiteX116" fmla="*/ 106989 w 1307139"/>
              <a:gd name="connsiteY116" fmla="*/ 129381 h 741653"/>
              <a:gd name="connsiteX117" fmla="*/ 111752 w 1307139"/>
              <a:gd name="connsiteY117" fmla="*/ 115094 h 741653"/>
              <a:gd name="connsiteX118" fmla="*/ 149852 w 1307139"/>
              <a:gd name="connsiteY118" fmla="*/ 72231 h 741653"/>
              <a:gd name="connsiteX119" fmla="*/ 173664 w 1307139"/>
              <a:gd name="connsiteY119" fmla="*/ 43656 h 741653"/>
              <a:gd name="connsiteX120" fmla="*/ 187952 w 1307139"/>
              <a:gd name="connsiteY120" fmla="*/ 38894 h 741653"/>
              <a:gd name="connsiteX121" fmla="*/ 240339 w 1307139"/>
              <a:gd name="connsiteY121" fmla="*/ 34131 h 741653"/>
              <a:gd name="connsiteX122" fmla="*/ 292727 w 1307139"/>
              <a:gd name="connsiteY122" fmla="*/ 19844 h 741653"/>
              <a:gd name="connsiteX123" fmla="*/ 307014 w 1307139"/>
              <a:gd name="connsiteY123" fmla="*/ 15081 h 741653"/>
              <a:gd name="connsiteX124" fmla="*/ 326064 w 1307139"/>
              <a:gd name="connsiteY124" fmla="*/ 10319 h 741653"/>
              <a:gd name="connsiteX125" fmla="*/ 340352 w 1307139"/>
              <a:gd name="connsiteY125" fmla="*/ 794 h 7416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</a:cxnLst>
            <a:rect l="l" t="t" r="r" b="b"/>
            <a:pathLst>
              <a:path w="1307139" h="741653">
                <a:moveTo>
                  <a:pt x="340352" y="794"/>
                </a:moveTo>
                <a:cubicBezTo>
                  <a:pt x="344321" y="1588"/>
                  <a:pt x="345830" y="11034"/>
                  <a:pt x="349877" y="15081"/>
                </a:cubicBezTo>
                <a:cubicBezTo>
                  <a:pt x="368166" y="33370"/>
                  <a:pt x="390899" y="27037"/>
                  <a:pt x="416552" y="29369"/>
                </a:cubicBezTo>
                <a:cubicBezTo>
                  <a:pt x="426112" y="31759"/>
                  <a:pt x="443311" y="33789"/>
                  <a:pt x="449889" y="43656"/>
                </a:cubicBezTo>
                <a:cubicBezTo>
                  <a:pt x="453520" y="49102"/>
                  <a:pt x="453064" y="56356"/>
                  <a:pt x="454652" y="62706"/>
                </a:cubicBezTo>
                <a:cubicBezTo>
                  <a:pt x="453064" y="70644"/>
                  <a:pt x="453509" y="79279"/>
                  <a:pt x="449889" y="86519"/>
                </a:cubicBezTo>
                <a:cubicBezTo>
                  <a:pt x="445949" y="94400"/>
                  <a:pt x="428972" y="105955"/>
                  <a:pt x="421314" y="110331"/>
                </a:cubicBezTo>
                <a:cubicBezTo>
                  <a:pt x="407636" y="118147"/>
                  <a:pt x="388702" y="126378"/>
                  <a:pt x="373689" y="129381"/>
                </a:cubicBezTo>
                <a:cubicBezTo>
                  <a:pt x="365752" y="130969"/>
                  <a:pt x="357779" y="132388"/>
                  <a:pt x="349877" y="134144"/>
                </a:cubicBezTo>
                <a:cubicBezTo>
                  <a:pt x="343487" y="135564"/>
                  <a:pt x="337245" y="137622"/>
                  <a:pt x="330827" y="138906"/>
                </a:cubicBezTo>
                <a:cubicBezTo>
                  <a:pt x="321358" y="140800"/>
                  <a:pt x="311721" y="141775"/>
                  <a:pt x="302252" y="143669"/>
                </a:cubicBezTo>
                <a:cubicBezTo>
                  <a:pt x="295834" y="144953"/>
                  <a:pt x="289496" y="146633"/>
                  <a:pt x="283202" y="148431"/>
                </a:cubicBezTo>
                <a:cubicBezTo>
                  <a:pt x="278375" y="149810"/>
                  <a:pt x="273876" y="152431"/>
                  <a:pt x="268914" y="153194"/>
                </a:cubicBezTo>
                <a:cubicBezTo>
                  <a:pt x="253145" y="155620"/>
                  <a:pt x="237164" y="156369"/>
                  <a:pt x="221289" y="157956"/>
                </a:cubicBezTo>
                <a:cubicBezTo>
                  <a:pt x="222877" y="164306"/>
                  <a:pt x="224171" y="170737"/>
                  <a:pt x="226052" y="177006"/>
                </a:cubicBezTo>
                <a:cubicBezTo>
                  <a:pt x="228937" y="186623"/>
                  <a:pt x="235577" y="205581"/>
                  <a:pt x="235577" y="205581"/>
                </a:cubicBezTo>
                <a:cubicBezTo>
                  <a:pt x="233989" y="219869"/>
                  <a:pt x="233633" y="234348"/>
                  <a:pt x="230814" y="248444"/>
                </a:cubicBezTo>
                <a:cubicBezTo>
                  <a:pt x="228845" y="258289"/>
                  <a:pt x="221289" y="277019"/>
                  <a:pt x="221289" y="277019"/>
                </a:cubicBezTo>
                <a:cubicBezTo>
                  <a:pt x="223043" y="303323"/>
                  <a:pt x="213627" y="340793"/>
                  <a:pt x="235577" y="362744"/>
                </a:cubicBezTo>
                <a:cubicBezTo>
                  <a:pt x="239624" y="366791"/>
                  <a:pt x="245102" y="369094"/>
                  <a:pt x="249864" y="372269"/>
                </a:cubicBezTo>
                <a:cubicBezTo>
                  <a:pt x="261199" y="406274"/>
                  <a:pt x="251035" y="395275"/>
                  <a:pt x="273677" y="410369"/>
                </a:cubicBezTo>
                <a:cubicBezTo>
                  <a:pt x="276852" y="415131"/>
                  <a:pt x="279538" y="420259"/>
                  <a:pt x="283202" y="424656"/>
                </a:cubicBezTo>
                <a:cubicBezTo>
                  <a:pt x="287514" y="429830"/>
                  <a:pt x="294147" y="433096"/>
                  <a:pt x="297489" y="438944"/>
                </a:cubicBezTo>
                <a:cubicBezTo>
                  <a:pt x="300736" y="444627"/>
                  <a:pt x="298621" y="452548"/>
                  <a:pt x="302252" y="457994"/>
                </a:cubicBezTo>
                <a:cubicBezTo>
                  <a:pt x="305618" y="463043"/>
                  <a:pt x="332293" y="475396"/>
                  <a:pt x="335589" y="477044"/>
                </a:cubicBezTo>
                <a:cubicBezTo>
                  <a:pt x="356227" y="473869"/>
                  <a:pt x="377572" y="473747"/>
                  <a:pt x="397502" y="467519"/>
                </a:cubicBezTo>
                <a:cubicBezTo>
                  <a:pt x="412319" y="462888"/>
                  <a:pt x="411909" y="449777"/>
                  <a:pt x="416552" y="438944"/>
                </a:cubicBezTo>
                <a:cubicBezTo>
                  <a:pt x="419349" y="432419"/>
                  <a:pt x="422902" y="426244"/>
                  <a:pt x="426077" y="419894"/>
                </a:cubicBezTo>
                <a:cubicBezTo>
                  <a:pt x="424489" y="415131"/>
                  <a:pt x="419069" y="410096"/>
                  <a:pt x="421314" y="405606"/>
                </a:cubicBezTo>
                <a:cubicBezTo>
                  <a:pt x="430477" y="387279"/>
                  <a:pt x="459190" y="388629"/>
                  <a:pt x="473702" y="386556"/>
                </a:cubicBezTo>
                <a:cubicBezTo>
                  <a:pt x="507039" y="375444"/>
                  <a:pt x="492752" y="373856"/>
                  <a:pt x="516564" y="381794"/>
                </a:cubicBezTo>
                <a:cubicBezTo>
                  <a:pt x="521327" y="386556"/>
                  <a:pt x="529117" y="389573"/>
                  <a:pt x="530852" y="396081"/>
                </a:cubicBezTo>
                <a:cubicBezTo>
                  <a:pt x="555296" y="487747"/>
                  <a:pt x="519259" y="428698"/>
                  <a:pt x="545139" y="467519"/>
                </a:cubicBezTo>
                <a:cubicBezTo>
                  <a:pt x="552962" y="498809"/>
                  <a:pt x="544809" y="475275"/>
                  <a:pt x="559427" y="500856"/>
                </a:cubicBezTo>
                <a:cubicBezTo>
                  <a:pt x="562949" y="507020"/>
                  <a:pt x="564332" y="514516"/>
                  <a:pt x="568952" y="519906"/>
                </a:cubicBezTo>
                <a:cubicBezTo>
                  <a:pt x="574118" y="525933"/>
                  <a:pt x="581652" y="529431"/>
                  <a:pt x="588002" y="534194"/>
                </a:cubicBezTo>
                <a:cubicBezTo>
                  <a:pt x="589589" y="538956"/>
                  <a:pt x="589214" y="544931"/>
                  <a:pt x="592764" y="548481"/>
                </a:cubicBezTo>
                <a:cubicBezTo>
                  <a:pt x="603155" y="558872"/>
                  <a:pt x="634606" y="549307"/>
                  <a:pt x="640389" y="548481"/>
                </a:cubicBezTo>
                <a:cubicBezTo>
                  <a:pt x="645152" y="545306"/>
                  <a:pt x="650629" y="543003"/>
                  <a:pt x="654677" y="538956"/>
                </a:cubicBezTo>
                <a:cubicBezTo>
                  <a:pt x="658724" y="534909"/>
                  <a:pt x="659440" y="527844"/>
                  <a:pt x="664202" y="524669"/>
                </a:cubicBezTo>
                <a:cubicBezTo>
                  <a:pt x="669648" y="521038"/>
                  <a:pt x="676902" y="521494"/>
                  <a:pt x="683252" y="519906"/>
                </a:cubicBezTo>
                <a:cubicBezTo>
                  <a:pt x="688014" y="516731"/>
                  <a:pt x="693142" y="514045"/>
                  <a:pt x="697539" y="510381"/>
                </a:cubicBezTo>
                <a:cubicBezTo>
                  <a:pt x="702713" y="506069"/>
                  <a:pt x="706346" y="500009"/>
                  <a:pt x="711827" y="496094"/>
                </a:cubicBezTo>
                <a:cubicBezTo>
                  <a:pt x="717604" y="491968"/>
                  <a:pt x="724527" y="489744"/>
                  <a:pt x="730877" y="486569"/>
                </a:cubicBezTo>
                <a:cubicBezTo>
                  <a:pt x="734052" y="480219"/>
                  <a:pt x="736276" y="473296"/>
                  <a:pt x="740402" y="467519"/>
                </a:cubicBezTo>
                <a:cubicBezTo>
                  <a:pt x="744317" y="462038"/>
                  <a:pt x="752954" y="459739"/>
                  <a:pt x="754689" y="453231"/>
                </a:cubicBezTo>
                <a:cubicBezTo>
                  <a:pt x="759614" y="434760"/>
                  <a:pt x="757864" y="415131"/>
                  <a:pt x="759452" y="396081"/>
                </a:cubicBezTo>
                <a:cubicBezTo>
                  <a:pt x="794377" y="397669"/>
                  <a:pt x="830468" y="391755"/>
                  <a:pt x="864227" y="400844"/>
                </a:cubicBezTo>
                <a:cubicBezTo>
                  <a:pt x="875281" y="403820"/>
                  <a:pt x="876927" y="419894"/>
                  <a:pt x="883277" y="429419"/>
                </a:cubicBezTo>
                <a:cubicBezTo>
                  <a:pt x="889380" y="438573"/>
                  <a:pt x="902976" y="439902"/>
                  <a:pt x="911852" y="443706"/>
                </a:cubicBezTo>
                <a:cubicBezTo>
                  <a:pt x="932190" y="452422"/>
                  <a:pt x="931720" y="453845"/>
                  <a:pt x="949952" y="467519"/>
                </a:cubicBezTo>
                <a:cubicBezTo>
                  <a:pt x="961571" y="463645"/>
                  <a:pt x="969296" y="462462"/>
                  <a:pt x="978527" y="453231"/>
                </a:cubicBezTo>
                <a:cubicBezTo>
                  <a:pt x="980682" y="451076"/>
                  <a:pt x="999636" y="425300"/>
                  <a:pt x="1002339" y="419894"/>
                </a:cubicBezTo>
                <a:cubicBezTo>
                  <a:pt x="1004584" y="415404"/>
                  <a:pt x="1004664" y="409995"/>
                  <a:pt x="1007102" y="405606"/>
                </a:cubicBezTo>
                <a:cubicBezTo>
                  <a:pt x="1012661" y="395599"/>
                  <a:pt x="1019802" y="386556"/>
                  <a:pt x="1026152" y="377031"/>
                </a:cubicBezTo>
                <a:cubicBezTo>
                  <a:pt x="1030090" y="371124"/>
                  <a:pt x="1031132" y="363435"/>
                  <a:pt x="1035677" y="357981"/>
                </a:cubicBezTo>
                <a:cubicBezTo>
                  <a:pt x="1039341" y="353584"/>
                  <a:pt x="1045202" y="351631"/>
                  <a:pt x="1049964" y="348456"/>
                </a:cubicBezTo>
                <a:cubicBezTo>
                  <a:pt x="1053838" y="336837"/>
                  <a:pt x="1055021" y="329113"/>
                  <a:pt x="1064252" y="319881"/>
                </a:cubicBezTo>
                <a:cubicBezTo>
                  <a:pt x="1068299" y="315834"/>
                  <a:pt x="1073777" y="313531"/>
                  <a:pt x="1078539" y="310356"/>
                </a:cubicBezTo>
                <a:cubicBezTo>
                  <a:pt x="1103687" y="318739"/>
                  <a:pt x="1088651" y="312334"/>
                  <a:pt x="1121402" y="334169"/>
                </a:cubicBezTo>
                <a:lnTo>
                  <a:pt x="1135689" y="343694"/>
                </a:lnTo>
                <a:cubicBezTo>
                  <a:pt x="1148389" y="342106"/>
                  <a:pt x="1161274" y="341613"/>
                  <a:pt x="1173789" y="338931"/>
                </a:cubicBezTo>
                <a:cubicBezTo>
                  <a:pt x="1183606" y="336827"/>
                  <a:pt x="1194010" y="334975"/>
                  <a:pt x="1202364" y="329406"/>
                </a:cubicBezTo>
                <a:cubicBezTo>
                  <a:pt x="1207127" y="326231"/>
                  <a:pt x="1211222" y="321691"/>
                  <a:pt x="1216652" y="319881"/>
                </a:cubicBezTo>
                <a:cubicBezTo>
                  <a:pt x="1225813" y="316828"/>
                  <a:pt x="1235702" y="316706"/>
                  <a:pt x="1245227" y="315119"/>
                </a:cubicBezTo>
                <a:cubicBezTo>
                  <a:pt x="1259964" y="295468"/>
                  <a:pt x="1260456" y="299947"/>
                  <a:pt x="1264277" y="277019"/>
                </a:cubicBezTo>
                <a:cubicBezTo>
                  <a:pt x="1271563" y="233304"/>
                  <a:pt x="1256151" y="243215"/>
                  <a:pt x="1283327" y="234156"/>
                </a:cubicBezTo>
                <a:cubicBezTo>
                  <a:pt x="1286502" y="240506"/>
                  <a:pt x="1291364" y="246264"/>
                  <a:pt x="1292852" y="253206"/>
                </a:cubicBezTo>
                <a:cubicBezTo>
                  <a:pt x="1296195" y="268806"/>
                  <a:pt x="1295944" y="284964"/>
                  <a:pt x="1297614" y="300831"/>
                </a:cubicBezTo>
                <a:cubicBezTo>
                  <a:pt x="1299119" y="315128"/>
                  <a:pt x="1300014" y="329514"/>
                  <a:pt x="1302377" y="343694"/>
                </a:cubicBezTo>
                <a:cubicBezTo>
                  <a:pt x="1303202" y="348646"/>
                  <a:pt x="1305552" y="353219"/>
                  <a:pt x="1307139" y="357981"/>
                </a:cubicBezTo>
                <a:cubicBezTo>
                  <a:pt x="1305552" y="386556"/>
                  <a:pt x="1305090" y="415216"/>
                  <a:pt x="1302377" y="443706"/>
                </a:cubicBezTo>
                <a:cubicBezTo>
                  <a:pt x="1301901" y="448704"/>
                  <a:pt x="1300052" y="453605"/>
                  <a:pt x="1297614" y="457994"/>
                </a:cubicBezTo>
                <a:cubicBezTo>
                  <a:pt x="1289239" y="473069"/>
                  <a:pt x="1274978" y="491351"/>
                  <a:pt x="1264277" y="505619"/>
                </a:cubicBezTo>
                <a:cubicBezTo>
                  <a:pt x="1256341" y="529425"/>
                  <a:pt x="1263574" y="512745"/>
                  <a:pt x="1245227" y="538956"/>
                </a:cubicBezTo>
                <a:cubicBezTo>
                  <a:pt x="1238662" y="548334"/>
                  <a:pt x="1232527" y="558006"/>
                  <a:pt x="1226177" y="567531"/>
                </a:cubicBezTo>
                <a:cubicBezTo>
                  <a:pt x="1216810" y="581582"/>
                  <a:pt x="1216118" y="584644"/>
                  <a:pt x="1202364" y="596106"/>
                </a:cubicBezTo>
                <a:cubicBezTo>
                  <a:pt x="1197967" y="599770"/>
                  <a:pt x="1192474" y="601967"/>
                  <a:pt x="1188077" y="605631"/>
                </a:cubicBezTo>
                <a:cubicBezTo>
                  <a:pt x="1164295" y="625450"/>
                  <a:pt x="1184609" y="616312"/>
                  <a:pt x="1159502" y="624681"/>
                </a:cubicBezTo>
                <a:lnTo>
                  <a:pt x="1130927" y="643731"/>
                </a:lnTo>
                <a:cubicBezTo>
                  <a:pt x="1118615" y="651939"/>
                  <a:pt x="1101950" y="654052"/>
                  <a:pt x="1088064" y="658019"/>
                </a:cubicBezTo>
                <a:cubicBezTo>
                  <a:pt x="1083237" y="659398"/>
                  <a:pt x="1078539" y="661194"/>
                  <a:pt x="1073777" y="662781"/>
                </a:cubicBezTo>
                <a:cubicBezTo>
                  <a:pt x="1032828" y="690079"/>
                  <a:pt x="1084638" y="657350"/>
                  <a:pt x="1045202" y="677069"/>
                </a:cubicBezTo>
                <a:cubicBezTo>
                  <a:pt x="1024303" y="687519"/>
                  <a:pt x="1036906" y="687772"/>
                  <a:pt x="1011864" y="696119"/>
                </a:cubicBezTo>
                <a:cubicBezTo>
                  <a:pt x="999445" y="700259"/>
                  <a:pt x="985473" y="699790"/>
                  <a:pt x="973764" y="705644"/>
                </a:cubicBezTo>
                <a:cubicBezTo>
                  <a:pt x="948860" y="718096"/>
                  <a:pt x="961602" y="713447"/>
                  <a:pt x="935664" y="719931"/>
                </a:cubicBezTo>
                <a:lnTo>
                  <a:pt x="721352" y="715169"/>
                </a:lnTo>
                <a:cubicBezTo>
                  <a:pt x="657311" y="712555"/>
                  <a:pt x="767264" y="701125"/>
                  <a:pt x="668964" y="715169"/>
                </a:cubicBezTo>
                <a:cubicBezTo>
                  <a:pt x="664202" y="718344"/>
                  <a:pt x="659938" y="722439"/>
                  <a:pt x="654677" y="724694"/>
                </a:cubicBezTo>
                <a:cubicBezTo>
                  <a:pt x="648661" y="727272"/>
                  <a:pt x="642172" y="729456"/>
                  <a:pt x="635627" y="729456"/>
                </a:cubicBezTo>
                <a:cubicBezTo>
                  <a:pt x="592735" y="729456"/>
                  <a:pt x="549902" y="726281"/>
                  <a:pt x="507039" y="724694"/>
                </a:cubicBezTo>
                <a:cubicBezTo>
                  <a:pt x="470527" y="726281"/>
                  <a:pt x="433949" y="726756"/>
                  <a:pt x="397502" y="729456"/>
                </a:cubicBezTo>
                <a:cubicBezTo>
                  <a:pt x="359760" y="732252"/>
                  <a:pt x="398663" y="741653"/>
                  <a:pt x="349877" y="729456"/>
                </a:cubicBezTo>
                <a:cubicBezTo>
                  <a:pt x="326049" y="723499"/>
                  <a:pt x="323854" y="722434"/>
                  <a:pt x="307014" y="710406"/>
                </a:cubicBezTo>
                <a:cubicBezTo>
                  <a:pt x="300555" y="705793"/>
                  <a:pt x="295063" y="699669"/>
                  <a:pt x="287964" y="696119"/>
                </a:cubicBezTo>
                <a:cubicBezTo>
                  <a:pt x="209925" y="657101"/>
                  <a:pt x="298583" y="710352"/>
                  <a:pt x="240339" y="677069"/>
                </a:cubicBezTo>
                <a:cubicBezTo>
                  <a:pt x="235369" y="674229"/>
                  <a:pt x="230449" y="671208"/>
                  <a:pt x="226052" y="667544"/>
                </a:cubicBezTo>
                <a:cubicBezTo>
                  <a:pt x="220878" y="663232"/>
                  <a:pt x="217652" y="656527"/>
                  <a:pt x="211764" y="653256"/>
                </a:cubicBezTo>
                <a:cubicBezTo>
                  <a:pt x="202987" y="648380"/>
                  <a:pt x="192714" y="646906"/>
                  <a:pt x="183189" y="643731"/>
                </a:cubicBezTo>
                <a:cubicBezTo>
                  <a:pt x="171528" y="639844"/>
                  <a:pt x="160152" y="636801"/>
                  <a:pt x="149852" y="629444"/>
                </a:cubicBezTo>
                <a:cubicBezTo>
                  <a:pt x="144371" y="625529"/>
                  <a:pt x="140738" y="619468"/>
                  <a:pt x="135564" y="615156"/>
                </a:cubicBezTo>
                <a:cubicBezTo>
                  <a:pt x="131167" y="611492"/>
                  <a:pt x="125324" y="609678"/>
                  <a:pt x="121277" y="605631"/>
                </a:cubicBezTo>
                <a:cubicBezTo>
                  <a:pt x="108075" y="592429"/>
                  <a:pt x="108252" y="582661"/>
                  <a:pt x="92702" y="572294"/>
                </a:cubicBezTo>
                <a:cubicBezTo>
                  <a:pt x="88525" y="569509"/>
                  <a:pt x="83241" y="568910"/>
                  <a:pt x="78414" y="567531"/>
                </a:cubicBezTo>
                <a:cubicBezTo>
                  <a:pt x="36562" y="555573"/>
                  <a:pt x="79326" y="569424"/>
                  <a:pt x="45077" y="558006"/>
                </a:cubicBezTo>
                <a:lnTo>
                  <a:pt x="26027" y="529431"/>
                </a:lnTo>
                <a:cubicBezTo>
                  <a:pt x="18765" y="518539"/>
                  <a:pt x="19677" y="504031"/>
                  <a:pt x="16502" y="491331"/>
                </a:cubicBezTo>
                <a:cubicBezTo>
                  <a:pt x="13779" y="480441"/>
                  <a:pt x="13747" y="469038"/>
                  <a:pt x="11739" y="457994"/>
                </a:cubicBezTo>
                <a:cubicBezTo>
                  <a:pt x="10568" y="451554"/>
                  <a:pt x="8564" y="445294"/>
                  <a:pt x="6977" y="438944"/>
                </a:cubicBezTo>
                <a:cubicBezTo>
                  <a:pt x="1179" y="375167"/>
                  <a:pt x="0" y="395691"/>
                  <a:pt x="6977" y="329406"/>
                </a:cubicBezTo>
                <a:cubicBezTo>
                  <a:pt x="8714" y="312905"/>
                  <a:pt x="9267" y="291015"/>
                  <a:pt x="21264" y="277019"/>
                </a:cubicBezTo>
                <a:cubicBezTo>
                  <a:pt x="26430" y="270992"/>
                  <a:pt x="33964" y="267494"/>
                  <a:pt x="40314" y="262731"/>
                </a:cubicBezTo>
                <a:cubicBezTo>
                  <a:pt x="49587" y="234916"/>
                  <a:pt x="37822" y="260462"/>
                  <a:pt x="59364" y="238919"/>
                </a:cubicBezTo>
                <a:cubicBezTo>
                  <a:pt x="65091" y="233192"/>
                  <a:pt x="75924" y="211806"/>
                  <a:pt x="78414" y="205581"/>
                </a:cubicBezTo>
                <a:cubicBezTo>
                  <a:pt x="82143" y="196259"/>
                  <a:pt x="83449" y="185986"/>
                  <a:pt x="87939" y="177006"/>
                </a:cubicBezTo>
                <a:cubicBezTo>
                  <a:pt x="91114" y="170656"/>
                  <a:pt x="94827" y="164548"/>
                  <a:pt x="97464" y="157956"/>
                </a:cubicBezTo>
                <a:cubicBezTo>
                  <a:pt x="101193" y="148634"/>
                  <a:pt x="103814" y="138906"/>
                  <a:pt x="106989" y="129381"/>
                </a:cubicBezTo>
                <a:lnTo>
                  <a:pt x="111752" y="115094"/>
                </a:lnTo>
                <a:cubicBezTo>
                  <a:pt x="116003" y="102344"/>
                  <a:pt x="147226" y="74857"/>
                  <a:pt x="149852" y="72231"/>
                </a:cubicBezTo>
                <a:cubicBezTo>
                  <a:pt x="167419" y="54664"/>
                  <a:pt x="150263" y="59256"/>
                  <a:pt x="173664" y="43656"/>
                </a:cubicBezTo>
                <a:cubicBezTo>
                  <a:pt x="177841" y="40871"/>
                  <a:pt x="182982" y="39604"/>
                  <a:pt x="187952" y="38894"/>
                </a:cubicBezTo>
                <a:cubicBezTo>
                  <a:pt x="205310" y="36414"/>
                  <a:pt x="222877" y="35719"/>
                  <a:pt x="240339" y="34131"/>
                </a:cubicBezTo>
                <a:cubicBezTo>
                  <a:pt x="267046" y="25230"/>
                  <a:pt x="249757" y="30587"/>
                  <a:pt x="292727" y="19844"/>
                </a:cubicBezTo>
                <a:cubicBezTo>
                  <a:pt x="297597" y="18626"/>
                  <a:pt x="302187" y="16460"/>
                  <a:pt x="307014" y="15081"/>
                </a:cubicBezTo>
                <a:cubicBezTo>
                  <a:pt x="313308" y="13283"/>
                  <a:pt x="319770" y="12117"/>
                  <a:pt x="326064" y="10319"/>
                </a:cubicBezTo>
                <a:cubicBezTo>
                  <a:pt x="330891" y="8940"/>
                  <a:pt x="336383" y="0"/>
                  <a:pt x="340352" y="794"/>
                </a:cubicBezTo>
                <a:close/>
              </a:path>
            </a:pathLst>
          </a:custGeom>
          <a:noFill/>
          <a:ln w="222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19" name="手繪多邊形 118"/>
          <p:cNvSpPr/>
          <p:nvPr/>
        </p:nvSpPr>
        <p:spPr>
          <a:xfrm>
            <a:off x="3644318" y="2569723"/>
            <a:ext cx="1307139" cy="741653"/>
          </a:xfrm>
          <a:custGeom>
            <a:avLst/>
            <a:gdLst>
              <a:gd name="connsiteX0" fmla="*/ 340352 w 1307139"/>
              <a:gd name="connsiteY0" fmla="*/ 794 h 741653"/>
              <a:gd name="connsiteX1" fmla="*/ 349877 w 1307139"/>
              <a:gd name="connsiteY1" fmla="*/ 15081 h 741653"/>
              <a:gd name="connsiteX2" fmla="*/ 416552 w 1307139"/>
              <a:gd name="connsiteY2" fmla="*/ 29369 h 741653"/>
              <a:gd name="connsiteX3" fmla="*/ 449889 w 1307139"/>
              <a:gd name="connsiteY3" fmla="*/ 43656 h 741653"/>
              <a:gd name="connsiteX4" fmla="*/ 454652 w 1307139"/>
              <a:gd name="connsiteY4" fmla="*/ 62706 h 741653"/>
              <a:gd name="connsiteX5" fmla="*/ 449889 w 1307139"/>
              <a:gd name="connsiteY5" fmla="*/ 86519 h 741653"/>
              <a:gd name="connsiteX6" fmla="*/ 421314 w 1307139"/>
              <a:gd name="connsiteY6" fmla="*/ 110331 h 741653"/>
              <a:gd name="connsiteX7" fmla="*/ 373689 w 1307139"/>
              <a:gd name="connsiteY7" fmla="*/ 129381 h 741653"/>
              <a:gd name="connsiteX8" fmla="*/ 349877 w 1307139"/>
              <a:gd name="connsiteY8" fmla="*/ 134144 h 741653"/>
              <a:gd name="connsiteX9" fmla="*/ 330827 w 1307139"/>
              <a:gd name="connsiteY9" fmla="*/ 138906 h 741653"/>
              <a:gd name="connsiteX10" fmla="*/ 302252 w 1307139"/>
              <a:gd name="connsiteY10" fmla="*/ 143669 h 741653"/>
              <a:gd name="connsiteX11" fmla="*/ 283202 w 1307139"/>
              <a:gd name="connsiteY11" fmla="*/ 148431 h 741653"/>
              <a:gd name="connsiteX12" fmla="*/ 268914 w 1307139"/>
              <a:gd name="connsiteY12" fmla="*/ 153194 h 741653"/>
              <a:gd name="connsiteX13" fmla="*/ 221289 w 1307139"/>
              <a:gd name="connsiteY13" fmla="*/ 157956 h 741653"/>
              <a:gd name="connsiteX14" fmla="*/ 226052 w 1307139"/>
              <a:gd name="connsiteY14" fmla="*/ 177006 h 741653"/>
              <a:gd name="connsiteX15" fmla="*/ 235577 w 1307139"/>
              <a:gd name="connsiteY15" fmla="*/ 205581 h 741653"/>
              <a:gd name="connsiteX16" fmla="*/ 230814 w 1307139"/>
              <a:gd name="connsiteY16" fmla="*/ 248444 h 741653"/>
              <a:gd name="connsiteX17" fmla="*/ 221289 w 1307139"/>
              <a:gd name="connsiteY17" fmla="*/ 277019 h 741653"/>
              <a:gd name="connsiteX18" fmla="*/ 235577 w 1307139"/>
              <a:gd name="connsiteY18" fmla="*/ 362744 h 741653"/>
              <a:gd name="connsiteX19" fmla="*/ 249864 w 1307139"/>
              <a:gd name="connsiteY19" fmla="*/ 372269 h 741653"/>
              <a:gd name="connsiteX20" fmla="*/ 273677 w 1307139"/>
              <a:gd name="connsiteY20" fmla="*/ 410369 h 741653"/>
              <a:gd name="connsiteX21" fmla="*/ 283202 w 1307139"/>
              <a:gd name="connsiteY21" fmla="*/ 424656 h 741653"/>
              <a:gd name="connsiteX22" fmla="*/ 297489 w 1307139"/>
              <a:gd name="connsiteY22" fmla="*/ 438944 h 741653"/>
              <a:gd name="connsiteX23" fmla="*/ 302252 w 1307139"/>
              <a:gd name="connsiteY23" fmla="*/ 457994 h 741653"/>
              <a:gd name="connsiteX24" fmla="*/ 335589 w 1307139"/>
              <a:gd name="connsiteY24" fmla="*/ 477044 h 741653"/>
              <a:gd name="connsiteX25" fmla="*/ 397502 w 1307139"/>
              <a:gd name="connsiteY25" fmla="*/ 467519 h 741653"/>
              <a:gd name="connsiteX26" fmla="*/ 416552 w 1307139"/>
              <a:gd name="connsiteY26" fmla="*/ 438944 h 741653"/>
              <a:gd name="connsiteX27" fmla="*/ 426077 w 1307139"/>
              <a:gd name="connsiteY27" fmla="*/ 419894 h 741653"/>
              <a:gd name="connsiteX28" fmla="*/ 421314 w 1307139"/>
              <a:gd name="connsiteY28" fmla="*/ 405606 h 741653"/>
              <a:gd name="connsiteX29" fmla="*/ 473702 w 1307139"/>
              <a:gd name="connsiteY29" fmla="*/ 386556 h 741653"/>
              <a:gd name="connsiteX30" fmla="*/ 516564 w 1307139"/>
              <a:gd name="connsiteY30" fmla="*/ 381794 h 741653"/>
              <a:gd name="connsiteX31" fmla="*/ 530852 w 1307139"/>
              <a:gd name="connsiteY31" fmla="*/ 396081 h 741653"/>
              <a:gd name="connsiteX32" fmla="*/ 545139 w 1307139"/>
              <a:gd name="connsiteY32" fmla="*/ 467519 h 741653"/>
              <a:gd name="connsiteX33" fmla="*/ 559427 w 1307139"/>
              <a:gd name="connsiteY33" fmla="*/ 500856 h 741653"/>
              <a:gd name="connsiteX34" fmla="*/ 568952 w 1307139"/>
              <a:gd name="connsiteY34" fmla="*/ 519906 h 741653"/>
              <a:gd name="connsiteX35" fmla="*/ 588002 w 1307139"/>
              <a:gd name="connsiteY35" fmla="*/ 534194 h 741653"/>
              <a:gd name="connsiteX36" fmla="*/ 592764 w 1307139"/>
              <a:gd name="connsiteY36" fmla="*/ 548481 h 741653"/>
              <a:gd name="connsiteX37" fmla="*/ 640389 w 1307139"/>
              <a:gd name="connsiteY37" fmla="*/ 548481 h 741653"/>
              <a:gd name="connsiteX38" fmla="*/ 654677 w 1307139"/>
              <a:gd name="connsiteY38" fmla="*/ 538956 h 741653"/>
              <a:gd name="connsiteX39" fmla="*/ 664202 w 1307139"/>
              <a:gd name="connsiteY39" fmla="*/ 524669 h 741653"/>
              <a:gd name="connsiteX40" fmla="*/ 683252 w 1307139"/>
              <a:gd name="connsiteY40" fmla="*/ 519906 h 741653"/>
              <a:gd name="connsiteX41" fmla="*/ 697539 w 1307139"/>
              <a:gd name="connsiteY41" fmla="*/ 510381 h 741653"/>
              <a:gd name="connsiteX42" fmla="*/ 711827 w 1307139"/>
              <a:gd name="connsiteY42" fmla="*/ 496094 h 741653"/>
              <a:gd name="connsiteX43" fmla="*/ 730877 w 1307139"/>
              <a:gd name="connsiteY43" fmla="*/ 486569 h 741653"/>
              <a:gd name="connsiteX44" fmla="*/ 740402 w 1307139"/>
              <a:gd name="connsiteY44" fmla="*/ 467519 h 741653"/>
              <a:gd name="connsiteX45" fmla="*/ 754689 w 1307139"/>
              <a:gd name="connsiteY45" fmla="*/ 453231 h 741653"/>
              <a:gd name="connsiteX46" fmla="*/ 759452 w 1307139"/>
              <a:gd name="connsiteY46" fmla="*/ 396081 h 741653"/>
              <a:gd name="connsiteX47" fmla="*/ 864227 w 1307139"/>
              <a:gd name="connsiteY47" fmla="*/ 400844 h 741653"/>
              <a:gd name="connsiteX48" fmla="*/ 883277 w 1307139"/>
              <a:gd name="connsiteY48" fmla="*/ 429419 h 741653"/>
              <a:gd name="connsiteX49" fmla="*/ 911852 w 1307139"/>
              <a:gd name="connsiteY49" fmla="*/ 443706 h 741653"/>
              <a:gd name="connsiteX50" fmla="*/ 949952 w 1307139"/>
              <a:gd name="connsiteY50" fmla="*/ 467519 h 741653"/>
              <a:gd name="connsiteX51" fmla="*/ 978527 w 1307139"/>
              <a:gd name="connsiteY51" fmla="*/ 453231 h 741653"/>
              <a:gd name="connsiteX52" fmla="*/ 1002339 w 1307139"/>
              <a:gd name="connsiteY52" fmla="*/ 419894 h 741653"/>
              <a:gd name="connsiteX53" fmla="*/ 1007102 w 1307139"/>
              <a:gd name="connsiteY53" fmla="*/ 405606 h 741653"/>
              <a:gd name="connsiteX54" fmla="*/ 1026152 w 1307139"/>
              <a:gd name="connsiteY54" fmla="*/ 377031 h 741653"/>
              <a:gd name="connsiteX55" fmla="*/ 1035677 w 1307139"/>
              <a:gd name="connsiteY55" fmla="*/ 357981 h 741653"/>
              <a:gd name="connsiteX56" fmla="*/ 1049964 w 1307139"/>
              <a:gd name="connsiteY56" fmla="*/ 348456 h 741653"/>
              <a:gd name="connsiteX57" fmla="*/ 1064252 w 1307139"/>
              <a:gd name="connsiteY57" fmla="*/ 319881 h 741653"/>
              <a:gd name="connsiteX58" fmla="*/ 1078539 w 1307139"/>
              <a:gd name="connsiteY58" fmla="*/ 310356 h 741653"/>
              <a:gd name="connsiteX59" fmla="*/ 1121402 w 1307139"/>
              <a:gd name="connsiteY59" fmla="*/ 334169 h 741653"/>
              <a:gd name="connsiteX60" fmla="*/ 1135689 w 1307139"/>
              <a:gd name="connsiteY60" fmla="*/ 343694 h 741653"/>
              <a:gd name="connsiteX61" fmla="*/ 1173789 w 1307139"/>
              <a:gd name="connsiteY61" fmla="*/ 338931 h 741653"/>
              <a:gd name="connsiteX62" fmla="*/ 1202364 w 1307139"/>
              <a:gd name="connsiteY62" fmla="*/ 329406 h 741653"/>
              <a:gd name="connsiteX63" fmla="*/ 1216652 w 1307139"/>
              <a:gd name="connsiteY63" fmla="*/ 319881 h 741653"/>
              <a:gd name="connsiteX64" fmla="*/ 1245227 w 1307139"/>
              <a:gd name="connsiteY64" fmla="*/ 315119 h 741653"/>
              <a:gd name="connsiteX65" fmla="*/ 1264277 w 1307139"/>
              <a:gd name="connsiteY65" fmla="*/ 277019 h 741653"/>
              <a:gd name="connsiteX66" fmla="*/ 1283327 w 1307139"/>
              <a:gd name="connsiteY66" fmla="*/ 234156 h 741653"/>
              <a:gd name="connsiteX67" fmla="*/ 1292852 w 1307139"/>
              <a:gd name="connsiteY67" fmla="*/ 253206 h 741653"/>
              <a:gd name="connsiteX68" fmla="*/ 1297614 w 1307139"/>
              <a:gd name="connsiteY68" fmla="*/ 300831 h 741653"/>
              <a:gd name="connsiteX69" fmla="*/ 1302377 w 1307139"/>
              <a:gd name="connsiteY69" fmla="*/ 343694 h 741653"/>
              <a:gd name="connsiteX70" fmla="*/ 1307139 w 1307139"/>
              <a:gd name="connsiteY70" fmla="*/ 357981 h 741653"/>
              <a:gd name="connsiteX71" fmla="*/ 1302377 w 1307139"/>
              <a:gd name="connsiteY71" fmla="*/ 443706 h 741653"/>
              <a:gd name="connsiteX72" fmla="*/ 1297614 w 1307139"/>
              <a:gd name="connsiteY72" fmla="*/ 457994 h 741653"/>
              <a:gd name="connsiteX73" fmla="*/ 1264277 w 1307139"/>
              <a:gd name="connsiteY73" fmla="*/ 505619 h 741653"/>
              <a:gd name="connsiteX74" fmla="*/ 1245227 w 1307139"/>
              <a:gd name="connsiteY74" fmla="*/ 538956 h 741653"/>
              <a:gd name="connsiteX75" fmla="*/ 1226177 w 1307139"/>
              <a:gd name="connsiteY75" fmla="*/ 567531 h 741653"/>
              <a:gd name="connsiteX76" fmla="*/ 1202364 w 1307139"/>
              <a:gd name="connsiteY76" fmla="*/ 596106 h 741653"/>
              <a:gd name="connsiteX77" fmla="*/ 1188077 w 1307139"/>
              <a:gd name="connsiteY77" fmla="*/ 605631 h 741653"/>
              <a:gd name="connsiteX78" fmla="*/ 1159502 w 1307139"/>
              <a:gd name="connsiteY78" fmla="*/ 624681 h 741653"/>
              <a:gd name="connsiteX79" fmla="*/ 1130927 w 1307139"/>
              <a:gd name="connsiteY79" fmla="*/ 643731 h 741653"/>
              <a:gd name="connsiteX80" fmla="*/ 1088064 w 1307139"/>
              <a:gd name="connsiteY80" fmla="*/ 658019 h 741653"/>
              <a:gd name="connsiteX81" fmla="*/ 1073777 w 1307139"/>
              <a:gd name="connsiteY81" fmla="*/ 662781 h 741653"/>
              <a:gd name="connsiteX82" fmla="*/ 1045202 w 1307139"/>
              <a:gd name="connsiteY82" fmla="*/ 677069 h 741653"/>
              <a:gd name="connsiteX83" fmla="*/ 1011864 w 1307139"/>
              <a:gd name="connsiteY83" fmla="*/ 696119 h 741653"/>
              <a:gd name="connsiteX84" fmla="*/ 973764 w 1307139"/>
              <a:gd name="connsiteY84" fmla="*/ 705644 h 741653"/>
              <a:gd name="connsiteX85" fmla="*/ 935664 w 1307139"/>
              <a:gd name="connsiteY85" fmla="*/ 719931 h 741653"/>
              <a:gd name="connsiteX86" fmla="*/ 721352 w 1307139"/>
              <a:gd name="connsiteY86" fmla="*/ 715169 h 741653"/>
              <a:gd name="connsiteX87" fmla="*/ 668964 w 1307139"/>
              <a:gd name="connsiteY87" fmla="*/ 715169 h 741653"/>
              <a:gd name="connsiteX88" fmla="*/ 654677 w 1307139"/>
              <a:gd name="connsiteY88" fmla="*/ 724694 h 741653"/>
              <a:gd name="connsiteX89" fmla="*/ 635627 w 1307139"/>
              <a:gd name="connsiteY89" fmla="*/ 729456 h 741653"/>
              <a:gd name="connsiteX90" fmla="*/ 507039 w 1307139"/>
              <a:gd name="connsiteY90" fmla="*/ 724694 h 741653"/>
              <a:gd name="connsiteX91" fmla="*/ 397502 w 1307139"/>
              <a:gd name="connsiteY91" fmla="*/ 729456 h 741653"/>
              <a:gd name="connsiteX92" fmla="*/ 349877 w 1307139"/>
              <a:gd name="connsiteY92" fmla="*/ 729456 h 741653"/>
              <a:gd name="connsiteX93" fmla="*/ 307014 w 1307139"/>
              <a:gd name="connsiteY93" fmla="*/ 710406 h 741653"/>
              <a:gd name="connsiteX94" fmla="*/ 287964 w 1307139"/>
              <a:gd name="connsiteY94" fmla="*/ 696119 h 741653"/>
              <a:gd name="connsiteX95" fmla="*/ 240339 w 1307139"/>
              <a:gd name="connsiteY95" fmla="*/ 677069 h 741653"/>
              <a:gd name="connsiteX96" fmla="*/ 226052 w 1307139"/>
              <a:gd name="connsiteY96" fmla="*/ 667544 h 741653"/>
              <a:gd name="connsiteX97" fmla="*/ 211764 w 1307139"/>
              <a:gd name="connsiteY97" fmla="*/ 653256 h 741653"/>
              <a:gd name="connsiteX98" fmla="*/ 183189 w 1307139"/>
              <a:gd name="connsiteY98" fmla="*/ 643731 h 741653"/>
              <a:gd name="connsiteX99" fmla="*/ 149852 w 1307139"/>
              <a:gd name="connsiteY99" fmla="*/ 629444 h 741653"/>
              <a:gd name="connsiteX100" fmla="*/ 135564 w 1307139"/>
              <a:gd name="connsiteY100" fmla="*/ 615156 h 741653"/>
              <a:gd name="connsiteX101" fmla="*/ 121277 w 1307139"/>
              <a:gd name="connsiteY101" fmla="*/ 605631 h 741653"/>
              <a:gd name="connsiteX102" fmla="*/ 92702 w 1307139"/>
              <a:gd name="connsiteY102" fmla="*/ 572294 h 741653"/>
              <a:gd name="connsiteX103" fmla="*/ 78414 w 1307139"/>
              <a:gd name="connsiteY103" fmla="*/ 567531 h 741653"/>
              <a:gd name="connsiteX104" fmla="*/ 45077 w 1307139"/>
              <a:gd name="connsiteY104" fmla="*/ 558006 h 741653"/>
              <a:gd name="connsiteX105" fmla="*/ 26027 w 1307139"/>
              <a:gd name="connsiteY105" fmla="*/ 529431 h 741653"/>
              <a:gd name="connsiteX106" fmla="*/ 16502 w 1307139"/>
              <a:gd name="connsiteY106" fmla="*/ 491331 h 741653"/>
              <a:gd name="connsiteX107" fmla="*/ 11739 w 1307139"/>
              <a:gd name="connsiteY107" fmla="*/ 457994 h 741653"/>
              <a:gd name="connsiteX108" fmla="*/ 6977 w 1307139"/>
              <a:gd name="connsiteY108" fmla="*/ 438944 h 741653"/>
              <a:gd name="connsiteX109" fmla="*/ 6977 w 1307139"/>
              <a:gd name="connsiteY109" fmla="*/ 329406 h 741653"/>
              <a:gd name="connsiteX110" fmla="*/ 21264 w 1307139"/>
              <a:gd name="connsiteY110" fmla="*/ 277019 h 741653"/>
              <a:gd name="connsiteX111" fmla="*/ 40314 w 1307139"/>
              <a:gd name="connsiteY111" fmla="*/ 262731 h 741653"/>
              <a:gd name="connsiteX112" fmla="*/ 59364 w 1307139"/>
              <a:gd name="connsiteY112" fmla="*/ 238919 h 741653"/>
              <a:gd name="connsiteX113" fmla="*/ 78414 w 1307139"/>
              <a:gd name="connsiteY113" fmla="*/ 205581 h 741653"/>
              <a:gd name="connsiteX114" fmla="*/ 87939 w 1307139"/>
              <a:gd name="connsiteY114" fmla="*/ 177006 h 741653"/>
              <a:gd name="connsiteX115" fmla="*/ 97464 w 1307139"/>
              <a:gd name="connsiteY115" fmla="*/ 157956 h 741653"/>
              <a:gd name="connsiteX116" fmla="*/ 106989 w 1307139"/>
              <a:gd name="connsiteY116" fmla="*/ 129381 h 741653"/>
              <a:gd name="connsiteX117" fmla="*/ 111752 w 1307139"/>
              <a:gd name="connsiteY117" fmla="*/ 115094 h 741653"/>
              <a:gd name="connsiteX118" fmla="*/ 149852 w 1307139"/>
              <a:gd name="connsiteY118" fmla="*/ 72231 h 741653"/>
              <a:gd name="connsiteX119" fmla="*/ 173664 w 1307139"/>
              <a:gd name="connsiteY119" fmla="*/ 43656 h 741653"/>
              <a:gd name="connsiteX120" fmla="*/ 187952 w 1307139"/>
              <a:gd name="connsiteY120" fmla="*/ 38894 h 741653"/>
              <a:gd name="connsiteX121" fmla="*/ 240339 w 1307139"/>
              <a:gd name="connsiteY121" fmla="*/ 34131 h 741653"/>
              <a:gd name="connsiteX122" fmla="*/ 292727 w 1307139"/>
              <a:gd name="connsiteY122" fmla="*/ 19844 h 741653"/>
              <a:gd name="connsiteX123" fmla="*/ 307014 w 1307139"/>
              <a:gd name="connsiteY123" fmla="*/ 15081 h 741653"/>
              <a:gd name="connsiteX124" fmla="*/ 326064 w 1307139"/>
              <a:gd name="connsiteY124" fmla="*/ 10319 h 741653"/>
              <a:gd name="connsiteX125" fmla="*/ 340352 w 1307139"/>
              <a:gd name="connsiteY125" fmla="*/ 794 h 7416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</a:cxnLst>
            <a:rect l="l" t="t" r="r" b="b"/>
            <a:pathLst>
              <a:path w="1307139" h="741653">
                <a:moveTo>
                  <a:pt x="340352" y="794"/>
                </a:moveTo>
                <a:cubicBezTo>
                  <a:pt x="344321" y="1588"/>
                  <a:pt x="345830" y="11034"/>
                  <a:pt x="349877" y="15081"/>
                </a:cubicBezTo>
                <a:cubicBezTo>
                  <a:pt x="368166" y="33370"/>
                  <a:pt x="390899" y="27037"/>
                  <a:pt x="416552" y="29369"/>
                </a:cubicBezTo>
                <a:cubicBezTo>
                  <a:pt x="426112" y="31759"/>
                  <a:pt x="443311" y="33789"/>
                  <a:pt x="449889" y="43656"/>
                </a:cubicBezTo>
                <a:cubicBezTo>
                  <a:pt x="453520" y="49102"/>
                  <a:pt x="453064" y="56356"/>
                  <a:pt x="454652" y="62706"/>
                </a:cubicBezTo>
                <a:cubicBezTo>
                  <a:pt x="453064" y="70644"/>
                  <a:pt x="453509" y="79279"/>
                  <a:pt x="449889" y="86519"/>
                </a:cubicBezTo>
                <a:cubicBezTo>
                  <a:pt x="445949" y="94400"/>
                  <a:pt x="428972" y="105955"/>
                  <a:pt x="421314" y="110331"/>
                </a:cubicBezTo>
                <a:cubicBezTo>
                  <a:pt x="407636" y="118147"/>
                  <a:pt x="388702" y="126378"/>
                  <a:pt x="373689" y="129381"/>
                </a:cubicBezTo>
                <a:cubicBezTo>
                  <a:pt x="365752" y="130969"/>
                  <a:pt x="357779" y="132388"/>
                  <a:pt x="349877" y="134144"/>
                </a:cubicBezTo>
                <a:cubicBezTo>
                  <a:pt x="343487" y="135564"/>
                  <a:pt x="337245" y="137622"/>
                  <a:pt x="330827" y="138906"/>
                </a:cubicBezTo>
                <a:cubicBezTo>
                  <a:pt x="321358" y="140800"/>
                  <a:pt x="311721" y="141775"/>
                  <a:pt x="302252" y="143669"/>
                </a:cubicBezTo>
                <a:cubicBezTo>
                  <a:pt x="295834" y="144953"/>
                  <a:pt x="289496" y="146633"/>
                  <a:pt x="283202" y="148431"/>
                </a:cubicBezTo>
                <a:cubicBezTo>
                  <a:pt x="278375" y="149810"/>
                  <a:pt x="273876" y="152431"/>
                  <a:pt x="268914" y="153194"/>
                </a:cubicBezTo>
                <a:cubicBezTo>
                  <a:pt x="253145" y="155620"/>
                  <a:pt x="237164" y="156369"/>
                  <a:pt x="221289" y="157956"/>
                </a:cubicBezTo>
                <a:cubicBezTo>
                  <a:pt x="222877" y="164306"/>
                  <a:pt x="224171" y="170737"/>
                  <a:pt x="226052" y="177006"/>
                </a:cubicBezTo>
                <a:cubicBezTo>
                  <a:pt x="228937" y="186623"/>
                  <a:pt x="235577" y="205581"/>
                  <a:pt x="235577" y="205581"/>
                </a:cubicBezTo>
                <a:cubicBezTo>
                  <a:pt x="233989" y="219869"/>
                  <a:pt x="233633" y="234348"/>
                  <a:pt x="230814" y="248444"/>
                </a:cubicBezTo>
                <a:cubicBezTo>
                  <a:pt x="228845" y="258289"/>
                  <a:pt x="221289" y="277019"/>
                  <a:pt x="221289" y="277019"/>
                </a:cubicBezTo>
                <a:cubicBezTo>
                  <a:pt x="223043" y="303323"/>
                  <a:pt x="213627" y="340793"/>
                  <a:pt x="235577" y="362744"/>
                </a:cubicBezTo>
                <a:cubicBezTo>
                  <a:pt x="239624" y="366791"/>
                  <a:pt x="245102" y="369094"/>
                  <a:pt x="249864" y="372269"/>
                </a:cubicBezTo>
                <a:cubicBezTo>
                  <a:pt x="261199" y="406274"/>
                  <a:pt x="251035" y="395275"/>
                  <a:pt x="273677" y="410369"/>
                </a:cubicBezTo>
                <a:cubicBezTo>
                  <a:pt x="276852" y="415131"/>
                  <a:pt x="279538" y="420259"/>
                  <a:pt x="283202" y="424656"/>
                </a:cubicBezTo>
                <a:cubicBezTo>
                  <a:pt x="287514" y="429830"/>
                  <a:pt x="294147" y="433096"/>
                  <a:pt x="297489" y="438944"/>
                </a:cubicBezTo>
                <a:cubicBezTo>
                  <a:pt x="300736" y="444627"/>
                  <a:pt x="298621" y="452548"/>
                  <a:pt x="302252" y="457994"/>
                </a:cubicBezTo>
                <a:cubicBezTo>
                  <a:pt x="305618" y="463043"/>
                  <a:pt x="332293" y="475396"/>
                  <a:pt x="335589" y="477044"/>
                </a:cubicBezTo>
                <a:cubicBezTo>
                  <a:pt x="356227" y="473869"/>
                  <a:pt x="377572" y="473747"/>
                  <a:pt x="397502" y="467519"/>
                </a:cubicBezTo>
                <a:cubicBezTo>
                  <a:pt x="412319" y="462888"/>
                  <a:pt x="411909" y="449777"/>
                  <a:pt x="416552" y="438944"/>
                </a:cubicBezTo>
                <a:cubicBezTo>
                  <a:pt x="419349" y="432419"/>
                  <a:pt x="422902" y="426244"/>
                  <a:pt x="426077" y="419894"/>
                </a:cubicBezTo>
                <a:cubicBezTo>
                  <a:pt x="424489" y="415131"/>
                  <a:pt x="419069" y="410096"/>
                  <a:pt x="421314" y="405606"/>
                </a:cubicBezTo>
                <a:cubicBezTo>
                  <a:pt x="430477" y="387279"/>
                  <a:pt x="459190" y="388629"/>
                  <a:pt x="473702" y="386556"/>
                </a:cubicBezTo>
                <a:cubicBezTo>
                  <a:pt x="507039" y="375444"/>
                  <a:pt x="492752" y="373856"/>
                  <a:pt x="516564" y="381794"/>
                </a:cubicBezTo>
                <a:cubicBezTo>
                  <a:pt x="521327" y="386556"/>
                  <a:pt x="529117" y="389573"/>
                  <a:pt x="530852" y="396081"/>
                </a:cubicBezTo>
                <a:cubicBezTo>
                  <a:pt x="555296" y="487747"/>
                  <a:pt x="519259" y="428698"/>
                  <a:pt x="545139" y="467519"/>
                </a:cubicBezTo>
                <a:cubicBezTo>
                  <a:pt x="552962" y="498809"/>
                  <a:pt x="544809" y="475275"/>
                  <a:pt x="559427" y="500856"/>
                </a:cubicBezTo>
                <a:cubicBezTo>
                  <a:pt x="562949" y="507020"/>
                  <a:pt x="564332" y="514516"/>
                  <a:pt x="568952" y="519906"/>
                </a:cubicBezTo>
                <a:cubicBezTo>
                  <a:pt x="574118" y="525933"/>
                  <a:pt x="581652" y="529431"/>
                  <a:pt x="588002" y="534194"/>
                </a:cubicBezTo>
                <a:cubicBezTo>
                  <a:pt x="589589" y="538956"/>
                  <a:pt x="589214" y="544931"/>
                  <a:pt x="592764" y="548481"/>
                </a:cubicBezTo>
                <a:cubicBezTo>
                  <a:pt x="603155" y="558872"/>
                  <a:pt x="634606" y="549307"/>
                  <a:pt x="640389" y="548481"/>
                </a:cubicBezTo>
                <a:cubicBezTo>
                  <a:pt x="645152" y="545306"/>
                  <a:pt x="650629" y="543003"/>
                  <a:pt x="654677" y="538956"/>
                </a:cubicBezTo>
                <a:cubicBezTo>
                  <a:pt x="658724" y="534909"/>
                  <a:pt x="659440" y="527844"/>
                  <a:pt x="664202" y="524669"/>
                </a:cubicBezTo>
                <a:cubicBezTo>
                  <a:pt x="669648" y="521038"/>
                  <a:pt x="676902" y="521494"/>
                  <a:pt x="683252" y="519906"/>
                </a:cubicBezTo>
                <a:cubicBezTo>
                  <a:pt x="688014" y="516731"/>
                  <a:pt x="693142" y="514045"/>
                  <a:pt x="697539" y="510381"/>
                </a:cubicBezTo>
                <a:cubicBezTo>
                  <a:pt x="702713" y="506069"/>
                  <a:pt x="706346" y="500009"/>
                  <a:pt x="711827" y="496094"/>
                </a:cubicBezTo>
                <a:cubicBezTo>
                  <a:pt x="717604" y="491968"/>
                  <a:pt x="724527" y="489744"/>
                  <a:pt x="730877" y="486569"/>
                </a:cubicBezTo>
                <a:cubicBezTo>
                  <a:pt x="734052" y="480219"/>
                  <a:pt x="736276" y="473296"/>
                  <a:pt x="740402" y="467519"/>
                </a:cubicBezTo>
                <a:cubicBezTo>
                  <a:pt x="744317" y="462038"/>
                  <a:pt x="752954" y="459739"/>
                  <a:pt x="754689" y="453231"/>
                </a:cubicBezTo>
                <a:cubicBezTo>
                  <a:pt x="759614" y="434760"/>
                  <a:pt x="757864" y="415131"/>
                  <a:pt x="759452" y="396081"/>
                </a:cubicBezTo>
                <a:cubicBezTo>
                  <a:pt x="794377" y="397669"/>
                  <a:pt x="830468" y="391755"/>
                  <a:pt x="864227" y="400844"/>
                </a:cubicBezTo>
                <a:cubicBezTo>
                  <a:pt x="875281" y="403820"/>
                  <a:pt x="876927" y="419894"/>
                  <a:pt x="883277" y="429419"/>
                </a:cubicBezTo>
                <a:cubicBezTo>
                  <a:pt x="889380" y="438573"/>
                  <a:pt x="902976" y="439902"/>
                  <a:pt x="911852" y="443706"/>
                </a:cubicBezTo>
                <a:cubicBezTo>
                  <a:pt x="932190" y="452422"/>
                  <a:pt x="931720" y="453845"/>
                  <a:pt x="949952" y="467519"/>
                </a:cubicBezTo>
                <a:cubicBezTo>
                  <a:pt x="961571" y="463645"/>
                  <a:pt x="969296" y="462462"/>
                  <a:pt x="978527" y="453231"/>
                </a:cubicBezTo>
                <a:cubicBezTo>
                  <a:pt x="980682" y="451076"/>
                  <a:pt x="999636" y="425300"/>
                  <a:pt x="1002339" y="419894"/>
                </a:cubicBezTo>
                <a:cubicBezTo>
                  <a:pt x="1004584" y="415404"/>
                  <a:pt x="1004664" y="409995"/>
                  <a:pt x="1007102" y="405606"/>
                </a:cubicBezTo>
                <a:cubicBezTo>
                  <a:pt x="1012661" y="395599"/>
                  <a:pt x="1019802" y="386556"/>
                  <a:pt x="1026152" y="377031"/>
                </a:cubicBezTo>
                <a:cubicBezTo>
                  <a:pt x="1030090" y="371124"/>
                  <a:pt x="1031132" y="363435"/>
                  <a:pt x="1035677" y="357981"/>
                </a:cubicBezTo>
                <a:cubicBezTo>
                  <a:pt x="1039341" y="353584"/>
                  <a:pt x="1045202" y="351631"/>
                  <a:pt x="1049964" y="348456"/>
                </a:cubicBezTo>
                <a:cubicBezTo>
                  <a:pt x="1053838" y="336837"/>
                  <a:pt x="1055021" y="329113"/>
                  <a:pt x="1064252" y="319881"/>
                </a:cubicBezTo>
                <a:cubicBezTo>
                  <a:pt x="1068299" y="315834"/>
                  <a:pt x="1073777" y="313531"/>
                  <a:pt x="1078539" y="310356"/>
                </a:cubicBezTo>
                <a:cubicBezTo>
                  <a:pt x="1103687" y="318739"/>
                  <a:pt x="1088651" y="312334"/>
                  <a:pt x="1121402" y="334169"/>
                </a:cubicBezTo>
                <a:lnTo>
                  <a:pt x="1135689" y="343694"/>
                </a:lnTo>
                <a:cubicBezTo>
                  <a:pt x="1148389" y="342106"/>
                  <a:pt x="1161274" y="341613"/>
                  <a:pt x="1173789" y="338931"/>
                </a:cubicBezTo>
                <a:cubicBezTo>
                  <a:pt x="1183606" y="336827"/>
                  <a:pt x="1194010" y="334975"/>
                  <a:pt x="1202364" y="329406"/>
                </a:cubicBezTo>
                <a:cubicBezTo>
                  <a:pt x="1207127" y="326231"/>
                  <a:pt x="1211222" y="321691"/>
                  <a:pt x="1216652" y="319881"/>
                </a:cubicBezTo>
                <a:cubicBezTo>
                  <a:pt x="1225813" y="316828"/>
                  <a:pt x="1235702" y="316706"/>
                  <a:pt x="1245227" y="315119"/>
                </a:cubicBezTo>
                <a:cubicBezTo>
                  <a:pt x="1259964" y="295468"/>
                  <a:pt x="1260456" y="299947"/>
                  <a:pt x="1264277" y="277019"/>
                </a:cubicBezTo>
                <a:cubicBezTo>
                  <a:pt x="1271563" y="233304"/>
                  <a:pt x="1256151" y="243215"/>
                  <a:pt x="1283327" y="234156"/>
                </a:cubicBezTo>
                <a:cubicBezTo>
                  <a:pt x="1286502" y="240506"/>
                  <a:pt x="1291364" y="246264"/>
                  <a:pt x="1292852" y="253206"/>
                </a:cubicBezTo>
                <a:cubicBezTo>
                  <a:pt x="1296195" y="268806"/>
                  <a:pt x="1295944" y="284964"/>
                  <a:pt x="1297614" y="300831"/>
                </a:cubicBezTo>
                <a:cubicBezTo>
                  <a:pt x="1299119" y="315128"/>
                  <a:pt x="1300014" y="329514"/>
                  <a:pt x="1302377" y="343694"/>
                </a:cubicBezTo>
                <a:cubicBezTo>
                  <a:pt x="1303202" y="348646"/>
                  <a:pt x="1305552" y="353219"/>
                  <a:pt x="1307139" y="357981"/>
                </a:cubicBezTo>
                <a:cubicBezTo>
                  <a:pt x="1305552" y="386556"/>
                  <a:pt x="1305090" y="415216"/>
                  <a:pt x="1302377" y="443706"/>
                </a:cubicBezTo>
                <a:cubicBezTo>
                  <a:pt x="1301901" y="448704"/>
                  <a:pt x="1300052" y="453605"/>
                  <a:pt x="1297614" y="457994"/>
                </a:cubicBezTo>
                <a:cubicBezTo>
                  <a:pt x="1289239" y="473069"/>
                  <a:pt x="1274978" y="491351"/>
                  <a:pt x="1264277" y="505619"/>
                </a:cubicBezTo>
                <a:cubicBezTo>
                  <a:pt x="1256341" y="529425"/>
                  <a:pt x="1263574" y="512745"/>
                  <a:pt x="1245227" y="538956"/>
                </a:cubicBezTo>
                <a:cubicBezTo>
                  <a:pt x="1238662" y="548334"/>
                  <a:pt x="1232527" y="558006"/>
                  <a:pt x="1226177" y="567531"/>
                </a:cubicBezTo>
                <a:cubicBezTo>
                  <a:pt x="1216810" y="581582"/>
                  <a:pt x="1216118" y="584644"/>
                  <a:pt x="1202364" y="596106"/>
                </a:cubicBezTo>
                <a:cubicBezTo>
                  <a:pt x="1197967" y="599770"/>
                  <a:pt x="1192474" y="601967"/>
                  <a:pt x="1188077" y="605631"/>
                </a:cubicBezTo>
                <a:cubicBezTo>
                  <a:pt x="1164295" y="625450"/>
                  <a:pt x="1184609" y="616312"/>
                  <a:pt x="1159502" y="624681"/>
                </a:cubicBezTo>
                <a:lnTo>
                  <a:pt x="1130927" y="643731"/>
                </a:lnTo>
                <a:cubicBezTo>
                  <a:pt x="1118615" y="651939"/>
                  <a:pt x="1101950" y="654052"/>
                  <a:pt x="1088064" y="658019"/>
                </a:cubicBezTo>
                <a:cubicBezTo>
                  <a:pt x="1083237" y="659398"/>
                  <a:pt x="1078539" y="661194"/>
                  <a:pt x="1073777" y="662781"/>
                </a:cubicBezTo>
                <a:cubicBezTo>
                  <a:pt x="1032828" y="690079"/>
                  <a:pt x="1084638" y="657350"/>
                  <a:pt x="1045202" y="677069"/>
                </a:cubicBezTo>
                <a:cubicBezTo>
                  <a:pt x="1024303" y="687519"/>
                  <a:pt x="1036906" y="687772"/>
                  <a:pt x="1011864" y="696119"/>
                </a:cubicBezTo>
                <a:cubicBezTo>
                  <a:pt x="999445" y="700259"/>
                  <a:pt x="985473" y="699790"/>
                  <a:pt x="973764" y="705644"/>
                </a:cubicBezTo>
                <a:cubicBezTo>
                  <a:pt x="948860" y="718096"/>
                  <a:pt x="961602" y="713447"/>
                  <a:pt x="935664" y="719931"/>
                </a:cubicBezTo>
                <a:lnTo>
                  <a:pt x="721352" y="715169"/>
                </a:lnTo>
                <a:cubicBezTo>
                  <a:pt x="657311" y="712555"/>
                  <a:pt x="767264" y="701125"/>
                  <a:pt x="668964" y="715169"/>
                </a:cubicBezTo>
                <a:cubicBezTo>
                  <a:pt x="664202" y="718344"/>
                  <a:pt x="659938" y="722439"/>
                  <a:pt x="654677" y="724694"/>
                </a:cubicBezTo>
                <a:cubicBezTo>
                  <a:pt x="648661" y="727272"/>
                  <a:pt x="642172" y="729456"/>
                  <a:pt x="635627" y="729456"/>
                </a:cubicBezTo>
                <a:cubicBezTo>
                  <a:pt x="592735" y="729456"/>
                  <a:pt x="549902" y="726281"/>
                  <a:pt x="507039" y="724694"/>
                </a:cubicBezTo>
                <a:cubicBezTo>
                  <a:pt x="470527" y="726281"/>
                  <a:pt x="433949" y="726756"/>
                  <a:pt x="397502" y="729456"/>
                </a:cubicBezTo>
                <a:cubicBezTo>
                  <a:pt x="359760" y="732252"/>
                  <a:pt x="398663" y="741653"/>
                  <a:pt x="349877" y="729456"/>
                </a:cubicBezTo>
                <a:cubicBezTo>
                  <a:pt x="326049" y="723499"/>
                  <a:pt x="323854" y="722434"/>
                  <a:pt x="307014" y="710406"/>
                </a:cubicBezTo>
                <a:cubicBezTo>
                  <a:pt x="300555" y="705793"/>
                  <a:pt x="295063" y="699669"/>
                  <a:pt x="287964" y="696119"/>
                </a:cubicBezTo>
                <a:cubicBezTo>
                  <a:pt x="209925" y="657101"/>
                  <a:pt x="298583" y="710352"/>
                  <a:pt x="240339" y="677069"/>
                </a:cubicBezTo>
                <a:cubicBezTo>
                  <a:pt x="235369" y="674229"/>
                  <a:pt x="230449" y="671208"/>
                  <a:pt x="226052" y="667544"/>
                </a:cubicBezTo>
                <a:cubicBezTo>
                  <a:pt x="220878" y="663232"/>
                  <a:pt x="217652" y="656527"/>
                  <a:pt x="211764" y="653256"/>
                </a:cubicBezTo>
                <a:cubicBezTo>
                  <a:pt x="202987" y="648380"/>
                  <a:pt x="192714" y="646906"/>
                  <a:pt x="183189" y="643731"/>
                </a:cubicBezTo>
                <a:cubicBezTo>
                  <a:pt x="171528" y="639844"/>
                  <a:pt x="160152" y="636801"/>
                  <a:pt x="149852" y="629444"/>
                </a:cubicBezTo>
                <a:cubicBezTo>
                  <a:pt x="144371" y="625529"/>
                  <a:pt x="140738" y="619468"/>
                  <a:pt x="135564" y="615156"/>
                </a:cubicBezTo>
                <a:cubicBezTo>
                  <a:pt x="131167" y="611492"/>
                  <a:pt x="125324" y="609678"/>
                  <a:pt x="121277" y="605631"/>
                </a:cubicBezTo>
                <a:cubicBezTo>
                  <a:pt x="108075" y="592429"/>
                  <a:pt x="108252" y="582661"/>
                  <a:pt x="92702" y="572294"/>
                </a:cubicBezTo>
                <a:cubicBezTo>
                  <a:pt x="88525" y="569509"/>
                  <a:pt x="83241" y="568910"/>
                  <a:pt x="78414" y="567531"/>
                </a:cubicBezTo>
                <a:cubicBezTo>
                  <a:pt x="36562" y="555573"/>
                  <a:pt x="79326" y="569424"/>
                  <a:pt x="45077" y="558006"/>
                </a:cubicBezTo>
                <a:lnTo>
                  <a:pt x="26027" y="529431"/>
                </a:lnTo>
                <a:cubicBezTo>
                  <a:pt x="18765" y="518539"/>
                  <a:pt x="19677" y="504031"/>
                  <a:pt x="16502" y="491331"/>
                </a:cubicBezTo>
                <a:cubicBezTo>
                  <a:pt x="13779" y="480441"/>
                  <a:pt x="13747" y="469038"/>
                  <a:pt x="11739" y="457994"/>
                </a:cubicBezTo>
                <a:cubicBezTo>
                  <a:pt x="10568" y="451554"/>
                  <a:pt x="8564" y="445294"/>
                  <a:pt x="6977" y="438944"/>
                </a:cubicBezTo>
                <a:cubicBezTo>
                  <a:pt x="1179" y="375167"/>
                  <a:pt x="0" y="395691"/>
                  <a:pt x="6977" y="329406"/>
                </a:cubicBezTo>
                <a:cubicBezTo>
                  <a:pt x="8714" y="312905"/>
                  <a:pt x="9267" y="291015"/>
                  <a:pt x="21264" y="277019"/>
                </a:cubicBezTo>
                <a:cubicBezTo>
                  <a:pt x="26430" y="270992"/>
                  <a:pt x="33964" y="267494"/>
                  <a:pt x="40314" y="262731"/>
                </a:cubicBezTo>
                <a:cubicBezTo>
                  <a:pt x="49587" y="234916"/>
                  <a:pt x="37822" y="260462"/>
                  <a:pt x="59364" y="238919"/>
                </a:cubicBezTo>
                <a:cubicBezTo>
                  <a:pt x="65091" y="233192"/>
                  <a:pt x="75924" y="211806"/>
                  <a:pt x="78414" y="205581"/>
                </a:cubicBezTo>
                <a:cubicBezTo>
                  <a:pt x="82143" y="196259"/>
                  <a:pt x="83449" y="185986"/>
                  <a:pt x="87939" y="177006"/>
                </a:cubicBezTo>
                <a:cubicBezTo>
                  <a:pt x="91114" y="170656"/>
                  <a:pt x="94827" y="164548"/>
                  <a:pt x="97464" y="157956"/>
                </a:cubicBezTo>
                <a:cubicBezTo>
                  <a:pt x="101193" y="148634"/>
                  <a:pt x="103814" y="138906"/>
                  <a:pt x="106989" y="129381"/>
                </a:cubicBezTo>
                <a:lnTo>
                  <a:pt x="111752" y="115094"/>
                </a:lnTo>
                <a:cubicBezTo>
                  <a:pt x="116003" y="102344"/>
                  <a:pt x="147226" y="74857"/>
                  <a:pt x="149852" y="72231"/>
                </a:cubicBezTo>
                <a:cubicBezTo>
                  <a:pt x="167419" y="54664"/>
                  <a:pt x="150263" y="59256"/>
                  <a:pt x="173664" y="43656"/>
                </a:cubicBezTo>
                <a:cubicBezTo>
                  <a:pt x="177841" y="40871"/>
                  <a:pt x="182982" y="39604"/>
                  <a:pt x="187952" y="38894"/>
                </a:cubicBezTo>
                <a:cubicBezTo>
                  <a:pt x="205310" y="36414"/>
                  <a:pt x="222877" y="35719"/>
                  <a:pt x="240339" y="34131"/>
                </a:cubicBezTo>
                <a:cubicBezTo>
                  <a:pt x="267046" y="25230"/>
                  <a:pt x="249757" y="30587"/>
                  <a:pt x="292727" y="19844"/>
                </a:cubicBezTo>
                <a:cubicBezTo>
                  <a:pt x="297597" y="18626"/>
                  <a:pt x="302187" y="16460"/>
                  <a:pt x="307014" y="15081"/>
                </a:cubicBezTo>
                <a:cubicBezTo>
                  <a:pt x="313308" y="13283"/>
                  <a:pt x="319770" y="12117"/>
                  <a:pt x="326064" y="10319"/>
                </a:cubicBezTo>
                <a:cubicBezTo>
                  <a:pt x="330891" y="8940"/>
                  <a:pt x="336383" y="0"/>
                  <a:pt x="340352" y="794"/>
                </a:cubicBezTo>
                <a:close/>
              </a:path>
            </a:pathLst>
          </a:custGeom>
          <a:noFill/>
          <a:ln w="222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20" name="手繪多邊形 119"/>
          <p:cNvSpPr/>
          <p:nvPr/>
        </p:nvSpPr>
        <p:spPr>
          <a:xfrm>
            <a:off x="3657018" y="3471015"/>
            <a:ext cx="1307139" cy="741653"/>
          </a:xfrm>
          <a:custGeom>
            <a:avLst/>
            <a:gdLst>
              <a:gd name="connsiteX0" fmla="*/ 340352 w 1307139"/>
              <a:gd name="connsiteY0" fmla="*/ 794 h 741653"/>
              <a:gd name="connsiteX1" fmla="*/ 349877 w 1307139"/>
              <a:gd name="connsiteY1" fmla="*/ 15081 h 741653"/>
              <a:gd name="connsiteX2" fmla="*/ 416552 w 1307139"/>
              <a:gd name="connsiteY2" fmla="*/ 29369 h 741653"/>
              <a:gd name="connsiteX3" fmla="*/ 449889 w 1307139"/>
              <a:gd name="connsiteY3" fmla="*/ 43656 h 741653"/>
              <a:gd name="connsiteX4" fmla="*/ 454652 w 1307139"/>
              <a:gd name="connsiteY4" fmla="*/ 62706 h 741653"/>
              <a:gd name="connsiteX5" fmla="*/ 449889 w 1307139"/>
              <a:gd name="connsiteY5" fmla="*/ 86519 h 741653"/>
              <a:gd name="connsiteX6" fmla="*/ 421314 w 1307139"/>
              <a:gd name="connsiteY6" fmla="*/ 110331 h 741653"/>
              <a:gd name="connsiteX7" fmla="*/ 373689 w 1307139"/>
              <a:gd name="connsiteY7" fmla="*/ 129381 h 741653"/>
              <a:gd name="connsiteX8" fmla="*/ 349877 w 1307139"/>
              <a:gd name="connsiteY8" fmla="*/ 134144 h 741653"/>
              <a:gd name="connsiteX9" fmla="*/ 330827 w 1307139"/>
              <a:gd name="connsiteY9" fmla="*/ 138906 h 741653"/>
              <a:gd name="connsiteX10" fmla="*/ 302252 w 1307139"/>
              <a:gd name="connsiteY10" fmla="*/ 143669 h 741653"/>
              <a:gd name="connsiteX11" fmla="*/ 283202 w 1307139"/>
              <a:gd name="connsiteY11" fmla="*/ 148431 h 741653"/>
              <a:gd name="connsiteX12" fmla="*/ 268914 w 1307139"/>
              <a:gd name="connsiteY12" fmla="*/ 153194 h 741653"/>
              <a:gd name="connsiteX13" fmla="*/ 221289 w 1307139"/>
              <a:gd name="connsiteY13" fmla="*/ 157956 h 741653"/>
              <a:gd name="connsiteX14" fmla="*/ 226052 w 1307139"/>
              <a:gd name="connsiteY14" fmla="*/ 177006 h 741653"/>
              <a:gd name="connsiteX15" fmla="*/ 235577 w 1307139"/>
              <a:gd name="connsiteY15" fmla="*/ 205581 h 741653"/>
              <a:gd name="connsiteX16" fmla="*/ 230814 w 1307139"/>
              <a:gd name="connsiteY16" fmla="*/ 248444 h 741653"/>
              <a:gd name="connsiteX17" fmla="*/ 221289 w 1307139"/>
              <a:gd name="connsiteY17" fmla="*/ 277019 h 741653"/>
              <a:gd name="connsiteX18" fmla="*/ 235577 w 1307139"/>
              <a:gd name="connsiteY18" fmla="*/ 362744 h 741653"/>
              <a:gd name="connsiteX19" fmla="*/ 249864 w 1307139"/>
              <a:gd name="connsiteY19" fmla="*/ 372269 h 741653"/>
              <a:gd name="connsiteX20" fmla="*/ 273677 w 1307139"/>
              <a:gd name="connsiteY20" fmla="*/ 410369 h 741653"/>
              <a:gd name="connsiteX21" fmla="*/ 283202 w 1307139"/>
              <a:gd name="connsiteY21" fmla="*/ 424656 h 741653"/>
              <a:gd name="connsiteX22" fmla="*/ 297489 w 1307139"/>
              <a:gd name="connsiteY22" fmla="*/ 438944 h 741653"/>
              <a:gd name="connsiteX23" fmla="*/ 302252 w 1307139"/>
              <a:gd name="connsiteY23" fmla="*/ 457994 h 741653"/>
              <a:gd name="connsiteX24" fmla="*/ 335589 w 1307139"/>
              <a:gd name="connsiteY24" fmla="*/ 477044 h 741653"/>
              <a:gd name="connsiteX25" fmla="*/ 397502 w 1307139"/>
              <a:gd name="connsiteY25" fmla="*/ 467519 h 741653"/>
              <a:gd name="connsiteX26" fmla="*/ 416552 w 1307139"/>
              <a:gd name="connsiteY26" fmla="*/ 438944 h 741653"/>
              <a:gd name="connsiteX27" fmla="*/ 426077 w 1307139"/>
              <a:gd name="connsiteY27" fmla="*/ 419894 h 741653"/>
              <a:gd name="connsiteX28" fmla="*/ 421314 w 1307139"/>
              <a:gd name="connsiteY28" fmla="*/ 405606 h 741653"/>
              <a:gd name="connsiteX29" fmla="*/ 473702 w 1307139"/>
              <a:gd name="connsiteY29" fmla="*/ 386556 h 741653"/>
              <a:gd name="connsiteX30" fmla="*/ 516564 w 1307139"/>
              <a:gd name="connsiteY30" fmla="*/ 381794 h 741653"/>
              <a:gd name="connsiteX31" fmla="*/ 530852 w 1307139"/>
              <a:gd name="connsiteY31" fmla="*/ 396081 h 741653"/>
              <a:gd name="connsiteX32" fmla="*/ 545139 w 1307139"/>
              <a:gd name="connsiteY32" fmla="*/ 467519 h 741653"/>
              <a:gd name="connsiteX33" fmla="*/ 559427 w 1307139"/>
              <a:gd name="connsiteY33" fmla="*/ 500856 h 741653"/>
              <a:gd name="connsiteX34" fmla="*/ 568952 w 1307139"/>
              <a:gd name="connsiteY34" fmla="*/ 519906 h 741653"/>
              <a:gd name="connsiteX35" fmla="*/ 588002 w 1307139"/>
              <a:gd name="connsiteY35" fmla="*/ 534194 h 741653"/>
              <a:gd name="connsiteX36" fmla="*/ 592764 w 1307139"/>
              <a:gd name="connsiteY36" fmla="*/ 548481 h 741653"/>
              <a:gd name="connsiteX37" fmla="*/ 640389 w 1307139"/>
              <a:gd name="connsiteY37" fmla="*/ 548481 h 741653"/>
              <a:gd name="connsiteX38" fmla="*/ 654677 w 1307139"/>
              <a:gd name="connsiteY38" fmla="*/ 538956 h 741653"/>
              <a:gd name="connsiteX39" fmla="*/ 664202 w 1307139"/>
              <a:gd name="connsiteY39" fmla="*/ 524669 h 741653"/>
              <a:gd name="connsiteX40" fmla="*/ 683252 w 1307139"/>
              <a:gd name="connsiteY40" fmla="*/ 519906 h 741653"/>
              <a:gd name="connsiteX41" fmla="*/ 697539 w 1307139"/>
              <a:gd name="connsiteY41" fmla="*/ 510381 h 741653"/>
              <a:gd name="connsiteX42" fmla="*/ 711827 w 1307139"/>
              <a:gd name="connsiteY42" fmla="*/ 496094 h 741653"/>
              <a:gd name="connsiteX43" fmla="*/ 730877 w 1307139"/>
              <a:gd name="connsiteY43" fmla="*/ 486569 h 741653"/>
              <a:gd name="connsiteX44" fmla="*/ 740402 w 1307139"/>
              <a:gd name="connsiteY44" fmla="*/ 467519 h 741653"/>
              <a:gd name="connsiteX45" fmla="*/ 754689 w 1307139"/>
              <a:gd name="connsiteY45" fmla="*/ 453231 h 741653"/>
              <a:gd name="connsiteX46" fmla="*/ 759452 w 1307139"/>
              <a:gd name="connsiteY46" fmla="*/ 396081 h 741653"/>
              <a:gd name="connsiteX47" fmla="*/ 864227 w 1307139"/>
              <a:gd name="connsiteY47" fmla="*/ 400844 h 741653"/>
              <a:gd name="connsiteX48" fmla="*/ 883277 w 1307139"/>
              <a:gd name="connsiteY48" fmla="*/ 429419 h 741653"/>
              <a:gd name="connsiteX49" fmla="*/ 911852 w 1307139"/>
              <a:gd name="connsiteY49" fmla="*/ 443706 h 741653"/>
              <a:gd name="connsiteX50" fmla="*/ 949952 w 1307139"/>
              <a:gd name="connsiteY50" fmla="*/ 467519 h 741653"/>
              <a:gd name="connsiteX51" fmla="*/ 978527 w 1307139"/>
              <a:gd name="connsiteY51" fmla="*/ 453231 h 741653"/>
              <a:gd name="connsiteX52" fmla="*/ 1002339 w 1307139"/>
              <a:gd name="connsiteY52" fmla="*/ 419894 h 741653"/>
              <a:gd name="connsiteX53" fmla="*/ 1007102 w 1307139"/>
              <a:gd name="connsiteY53" fmla="*/ 405606 h 741653"/>
              <a:gd name="connsiteX54" fmla="*/ 1026152 w 1307139"/>
              <a:gd name="connsiteY54" fmla="*/ 377031 h 741653"/>
              <a:gd name="connsiteX55" fmla="*/ 1035677 w 1307139"/>
              <a:gd name="connsiteY55" fmla="*/ 357981 h 741653"/>
              <a:gd name="connsiteX56" fmla="*/ 1049964 w 1307139"/>
              <a:gd name="connsiteY56" fmla="*/ 348456 h 741653"/>
              <a:gd name="connsiteX57" fmla="*/ 1064252 w 1307139"/>
              <a:gd name="connsiteY57" fmla="*/ 319881 h 741653"/>
              <a:gd name="connsiteX58" fmla="*/ 1078539 w 1307139"/>
              <a:gd name="connsiteY58" fmla="*/ 310356 h 741653"/>
              <a:gd name="connsiteX59" fmla="*/ 1121402 w 1307139"/>
              <a:gd name="connsiteY59" fmla="*/ 334169 h 741653"/>
              <a:gd name="connsiteX60" fmla="*/ 1135689 w 1307139"/>
              <a:gd name="connsiteY60" fmla="*/ 343694 h 741653"/>
              <a:gd name="connsiteX61" fmla="*/ 1173789 w 1307139"/>
              <a:gd name="connsiteY61" fmla="*/ 338931 h 741653"/>
              <a:gd name="connsiteX62" fmla="*/ 1202364 w 1307139"/>
              <a:gd name="connsiteY62" fmla="*/ 329406 h 741653"/>
              <a:gd name="connsiteX63" fmla="*/ 1216652 w 1307139"/>
              <a:gd name="connsiteY63" fmla="*/ 319881 h 741653"/>
              <a:gd name="connsiteX64" fmla="*/ 1245227 w 1307139"/>
              <a:gd name="connsiteY64" fmla="*/ 315119 h 741653"/>
              <a:gd name="connsiteX65" fmla="*/ 1264277 w 1307139"/>
              <a:gd name="connsiteY65" fmla="*/ 277019 h 741653"/>
              <a:gd name="connsiteX66" fmla="*/ 1283327 w 1307139"/>
              <a:gd name="connsiteY66" fmla="*/ 234156 h 741653"/>
              <a:gd name="connsiteX67" fmla="*/ 1292852 w 1307139"/>
              <a:gd name="connsiteY67" fmla="*/ 253206 h 741653"/>
              <a:gd name="connsiteX68" fmla="*/ 1297614 w 1307139"/>
              <a:gd name="connsiteY68" fmla="*/ 300831 h 741653"/>
              <a:gd name="connsiteX69" fmla="*/ 1302377 w 1307139"/>
              <a:gd name="connsiteY69" fmla="*/ 343694 h 741653"/>
              <a:gd name="connsiteX70" fmla="*/ 1307139 w 1307139"/>
              <a:gd name="connsiteY70" fmla="*/ 357981 h 741653"/>
              <a:gd name="connsiteX71" fmla="*/ 1302377 w 1307139"/>
              <a:gd name="connsiteY71" fmla="*/ 443706 h 741653"/>
              <a:gd name="connsiteX72" fmla="*/ 1297614 w 1307139"/>
              <a:gd name="connsiteY72" fmla="*/ 457994 h 741653"/>
              <a:gd name="connsiteX73" fmla="*/ 1264277 w 1307139"/>
              <a:gd name="connsiteY73" fmla="*/ 505619 h 741653"/>
              <a:gd name="connsiteX74" fmla="*/ 1245227 w 1307139"/>
              <a:gd name="connsiteY74" fmla="*/ 538956 h 741653"/>
              <a:gd name="connsiteX75" fmla="*/ 1226177 w 1307139"/>
              <a:gd name="connsiteY75" fmla="*/ 567531 h 741653"/>
              <a:gd name="connsiteX76" fmla="*/ 1202364 w 1307139"/>
              <a:gd name="connsiteY76" fmla="*/ 596106 h 741653"/>
              <a:gd name="connsiteX77" fmla="*/ 1188077 w 1307139"/>
              <a:gd name="connsiteY77" fmla="*/ 605631 h 741653"/>
              <a:gd name="connsiteX78" fmla="*/ 1159502 w 1307139"/>
              <a:gd name="connsiteY78" fmla="*/ 624681 h 741653"/>
              <a:gd name="connsiteX79" fmla="*/ 1130927 w 1307139"/>
              <a:gd name="connsiteY79" fmla="*/ 643731 h 741653"/>
              <a:gd name="connsiteX80" fmla="*/ 1088064 w 1307139"/>
              <a:gd name="connsiteY80" fmla="*/ 658019 h 741653"/>
              <a:gd name="connsiteX81" fmla="*/ 1073777 w 1307139"/>
              <a:gd name="connsiteY81" fmla="*/ 662781 h 741653"/>
              <a:gd name="connsiteX82" fmla="*/ 1045202 w 1307139"/>
              <a:gd name="connsiteY82" fmla="*/ 677069 h 741653"/>
              <a:gd name="connsiteX83" fmla="*/ 1011864 w 1307139"/>
              <a:gd name="connsiteY83" fmla="*/ 696119 h 741653"/>
              <a:gd name="connsiteX84" fmla="*/ 973764 w 1307139"/>
              <a:gd name="connsiteY84" fmla="*/ 705644 h 741653"/>
              <a:gd name="connsiteX85" fmla="*/ 935664 w 1307139"/>
              <a:gd name="connsiteY85" fmla="*/ 719931 h 741653"/>
              <a:gd name="connsiteX86" fmla="*/ 721352 w 1307139"/>
              <a:gd name="connsiteY86" fmla="*/ 715169 h 741653"/>
              <a:gd name="connsiteX87" fmla="*/ 668964 w 1307139"/>
              <a:gd name="connsiteY87" fmla="*/ 715169 h 741653"/>
              <a:gd name="connsiteX88" fmla="*/ 654677 w 1307139"/>
              <a:gd name="connsiteY88" fmla="*/ 724694 h 741653"/>
              <a:gd name="connsiteX89" fmla="*/ 635627 w 1307139"/>
              <a:gd name="connsiteY89" fmla="*/ 729456 h 741653"/>
              <a:gd name="connsiteX90" fmla="*/ 507039 w 1307139"/>
              <a:gd name="connsiteY90" fmla="*/ 724694 h 741653"/>
              <a:gd name="connsiteX91" fmla="*/ 397502 w 1307139"/>
              <a:gd name="connsiteY91" fmla="*/ 729456 h 741653"/>
              <a:gd name="connsiteX92" fmla="*/ 349877 w 1307139"/>
              <a:gd name="connsiteY92" fmla="*/ 729456 h 741653"/>
              <a:gd name="connsiteX93" fmla="*/ 307014 w 1307139"/>
              <a:gd name="connsiteY93" fmla="*/ 710406 h 741653"/>
              <a:gd name="connsiteX94" fmla="*/ 287964 w 1307139"/>
              <a:gd name="connsiteY94" fmla="*/ 696119 h 741653"/>
              <a:gd name="connsiteX95" fmla="*/ 240339 w 1307139"/>
              <a:gd name="connsiteY95" fmla="*/ 677069 h 741653"/>
              <a:gd name="connsiteX96" fmla="*/ 226052 w 1307139"/>
              <a:gd name="connsiteY96" fmla="*/ 667544 h 741653"/>
              <a:gd name="connsiteX97" fmla="*/ 211764 w 1307139"/>
              <a:gd name="connsiteY97" fmla="*/ 653256 h 741653"/>
              <a:gd name="connsiteX98" fmla="*/ 183189 w 1307139"/>
              <a:gd name="connsiteY98" fmla="*/ 643731 h 741653"/>
              <a:gd name="connsiteX99" fmla="*/ 149852 w 1307139"/>
              <a:gd name="connsiteY99" fmla="*/ 629444 h 741653"/>
              <a:gd name="connsiteX100" fmla="*/ 135564 w 1307139"/>
              <a:gd name="connsiteY100" fmla="*/ 615156 h 741653"/>
              <a:gd name="connsiteX101" fmla="*/ 121277 w 1307139"/>
              <a:gd name="connsiteY101" fmla="*/ 605631 h 741653"/>
              <a:gd name="connsiteX102" fmla="*/ 92702 w 1307139"/>
              <a:gd name="connsiteY102" fmla="*/ 572294 h 741653"/>
              <a:gd name="connsiteX103" fmla="*/ 78414 w 1307139"/>
              <a:gd name="connsiteY103" fmla="*/ 567531 h 741653"/>
              <a:gd name="connsiteX104" fmla="*/ 45077 w 1307139"/>
              <a:gd name="connsiteY104" fmla="*/ 558006 h 741653"/>
              <a:gd name="connsiteX105" fmla="*/ 26027 w 1307139"/>
              <a:gd name="connsiteY105" fmla="*/ 529431 h 741653"/>
              <a:gd name="connsiteX106" fmla="*/ 16502 w 1307139"/>
              <a:gd name="connsiteY106" fmla="*/ 491331 h 741653"/>
              <a:gd name="connsiteX107" fmla="*/ 11739 w 1307139"/>
              <a:gd name="connsiteY107" fmla="*/ 457994 h 741653"/>
              <a:gd name="connsiteX108" fmla="*/ 6977 w 1307139"/>
              <a:gd name="connsiteY108" fmla="*/ 438944 h 741653"/>
              <a:gd name="connsiteX109" fmla="*/ 6977 w 1307139"/>
              <a:gd name="connsiteY109" fmla="*/ 329406 h 741653"/>
              <a:gd name="connsiteX110" fmla="*/ 21264 w 1307139"/>
              <a:gd name="connsiteY110" fmla="*/ 277019 h 741653"/>
              <a:gd name="connsiteX111" fmla="*/ 40314 w 1307139"/>
              <a:gd name="connsiteY111" fmla="*/ 262731 h 741653"/>
              <a:gd name="connsiteX112" fmla="*/ 59364 w 1307139"/>
              <a:gd name="connsiteY112" fmla="*/ 238919 h 741653"/>
              <a:gd name="connsiteX113" fmla="*/ 78414 w 1307139"/>
              <a:gd name="connsiteY113" fmla="*/ 205581 h 741653"/>
              <a:gd name="connsiteX114" fmla="*/ 87939 w 1307139"/>
              <a:gd name="connsiteY114" fmla="*/ 177006 h 741653"/>
              <a:gd name="connsiteX115" fmla="*/ 97464 w 1307139"/>
              <a:gd name="connsiteY115" fmla="*/ 157956 h 741653"/>
              <a:gd name="connsiteX116" fmla="*/ 106989 w 1307139"/>
              <a:gd name="connsiteY116" fmla="*/ 129381 h 741653"/>
              <a:gd name="connsiteX117" fmla="*/ 111752 w 1307139"/>
              <a:gd name="connsiteY117" fmla="*/ 115094 h 741653"/>
              <a:gd name="connsiteX118" fmla="*/ 149852 w 1307139"/>
              <a:gd name="connsiteY118" fmla="*/ 72231 h 741653"/>
              <a:gd name="connsiteX119" fmla="*/ 173664 w 1307139"/>
              <a:gd name="connsiteY119" fmla="*/ 43656 h 741653"/>
              <a:gd name="connsiteX120" fmla="*/ 187952 w 1307139"/>
              <a:gd name="connsiteY120" fmla="*/ 38894 h 741653"/>
              <a:gd name="connsiteX121" fmla="*/ 240339 w 1307139"/>
              <a:gd name="connsiteY121" fmla="*/ 34131 h 741653"/>
              <a:gd name="connsiteX122" fmla="*/ 292727 w 1307139"/>
              <a:gd name="connsiteY122" fmla="*/ 19844 h 741653"/>
              <a:gd name="connsiteX123" fmla="*/ 307014 w 1307139"/>
              <a:gd name="connsiteY123" fmla="*/ 15081 h 741653"/>
              <a:gd name="connsiteX124" fmla="*/ 326064 w 1307139"/>
              <a:gd name="connsiteY124" fmla="*/ 10319 h 741653"/>
              <a:gd name="connsiteX125" fmla="*/ 340352 w 1307139"/>
              <a:gd name="connsiteY125" fmla="*/ 794 h 7416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</a:cxnLst>
            <a:rect l="l" t="t" r="r" b="b"/>
            <a:pathLst>
              <a:path w="1307139" h="741653">
                <a:moveTo>
                  <a:pt x="340352" y="794"/>
                </a:moveTo>
                <a:cubicBezTo>
                  <a:pt x="344321" y="1588"/>
                  <a:pt x="345830" y="11034"/>
                  <a:pt x="349877" y="15081"/>
                </a:cubicBezTo>
                <a:cubicBezTo>
                  <a:pt x="368166" y="33370"/>
                  <a:pt x="390899" y="27037"/>
                  <a:pt x="416552" y="29369"/>
                </a:cubicBezTo>
                <a:cubicBezTo>
                  <a:pt x="426112" y="31759"/>
                  <a:pt x="443311" y="33789"/>
                  <a:pt x="449889" y="43656"/>
                </a:cubicBezTo>
                <a:cubicBezTo>
                  <a:pt x="453520" y="49102"/>
                  <a:pt x="453064" y="56356"/>
                  <a:pt x="454652" y="62706"/>
                </a:cubicBezTo>
                <a:cubicBezTo>
                  <a:pt x="453064" y="70644"/>
                  <a:pt x="453509" y="79279"/>
                  <a:pt x="449889" y="86519"/>
                </a:cubicBezTo>
                <a:cubicBezTo>
                  <a:pt x="445949" y="94400"/>
                  <a:pt x="428972" y="105955"/>
                  <a:pt x="421314" y="110331"/>
                </a:cubicBezTo>
                <a:cubicBezTo>
                  <a:pt x="407636" y="118147"/>
                  <a:pt x="388702" y="126378"/>
                  <a:pt x="373689" y="129381"/>
                </a:cubicBezTo>
                <a:cubicBezTo>
                  <a:pt x="365752" y="130969"/>
                  <a:pt x="357779" y="132388"/>
                  <a:pt x="349877" y="134144"/>
                </a:cubicBezTo>
                <a:cubicBezTo>
                  <a:pt x="343487" y="135564"/>
                  <a:pt x="337245" y="137622"/>
                  <a:pt x="330827" y="138906"/>
                </a:cubicBezTo>
                <a:cubicBezTo>
                  <a:pt x="321358" y="140800"/>
                  <a:pt x="311721" y="141775"/>
                  <a:pt x="302252" y="143669"/>
                </a:cubicBezTo>
                <a:cubicBezTo>
                  <a:pt x="295834" y="144953"/>
                  <a:pt x="289496" y="146633"/>
                  <a:pt x="283202" y="148431"/>
                </a:cubicBezTo>
                <a:cubicBezTo>
                  <a:pt x="278375" y="149810"/>
                  <a:pt x="273876" y="152431"/>
                  <a:pt x="268914" y="153194"/>
                </a:cubicBezTo>
                <a:cubicBezTo>
                  <a:pt x="253145" y="155620"/>
                  <a:pt x="237164" y="156369"/>
                  <a:pt x="221289" y="157956"/>
                </a:cubicBezTo>
                <a:cubicBezTo>
                  <a:pt x="222877" y="164306"/>
                  <a:pt x="224171" y="170737"/>
                  <a:pt x="226052" y="177006"/>
                </a:cubicBezTo>
                <a:cubicBezTo>
                  <a:pt x="228937" y="186623"/>
                  <a:pt x="235577" y="205581"/>
                  <a:pt x="235577" y="205581"/>
                </a:cubicBezTo>
                <a:cubicBezTo>
                  <a:pt x="233989" y="219869"/>
                  <a:pt x="233633" y="234348"/>
                  <a:pt x="230814" y="248444"/>
                </a:cubicBezTo>
                <a:cubicBezTo>
                  <a:pt x="228845" y="258289"/>
                  <a:pt x="221289" y="277019"/>
                  <a:pt x="221289" y="277019"/>
                </a:cubicBezTo>
                <a:cubicBezTo>
                  <a:pt x="223043" y="303323"/>
                  <a:pt x="213627" y="340793"/>
                  <a:pt x="235577" y="362744"/>
                </a:cubicBezTo>
                <a:cubicBezTo>
                  <a:pt x="239624" y="366791"/>
                  <a:pt x="245102" y="369094"/>
                  <a:pt x="249864" y="372269"/>
                </a:cubicBezTo>
                <a:cubicBezTo>
                  <a:pt x="261199" y="406274"/>
                  <a:pt x="251035" y="395275"/>
                  <a:pt x="273677" y="410369"/>
                </a:cubicBezTo>
                <a:cubicBezTo>
                  <a:pt x="276852" y="415131"/>
                  <a:pt x="279538" y="420259"/>
                  <a:pt x="283202" y="424656"/>
                </a:cubicBezTo>
                <a:cubicBezTo>
                  <a:pt x="287514" y="429830"/>
                  <a:pt x="294147" y="433096"/>
                  <a:pt x="297489" y="438944"/>
                </a:cubicBezTo>
                <a:cubicBezTo>
                  <a:pt x="300736" y="444627"/>
                  <a:pt x="298621" y="452548"/>
                  <a:pt x="302252" y="457994"/>
                </a:cubicBezTo>
                <a:cubicBezTo>
                  <a:pt x="305618" y="463043"/>
                  <a:pt x="332293" y="475396"/>
                  <a:pt x="335589" y="477044"/>
                </a:cubicBezTo>
                <a:cubicBezTo>
                  <a:pt x="356227" y="473869"/>
                  <a:pt x="377572" y="473747"/>
                  <a:pt x="397502" y="467519"/>
                </a:cubicBezTo>
                <a:cubicBezTo>
                  <a:pt x="412319" y="462888"/>
                  <a:pt x="411909" y="449777"/>
                  <a:pt x="416552" y="438944"/>
                </a:cubicBezTo>
                <a:cubicBezTo>
                  <a:pt x="419349" y="432419"/>
                  <a:pt x="422902" y="426244"/>
                  <a:pt x="426077" y="419894"/>
                </a:cubicBezTo>
                <a:cubicBezTo>
                  <a:pt x="424489" y="415131"/>
                  <a:pt x="419069" y="410096"/>
                  <a:pt x="421314" y="405606"/>
                </a:cubicBezTo>
                <a:cubicBezTo>
                  <a:pt x="430477" y="387279"/>
                  <a:pt x="459190" y="388629"/>
                  <a:pt x="473702" y="386556"/>
                </a:cubicBezTo>
                <a:cubicBezTo>
                  <a:pt x="507039" y="375444"/>
                  <a:pt x="492752" y="373856"/>
                  <a:pt x="516564" y="381794"/>
                </a:cubicBezTo>
                <a:cubicBezTo>
                  <a:pt x="521327" y="386556"/>
                  <a:pt x="529117" y="389573"/>
                  <a:pt x="530852" y="396081"/>
                </a:cubicBezTo>
                <a:cubicBezTo>
                  <a:pt x="555296" y="487747"/>
                  <a:pt x="519259" y="428698"/>
                  <a:pt x="545139" y="467519"/>
                </a:cubicBezTo>
                <a:cubicBezTo>
                  <a:pt x="552962" y="498809"/>
                  <a:pt x="544809" y="475275"/>
                  <a:pt x="559427" y="500856"/>
                </a:cubicBezTo>
                <a:cubicBezTo>
                  <a:pt x="562949" y="507020"/>
                  <a:pt x="564332" y="514516"/>
                  <a:pt x="568952" y="519906"/>
                </a:cubicBezTo>
                <a:cubicBezTo>
                  <a:pt x="574118" y="525933"/>
                  <a:pt x="581652" y="529431"/>
                  <a:pt x="588002" y="534194"/>
                </a:cubicBezTo>
                <a:cubicBezTo>
                  <a:pt x="589589" y="538956"/>
                  <a:pt x="589214" y="544931"/>
                  <a:pt x="592764" y="548481"/>
                </a:cubicBezTo>
                <a:cubicBezTo>
                  <a:pt x="603155" y="558872"/>
                  <a:pt x="634606" y="549307"/>
                  <a:pt x="640389" y="548481"/>
                </a:cubicBezTo>
                <a:cubicBezTo>
                  <a:pt x="645152" y="545306"/>
                  <a:pt x="650629" y="543003"/>
                  <a:pt x="654677" y="538956"/>
                </a:cubicBezTo>
                <a:cubicBezTo>
                  <a:pt x="658724" y="534909"/>
                  <a:pt x="659440" y="527844"/>
                  <a:pt x="664202" y="524669"/>
                </a:cubicBezTo>
                <a:cubicBezTo>
                  <a:pt x="669648" y="521038"/>
                  <a:pt x="676902" y="521494"/>
                  <a:pt x="683252" y="519906"/>
                </a:cubicBezTo>
                <a:cubicBezTo>
                  <a:pt x="688014" y="516731"/>
                  <a:pt x="693142" y="514045"/>
                  <a:pt x="697539" y="510381"/>
                </a:cubicBezTo>
                <a:cubicBezTo>
                  <a:pt x="702713" y="506069"/>
                  <a:pt x="706346" y="500009"/>
                  <a:pt x="711827" y="496094"/>
                </a:cubicBezTo>
                <a:cubicBezTo>
                  <a:pt x="717604" y="491968"/>
                  <a:pt x="724527" y="489744"/>
                  <a:pt x="730877" y="486569"/>
                </a:cubicBezTo>
                <a:cubicBezTo>
                  <a:pt x="734052" y="480219"/>
                  <a:pt x="736276" y="473296"/>
                  <a:pt x="740402" y="467519"/>
                </a:cubicBezTo>
                <a:cubicBezTo>
                  <a:pt x="744317" y="462038"/>
                  <a:pt x="752954" y="459739"/>
                  <a:pt x="754689" y="453231"/>
                </a:cubicBezTo>
                <a:cubicBezTo>
                  <a:pt x="759614" y="434760"/>
                  <a:pt x="757864" y="415131"/>
                  <a:pt x="759452" y="396081"/>
                </a:cubicBezTo>
                <a:cubicBezTo>
                  <a:pt x="794377" y="397669"/>
                  <a:pt x="830468" y="391755"/>
                  <a:pt x="864227" y="400844"/>
                </a:cubicBezTo>
                <a:cubicBezTo>
                  <a:pt x="875281" y="403820"/>
                  <a:pt x="876927" y="419894"/>
                  <a:pt x="883277" y="429419"/>
                </a:cubicBezTo>
                <a:cubicBezTo>
                  <a:pt x="889380" y="438573"/>
                  <a:pt x="902976" y="439902"/>
                  <a:pt x="911852" y="443706"/>
                </a:cubicBezTo>
                <a:cubicBezTo>
                  <a:pt x="932190" y="452422"/>
                  <a:pt x="931720" y="453845"/>
                  <a:pt x="949952" y="467519"/>
                </a:cubicBezTo>
                <a:cubicBezTo>
                  <a:pt x="961571" y="463645"/>
                  <a:pt x="969296" y="462462"/>
                  <a:pt x="978527" y="453231"/>
                </a:cubicBezTo>
                <a:cubicBezTo>
                  <a:pt x="980682" y="451076"/>
                  <a:pt x="999636" y="425300"/>
                  <a:pt x="1002339" y="419894"/>
                </a:cubicBezTo>
                <a:cubicBezTo>
                  <a:pt x="1004584" y="415404"/>
                  <a:pt x="1004664" y="409995"/>
                  <a:pt x="1007102" y="405606"/>
                </a:cubicBezTo>
                <a:cubicBezTo>
                  <a:pt x="1012661" y="395599"/>
                  <a:pt x="1019802" y="386556"/>
                  <a:pt x="1026152" y="377031"/>
                </a:cubicBezTo>
                <a:cubicBezTo>
                  <a:pt x="1030090" y="371124"/>
                  <a:pt x="1031132" y="363435"/>
                  <a:pt x="1035677" y="357981"/>
                </a:cubicBezTo>
                <a:cubicBezTo>
                  <a:pt x="1039341" y="353584"/>
                  <a:pt x="1045202" y="351631"/>
                  <a:pt x="1049964" y="348456"/>
                </a:cubicBezTo>
                <a:cubicBezTo>
                  <a:pt x="1053838" y="336837"/>
                  <a:pt x="1055021" y="329113"/>
                  <a:pt x="1064252" y="319881"/>
                </a:cubicBezTo>
                <a:cubicBezTo>
                  <a:pt x="1068299" y="315834"/>
                  <a:pt x="1073777" y="313531"/>
                  <a:pt x="1078539" y="310356"/>
                </a:cubicBezTo>
                <a:cubicBezTo>
                  <a:pt x="1103687" y="318739"/>
                  <a:pt x="1088651" y="312334"/>
                  <a:pt x="1121402" y="334169"/>
                </a:cubicBezTo>
                <a:lnTo>
                  <a:pt x="1135689" y="343694"/>
                </a:lnTo>
                <a:cubicBezTo>
                  <a:pt x="1148389" y="342106"/>
                  <a:pt x="1161274" y="341613"/>
                  <a:pt x="1173789" y="338931"/>
                </a:cubicBezTo>
                <a:cubicBezTo>
                  <a:pt x="1183606" y="336827"/>
                  <a:pt x="1194010" y="334975"/>
                  <a:pt x="1202364" y="329406"/>
                </a:cubicBezTo>
                <a:cubicBezTo>
                  <a:pt x="1207127" y="326231"/>
                  <a:pt x="1211222" y="321691"/>
                  <a:pt x="1216652" y="319881"/>
                </a:cubicBezTo>
                <a:cubicBezTo>
                  <a:pt x="1225813" y="316828"/>
                  <a:pt x="1235702" y="316706"/>
                  <a:pt x="1245227" y="315119"/>
                </a:cubicBezTo>
                <a:cubicBezTo>
                  <a:pt x="1259964" y="295468"/>
                  <a:pt x="1260456" y="299947"/>
                  <a:pt x="1264277" y="277019"/>
                </a:cubicBezTo>
                <a:cubicBezTo>
                  <a:pt x="1271563" y="233304"/>
                  <a:pt x="1256151" y="243215"/>
                  <a:pt x="1283327" y="234156"/>
                </a:cubicBezTo>
                <a:cubicBezTo>
                  <a:pt x="1286502" y="240506"/>
                  <a:pt x="1291364" y="246264"/>
                  <a:pt x="1292852" y="253206"/>
                </a:cubicBezTo>
                <a:cubicBezTo>
                  <a:pt x="1296195" y="268806"/>
                  <a:pt x="1295944" y="284964"/>
                  <a:pt x="1297614" y="300831"/>
                </a:cubicBezTo>
                <a:cubicBezTo>
                  <a:pt x="1299119" y="315128"/>
                  <a:pt x="1300014" y="329514"/>
                  <a:pt x="1302377" y="343694"/>
                </a:cubicBezTo>
                <a:cubicBezTo>
                  <a:pt x="1303202" y="348646"/>
                  <a:pt x="1305552" y="353219"/>
                  <a:pt x="1307139" y="357981"/>
                </a:cubicBezTo>
                <a:cubicBezTo>
                  <a:pt x="1305552" y="386556"/>
                  <a:pt x="1305090" y="415216"/>
                  <a:pt x="1302377" y="443706"/>
                </a:cubicBezTo>
                <a:cubicBezTo>
                  <a:pt x="1301901" y="448704"/>
                  <a:pt x="1300052" y="453605"/>
                  <a:pt x="1297614" y="457994"/>
                </a:cubicBezTo>
                <a:cubicBezTo>
                  <a:pt x="1289239" y="473069"/>
                  <a:pt x="1274978" y="491351"/>
                  <a:pt x="1264277" y="505619"/>
                </a:cubicBezTo>
                <a:cubicBezTo>
                  <a:pt x="1256341" y="529425"/>
                  <a:pt x="1263574" y="512745"/>
                  <a:pt x="1245227" y="538956"/>
                </a:cubicBezTo>
                <a:cubicBezTo>
                  <a:pt x="1238662" y="548334"/>
                  <a:pt x="1232527" y="558006"/>
                  <a:pt x="1226177" y="567531"/>
                </a:cubicBezTo>
                <a:cubicBezTo>
                  <a:pt x="1216810" y="581582"/>
                  <a:pt x="1216118" y="584644"/>
                  <a:pt x="1202364" y="596106"/>
                </a:cubicBezTo>
                <a:cubicBezTo>
                  <a:pt x="1197967" y="599770"/>
                  <a:pt x="1192474" y="601967"/>
                  <a:pt x="1188077" y="605631"/>
                </a:cubicBezTo>
                <a:cubicBezTo>
                  <a:pt x="1164295" y="625450"/>
                  <a:pt x="1184609" y="616312"/>
                  <a:pt x="1159502" y="624681"/>
                </a:cubicBezTo>
                <a:lnTo>
                  <a:pt x="1130927" y="643731"/>
                </a:lnTo>
                <a:cubicBezTo>
                  <a:pt x="1118615" y="651939"/>
                  <a:pt x="1101950" y="654052"/>
                  <a:pt x="1088064" y="658019"/>
                </a:cubicBezTo>
                <a:cubicBezTo>
                  <a:pt x="1083237" y="659398"/>
                  <a:pt x="1078539" y="661194"/>
                  <a:pt x="1073777" y="662781"/>
                </a:cubicBezTo>
                <a:cubicBezTo>
                  <a:pt x="1032828" y="690079"/>
                  <a:pt x="1084638" y="657350"/>
                  <a:pt x="1045202" y="677069"/>
                </a:cubicBezTo>
                <a:cubicBezTo>
                  <a:pt x="1024303" y="687519"/>
                  <a:pt x="1036906" y="687772"/>
                  <a:pt x="1011864" y="696119"/>
                </a:cubicBezTo>
                <a:cubicBezTo>
                  <a:pt x="999445" y="700259"/>
                  <a:pt x="985473" y="699790"/>
                  <a:pt x="973764" y="705644"/>
                </a:cubicBezTo>
                <a:cubicBezTo>
                  <a:pt x="948860" y="718096"/>
                  <a:pt x="961602" y="713447"/>
                  <a:pt x="935664" y="719931"/>
                </a:cubicBezTo>
                <a:lnTo>
                  <a:pt x="721352" y="715169"/>
                </a:lnTo>
                <a:cubicBezTo>
                  <a:pt x="657311" y="712555"/>
                  <a:pt x="767264" y="701125"/>
                  <a:pt x="668964" y="715169"/>
                </a:cubicBezTo>
                <a:cubicBezTo>
                  <a:pt x="664202" y="718344"/>
                  <a:pt x="659938" y="722439"/>
                  <a:pt x="654677" y="724694"/>
                </a:cubicBezTo>
                <a:cubicBezTo>
                  <a:pt x="648661" y="727272"/>
                  <a:pt x="642172" y="729456"/>
                  <a:pt x="635627" y="729456"/>
                </a:cubicBezTo>
                <a:cubicBezTo>
                  <a:pt x="592735" y="729456"/>
                  <a:pt x="549902" y="726281"/>
                  <a:pt x="507039" y="724694"/>
                </a:cubicBezTo>
                <a:cubicBezTo>
                  <a:pt x="470527" y="726281"/>
                  <a:pt x="433949" y="726756"/>
                  <a:pt x="397502" y="729456"/>
                </a:cubicBezTo>
                <a:cubicBezTo>
                  <a:pt x="359760" y="732252"/>
                  <a:pt x="398663" y="741653"/>
                  <a:pt x="349877" y="729456"/>
                </a:cubicBezTo>
                <a:cubicBezTo>
                  <a:pt x="326049" y="723499"/>
                  <a:pt x="323854" y="722434"/>
                  <a:pt x="307014" y="710406"/>
                </a:cubicBezTo>
                <a:cubicBezTo>
                  <a:pt x="300555" y="705793"/>
                  <a:pt x="295063" y="699669"/>
                  <a:pt x="287964" y="696119"/>
                </a:cubicBezTo>
                <a:cubicBezTo>
                  <a:pt x="209925" y="657101"/>
                  <a:pt x="298583" y="710352"/>
                  <a:pt x="240339" y="677069"/>
                </a:cubicBezTo>
                <a:cubicBezTo>
                  <a:pt x="235369" y="674229"/>
                  <a:pt x="230449" y="671208"/>
                  <a:pt x="226052" y="667544"/>
                </a:cubicBezTo>
                <a:cubicBezTo>
                  <a:pt x="220878" y="663232"/>
                  <a:pt x="217652" y="656527"/>
                  <a:pt x="211764" y="653256"/>
                </a:cubicBezTo>
                <a:cubicBezTo>
                  <a:pt x="202987" y="648380"/>
                  <a:pt x="192714" y="646906"/>
                  <a:pt x="183189" y="643731"/>
                </a:cubicBezTo>
                <a:cubicBezTo>
                  <a:pt x="171528" y="639844"/>
                  <a:pt x="160152" y="636801"/>
                  <a:pt x="149852" y="629444"/>
                </a:cubicBezTo>
                <a:cubicBezTo>
                  <a:pt x="144371" y="625529"/>
                  <a:pt x="140738" y="619468"/>
                  <a:pt x="135564" y="615156"/>
                </a:cubicBezTo>
                <a:cubicBezTo>
                  <a:pt x="131167" y="611492"/>
                  <a:pt x="125324" y="609678"/>
                  <a:pt x="121277" y="605631"/>
                </a:cubicBezTo>
                <a:cubicBezTo>
                  <a:pt x="108075" y="592429"/>
                  <a:pt x="108252" y="582661"/>
                  <a:pt x="92702" y="572294"/>
                </a:cubicBezTo>
                <a:cubicBezTo>
                  <a:pt x="88525" y="569509"/>
                  <a:pt x="83241" y="568910"/>
                  <a:pt x="78414" y="567531"/>
                </a:cubicBezTo>
                <a:cubicBezTo>
                  <a:pt x="36562" y="555573"/>
                  <a:pt x="79326" y="569424"/>
                  <a:pt x="45077" y="558006"/>
                </a:cubicBezTo>
                <a:lnTo>
                  <a:pt x="26027" y="529431"/>
                </a:lnTo>
                <a:cubicBezTo>
                  <a:pt x="18765" y="518539"/>
                  <a:pt x="19677" y="504031"/>
                  <a:pt x="16502" y="491331"/>
                </a:cubicBezTo>
                <a:cubicBezTo>
                  <a:pt x="13779" y="480441"/>
                  <a:pt x="13747" y="469038"/>
                  <a:pt x="11739" y="457994"/>
                </a:cubicBezTo>
                <a:cubicBezTo>
                  <a:pt x="10568" y="451554"/>
                  <a:pt x="8564" y="445294"/>
                  <a:pt x="6977" y="438944"/>
                </a:cubicBezTo>
                <a:cubicBezTo>
                  <a:pt x="1179" y="375167"/>
                  <a:pt x="0" y="395691"/>
                  <a:pt x="6977" y="329406"/>
                </a:cubicBezTo>
                <a:cubicBezTo>
                  <a:pt x="8714" y="312905"/>
                  <a:pt x="9267" y="291015"/>
                  <a:pt x="21264" y="277019"/>
                </a:cubicBezTo>
                <a:cubicBezTo>
                  <a:pt x="26430" y="270992"/>
                  <a:pt x="33964" y="267494"/>
                  <a:pt x="40314" y="262731"/>
                </a:cubicBezTo>
                <a:cubicBezTo>
                  <a:pt x="49587" y="234916"/>
                  <a:pt x="37822" y="260462"/>
                  <a:pt x="59364" y="238919"/>
                </a:cubicBezTo>
                <a:cubicBezTo>
                  <a:pt x="65091" y="233192"/>
                  <a:pt x="75924" y="211806"/>
                  <a:pt x="78414" y="205581"/>
                </a:cubicBezTo>
                <a:cubicBezTo>
                  <a:pt x="82143" y="196259"/>
                  <a:pt x="83449" y="185986"/>
                  <a:pt x="87939" y="177006"/>
                </a:cubicBezTo>
                <a:cubicBezTo>
                  <a:pt x="91114" y="170656"/>
                  <a:pt x="94827" y="164548"/>
                  <a:pt x="97464" y="157956"/>
                </a:cubicBezTo>
                <a:cubicBezTo>
                  <a:pt x="101193" y="148634"/>
                  <a:pt x="103814" y="138906"/>
                  <a:pt x="106989" y="129381"/>
                </a:cubicBezTo>
                <a:lnTo>
                  <a:pt x="111752" y="115094"/>
                </a:lnTo>
                <a:cubicBezTo>
                  <a:pt x="116003" y="102344"/>
                  <a:pt x="147226" y="74857"/>
                  <a:pt x="149852" y="72231"/>
                </a:cubicBezTo>
                <a:cubicBezTo>
                  <a:pt x="167419" y="54664"/>
                  <a:pt x="150263" y="59256"/>
                  <a:pt x="173664" y="43656"/>
                </a:cubicBezTo>
                <a:cubicBezTo>
                  <a:pt x="177841" y="40871"/>
                  <a:pt x="182982" y="39604"/>
                  <a:pt x="187952" y="38894"/>
                </a:cubicBezTo>
                <a:cubicBezTo>
                  <a:pt x="205310" y="36414"/>
                  <a:pt x="222877" y="35719"/>
                  <a:pt x="240339" y="34131"/>
                </a:cubicBezTo>
                <a:cubicBezTo>
                  <a:pt x="267046" y="25230"/>
                  <a:pt x="249757" y="30587"/>
                  <a:pt x="292727" y="19844"/>
                </a:cubicBezTo>
                <a:cubicBezTo>
                  <a:pt x="297597" y="18626"/>
                  <a:pt x="302187" y="16460"/>
                  <a:pt x="307014" y="15081"/>
                </a:cubicBezTo>
                <a:cubicBezTo>
                  <a:pt x="313308" y="13283"/>
                  <a:pt x="319770" y="12117"/>
                  <a:pt x="326064" y="10319"/>
                </a:cubicBezTo>
                <a:cubicBezTo>
                  <a:pt x="330891" y="8940"/>
                  <a:pt x="336383" y="0"/>
                  <a:pt x="340352" y="794"/>
                </a:cubicBezTo>
                <a:close/>
              </a:path>
            </a:pathLst>
          </a:custGeom>
          <a:noFill/>
          <a:ln w="222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21" name="手繪多邊形 120"/>
          <p:cNvSpPr/>
          <p:nvPr/>
        </p:nvSpPr>
        <p:spPr>
          <a:xfrm>
            <a:off x="5055155" y="1692183"/>
            <a:ext cx="1237711" cy="720278"/>
          </a:xfrm>
          <a:custGeom>
            <a:avLst/>
            <a:gdLst>
              <a:gd name="connsiteX0" fmla="*/ 238216 w 1237711"/>
              <a:gd name="connsiteY0" fmla="*/ 83518 h 720278"/>
              <a:gd name="connsiteX1" fmla="*/ 247269 w 1237711"/>
              <a:gd name="connsiteY1" fmla="*/ 80500 h 720278"/>
              <a:gd name="connsiteX2" fmla="*/ 256323 w 1237711"/>
              <a:gd name="connsiteY2" fmla="*/ 83518 h 720278"/>
              <a:gd name="connsiteX3" fmla="*/ 271412 w 1237711"/>
              <a:gd name="connsiteY3" fmla="*/ 86535 h 720278"/>
              <a:gd name="connsiteX4" fmla="*/ 277447 w 1237711"/>
              <a:gd name="connsiteY4" fmla="*/ 98607 h 720278"/>
              <a:gd name="connsiteX5" fmla="*/ 283483 w 1237711"/>
              <a:gd name="connsiteY5" fmla="*/ 140856 h 720278"/>
              <a:gd name="connsiteX6" fmla="*/ 280465 w 1237711"/>
              <a:gd name="connsiteY6" fmla="*/ 216302 h 720278"/>
              <a:gd name="connsiteX7" fmla="*/ 274430 w 1237711"/>
              <a:gd name="connsiteY7" fmla="*/ 285712 h 720278"/>
              <a:gd name="connsiteX8" fmla="*/ 268394 w 1237711"/>
              <a:gd name="connsiteY8" fmla="*/ 303819 h 720278"/>
              <a:gd name="connsiteX9" fmla="*/ 265376 w 1237711"/>
              <a:gd name="connsiteY9" fmla="*/ 318908 h 720278"/>
              <a:gd name="connsiteX10" fmla="*/ 262358 w 1237711"/>
              <a:gd name="connsiteY10" fmla="*/ 327961 h 720278"/>
              <a:gd name="connsiteX11" fmla="*/ 277447 w 1237711"/>
              <a:gd name="connsiteY11" fmla="*/ 385300 h 720278"/>
              <a:gd name="connsiteX12" fmla="*/ 283483 w 1237711"/>
              <a:gd name="connsiteY12" fmla="*/ 403407 h 720278"/>
              <a:gd name="connsiteX13" fmla="*/ 304608 w 1237711"/>
              <a:gd name="connsiteY13" fmla="*/ 412460 h 720278"/>
              <a:gd name="connsiteX14" fmla="*/ 322715 w 1237711"/>
              <a:gd name="connsiteY14" fmla="*/ 415478 h 720278"/>
              <a:gd name="connsiteX15" fmla="*/ 343839 w 1237711"/>
              <a:gd name="connsiteY15" fmla="*/ 415478 h 720278"/>
              <a:gd name="connsiteX16" fmla="*/ 349875 w 1237711"/>
              <a:gd name="connsiteY16" fmla="*/ 406425 h 720278"/>
              <a:gd name="connsiteX17" fmla="*/ 361946 w 1237711"/>
              <a:gd name="connsiteY17" fmla="*/ 388318 h 720278"/>
              <a:gd name="connsiteX18" fmla="*/ 367982 w 1237711"/>
              <a:gd name="connsiteY18" fmla="*/ 379264 h 720278"/>
              <a:gd name="connsiteX19" fmla="*/ 377036 w 1237711"/>
              <a:gd name="connsiteY19" fmla="*/ 361157 h 720278"/>
              <a:gd name="connsiteX20" fmla="*/ 395142 w 1237711"/>
              <a:gd name="connsiteY20" fmla="*/ 346068 h 720278"/>
              <a:gd name="connsiteX21" fmla="*/ 404196 w 1237711"/>
              <a:gd name="connsiteY21" fmla="*/ 337015 h 720278"/>
              <a:gd name="connsiteX22" fmla="*/ 416267 w 1237711"/>
              <a:gd name="connsiteY22" fmla="*/ 318908 h 720278"/>
              <a:gd name="connsiteX23" fmla="*/ 419285 w 1237711"/>
              <a:gd name="connsiteY23" fmla="*/ 306836 h 720278"/>
              <a:gd name="connsiteX24" fmla="*/ 437392 w 1237711"/>
              <a:gd name="connsiteY24" fmla="*/ 297783 h 720278"/>
              <a:gd name="connsiteX25" fmla="*/ 446445 w 1237711"/>
              <a:gd name="connsiteY25" fmla="*/ 291747 h 720278"/>
              <a:gd name="connsiteX26" fmla="*/ 464552 w 1237711"/>
              <a:gd name="connsiteY26" fmla="*/ 297783 h 720278"/>
              <a:gd name="connsiteX27" fmla="*/ 470588 w 1237711"/>
              <a:gd name="connsiteY27" fmla="*/ 330979 h 720278"/>
              <a:gd name="connsiteX28" fmla="*/ 473606 w 1237711"/>
              <a:gd name="connsiteY28" fmla="*/ 349086 h 720278"/>
              <a:gd name="connsiteX29" fmla="*/ 494731 w 1237711"/>
              <a:gd name="connsiteY29" fmla="*/ 364175 h 720278"/>
              <a:gd name="connsiteX30" fmla="*/ 512838 w 1237711"/>
              <a:gd name="connsiteY30" fmla="*/ 370211 h 720278"/>
              <a:gd name="connsiteX31" fmla="*/ 558105 w 1237711"/>
              <a:gd name="connsiteY31" fmla="*/ 367193 h 720278"/>
              <a:gd name="connsiteX32" fmla="*/ 576212 w 1237711"/>
              <a:gd name="connsiteY32" fmla="*/ 355122 h 720278"/>
              <a:gd name="connsiteX33" fmla="*/ 579230 w 1237711"/>
              <a:gd name="connsiteY33" fmla="*/ 324943 h 720278"/>
              <a:gd name="connsiteX34" fmla="*/ 582247 w 1237711"/>
              <a:gd name="connsiteY34" fmla="*/ 315890 h 720278"/>
              <a:gd name="connsiteX35" fmla="*/ 591301 w 1237711"/>
              <a:gd name="connsiteY35" fmla="*/ 306836 h 720278"/>
              <a:gd name="connsiteX36" fmla="*/ 609408 w 1237711"/>
              <a:gd name="connsiteY36" fmla="*/ 288729 h 720278"/>
              <a:gd name="connsiteX37" fmla="*/ 621479 w 1237711"/>
              <a:gd name="connsiteY37" fmla="*/ 285712 h 720278"/>
              <a:gd name="connsiteX38" fmla="*/ 645622 w 1237711"/>
              <a:gd name="connsiteY38" fmla="*/ 273640 h 720278"/>
              <a:gd name="connsiteX39" fmla="*/ 651657 w 1237711"/>
              <a:gd name="connsiteY39" fmla="*/ 264587 h 720278"/>
              <a:gd name="connsiteX40" fmla="*/ 672782 w 1237711"/>
              <a:gd name="connsiteY40" fmla="*/ 276658 h 720278"/>
              <a:gd name="connsiteX41" fmla="*/ 681836 w 1237711"/>
              <a:gd name="connsiteY41" fmla="*/ 285712 h 720278"/>
              <a:gd name="connsiteX42" fmla="*/ 687871 w 1237711"/>
              <a:gd name="connsiteY42" fmla="*/ 297783 h 720278"/>
              <a:gd name="connsiteX43" fmla="*/ 705978 w 1237711"/>
              <a:gd name="connsiteY43" fmla="*/ 312872 h 720278"/>
              <a:gd name="connsiteX44" fmla="*/ 708996 w 1237711"/>
              <a:gd name="connsiteY44" fmla="*/ 324943 h 720278"/>
              <a:gd name="connsiteX45" fmla="*/ 724085 w 1237711"/>
              <a:gd name="connsiteY45" fmla="*/ 349086 h 720278"/>
              <a:gd name="connsiteX46" fmla="*/ 736156 w 1237711"/>
              <a:gd name="connsiteY46" fmla="*/ 367193 h 720278"/>
              <a:gd name="connsiteX47" fmla="*/ 742192 w 1237711"/>
              <a:gd name="connsiteY47" fmla="*/ 376246 h 720278"/>
              <a:gd name="connsiteX48" fmla="*/ 757281 w 1237711"/>
              <a:gd name="connsiteY48" fmla="*/ 388318 h 720278"/>
              <a:gd name="connsiteX49" fmla="*/ 787459 w 1237711"/>
              <a:gd name="connsiteY49" fmla="*/ 409442 h 720278"/>
              <a:gd name="connsiteX50" fmla="*/ 814620 w 1237711"/>
              <a:gd name="connsiteY50" fmla="*/ 406425 h 720278"/>
              <a:gd name="connsiteX51" fmla="*/ 820655 w 1237711"/>
              <a:gd name="connsiteY51" fmla="*/ 397371 h 720278"/>
              <a:gd name="connsiteX52" fmla="*/ 829709 w 1237711"/>
              <a:gd name="connsiteY52" fmla="*/ 388318 h 720278"/>
              <a:gd name="connsiteX53" fmla="*/ 826691 w 1237711"/>
              <a:gd name="connsiteY53" fmla="*/ 306836 h 720278"/>
              <a:gd name="connsiteX54" fmla="*/ 823673 w 1237711"/>
              <a:gd name="connsiteY54" fmla="*/ 294765 h 720278"/>
              <a:gd name="connsiteX55" fmla="*/ 817638 w 1237711"/>
              <a:gd name="connsiteY55" fmla="*/ 258551 h 720278"/>
              <a:gd name="connsiteX56" fmla="*/ 808584 w 1237711"/>
              <a:gd name="connsiteY56" fmla="*/ 228373 h 720278"/>
              <a:gd name="connsiteX57" fmla="*/ 820655 w 1237711"/>
              <a:gd name="connsiteY57" fmla="*/ 171034 h 720278"/>
              <a:gd name="connsiteX58" fmla="*/ 829709 w 1237711"/>
              <a:gd name="connsiteY58" fmla="*/ 168017 h 720278"/>
              <a:gd name="connsiteX59" fmla="*/ 844798 w 1237711"/>
              <a:gd name="connsiteY59" fmla="*/ 186124 h 720278"/>
              <a:gd name="connsiteX60" fmla="*/ 862905 w 1237711"/>
              <a:gd name="connsiteY60" fmla="*/ 213284 h 720278"/>
              <a:gd name="connsiteX61" fmla="*/ 874976 w 1237711"/>
              <a:gd name="connsiteY61" fmla="*/ 231391 h 720278"/>
              <a:gd name="connsiteX62" fmla="*/ 881012 w 1237711"/>
              <a:gd name="connsiteY62" fmla="*/ 240444 h 720278"/>
              <a:gd name="connsiteX63" fmla="*/ 890065 w 1237711"/>
              <a:gd name="connsiteY63" fmla="*/ 261569 h 720278"/>
              <a:gd name="connsiteX64" fmla="*/ 893083 w 1237711"/>
              <a:gd name="connsiteY64" fmla="*/ 270623 h 720278"/>
              <a:gd name="connsiteX65" fmla="*/ 908172 w 1237711"/>
              <a:gd name="connsiteY65" fmla="*/ 279676 h 720278"/>
              <a:gd name="connsiteX66" fmla="*/ 920243 w 1237711"/>
              <a:gd name="connsiteY66" fmla="*/ 285712 h 720278"/>
              <a:gd name="connsiteX67" fmla="*/ 938350 w 1237711"/>
              <a:gd name="connsiteY67" fmla="*/ 294765 h 720278"/>
              <a:gd name="connsiteX68" fmla="*/ 998707 w 1237711"/>
              <a:gd name="connsiteY68" fmla="*/ 288729 h 720278"/>
              <a:gd name="connsiteX69" fmla="*/ 1004742 w 1237711"/>
              <a:gd name="connsiteY69" fmla="*/ 276658 h 720278"/>
              <a:gd name="connsiteX70" fmla="*/ 1010778 w 1237711"/>
              <a:gd name="connsiteY70" fmla="*/ 258551 h 720278"/>
              <a:gd name="connsiteX71" fmla="*/ 1013796 w 1237711"/>
              <a:gd name="connsiteY71" fmla="*/ 249498 h 720278"/>
              <a:gd name="connsiteX72" fmla="*/ 1010778 w 1237711"/>
              <a:gd name="connsiteY72" fmla="*/ 201213 h 720278"/>
              <a:gd name="connsiteX73" fmla="*/ 983618 w 1237711"/>
              <a:gd name="connsiteY73" fmla="*/ 177070 h 720278"/>
              <a:gd name="connsiteX74" fmla="*/ 974564 w 1237711"/>
              <a:gd name="connsiteY74" fmla="*/ 174052 h 720278"/>
              <a:gd name="connsiteX75" fmla="*/ 941368 w 1237711"/>
              <a:gd name="connsiteY75" fmla="*/ 143874 h 720278"/>
              <a:gd name="connsiteX76" fmla="*/ 932315 w 1237711"/>
              <a:gd name="connsiteY76" fmla="*/ 119731 h 720278"/>
              <a:gd name="connsiteX77" fmla="*/ 929297 w 1237711"/>
              <a:gd name="connsiteY77" fmla="*/ 98607 h 720278"/>
              <a:gd name="connsiteX78" fmla="*/ 926279 w 1237711"/>
              <a:gd name="connsiteY78" fmla="*/ 86535 h 720278"/>
              <a:gd name="connsiteX79" fmla="*/ 932315 w 1237711"/>
              <a:gd name="connsiteY79" fmla="*/ 35232 h 720278"/>
              <a:gd name="connsiteX80" fmla="*/ 959475 w 1237711"/>
              <a:gd name="connsiteY80" fmla="*/ 38250 h 720278"/>
              <a:gd name="connsiteX81" fmla="*/ 1122438 w 1237711"/>
              <a:gd name="connsiteY81" fmla="*/ 53339 h 720278"/>
              <a:gd name="connsiteX82" fmla="*/ 1125455 w 1237711"/>
              <a:gd name="connsiteY82" fmla="*/ 62393 h 720278"/>
              <a:gd name="connsiteX83" fmla="*/ 1128473 w 1237711"/>
              <a:gd name="connsiteY83" fmla="*/ 74464 h 720278"/>
              <a:gd name="connsiteX84" fmla="*/ 1134509 w 1237711"/>
              <a:gd name="connsiteY84" fmla="*/ 83518 h 720278"/>
              <a:gd name="connsiteX85" fmla="*/ 1137527 w 1237711"/>
              <a:gd name="connsiteY85" fmla="*/ 92571 h 720278"/>
              <a:gd name="connsiteX86" fmla="*/ 1152616 w 1237711"/>
              <a:gd name="connsiteY86" fmla="*/ 110678 h 720278"/>
              <a:gd name="connsiteX87" fmla="*/ 1167705 w 1237711"/>
              <a:gd name="connsiteY87" fmla="*/ 125767 h 720278"/>
              <a:gd name="connsiteX88" fmla="*/ 1185812 w 1237711"/>
              <a:gd name="connsiteY88" fmla="*/ 140856 h 720278"/>
              <a:gd name="connsiteX89" fmla="*/ 1197883 w 1237711"/>
              <a:gd name="connsiteY89" fmla="*/ 158963 h 720278"/>
              <a:gd name="connsiteX90" fmla="*/ 1206937 w 1237711"/>
              <a:gd name="connsiteY90" fmla="*/ 177070 h 720278"/>
              <a:gd name="connsiteX91" fmla="*/ 1209954 w 1237711"/>
              <a:gd name="connsiteY91" fmla="*/ 186124 h 720278"/>
              <a:gd name="connsiteX92" fmla="*/ 1215990 w 1237711"/>
              <a:gd name="connsiteY92" fmla="*/ 198195 h 720278"/>
              <a:gd name="connsiteX93" fmla="*/ 1219008 w 1237711"/>
              <a:gd name="connsiteY93" fmla="*/ 210266 h 720278"/>
              <a:gd name="connsiteX94" fmla="*/ 1225043 w 1237711"/>
              <a:gd name="connsiteY94" fmla="*/ 219320 h 720278"/>
              <a:gd name="connsiteX95" fmla="*/ 1231079 w 1237711"/>
              <a:gd name="connsiteY95" fmla="*/ 249498 h 720278"/>
              <a:gd name="connsiteX96" fmla="*/ 1237115 w 1237711"/>
              <a:gd name="connsiteY96" fmla="*/ 276658 h 720278"/>
              <a:gd name="connsiteX97" fmla="*/ 1231079 w 1237711"/>
              <a:gd name="connsiteY97" fmla="*/ 370211 h 720278"/>
              <a:gd name="connsiteX98" fmla="*/ 1222026 w 1237711"/>
              <a:gd name="connsiteY98" fmla="*/ 391335 h 720278"/>
              <a:gd name="connsiteX99" fmla="*/ 1212972 w 1237711"/>
              <a:gd name="connsiteY99" fmla="*/ 409442 h 720278"/>
              <a:gd name="connsiteX100" fmla="*/ 1206937 w 1237711"/>
              <a:gd name="connsiteY100" fmla="*/ 427549 h 720278"/>
              <a:gd name="connsiteX101" fmla="*/ 1203919 w 1237711"/>
              <a:gd name="connsiteY101" fmla="*/ 436603 h 720278"/>
              <a:gd name="connsiteX102" fmla="*/ 1197883 w 1237711"/>
              <a:gd name="connsiteY102" fmla="*/ 445656 h 720278"/>
              <a:gd name="connsiteX103" fmla="*/ 1176758 w 1237711"/>
              <a:gd name="connsiteY103" fmla="*/ 463763 h 720278"/>
              <a:gd name="connsiteX104" fmla="*/ 1167705 w 1237711"/>
              <a:gd name="connsiteY104" fmla="*/ 466781 h 720278"/>
              <a:gd name="connsiteX105" fmla="*/ 1158651 w 1237711"/>
              <a:gd name="connsiteY105" fmla="*/ 472817 h 720278"/>
              <a:gd name="connsiteX106" fmla="*/ 1149598 w 1237711"/>
              <a:gd name="connsiteY106" fmla="*/ 475834 h 720278"/>
              <a:gd name="connsiteX107" fmla="*/ 1137527 w 1237711"/>
              <a:gd name="connsiteY107" fmla="*/ 481870 h 720278"/>
              <a:gd name="connsiteX108" fmla="*/ 1119420 w 1237711"/>
              <a:gd name="connsiteY108" fmla="*/ 487906 h 720278"/>
              <a:gd name="connsiteX109" fmla="*/ 1098295 w 1237711"/>
              <a:gd name="connsiteY109" fmla="*/ 502995 h 720278"/>
              <a:gd name="connsiteX110" fmla="*/ 1089241 w 1237711"/>
              <a:gd name="connsiteY110" fmla="*/ 512048 h 720278"/>
              <a:gd name="connsiteX111" fmla="*/ 1080188 w 1237711"/>
              <a:gd name="connsiteY111" fmla="*/ 515066 h 720278"/>
              <a:gd name="connsiteX112" fmla="*/ 1062081 w 1237711"/>
              <a:gd name="connsiteY112" fmla="*/ 530155 h 720278"/>
              <a:gd name="connsiteX113" fmla="*/ 1053028 w 1237711"/>
              <a:gd name="connsiteY113" fmla="*/ 536191 h 720278"/>
              <a:gd name="connsiteX114" fmla="*/ 1043974 w 1237711"/>
              <a:gd name="connsiteY114" fmla="*/ 548262 h 720278"/>
              <a:gd name="connsiteX115" fmla="*/ 1031903 w 1237711"/>
              <a:gd name="connsiteY115" fmla="*/ 566369 h 720278"/>
              <a:gd name="connsiteX116" fmla="*/ 1013796 w 1237711"/>
              <a:gd name="connsiteY116" fmla="*/ 584476 h 720278"/>
              <a:gd name="connsiteX117" fmla="*/ 992671 w 1237711"/>
              <a:gd name="connsiteY117" fmla="*/ 590512 h 720278"/>
              <a:gd name="connsiteX118" fmla="*/ 956457 w 1237711"/>
              <a:gd name="connsiteY118" fmla="*/ 599565 h 720278"/>
              <a:gd name="connsiteX119" fmla="*/ 944386 w 1237711"/>
              <a:gd name="connsiteY119" fmla="*/ 605601 h 720278"/>
              <a:gd name="connsiteX120" fmla="*/ 932315 w 1237711"/>
              <a:gd name="connsiteY120" fmla="*/ 608619 h 720278"/>
              <a:gd name="connsiteX121" fmla="*/ 920243 w 1237711"/>
              <a:gd name="connsiteY121" fmla="*/ 614654 h 720278"/>
              <a:gd name="connsiteX122" fmla="*/ 881012 w 1237711"/>
              <a:gd name="connsiteY122" fmla="*/ 617672 h 720278"/>
              <a:gd name="connsiteX123" fmla="*/ 802548 w 1237711"/>
              <a:gd name="connsiteY123" fmla="*/ 620690 h 720278"/>
              <a:gd name="connsiteX124" fmla="*/ 793495 w 1237711"/>
              <a:gd name="connsiteY124" fmla="*/ 617672 h 720278"/>
              <a:gd name="connsiteX125" fmla="*/ 781424 w 1237711"/>
              <a:gd name="connsiteY125" fmla="*/ 611636 h 720278"/>
              <a:gd name="connsiteX126" fmla="*/ 763317 w 1237711"/>
              <a:gd name="connsiteY126" fmla="*/ 614654 h 720278"/>
              <a:gd name="connsiteX127" fmla="*/ 757281 w 1237711"/>
              <a:gd name="connsiteY127" fmla="*/ 623708 h 720278"/>
              <a:gd name="connsiteX128" fmla="*/ 733139 w 1237711"/>
              <a:gd name="connsiteY128" fmla="*/ 632761 h 720278"/>
              <a:gd name="connsiteX129" fmla="*/ 724085 w 1237711"/>
              <a:gd name="connsiteY129" fmla="*/ 635779 h 720278"/>
              <a:gd name="connsiteX130" fmla="*/ 715032 w 1237711"/>
              <a:gd name="connsiteY130" fmla="*/ 641815 h 720278"/>
              <a:gd name="connsiteX131" fmla="*/ 705978 w 1237711"/>
              <a:gd name="connsiteY131" fmla="*/ 650868 h 720278"/>
              <a:gd name="connsiteX132" fmla="*/ 696925 w 1237711"/>
              <a:gd name="connsiteY132" fmla="*/ 653886 h 720278"/>
              <a:gd name="connsiteX133" fmla="*/ 684853 w 1237711"/>
              <a:gd name="connsiteY133" fmla="*/ 662939 h 720278"/>
              <a:gd name="connsiteX134" fmla="*/ 672782 w 1237711"/>
              <a:gd name="connsiteY134" fmla="*/ 665957 h 720278"/>
              <a:gd name="connsiteX135" fmla="*/ 618461 w 1237711"/>
              <a:gd name="connsiteY135" fmla="*/ 671993 h 720278"/>
              <a:gd name="connsiteX136" fmla="*/ 588283 w 1237711"/>
              <a:gd name="connsiteY136" fmla="*/ 684064 h 720278"/>
              <a:gd name="connsiteX137" fmla="*/ 579230 w 1237711"/>
              <a:gd name="connsiteY137" fmla="*/ 687082 h 720278"/>
              <a:gd name="connsiteX138" fmla="*/ 558105 w 1237711"/>
              <a:gd name="connsiteY138" fmla="*/ 699153 h 720278"/>
              <a:gd name="connsiteX139" fmla="*/ 546034 w 1237711"/>
              <a:gd name="connsiteY139" fmla="*/ 702171 h 720278"/>
              <a:gd name="connsiteX140" fmla="*/ 533962 w 1237711"/>
              <a:gd name="connsiteY140" fmla="*/ 708207 h 720278"/>
              <a:gd name="connsiteX141" fmla="*/ 485677 w 1237711"/>
              <a:gd name="connsiteY141" fmla="*/ 714242 h 720278"/>
              <a:gd name="connsiteX142" fmla="*/ 458517 w 1237711"/>
              <a:gd name="connsiteY142" fmla="*/ 720278 h 720278"/>
              <a:gd name="connsiteX143" fmla="*/ 401178 w 1237711"/>
              <a:gd name="connsiteY143" fmla="*/ 717260 h 720278"/>
              <a:gd name="connsiteX144" fmla="*/ 367982 w 1237711"/>
              <a:gd name="connsiteY144" fmla="*/ 711225 h 720278"/>
              <a:gd name="connsiteX145" fmla="*/ 349875 w 1237711"/>
              <a:gd name="connsiteY145" fmla="*/ 708207 h 720278"/>
              <a:gd name="connsiteX146" fmla="*/ 334786 w 1237711"/>
              <a:gd name="connsiteY146" fmla="*/ 705189 h 720278"/>
              <a:gd name="connsiteX147" fmla="*/ 304608 w 1237711"/>
              <a:gd name="connsiteY147" fmla="*/ 702171 h 720278"/>
              <a:gd name="connsiteX148" fmla="*/ 214073 w 1237711"/>
              <a:gd name="connsiteY148" fmla="*/ 702171 h 720278"/>
              <a:gd name="connsiteX149" fmla="*/ 171824 w 1237711"/>
              <a:gd name="connsiteY149" fmla="*/ 699153 h 720278"/>
              <a:gd name="connsiteX150" fmla="*/ 162770 w 1237711"/>
              <a:gd name="connsiteY150" fmla="*/ 693118 h 720278"/>
              <a:gd name="connsiteX151" fmla="*/ 159752 w 1237711"/>
              <a:gd name="connsiteY151" fmla="*/ 684064 h 720278"/>
              <a:gd name="connsiteX152" fmla="*/ 147681 w 1237711"/>
              <a:gd name="connsiteY152" fmla="*/ 656904 h 720278"/>
              <a:gd name="connsiteX153" fmla="*/ 126556 w 1237711"/>
              <a:gd name="connsiteY153" fmla="*/ 638797 h 720278"/>
              <a:gd name="connsiteX154" fmla="*/ 114485 w 1237711"/>
              <a:gd name="connsiteY154" fmla="*/ 632761 h 720278"/>
              <a:gd name="connsiteX155" fmla="*/ 87325 w 1237711"/>
              <a:gd name="connsiteY155" fmla="*/ 602583 h 720278"/>
              <a:gd name="connsiteX156" fmla="*/ 72236 w 1237711"/>
              <a:gd name="connsiteY156" fmla="*/ 575423 h 720278"/>
              <a:gd name="connsiteX157" fmla="*/ 69218 w 1237711"/>
              <a:gd name="connsiteY157" fmla="*/ 566369 h 720278"/>
              <a:gd name="connsiteX158" fmla="*/ 54129 w 1237711"/>
              <a:gd name="connsiteY158" fmla="*/ 548262 h 720278"/>
              <a:gd name="connsiteX159" fmla="*/ 51111 w 1237711"/>
              <a:gd name="connsiteY159" fmla="*/ 539209 h 720278"/>
              <a:gd name="connsiteX160" fmla="*/ 45075 w 1237711"/>
              <a:gd name="connsiteY160" fmla="*/ 530155 h 720278"/>
              <a:gd name="connsiteX161" fmla="*/ 42057 w 1237711"/>
              <a:gd name="connsiteY161" fmla="*/ 521102 h 720278"/>
              <a:gd name="connsiteX162" fmla="*/ 36022 w 1237711"/>
              <a:gd name="connsiteY162" fmla="*/ 512048 h 720278"/>
              <a:gd name="connsiteX163" fmla="*/ 29986 w 1237711"/>
              <a:gd name="connsiteY163" fmla="*/ 496959 h 720278"/>
              <a:gd name="connsiteX164" fmla="*/ 23950 w 1237711"/>
              <a:gd name="connsiteY164" fmla="*/ 475834 h 720278"/>
              <a:gd name="connsiteX165" fmla="*/ 17915 w 1237711"/>
              <a:gd name="connsiteY165" fmla="*/ 463763 h 720278"/>
              <a:gd name="connsiteX166" fmla="*/ 11879 w 1237711"/>
              <a:gd name="connsiteY166" fmla="*/ 445656 h 720278"/>
              <a:gd name="connsiteX167" fmla="*/ 5843 w 1237711"/>
              <a:gd name="connsiteY167" fmla="*/ 430567 h 720278"/>
              <a:gd name="connsiteX168" fmla="*/ 5843 w 1237711"/>
              <a:gd name="connsiteY168" fmla="*/ 315890 h 720278"/>
              <a:gd name="connsiteX169" fmla="*/ 11879 w 1237711"/>
              <a:gd name="connsiteY169" fmla="*/ 279676 h 720278"/>
              <a:gd name="connsiteX170" fmla="*/ 17915 w 1237711"/>
              <a:gd name="connsiteY170" fmla="*/ 261569 h 720278"/>
              <a:gd name="connsiteX171" fmla="*/ 23950 w 1237711"/>
              <a:gd name="connsiteY171" fmla="*/ 228373 h 720278"/>
              <a:gd name="connsiteX172" fmla="*/ 26968 w 1237711"/>
              <a:gd name="connsiteY172" fmla="*/ 213284 h 720278"/>
              <a:gd name="connsiteX173" fmla="*/ 36022 w 1237711"/>
              <a:gd name="connsiteY173" fmla="*/ 192159 h 720278"/>
              <a:gd name="connsiteX174" fmla="*/ 42057 w 1237711"/>
              <a:gd name="connsiteY174" fmla="*/ 174052 h 720278"/>
              <a:gd name="connsiteX175" fmla="*/ 63182 w 1237711"/>
              <a:gd name="connsiteY175" fmla="*/ 161981 h 720278"/>
              <a:gd name="connsiteX176" fmla="*/ 81289 w 1237711"/>
              <a:gd name="connsiteY176" fmla="*/ 149910 h 720278"/>
              <a:gd name="connsiteX177" fmla="*/ 102414 w 1237711"/>
              <a:gd name="connsiteY177" fmla="*/ 143874 h 720278"/>
              <a:gd name="connsiteX178" fmla="*/ 135610 w 1237711"/>
              <a:gd name="connsiteY178" fmla="*/ 140856 h 720278"/>
              <a:gd name="connsiteX179" fmla="*/ 156735 w 1237711"/>
              <a:gd name="connsiteY179" fmla="*/ 137838 h 720278"/>
              <a:gd name="connsiteX180" fmla="*/ 165788 w 1237711"/>
              <a:gd name="connsiteY180" fmla="*/ 131803 h 720278"/>
              <a:gd name="connsiteX181" fmla="*/ 183895 w 1237711"/>
              <a:gd name="connsiteY181" fmla="*/ 116714 h 720278"/>
              <a:gd name="connsiteX182" fmla="*/ 202002 w 1237711"/>
              <a:gd name="connsiteY182" fmla="*/ 110678 h 720278"/>
              <a:gd name="connsiteX183" fmla="*/ 214073 w 1237711"/>
              <a:gd name="connsiteY183" fmla="*/ 92571 h 720278"/>
              <a:gd name="connsiteX184" fmla="*/ 238216 w 1237711"/>
              <a:gd name="connsiteY184" fmla="*/ 83518 h 72027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  <a:cxn ang="0">
                <a:pos x="connsiteX165" y="connsiteY165"/>
              </a:cxn>
              <a:cxn ang="0">
                <a:pos x="connsiteX166" y="connsiteY166"/>
              </a:cxn>
              <a:cxn ang="0">
                <a:pos x="connsiteX167" y="connsiteY167"/>
              </a:cxn>
              <a:cxn ang="0">
                <a:pos x="connsiteX168" y="connsiteY168"/>
              </a:cxn>
              <a:cxn ang="0">
                <a:pos x="connsiteX169" y="connsiteY169"/>
              </a:cxn>
              <a:cxn ang="0">
                <a:pos x="connsiteX170" y="connsiteY170"/>
              </a:cxn>
              <a:cxn ang="0">
                <a:pos x="connsiteX171" y="connsiteY171"/>
              </a:cxn>
              <a:cxn ang="0">
                <a:pos x="connsiteX172" y="connsiteY172"/>
              </a:cxn>
              <a:cxn ang="0">
                <a:pos x="connsiteX173" y="connsiteY173"/>
              </a:cxn>
              <a:cxn ang="0">
                <a:pos x="connsiteX174" y="connsiteY174"/>
              </a:cxn>
              <a:cxn ang="0">
                <a:pos x="connsiteX175" y="connsiteY175"/>
              </a:cxn>
              <a:cxn ang="0">
                <a:pos x="connsiteX176" y="connsiteY176"/>
              </a:cxn>
              <a:cxn ang="0">
                <a:pos x="connsiteX177" y="connsiteY177"/>
              </a:cxn>
              <a:cxn ang="0">
                <a:pos x="connsiteX178" y="connsiteY178"/>
              </a:cxn>
              <a:cxn ang="0">
                <a:pos x="connsiteX179" y="connsiteY179"/>
              </a:cxn>
              <a:cxn ang="0">
                <a:pos x="connsiteX180" y="connsiteY180"/>
              </a:cxn>
              <a:cxn ang="0">
                <a:pos x="connsiteX181" y="connsiteY181"/>
              </a:cxn>
              <a:cxn ang="0">
                <a:pos x="connsiteX182" y="connsiteY182"/>
              </a:cxn>
              <a:cxn ang="0">
                <a:pos x="connsiteX183" y="connsiteY183"/>
              </a:cxn>
              <a:cxn ang="0">
                <a:pos x="connsiteX184" y="connsiteY184"/>
              </a:cxn>
            </a:cxnLst>
            <a:rect l="l" t="t" r="r" b="b"/>
            <a:pathLst>
              <a:path w="1237711" h="720278">
                <a:moveTo>
                  <a:pt x="238216" y="83518"/>
                </a:moveTo>
                <a:cubicBezTo>
                  <a:pt x="243749" y="81506"/>
                  <a:pt x="244088" y="80500"/>
                  <a:pt x="247269" y="80500"/>
                </a:cubicBezTo>
                <a:cubicBezTo>
                  <a:pt x="250450" y="80500"/>
                  <a:pt x="253237" y="82747"/>
                  <a:pt x="256323" y="83518"/>
                </a:cubicBezTo>
                <a:cubicBezTo>
                  <a:pt x="261299" y="84762"/>
                  <a:pt x="266382" y="85529"/>
                  <a:pt x="271412" y="86535"/>
                </a:cubicBezTo>
                <a:cubicBezTo>
                  <a:pt x="273424" y="90559"/>
                  <a:pt x="275675" y="94472"/>
                  <a:pt x="277447" y="98607"/>
                </a:cubicBezTo>
                <a:cubicBezTo>
                  <a:pt x="283477" y="112677"/>
                  <a:pt x="281931" y="123785"/>
                  <a:pt x="283483" y="140856"/>
                </a:cubicBezTo>
                <a:cubicBezTo>
                  <a:pt x="282477" y="166005"/>
                  <a:pt x="281722" y="191165"/>
                  <a:pt x="280465" y="216302"/>
                </a:cubicBezTo>
                <a:cubicBezTo>
                  <a:pt x="280052" y="224560"/>
                  <a:pt x="277636" y="270751"/>
                  <a:pt x="274430" y="285712"/>
                </a:cubicBezTo>
                <a:cubicBezTo>
                  <a:pt x="273097" y="291933"/>
                  <a:pt x="270406" y="297783"/>
                  <a:pt x="268394" y="303819"/>
                </a:cubicBezTo>
                <a:cubicBezTo>
                  <a:pt x="266772" y="308685"/>
                  <a:pt x="266620" y="313932"/>
                  <a:pt x="265376" y="318908"/>
                </a:cubicBezTo>
                <a:cubicBezTo>
                  <a:pt x="264604" y="321994"/>
                  <a:pt x="263364" y="324943"/>
                  <a:pt x="262358" y="327961"/>
                </a:cubicBezTo>
                <a:cubicBezTo>
                  <a:pt x="268820" y="399044"/>
                  <a:pt x="258278" y="327795"/>
                  <a:pt x="277447" y="385300"/>
                </a:cubicBezTo>
                <a:cubicBezTo>
                  <a:pt x="279459" y="391336"/>
                  <a:pt x="277792" y="400562"/>
                  <a:pt x="283483" y="403407"/>
                </a:cubicBezTo>
                <a:cubicBezTo>
                  <a:pt x="290864" y="407097"/>
                  <a:pt x="296616" y="410684"/>
                  <a:pt x="304608" y="412460"/>
                </a:cubicBezTo>
                <a:cubicBezTo>
                  <a:pt x="310581" y="413787"/>
                  <a:pt x="316679" y="414472"/>
                  <a:pt x="322715" y="415478"/>
                </a:cubicBezTo>
                <a:cubicBezTo>
                  <a:pt x="330860" y="418193"/>
                  <a:pt x="334997" y="421373"/>
                  <a:pt x="343839" y="415478"/>
                </a:cubicBezTo>
                <a:cubicBezTo>
                  <a:pt x="346857" y="413466"/>
                  <a:pt x="347863" y="409443"/>
                  <a:pt x="349875" y="406425"/>
                </a:cubicBezTo>
                <a:cubicBezTo>
                  <a:pt x="355179" y="390514"/>
                  <a:pt x="349388" y="403388"/>
                  <a:pt x="361946" y="388318"/>
                </a:cubicBezTo>
                <a:cubicBezTo>
                  <a:pt x="364268" y="385532"/>
                  <a:pt x="366360" y="382508"/>
                  <a:pt x="367982" y="379264"/>
                </a:cubicBezTo>
                <a:cubicBezTo>
                  <a:pt x="374788" y="365654"/>
                  <a:pt x="366225" y="374131"/>
                  <a:pt x="377036" y="361157"/>
                </a:cubicBezTo>
                <a:cubicBezTo>
                  <a:pt x="389054" y="346735"/>
                  <a:pt x="382198" y="356855"/>
                  <a:pt x="395142" y="346068"/>
                </a:cubicBezTo>
                <a:cubicBezTo>
                  <a:pt x="398421" y="343336"/>
                  <a:pt x="401576" y="340384"/>
                  <a:pt x="404196" y="337015"/>
                </a:cubicBezTo>
                <a:cubicBezTo>
                  <a:pt x="408650" y="331289"/>
                  <a:pt x="416267" y="318908"/>
                  <a:pt x="416267" y="318908"/>
                </a:cubicBezTo>
                <a:cubicBezTo>
                  <a:pt x="417273" y="314884"/>
                  <a:pt x="416984" y="310287"/>
                  <a:pt x="419285" y="306836"/>
                </a:cubicBezTo>
                <a:cubicBezTo>
                  <a:pt x="423608" y="300351"/>
                  <a:pt x="431368" y="300795"/>
                  <a:pt x="437392" y="297783"/>
                </a:cubicBezTo>
                <a:cubicBezTo>
                  <a:pt x="440636" y="296161"/>
                  <a:pt x="443427" y="293759"/>
                  <a:pt x="446445" y="291747"/>
                </a:cubicBezTo>
                <a:cubicBezTo>
                  <a:pt x="452481" y="293759"/>
                  <a:pt x="463652" y="291485"/>
                  <a:pt x="464552" y="297783"/>
                </a:cubicBezTo>
                <a:cubicBezTo>
                  <a:pt x="472224" y="351485"/>
                  <a:pt x="463473" y="295406"/>
                  <a:pt x="470588" y="330979"/>
                </a:cubicBezTo>
                <a:cubicBezTo>
                  <a:pt x="471788" y="336979"/>
                  <a:pt x="471334" y="343405"/>
                  <a:pt x="473606" y="349086"/>
                </a:cubicBezTo>
                <a:cubicBezTo>
                  <a:pt x="479494" y="363807"/>
                  <a:pt x="482442" y="360488"/>
                  <a:pt x="494731" y="364175"/>
                </a:cubicBezTo>
                <a:cubicBezTo>
                  <a:pt x="500825" y="366003"/>
                  <a:pt x="512838" y="370211"/>
                  <a:pt x="512838" y="370211"/>
                </a:cubicBezTo>
                <a:cubicBezTo>
                  <a:pt x="527927" y="369205"/>
                  <a:pt x="543394" y="370696"/>
                  <a:pt x="558105" y="367193"/>
                </a:cubicBezTo>
                <a:cubicBezTo>
                  <a:pt x="565162" y="365513"/>
                  <a:pt x="576212" y="355122"/>
                  <a:pt x="576212" y="355122"/>
                </a:cubicBezTo>
                <a:cubicBezTo>
                  <a:pt x="577218" y="345062"/>
                  <a:pt x="577693" y="334935"/>
                  <a:pt x="579230" y="324943"/>
                </a:cubicBezTo>
                <a:cubicBezTo>
                  <a:pt x="579714" y="321799"/>
                  <a:pt x="580483" y="318537"/>
                  <a:pt x="582247" y="315890"/>
                </a:cubicBezTo>
                <a:cubicBezTo>
                  <a:pt x="584614" y="312339"/>
                  <a:pt x="588569" y="310115"/>
                  <a:pt x="591301" y="306836"/>
                </a:cubicBezTo>
                <a:cubicBezTo>
                  <a:pt x="600052" y="296336"/>
                  <a:pt x="594540" y="296163"/>
                  <a:pt x="609408" y="288729"/>
                </a:cubicBezTo>
                <a:cubicBezTo>
                  <a:pt x="613118" y="286874"/>
                  <a:pt x="617544" y="287023"/>
                  <a:pt x="621479" y="285712"/>
                </a:cubicBezTo>
                <a:cubicBezTo>
                  <a:pt x="636242" y="280791"/>
                  <a:pt x="634534" y="281032"/>
                  <a:pt x="645622" y="273640"/>
                </a:cubicBezTo>
                <a:cubicBezTo>
                  <a:pt x="647634" y="270622"/>
                  <a:pt x="648170" y="265583"/>
                  <a:pt x="651657" y="264587"/>
                </a:cubicBezTo>
                <a:cubicBezTo>
                  <a:pt x="666742" y="260277"/>
                  <a:pt x="666418" y="269022"/>
                  <a:pt x="672782" y="276658"/>
                </a:cubicBezTo>
                <a:cubicBezTo>
                  <a:pt x="675514" y="279937"/>
                  <a:pt x="678818" y="282694"/>
                  <a:pt x="681836" y="285712"/>
                </a:cubicBezTo>
                <a:cubicBezTo>
                  <a:pt x="683848" y="289736"/>
                  <a:pt x="685256" y="294122"/>
                  <a:pt x="687871" y="297783"/>
                </a:cubicBezTo>
                <a:cubicBezTo>
                  <a:pt x="693150" y="305174"/>
                  <a:pt x="698762" y="308061"/>
                  <a:pt x="705978" y="312872"/>
                </a:cubicBezTo>
                <a:cubicBezTo>
                  <a:pt x="706984" y="316896"/>
                  <a:pt x="707540" y="321060"/>
                  <a:pt x="708996" y="324943"/>
                </a:cubicBezTo>
                <a:cubicBezTo>
                  <a:pt x="713629" y="337297"/>
                  <a:pt x="716416" y="338130"/>
                  <a:pt x="724085" y="349086"/>
                </a:cubicBezTo>
                <a:cubicBezTo>
                  <a:pt x="728245" y="355029"/>
                  <a:pt x="732132" y="361157"/>
                  <a:pt x="736156" y="367193"/>
                </a:cubicBezTo>
                <a:cubicBezTo>
                  <a:pt x="738168" y="370211"/>
                  <a:pt x="739360" y="373980"/>
                  <a:pt x="742192" y="376246"/>
                </a:cubicBezTo>
                <a:cubicBezTo>
                  <a:pt x="747222" y="380270"/>
                  <a:pt x="752515" y="383985"/>
                  <a:pt x="757281" y="388318"/>
                </a:cubicBezTo>
                <a:cubicBezTo>
                  <a:pt x="781222" y="410083"/>
                  <a:pt x="765698" y="404003"/>
                  <a:pt x="787459" y="409442"/>
                </a:cubicBezTo>
                <a:cubicBezTo>
                  <a:pt x="796513" y="408436"/>
                  <a:pt x="806059" y="409538"/>
                  <a:pt x="814620" y="406425"/>
                </a:cubicBezTo>
                <a:cubicBezTo>
                  <a:pt x="818029" y="405186"/>
                  <a:pt x="818333" y="400157"/>
                  <a:pt x="820655" y="397371"/>
                </a:cubicBezTo>
                <a:cubicBezTo>
                  <a:pt x="823387" y="394092"/>
                  <a:pt x="826691" y="391336"/>
                  <a:pt x="829709" y="388318"/>
                </a:cubicBezTo>
                <a:cubicBezTo>
                  <a:pt x="828703" y="361157"/>
                  <a:pt x="828441" y="333959"/>
                  <a:pt x="826691" y="306836"/>
                </a:cubicBezTo>
                <a:cubicBezTo>
                  <a:pt x="826424" y="302697"/>
                  <a:pt x="824437" y="298841"/>
                  <a:pt x="823673" y="294765"/>
                </a:cubicBezTo>
                <a:cubicBezTo>
                  <a:pt x="821418" y="282737"/>
                  <a:pt x="821508" y="270161"/>
                  <a:pt x="817638" y="258551"/>
                </a:cubicBezTo>
                <a:cubicBezTo>
                  <a:pt x="810290" y="236509"/>
                  <a:pt x="813145" y="246616"/>
                  <a:pt x="808584" y="228373"/>
                </a:cubicBezTo>
                <a:cubicBezTo>
                  <a:pt x="810187" y="202723"/>
                  <a:pt x="800644" y="184374"/>
                  <a:pt x="820655" y="171034"/>
                </a:cubicBezTo>
                <a:cubicBezTo>
                  <a:pt x="823302" y="169269"/>
                  <a:pt x="826691" y="169023"/>
                  <a:pt x="829709" y="168017"/>
                </a:cubicBezTo>
                <a:cubicBezTo>
                  <a:pt x="846180" y="200963"/>
                  <a:pt x="824894" y="163377"/>
                  <a:pt x="844798" y="186124"/>
                </a:cubicBezTo>
                <a:cubicBezTo>
                  <a:pt x="844799" y="186125"/>
                  <a:pt x="859887" y="208757"/>
                  <a:pt x="862905" y="213284"/>
                </a:cubicBezTo>
                <a:lnTo>
                  <a:pt x="874976" y="231391"/>
                </a:lnTo>
                <a:lnTo>
                  <a:pt x="881012" y="240444"/>
                </a:lnTo>
                <a:cubicBezTo>
                  <a:pt x="888090" y="261678"/>
                  <a:pt x="878878" y="235464"/>
                  <a:pt x="890065" y="261569"/>
                </a:cubicBezTo>
                <a:cubicBezTo>
                  <a:pt x="891318" y="264493"/>
                  <a:pt x="890834" y="268374"/>
                  <a:pt x="893083" y="270623"/>
                </a:cubicBezTo>
                <a:cubicBezTo>
                  <a:pt x="897231" y="274771"/>
                  <a:pt x="903045" y="276827"/>
                  <a:pt x="908172" y="279676"/>
                </a:cubicBezTo>
                <a:cubicBezTo>
                  <a:pt x="912105" y="281861"/>
                  <a:pt x="916337" y="283480"/>
                  <a:pt x="920243" y="285712"/>
                </a:cubicBezTo>
                <a:cubicBezTo>
                  <a:pt x="936621" y="295070"/>
                  <a:pt x="921754" y="289233"/>
                  <a:pt x="938350" y="294765"/>
                </a:cubicBezTo>
                <a:cubicBezTo>
                  <a:pt x="958469" y="292753"/>
                  <a:pt x="979200" y="294049"/>
                  <a:pt x="998707" y="288729"/>
                </a:cubicBezTo>
                <a:cubicBezTo>
                  <a:pt x="1003047" y="287545"/>
                  <a:pt x="1003071" y="280835"/>
                  <a:pt x="1004742" y="276658"/>
                </a:cubicBezTo>
                <a:cubicBezTo>
                  <a:pt x="1007105" y="270751"/>
                  <a:pt x="1008766" y="264587"/>
                  <a:pt x="1010778" y="258551"/>
                </a:cubicBezTo>
                <a:lnTo>
                  <a:pt x="1013796" y="249498"/>
                </a:lnTo>
                <a:cubicBezTo>
                  <a:pt x="1012790" y="233403"/>
                  <a:pt x="1015668" y="216580"/>
                  <a:pt x="1010778" y="201213"/>
                </a:cubicBezTo>
                <a:cubicBezTo>
                  <a:pt x="1009266" y="196460"/>
                  <a:pt x="991632" y="181077"/>
                  <a:pt x="983618" y="177070"/>
                </a:cubicBezTo>
                <a:cubicBezTo>
                  <a:pt x="980773" y="175647"/>
                  <a:pt x="977345" y="175597"/>
                  <a:pt x="974564" y="174052"/>
                </a:cubicBezTo>
                <a:cubicBezTo>
                  <a:pt x="961785" y="166953"/>
                  <a:pt x="948138" y="157415"/>
                  <a:pt x="941368" y="143874"/>
                </a:cubicBezTo>
                <a:cubicBezTo>
                  <a:pt x="937761" y="136660"/>
                  <a:pt x="934926" y="127565"/>
                  <a:pt x="932315" y="119731"/>
                </a:cubicBezTo>
                <a:cubicBezTo>
                  <a:pt x="931309" y="112690"/>
                  <a:pt x="930569" y="105605"/>
                  <a:pt x="929297" y="98607"/>
                </a:cubicBezTo>
                <a:cubicBezTo>
                  <a:pt x="928555" y="94526"/>
                  <a:pt x="926082" y="90678"/>
                  <a:pt x="926279" y="86535"/>
                </a:cubicBezTo>
                <a:cubicBezTo>
                  <a:pt x="927098" y="69336"/>
                  <a:pt x="930303" y="52333"/>
                  <a:pt x="932315" y="35232"/>
                </a:cubicBezTo>
                <a:cubicBezTo>
                  <a:pt x="941368" y="36238"/>
                  <a:pt x="950371" y="37947"/>
                  <a:pt x="959475" y="38250"/>
                </a:cubicBezTo>
                <a:cubicBezTo>
                  <a:pt x="1120091" y="43604"/>
                  <a:pt x="1082430" y="0"/>
                  <a:pt x="1122438" y="53339"/>
                </a:cubicBezTo>
                <a:cubicBezTo>
                  <a:pt x="1123444" y="56357"/>
                  <a:pt x="1124581" y="59334"/>
                  <a:pt x="1125455" y="62393"/>
                </a:cubicBezTo>
                <a:cubicBezTo>
                  <a:pt x="1126594" y="66381"/>
                  <a:pt x="1126839" y="70652"/>
                  <a:pt x="1128473" y="74464"/>
                </a:cubicBezTo>
                <a:cubicBezTo>
                  <a:pt x="1129902" y="77798"/>
                  <a:pt x="1132887" y="80274"/>
                  <a:pt x="1134509" y="83518"/>
                </a:cubicBezTo>
                <a:cubicBezTo>
                  <a:pt x="1135932" y="86363"/>
                  <a:pt x="1136105" y="89726"/>
                  <a:pt x="1137527" y="92571"/>
                </a:cubicBezTo>
                <a:cubicBezTo>
                  <a:pt x="1143149" y="103816"/>
                  <a:pt x="1144268" y="100661"/>
                  <a:pt x="1152616" y="110678"/>
                </a:cubicBezTo>
                <a:cubicBezTo>
                  <a:pt x="1165192" y="125768"/>
                  <a:pt x="1151104" y="114700"/>
                  <a:pt x="1167705" y="125767"/>
                </a:cubicBezTo>
                <a:cubicBezTo>
                  <a:pt x="1188577" y="157080"/>
                  <a:pt x="1155187" y="110232"/>
                  <a:pt x="1185812" y="140856"/>
                </a:cubicBezTo>
                <a:cubicBezTo>
                  <a:pt x="1190941" y="145985"/>
                  <a:pt x="1197883" y="158963"/>
                  <a:pt x="1197883" y="158963"/>
                </a:cubicBezTo>
                <a:cubicBezTo>
                  <a:pt x="1205471" y="181728"/>
                  <a:pt x="1195233" y="153661"/>
                  <a:pt x="1206937" y="177070"/>
                </a:cubicBezTo>
                <a:cubicBezTo>
                  <a:pt x="1208360" y="179915"/>
                  <a:pt x="1208701" y="183200"/>
                  <a:pt x="1209954" y="186124"/>
                </a:cubicBezTo>
                <a:cubicBezTo>
                  <a:pt x="1211726" y="190259"/>
                  <a:pt x="1214410" y="193983"/>
                  <a:pt x="1215990" y="198195"/>
                </a:cubicBezTo>
                <a:cubicBezTo>
                  <a:pt x="1217446" y="202078"/>
                  <a:pt x="1217374" y="206454"/>
                  <a:pt x="1219008" y="210266"/>
                </a:cubicBezTo>
                <a:cubicBezTo>
                  <a:pt x="1220437" y="213600"/>
                  <a:pt x="1223031" y="216302"/>
                  <a:pt x="1225043" y="219320"/>
                </a:cubicBezTo>
                <a:lnTo>
                  <a:pt x="1231079" y="249498"/>
                </a:lnTo>
                <a:cubicBezTo>
                  <a:pt x="1236390" y="276054"/>
                  <a:pt x="1231241" y="259039"/>
                  <a:pt x="1237115" y="276658"/>
                </a:cubicBezTo>
                <a:cubicBezTo>
                  <a:pt x="1236006" y="304375"/>
                  <a:pt x="1237711" y="340368"/>
                  <a:pt x="1231079" y="370211"/>
                </a:cubicBezTo>
                <a:cubicBezTo>
                  <a:pt x="1228902" y="380007"/>
                  <a:pt x="1226282" y="381403"/>
                  <a:pt x="1222026" y="391335"/>
                </a:cubicBezTo>
                <a:cubicBezTo>
                  <a:pt x="1214531" y="408824"/>
                  <a:pt x="1224569" y="392048"/>
                  <a:pt x="1212972" y="409442"/>
                </a:cubicBezTo>
                <a:lnTo>
                  <a:pt x="1206937" y="427549"/>
                </a:lnTo>
                <a:cubicBezTo>
                  <a:pt x="1205931" y="430567"/>
                  <a:pt x="1205684" y="433956"/>
                  <a:pt x="1203919" y="436603"/>
                </a:cubicBezTo>
                <a:cubicBezTo>
                  <a:pt x="1201907" y="439621"/>
                  <a:pt x="1200205" y="442870"/>
                  <a:pt x="1197883" y="445656"/>
                </a:cubicBezTo>
                <a:cubicBezTo>
                  <a:pt x="1193015" y="451498"/>
                  <a:pt x="1183121" y="460127"/>
                  <a:pt x="1176758" y="463763"/>
                </a:cubicBezTo>
                <a:cubicBezTo>
                  <a:pt x="1173996" y="465341"/>
                  <a:pt x="1170550" y="465358"/>
                  <a:pt x="1167705" y="466781"/>
                </a:cubicBezTo>
                <a:cubicBezTo>
                  <a:pt x="1164461" y="468403"/>
                  <a:pt x="1161895" y="471195"/>
                  <a:pt x="1158651" y="472817"/>
                </a:cubicBezTo>
                <a:cubicBezTo>
                  <a:pt x="1155806" y="474239"/>
                  <a:pt x="1152522" y="474581"/>
                  <a:pt x="1149598" y="475834"/>
                </a:cubicBezTo>
                <a:cubicBezTo>
                  <a:pt x="1145463" y="477606"/>
                  <a:pt x="1141704" y="480199"/>
                  <a:pt x="1137527" y="481870"/>
                </a:cubicBezTo>
                <a:cubicBezTo>
                  <a:pt x="1131620" y="484233"/>
                  <a:pt x="1119420" y="487906"/>
                  <a:pt x="1119420" y="487906"/>
                </a:cubicBezTo>
                <a:cubicBezTo>
                  <a:pt x="1095879" y="511444"/>
                  <a:pt x="1126100" y="483134"/>
                  <a:pt x="1098295" y="502995"/>
                </a:cubicBezTo>
                <a:cubicBezTo>
                  <a:pt x="1094822" y="505476"/>
                  <a:pt x="1092792" y="509681"/>
                  <a:pt x="1089241" y="512048"/>
                </a:cubicBezTo>
                <a:cubicBezTo>
                  <a:pt x="1086594" y="513812"/>
                  <a:pt x="1083033" y="513643"/>
                  <a:pt x="1080188" y="515066"/>
                </a:cubicBezTo>
                <a:cubicBezTo>
                  <a:pt x="1068953" y="520684"/>
                  <a:pt x="1072089" y="521815"/>
                  <a:pt x="1062081" y="530155"/>
                </a:cubicBezTo>
                <a:cubicBezTo>
                  <a:pt x="1059295" y="532477"/>
                  <a:pt x="1055593" y="533626"/>
                  <a:pt x="1053028" y="536191"/>
                </a:cubicBezTo>
                <a:cubicBezTo>
                  <a:pt x="1049471" y="539748"/>
                  <a:pt x="1046858" y="544142"/>
                  <a:pt x="1043974" y="548262"/>
                </a:cubicBezTo>
                <a:cubicBezTo>
                  <a:pt x="1039814" y="554205"/>
                  <a:pt x="1037032" y="561240"/>
                  <a:pt x="1031903" y="566369"/>
                </a:cubicBezTo>
                <a:cubicBezTo>
                  <a:pt x="1025867" y="572405"/>
                  <a:pt x="1021894" y="581777"/>
                  <a:pt x="1013796" y="584476"/>
                </a:cubicBezTo>
                <a:cubicBezTo>
                  <a:pt x="1000807" y="588806"/>
                  <a:pt x="1007828" y="586722"/>
                  <a:pt x="992671" y="590512"/>
                </a:cubicBezTo>
                <a:cubicBezTo>
                  <a:pt x="972675" y="603842"/>
                  <a:pt x="995669" y="590516"/>
                  <a:pt x="956457" y="599565"/>
                </a:cubicBezTo>
                <a:cubicBezTo>
                  <a:pt x="952074" y="600577"/>
                  <a:pt x="948598" y="604021"/>
                  <a:pt x="944386" y="605601"/>
                </a:cubicBezTo>
                <a:cubicBezTo>
                  <a:pt x="940503" y="607057"/>
                  <a:pt x="936198" y="607163"/>
                  <a:pt x="932315" y="608619"/>
                </a:cubicBezTo>
                <a:cubicBezTo>
                  <a:pt x="928103" y="610199"/>
                  <a:pt x="924673" y="613872"/>
                  <a:pt x="920243" y="614654"/>
                </a:cubicBezTo>
                <a:cubicBezTo>
                  <a:pt x="907327" y="616933"/>
                  <a:pt x="894089" y="616666"/>
                  <a:pt x="881012" y="617672"/>
                </a:cubicBezTo>
                <a:cubicBezTo>
                  <a:pt x="843795" y="630078"/>
                  <a:pt x="869259" y="624026"/>
                  <a:pt x="802548" y="620690"/>
                </a:cubicBezTo>
                <a:cubicBezTo>
                  <a:pt x="799530" y="619684"/>
                  <a:pt x="796419" y="618925"/>
                  <a:pt x="793495" y="617672"/>
                </a:cubicBezTo>
                <a:cubicBezTo>
                  <a:pt x="789360" y="615900"/>
                  <a:pt x="785900" y="612084"/>
                  <a:pt x="781424" y="611636"/>
                </a:cubicBezTo>
                <a:cubicBezTo>
                  <a:pt x="775335" y="611027"/>
                  <a:pt x="769353" y="613648"/>
                  <a:pt x="763317" y="614654"/>
                </a:cubicBezTo>
                <a:cubicBezTo>
                  <a:pt x="761305" y="617672"/>
                  <a:pt x="760067" y="621386"/>
                  <a:pt x="757281" y="623708"/>
                </a:cubicBezTo>
                <a:cubicBezTo>
                  <a:pt x="749945" y="629821"/>
                  <a:pt x="741788" y="630290"/>
                  <a:pt x="733139" y="632761"/>
                </a:cubicBezTo>
                <a:cubicBezTo>
                  <a:pt x="730080" y="633635"/>
                  <a:pt x="727103" y="634773"/>
                  <a:pt x="724085" y="635779"/>
                </a:cubicBezTo>
                <a:cubicBezTo>
                  <a:pt x="721067" y="637791"/>
                  <a:pt x="717818" y="639493"/>
                  <a:pt x="715032" y="641815"/>
                </a:cubicBezTo>
                <a:cubicBezTo>
                  <a:pt x="711753" y="644547"/>
                  <a:pt x="709529" y="648501"/>
                  <a:pt x="705978" y="650868"/>
                </a:cubicBezTo>
                <a:cubicBezTo>
                  <a:pt x="703331" y="652632"/>
                  <a:pt x="699943" y="652880"/>
                  <a:pt x="696925" y="653886"/>
                </a:cubicBezTo>
                <a:cubicBezTo>
                  <a:pt x="692901" y="656904"/>
                  <a:pt x="689352" y="660690"/>
                  <a:pt x="684853" y="662939"/>
                </a:cubicBezTo>
                <a:cubicBezTo>
                  <a:pt x="681143" y="664794"/>
                  <a:pt x="676831" y="665057"/>
                  <a:pt x="672782" y="665957"/>
                </a:cubicBezTo>
                <a:cubicBezTo>
                  <a:pt x="649107" y="671219"/>
                  <a:pt x="651876" y="669423"/>
                  <a:pt x="618461" y="671993"/>
                </a:cubicBezTo>
                <a:cubicBezTo>
                  <a:pt x="577262" y="685724"/>
                  <a:pt x="619355" y="670746"/>
                  <a:pt x="588283" y="684064"/>
                </a:cubicBezTo>
                <a:cubicBezTo>
                  <a:pt x="585359" y="685317"/>
                  <a:pt x="582075" y="685659"/>
                  <a:pt x="579230" y="687082"/>
                </a:cubicBezTo>
                <a:cubicBezTo>
                  <a:pt x="561720" y="695837"/>
                  <a:pt x="579265" y="691218"/>
                  <a:pt x="558105" y="699153"/>
                </a:cubicBezTo>
                <a:cubicBezTo>
                  <a:pt x="554222" y="700609"/>
                  <a:pt x="549917" y="700715"/>
                  <a:pt x="546034" y="702171"/>
                </a:cubicBezTo>
                <a:cubicBezTo>
                  <a:pt x="541822" y="703751"/>
                  <a:pt x="538374" y="707325"/>
                  <a:pt x="533962" y="708207"/>
                </a:cubicBezTo>
                <a:cubicBezTo>
                  <a:pt x="518057" y="711388"/>
                  <a:pt x="485677" y="714242"/>
                  <a:pt x="485677" y="714242"/>
                </a:cubicBezTo>
                <a:cubicBezTo>
                  <a:pt x="481021" y="715406"/>
                  <a:pt x="462348" y="720278"/>
                  <a:pt x="458517" y="720278"/>
                </a:cubicBezTo>
                <a:cubicBezTo>
                  <a:pt x="439378" y="720278"/>
                  <a:pt x="420291" y="718266"/>
                  <a:pt x="401178" y="717260"/>
                </a:cubicBezTo>
                <a:cubicBezTo>
                  <a:pt x="347821" y="708367"/>
                  <a:pt x="414378" y="719660"/>
                  <a:pt x="367982" y="711225"/>
                </a:cubicBezTo>
                <a:cubicBezTo>
                  <a:pt x="361962" y="710131"/>
                  <a:pt x="355895" y="709302"/>
                  <a:pt x="349875" y="708207"/>
                </a:cubicBezTo>
                <a:cubicBezTo>
                  <a:pt x="344828" y="707289"/>
                  <a:pt x="339870" y="705867"/>
                  <a:pt x="334786" y="705189"/>
                </a:cubicBezTo>
                <a:cubicBezTo>
                  <a:pt x="324765" y="703853"/>
                  <a:pt x="314667" y="703177"/>
                  <a:pt x="304608" y="702171"/>
                </a:cubicBezTo>
                <a:cubicBezTo>
                  <a:pt x="265131" y="692301"/>
                  <a:pt x="309390" y="702171"/>
                  <a:pt x="214073" y="702171"/>
                </a:cubicBezTo>
                <a:cubicBezTo>
                  <a:pt x="199954" y="702171"/>
                  <a:pt x="185907" y="700159"/>
                  <a:pt x="171824" y="699153"/>
                </a:cubicBezTo>
                <a:cubicBezTo>
                  <a:pt x="168806" y="697141"/>
                  <a:pt x="165036" y="695950"/>
                  <a:pt x="162770" y="693118"/>
                </a:cubicBezTo>
                <a:cubicBezTo>
                  <a:pt x="160783" y="690634"/>
                  <a:pt x="161175" y="686909"/>
                  <a:pt x="159752" y="684064"/>
                </a:cubicBezTo>
                <a:cubicBezTo>
                  <a:pt x="145404" y="655367"/>
                  <a:pt x="163256" y="703625"/>
                  <a:pt x="147681" y="656904"/>
                </a:cubicBezTo>
                <a:cubicBezTo>
                  <a:pt x="145945" y="651697"/>
                  <a:pt x="132123" y="641978"/>
                  <a:pt x="126556" y="638797"/>
                </a:cubicBezTo>
                <a:cubicBezTo>
                  <a:pt x="122650" y="636565"/>
                  <a:pt x="117967" y="635610"/>
                  <a:pt x="114485" y="632761"/>
                </a:cubicBezTo>
                <a:cubicBezTo>
                  <a:pt x="110427" y="629441"/>
                  <a:pt x="91734" y="612504"/>
                  <a:pt x="87325" y="602583"/>
                </a:cubicBezTo>
                <a:cubicBezTo>
                  <a:pt x="75509" y="575997"/>
                  <a:pt x="88759" y="591946"/>
                  <a:pt x="72236" y="575423"/>
                </a:cubicBezTo>
                <a:cubicBezTo>
                  <a:pt x="71230" y="572405"/>
                  <a:pt x="70983" y="569016"/>
                  <a:pt x="69218" y="566369"/>
                </a:cubicBezTo>
                <a:cubicBezTo>
                  <a:pt x="55864" y="546340"/>
                  <a:pt x="64005" y="568016"/>
                  <a:pt x="54129" y="548262"/>
                </a:cubicBezTo>
                <a:cubicBezTo>
                  <a:pt x="52707" y="545417"/>
                  <a:pt x="52534" y="542054"/>
                  <a:pt x="51111" y="539209"/>
                </a:cubicBezTo>
                <a:cubicBezTo>
                  <a:pt x="49489" y="535965"/>
                  <a:pt x="46697" y="533399"/>
                  <a:pt x="45075" y="530155"/>
                </a:cubicBezTo>
                <a:cubicBezTo>
                  <a:pt x="43652" y="527310"/>
                  <a:pt x="43479" y="523947"/>
                  <a:pt x="42057" y="521102"/>
                </a:cubicBezTo>
                <a:cubicBezTo>
                  <a:pt x="40435" y="517858"/>
                  <a:pt x="37644" y="515292"/>
                  <a:pt x="36022" y="512048"/>
                </a:cubicBezTo>
                <a:cubicBezTo>
                  <a:pt x="33599" y="507203"/>
                  <a:pt x="31699" y="502098"/>
                  <a:pt x="29986" y="496959"/>
                </a:cubicBezTo>
                <a:cubicBezTo>
                  <a:pt x="26156" y="485470"/>
                  <a:pt x="28311" y="486009"/>
                  <a:pt x="23950" y="475834"/>
                </a:cubicBezTo>
                <a:cubicBezTo>
                  <a:pt x="22178" y="471699"/>
                  <a:pt x="19586" y="467940"/>
                  <a:pt x="17915" y="463763"/>
                </a:cubicBezTo>
                <a:cubicBezTo>
                  <a:pt x="15552" y="457856"/>
                  <a:pt x="13891" y="451692"/>
                  <a:pt x="11879" y="445656"/>
                </a:cubicBezTo>
                <a:cubicBezTo>
                  <a:pt x="10166" y="440517"/>
                  <a:pt x="7855" y="435597"/>
                  <a:pt x="5843" y="430567"/>
                </a:cubicBezTo>
                <a:cubicBezTo>
                  <a:pt x="0" y="377970"/>
                  <a:pt x="1240" y="401057"/>
                  <a:pt x="5843" y="315890"/>
                </a:cubicBezTo>
                <a:cubicBezTo>
                  <a:pt x="6501" y="303709"/>
                  <a:pt x="8364" y="291393"/>
                  <a:pt x="11879" y="279676"/>
                </a:cubicBezTo>
                <a:cubicBezTo>
                  <a:pt x="13707" y="273582"/>
                  <a:pt x="17915" y="261569"/>
                  <a:pt x="17915" y="261569"/>
                </a:cubicBezTo>
                <a:cubicBezTo>
                  <a:pt x="23145" y="224963"/>
                  <a:pt x="18261" y="253977"/>
                  <a:pt x="23950" y="228373"/>
                </a:cubicBezTo>
                <a:cubicBezTo>
                  <a:pt x="25063" y="223366"/>
                  <a:pt x="25724" y="218260"/>
                  <a:pt x="26968" y="213284"/>
                </a:cubicBezTo>
                <a:cubicBezTo>
                  <a:pt x="30207" y="200327"/>
                  <a:pt x="30262" y="206560"/>
                  <a:pt x="36022" y="192159"/>
                </a:cubicBezTo>
                <a:cubicBezTo>
                  <a:pt x="38385" y="186252"/>
                  <a:pt x="36967" y="177869"/>
                  <a:pt x="42057" y="174052"/>
                </a:cubicBezTo>
                <a:cubicBezTo>
                  <a:pt x="81664" y="144350"/>
                  <a:pt x="33553" y="178442"/>
                  <a:pt x="63182" y="161981"/>
                </a:cubicBezTo>
                <a:cubicBezTo>
                  <a:pt x="69523" y="158458"/>
                  <a:pt x="74252" y="151669"/>
                  <a:pt x="81289" y="149910"/>
                </a:cubicBezTo>
                <a:cubicBezTo>
                  <a:pt x="96446" y="146120"/>
                  <a:pt x="89425" y="148204"/>
                  <a:pt x="102414" y="143874"/>
                </a:cubicBezTo>
                <a:cubicBezTo>
                  <a:pt x="120541" y="131788"/>
                  <a:pt x="102667" y="140856"/>
                  <a:pt x="135610" y="140856"/>
                </a:cubicBezTo>
                <a:cubicBezTo>
                  <a:pt x="142723" y="140856"/>
                  <a:pt x="149693" y="138844"/>
                  <a:pt x="156735" y="137838"/>
                </a:cubicBezTo>
                <a:cubicBezTo>
                  <a:pt x="159753" y="135826"/>
                  <a:pt x="163002" y="134125"/>
                  <a:pt x="165788" y="131803"/>
                </a:cubicBezTo>
                <a:cubicBezTo>
                  <a:pt x="173915" y="125030"/>
                  <a:pt x="174256" y="120998"/>
                  <a:pt x="183895" y="116714"/>
                </a:cubicBezTo>
                <a:cubicBezTo>
                  <a:pt x="189709" y="114130"/>
                  <a:pt x="202002" y="110678"/>
                  <a:pt x="202002" y="110678"/>
                </a:cubicBezTo>
                <a:cubicBezTo>
                  <a:pt x="211351" y="101329"/>
                  <a:pt x="211161" y="104218"/>
                  <a:pt x="214073" y="92571"/>
                </a:cubicBezTo>
                <a:cubicBezTo>
                  <a:pt x="214317" y="91595"/>
                  <a:pt x="232683" y="85530"/>
                  <a:pt x="238216" y="83518"/>
                </a:cubicBezTo>
                <a:close/>
              </a:path>
            </a:pathLst>
          </a:custGeom>
          <a:noFill/>
          <a:ln w="222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22" name="手繪多邊形 121"/>
          <p:cNvSpPr/>
          <p:nvPr/>
        </p:nvSpPr>
        <p:spPr>
          <a:xfrm>
            <a:off x="5040028" y="2582423"/>
            <a:ext cx="1237711" cy="720278"/>
          </a:xfrm>
          <a:custGeom>
            <a:avLst/>
            <a:gdLst>
              <a:gd name="connsiteX0" fmla="*/ 238216 w 1237711"/>
              <a:gd name="connsiteY0" fmla="*/ 83518 h 720278"/>
              <a:gd name="connsiteX1" fmla="*/ 247269 w 1237711"/>
              <a:gd name="connsiteY1" fmla="*/ 80500 h 720278"/>
              <a:gd name="connsiteX2" fmla="*/ 256323 w 1237711"/>
              <a:gd name="connsiteY2" fmla="*/ 83518 h 720278"/>
              <a:gd name="connsiteX3" fmla="*/ 271412 w 1237711"/>
              <a:gd name="connsiteY3" fmla="*/ 86535 h 720278"/>
              <a:gd name="connsiteX4" fmla="*/ 277447 w 1237711"/>
              <a:gd name="connsiteY4" fmla="*/ 98607 h 720278"/>
              <a:gd name="connsiteX5" fmla="*/ 283483 w 1237711"/>
              <a:gd name="connsiteY5" fmla="*/ 140856 h 720278"/>
              <a:gd name="connsiteX6" fmla="*/ 280465 w 1237711"/>
              <a:gd name="connsiteY6" fmla="*/ 216302 h 720278"/>
              <a:gd name="connsiteX7" fmla="*/ 274430 w 1237711"/>
              <a:gd name="connsiteY7" fmla="*/ 285712 h 720278"/>
              <a:gd name="connsiteX8" fmla="*/ 268394 w 1237711"/>
              <a:gd name="connsiteY8" fmla="*/ 303819 h 720278"/>
              <a:gd name="connsiteX9" fmla="*/ 265376 w 1237711"/>
              <a:gd name="connsiteY9" fmla="*/ 318908 h 720278"/>
              <a:gd name="connsiteX10" fmla="*/ 262358 w 1237711"/>
              <a:gd name="connsiteY10" fmla="*/ 327961 h 720278"/>
              <a:gd name="connsiteX11" fmla="*/ 277447 w 1237711"/>
              <a:gd name="connsiteY11" fmla="*/ 385300 h 720278"/>
              <a:gd name="connsiteX12" fmla="*/ 283483 w 1237711"/>
              <a:gd name="connsiteY12" fmla="*/ 403407 h 720278"/>
              <a:gd name="connsiteX13" fmla="*/ 304608 w 1237711"/>
              <a:gd name="connsiteY13" fmla="*/ 412460 h 720278"/>
              <a:gd name="connsiteX14" fmla="*/ 322715 w 1237711"/>
              <a:gd name="connsiteY14" fmla="*/ 415478 h 720278"/>
              <a:gd name="connsiteX15" fmla="*/ 343839 w 1237711"/>
              <a:gd name="connsiteY15" fmla="*/ 415478 h 720278"/>
              <a:gd name="connsiteX16" fmla="*/ 349875 w 1237711"/>
              <a:gd name="connsiteY16" fmla="*/ 406425 h 720278"/>
              <a:gd name="connsiteX17" fmla="*/ 361946 w 1237711"/>
              <a:gd name="connsiteY17" fmla="*/ 388318 h 720278"/>
              <a:gd name="connsiteX18" fmla="*/ 367982 w 1237711"/>
              <a:gd name="connsiteY18" fmla="*/ 379264 h 720278"/>
              <a:gd name="connsiteX19" fmla="*/ 377036 w 1237711"/>
              <a:gd name="connsiteY19" fmla="*/ 361157 h 720278"/>
              <a:gd name="connsiteX20" fmla="*/ 395142 w 1237711"/>
              <a:gd name="connsiteY20" fmla="*/ 346068 h 720278"/>
              <a:gd name="connsiteX21" fmla="*/ 404196 w 1237711"/>
              <a:gd name="connsiteY21" fmla="*/ 337015 h 720278"/>
              <a:gd name="connsiteX22" fmla="*/ 416267 w 1237711"/>
              <a:gd name="connsiteY22" fmla="*/ 318908 h 720278"/>
              <a:gd name="connsiteX23" fmla="*/ 419285 w 1237711"/>
              <a:gd name="connsiteY23" fmla="*/ 306836 h 720278"/>
              <a:gd name="connsiteX24" fmla="*/ 437392 w 1237711"/>
              <a:gd name="connsiteY24" fmla="*/ 297783 h 720278"/>
              <a:gd name="connsiteX25" fmla="*/ 446445 w 1237711"/>
              <a:gd name="connsiteY25" fmla="*/ 291747 h 720278"/>
              <a:gd name="connsiteX26" fmla="*/ 464552 w 1237711"/>
              <a:gd name="connsiteY26" fmla="*/ 297783 h 720278"/>
              <a:gd name="connsiteX27" fmla="*/ 470588 w 1237711"/>
              <a:gd name="connsiteY27" fmla="*/ 330979 h 720278"/>
              <a:gd name="connsiteX28" fmla="*/ 473606 w 1237711"/>
              <a:gd name="connsiteY28" fmla="*/ 349086 h 720278"/>
              <a:gd name="connsiteX29" fmla="*/ 494731 w 1237711"/>
              <a:gd name="connsiteY29" fmla="*/ 364175 h 720278"/>
              <a:gd name="connsiteX30" fmla="*/ 512838 w 1237711"/>
              <a:gd name="connsiteY30" fmla="*/ 370211 h 720278"/>
              <a:gd name="connsiteX31" fmla="*/ 558105 w 1237711"/>
              <a:gd name="connsiteY31" fmla="*/ 367193 h 720278"/>
              <a:gd name="connsiteX32" fmla="*/ 576212 w 1237711"/>
              <a:gd name="connsiteY32" fmla="*/ 355122 h 720278"/>
              <a:gd name="connsiteX33" fmla="*/ 579230 w 1237711"/>
              <a:gd name="connsiteY33" fmla="*/ 324943 h 720278"/>
              <a:gd name="connsiteX34" fmla="*/ 582247 w 1237711"/>
              <a:gd name="connsiteY34" fmla="*/ 315890 h 720278"/>
              <a:gd name="connsiteX35" fmla="*/ 591301 w 1237711"/>
              <a:gd name="connsiteY35" fmla="*/ 306836 h 720278"/>
              <a:gd name="connsiteX36" fmla="*/ 609408 w 1237711"/>
              <a:gd name="connsiteY36" fmla="*/ 288729 h 720278"/>
              <a:gd name="connsiteX37" fmla="*/ 621479 w 1237711"/>
              <a:gd name="connsiteY37" fmla="*/ 285712 h 720278"/>
              <a:gd name="connsiteX38" fmla="*/ 645622 w 1237711"/>
              <a:gd name="connsiteY38" fmla="*/ 273640 h 720278"/>
              <a:gd name="connsiteX39" fmla="*/ 651657 w 1237711"/>
              <a:gd name="connsiteY39" fmla="*/ 264587 h 720278"/>
              <a:gd name="connsiteX40" fmla="*/ 672782 w 1237711"/>
              <a:gd name="connsiteY40" fmla="*/ 276658 h 720278"/>
              <a:gd name="connsiteX41" fmla="*/ 681836 w 1237711"/>
              <a:gd name="connsiteY41" fmla="*/ 285712 h 720278"/>
              <a:gd name="connsiteX42" fmla="*/ 687871 w 1237711"/>
              <a:gd name="connsiteY42" fmla="*/ 297783 h 720278"/>
              <a:gd name="connsiteX43" fmla="*/ 705978 w 1237711"/>
              <a:gd name="connsiteY43" fmla="*/ 312872 h 720278"/>
              <a:gd name="connsiteX44" fmla="*/ 708996 w 1237711"/>
              <a:gd name="connsiteY44" fmla="*/ 324943 h 720278"/>
              <a:gd name="connsiteX45" fmla="*/ 724085 w 1237711"/>
              <a:gd name="connsiteY45" fmla="*/ 349086 h 720278"/>
              <a:gd name="connsiteX46" fmla="*/ 736156 w 1237711"/>
              <a:gd name="connsiteY46" fmla="*/ 367193 h 720278"/>
              <a:gd name="connsiteX47" fmla="*/ 742192 w 1237711"/>
              <a:gd name="connsiteY47" fmla="*/ 376246 h 720278"/>
              <a:gd name="connsiteX48" fmla="*/ 757281 w 1237711"/>
              <a:gd name="connsiteY48" fmla="*/ 388318 h 720278"/>
              <a:gd name="connsiteX49" fmla="*/ 787459 w 1237711"/>
              <a:gd name="connsiteY49" fmla="*/ 409442 h 720278"/>
              <a:gd name="connsiteX50" fmla="*/ 814620 w 1237711"/>
              <a:gd name="connsiteY50" fmla="*/ 406425 h 720278"/>
              <a:gd name="connsiteX51" fmla="*/ 820655 w 1237711"/>
              <a:gd name="connsiteY51" fmla="*/ 397371 h 720278"/>
              <a:gd name="connsiteX52" fmla="*/ 829709 w 1237711"/>
              <a:gd name="connsiteY52" fmla="*/ 388318 h 720278"/>
              <a:gd name="connsiteX53" fmla="*/ 826691 w 1237711"/>
              <a:gd name="connsiteY53" fmla="*/ 306836 h 720278"/>
              <a:gd name="connsiteX54" fmla="*/ 823673 w 1237711"/>
              <a:gd name="connsiteY54" fmla="*/ 294765 h 720278"/>
              <a:gd name="connsiteX55" fmla="*/ 817638 w 1237711"/>
              <a:gd name="connsiteY55" fmla="*/ 258551 h 720278"/>
              <a:gd name="connsiteX56" fmla="*/ 808584 w 1237711"/>
              <a:gd name="connsiteY56" fmla="*/ 228373 h 720278"/>
              <a:gd name="connsiteX57" fmla="*/ 820655 w 1237711"/>
              <a:gd name="connsiteY57" fmla="*/ 171034 h 720278"/>
              <a:gd name="connsiteX58" fmla="*/ 829709 w 1237711"/>
              <a:gd name="connsiteY58" fmla="*/ 168017 h 720278"/>
              <a:gd name="connsiteX59" fmla="*/ 844798 w 1237711"/>
              <a:gd name="connsiteY59" fmla="*/ 186124 h 720278"/>
              <a:gd name="connsiteX60" fmla="*/ 862905 w 1237711"/>
              <a:gd name="connsiteY60" fmla="*/ 213284 h 720278"/>
              <a:gd name="connsiteX61" fmla="*/ 874976 w 1237711"/>
              <a:gd name="connsiteY61" fmla="*/ 231391 h 720278"/>
              <a:gd name="connsiteX62" fmla="*/ 881012 w 1237711"/>
              <a:gd name="connsiteY62" fmla="*/ 240444 h 720278"/>
              <a:gd name="connsiteX63" fmla="*/ 890065 w 1237711"/>
              <a:gd name="connsiteY63" fmla="*/ 261569 h 720278"/>
              <a:gd name="connsiteX64" fmla="*/ 893083 w 1237711"/>
              <a:gd name="connsiteY64" fmla="*/ 270623 h 720278"/>
              <a:gd name="connsiteX65" fmla="*/ 908172 w 1237711"/>
              <a:gd name="connsiteY65" fmla="*/ 279676 h 720278"/>
              <a:gd name="connsiteX66" fmla="*/ 920243 w 1237711"/>
              <a:gd name="connsiteY66" fmla="*/ 285712 h 720278"/>
              <a:gd name="connsiteX67" fmla="*/ 938350 w 1237711"/>
              <a:gd name="connsiteY67" fmla="*/ 294765 h 720278"/>
              <a:gd name="connsiteX68" fmla="*/ 998707 w 1237711"/>
              <a:gd name="connsiteY68" fmla="*/ 288729 h 720278"/>
              <a:gd name="connsiteX69" fmla="*/ 1004742 w 1237711"/>
              <a:gd name="connsiteY69" fmla="*/ 276658 h 720278"/>
              <a:gd name="connsiteX70" fmla="*/ 1010778 w 1237711"/>
              <a:gd name="connsiteY70" fmla="*/ 258551 h 720278"/>
              <a:gd name="connsiteX71" fmla="*/ 1013796 w 1237711"/>
              <a:gd name="connsiteY71" fmla="*/ 249498 h 720278"/>
              <a:gd name="connsiteX72" fmla="*/ 1010778 w 1237711"/>
              <a:gd name="connsiteY72" fmla="*/ 201213 h 720278"/>
              <a:gd name="connsiteX73" fmla="*/ 983618 w 1237711"/>
              <a:gd name="connsiteY73" fmla="*/ 177070 h 720278"/>
              <a:gd name="connsiteX74" fmla="*/ 974564 w 1237711"/>
              <a:gd name="connsiteY74" fmla="*/ 174052 h 720278"/>
              <a:gd name="connsiteX75" fmla="*/ 941368 w 1237711"/>
              <a:gd name="connsiteY75" fmla="*/ 143874 h 720278"/>
              <a:gd name="connsiteX76" fmla="*/ 932315 w 1237711"/>
              <a:gd name="connsiteY76" fmla="*/ 119731 h 720278"/>
              <a:gd name="connsiteX77" fmla="*/ 929297 w 1237711"/>
              <a:gd name="connsiteY77" fmla="*/ 98607 h 720278"/>
              <a:gd name="connsiteX78" fmla="*/ 926279 w 1237711"/>
              <a:gd name="connsiteY78" fmla="*/ 86535 h 720278"/>
              <a:gd name="connsiteX79" fmla="*/ 932315 w 1237711"/>
              <a:gd name="connsiteY79" fmla="*/ 35232 h 720278"/>
              <a:gd name="connsiteX80" fmla="*/ 959475 w 1237711"/>
              <a:gd name="connsiteY80" fmla="*/ 38250 h 720278"/>
              <a:gd name="connsiteX81" fmla="*/ 1122438 w 1237711"/>
              <a:gd name="connsiteY81" fmla="*/ 53339 h 720278"/>
              <a:gd name="connsiteX82" fmla="*/ 1125455 w 1237711"/>
              <a:gd name="connsiteY82" fmla="*/ 62393 h 720278"/>
              <a:gd name="connsiteX83" fmla="*/ 1128473 w 1237711"/>
              <a:gd name="connsiteY83" fmla="*/ 74464 h 720278"/>
              <a:gd name="connsiteX84" fmla="*/ 1134509 w 1237711"/>
              <a:gd name="connsiteY84" fmla="*/ 83518 h 720278"/>
              <a:gd name="connsiteX85" fmla="*/ 1137527 w 1237711"/>
              <a:gd name="connsiteY85" fmla="*/ 92571 h 720278"/>
              <a:gd name="connsiteX86" fmla="*/ 1152616 w 1237711"/>
              <a:gd name="connsiteY86" fmla="*/ 110678 h 720278"/>
              <a:gd name="connsiteX87" fmla="*/ 1167705 w 1237711"/>
              <a:gd name="connsiteY87" fmla="*/ 125767 h 720278"/>
              <a:gd name="connsiteX88" fmla="*/ 1185812 w 1237711"/>
              <a:gd name="connsiteY88" fmla="*/ 140856 h 720278"/>
              <a:gd name="connsiteX89" fmla="*/ 1197883 w 1237711"/>
              <a:gd name="connsiteY89" fmla="*/ 158963 h 720278"/>
              <a:gd name="connsiteX90" fmla="*/ 1206937 w 1237711"/>
              <a:gd name="connsiteY90" fmla="*/ 177070 h 720278"/>
              <a:gd name="connsiteX91" fmla="*/ 1209954 w 1237711"/>
              <a:gd name="connsiteY91" fmla="*/ 186124 h 720278"/>
              <a:gd name="connsiteX92" fmla="*/ 1215990 w 1237711"/>
              <a:gd name="connsiteY92" fmla="*/ 198195 h 720278"/>
              <a:gd name="connsiteX93" fmla="*/ 1219008 w 1237711"/>
              <a:gd name="connsiteY93" fmla="*/ 210266 h 720278"/>
              <a:gd name="connsiteX94" fmla="*/ 1225043 w 1237711"/>
              <a:gd name="connsiteY94" fmla="*/ 219320 h 720278"/>
              <a:gd name="connsiteX95" fmla="*/ 1231079 w 1237711"/>
              <a:gd name="connsiteY95" fmla="*/ 249498 h 720278"/>
              <a:gd name="connsiteX96" fmla="*/ 1237115 w 1237711"/>
              <a:gd name="connsiteY96" fmla="*/ 276658 h 720278"/>
              <a:gd name="connsiteX97" fmla="*/ 1231079 w 1237711"/>
              <a:gd name="connsiteY97" fmla="*/ 370211 h 720278"/>
              <a:gd name="connsiteX98" fmla="*/ 1222026 w 1237711"/>
              <a:gd name="connsiteY98" fmla="*/ 391335 h 720278"/>
              <a:gd name="connsiteX99" fmla="*/ 1212972 w 1237711"/>
              <a:gd name="connsiteY99" fmla="*/ 409442 h 720278"/>
              <a:gd name="connsiteX100" fmla="*/ 1206937 w 1237711"/>
              <a:gd name="connsiteY100" fmla="*/ 427549 h 720278"/>
              <a:gd name="connsiteX101" fmla="*/ 1203919 w 1237711"/>
              <a:gd name="connsiteY101" fmla="*/ 436603 h 720278"/>
              <a:gd name="connsiteX102" fmla="*/ 1197883 w 1237711"/>
              <a:gd name="connsiteY102" fmla="*/ 445656 h 720278"/>
              <a:gd name="connsiteX103" fmla="*/ 1176758 w 1237711"/>
              <a:gd name="connsiteY103" fmla="*/ 463763 h 720278"/>
              <a:gd name="connsiteX104" fmla="*/ 1167705 w 1237711"/>
              <a:gd name="connsiteY104" fmla="*/ 466781 h 720278"/>
              <a:gd name="connsiteX105" fmla="*/ 1158651 w 1237711"/>
              <a:gd name="connsiteY105" fmla="*/ 472817 h 720278"/>
              <a:gd name="connsiteX106" fmla="*/ 1149598 w 1237711"/>
              <a:gd name="connsiteY106" fmla="*/ 475834 h 720278"/>
              <a:gd name="connsiteX107" fmla="*/ 1137527 w 1237711"/>
              <a:gd name="connsiteY107" fmla="*/ 481870 h 720278"/>
              <a:gd name="connsiteX108" fmla="*/ 1119420 w 1237711"/>
              <a:gd name="connsiteY108" fmla="*/ 487906 h 720278"/>
              <a:gd name="connsiteX109" fmla="*/ 1098295 w 1237711"/>
              <a:gd name="connsiteY109" fmla="*/ 502995 h 720278"/>
              <a:gd name="connsiteX110" fmla="*/ 1089241 w 1237711"/>
              <a:gd name="connsiteY110" fmla="*/ 512048 h 720278"/>
              <a:gd name="connsiteX111" fmla="*/ 1080188 w 1237711"/>
              <a:gd name="connsiteY111" fmla="*/ 515066 h 720278"/>
              <a:gd name="connsiteX112" fmla="*/ 1062081 w 1237711"/>
              <a:gd name="connsiteY112" fmla="*/ 530155 h 720278"/>
              <a:gd name="connsiteX113" fmla="*/ 1053028 w 1237711"/>
              <a:gd name="connsiteY113" fmla="*/ 536191 h 720278"/>
              <a:gd name="connsiteX114" fmla="*/ 1043974 w 1237711"/>
              <a:gd name="connsiteY114" fmla="*/ 548262 h 720278"/>
              <a:gd name="connsiteX115" fmla="*/ 1031903 w 1237711"/>
              <a:gd name="connsiteY115" fmla="*/ 566369 h 720278"/>
              <a:gd name="connsiteX116" fmla="*/ 1013796 w 1237711"/>
              <a:gd name="connsiteY116" fmla="*/ 584476 h 720278"/>
              <a:gd name="connsiteX117" fmla="*/ 992671 w 1237711"/>
              <a:gd name="connsiteY117" fmla="*/ 590512 h 720278"/>
              <a:gd name="connsiteX118" fmla="*/ 956457 w 1237711"/>
              <a:gd name="connsiteY118" fmla="*/ 599565 h 720278"/>
              <a:gd name="connsiteX119" fmla="*/ 944386 w 1237711"/>
              <a:gd name="connsiteY119" fmla="*/ 605601 h 720278"/>
              <a:gd name="connsiteX120" fmla="*/ 932315 w 1237711"/>
              <a:gd name="connsiteY120" fmla="*/ 608619 h 720278"/>
              <a:gd name="connsiteX121" fmla="*/ 920243 w 1237711"/>
              <a:gd name="connsiteY121" fmla="*/ 614654 h 720278"/>
              <a:gd name="connsiteX122" fmla="*/ 881012 w 1237711"/>
              <a:gd name="connsiteY122" fmla="*/ 617672 h 720278"/>
              <a:gd name="connsiteX123" fmla="*/ 802548 w 1237711"/>
              <a:gd name="connsiteY123" fmla="*/ 620690 h 720278"/>
              <a:gd name="connsiteX124" fmla="*/ 793495 w 1237711"/>
              <a:gd name="connsiteY124" fmla="*/ 617672 h 720278"/>
              <a:gd name="connsiteX125" fmla="*/ 781424 w 1237711"/>
              <a:gd name="connsiteY125" fmla="*/ 611636 h 720278"/>
              <a:gd name="connsiteX126" fmla="*/ 763317 w 1237711"/>
              <a:gd name="connsiteY126" fmla="*/ 614654 h 720278"/>
              <a:gd name="connsiteX127" fmla="*/ 757281 w 1237711"/>
              <a:gd name="connsiteY127" fmla="*/ 623708 h 720278"/>
              <a:gd name="connsiteX128" fmla="*/ 733139 w 1237711"/>
              <a:gd name="connsiteY128" fmla="*/ 632761 h 720278"/>
              <a:gd name="connsiteX129" fmla="*/ 724085 w 1237711"/>
              <a:gd name="connsiteY129" fmla="*/ 635779 h 720278"/>
              <a:gd name="connsiteX130" fmla="*/ 715032 w 1237711"/>
              <a:gd name="connsiteY130" fmla="*/ 641815 h 720278"/>
              <a:gd name="connsiteX131" fmla="*/ 705978 w 1237711"/>
              <a:gd name="connsiteY131" fmla="*/ 650868 h 720278"/>
              <a:gd name="connsiteX132" fmla="*/ 696925 w 1237711"/>
              <a:gd name="connsiteY132" fmla="*/ 653886 h 720278"/>
              <a:gd name="connsiteX133" fmla="*/ 684853 w 1237711"/>
              <a:gd name="connsiteY133" fmla="*/ 662939 h 720278"/>
              <a:gd name="connsiteX134" fmla="*/ 672782 w 1237711"/>
              <a:gd name="connsiteY134" fmla="*/ 665957 h 720278"/>
              <a:gd name="connsiteX135" fmla="*/ 618461 w 1237711"/>
              <a:gd name="connsiteY135" fmla="*/ 671993 h 720278"/>
              <a:gd name="connsiteX136" fmla="*/ 588283 w 1237711"/>
              <a:gd name="connsiteY136" fmla="*/ 684064 h 720278"/>
              <a:gd name="connsiteX137" fmla="*/ 579230 w 1237711"/>
              <a:gd name="connsiteY137" fmla="*/ 687082 h 720278"/>
              <a:gd name="connsiteX138" fmla="*/ 558105 w 1237711"/>
              <a:gd name="connsiteY138" fmla="*/ 699153 h 720278"/>
              <a:gd name="connsiteX139" fmla="*/ 546034 w 1237711"/>
              <a:gd name="connsiteY139" fmla="*/ 702171 h 720278"/>
              <a:gd name="connsiteX140" fmla="*/ 533962 w 1237711"/>
              <a:gd name="connsiteY140" fmla="*/ 708207 h 720278"/>
              <a:gd name="connsiteX141" fmla="*/ 485677 w 1237711"/>
              <a:gd name="connsiteY141" fmla="*/ 714242 h 720278"/>
              <a:gd name="connsiteX142" fmla="*/ 458517 w 1237711"/>
              <a:gd name="connsiteY142" fmla="*/ 720278 h 720278"/>
              <a:gd name="connsiteX143" fmla="*/ 401178 w 1237711"/>
              <a:gd name="connsiteY143" fmla="*/ 717260 h 720278"/>
              <a:gd name="connsiteX144" fmla="*/ 367982 w 1237711"/>
              <a:gd name="connsiteY144" fmla="*/ 711225 h 720278"/>
              <a:gd name="connsiteX145" fmla="*/ 349875 w 1237711"/>
              <a:gd name="connsiteY145" fmla="*/ 708207 h 720278"/>
              <a:gd name="connsiteX146" fmla="*/ 334786 w 1237711"/>
              <a:gd name="connsiteY146" fmla="*/ 705189 h 720278"/>
              <a:gd name="connsiteX147" fmla="*/ 304608 w 1237711"/>
              <a:gd name="connsiteY147" fmla="*/ 702171 h 720278"/>
              <a:gd name="connsiteX148" fmla="*/ 214073 w 1237711"/>
              <a:gd name="connsiteY148" fmla="*/ 702171 h 720278"/>
              <a:gd name="connsiteX149" fmla="*/ 171824 w 1237711"/>
              <a:gd name="connsiteY149" fmla="*/ 699153 h 720278"/>
              <a:gd name="connsiteX150" fmla="*/ 162770 w 1237711"/>
              <a:gd name="connsiteY150" fmla="*/ 693118 h 720278"/>
              <a:gd name="connsiteX151" fmla="*/ 159752 w 1237711"/>
              <a:gd name="connsiteY151" fmla="*/ 684064 h 720278"/>
              <a:gd name="connsiteX152" fmla="*/ 147681 w 1237711"/>
              <a:gd name="connsiteY152" fmla="*/ 656904 h 720278"/>
              <a:gd name="connsiteX153" fmla="*/ 126556 w 1237711"/>
              <a:gd name="connsiteY153" fmla="*/ 638797 h 720278"/>
              <a:gd name="connsiteX154" fmla="*/ 114485 w 1237711"/>
              <a:gd name="connsiteY154" fmla="*/ 632761 h 720278"/>
              <a:gd name="connsiteX155" fmla="*/ 87325 w 1237711"/>
              <a:gd name="connsiteY155" fmla="*/ 602583 h 720278"/>
              <a:gd name="connsiteX156" fmla="*/ 72236 w 1237711"/>
              <a:gd name="connsiteY156" fmla="*/ 575423 h 720278"/>
              <a:gd name="connsiteX157" fmla="*/ 69218 w 1237711"/>
              <a:gd name="connsiteY157" fmla="*/ 566369 h 720278"/>
              <a:gd name="connsiteX158" fmla="*/ 54129 w 1237711"/>
              <a:gd name="connsiteY158" fmla="*/ 548262 h 720278"/>
              <a:gd name="connsiteX159" fmla="*/ 51111 w 1237711"/>
              <a:gd name="connsiteY159" fmla="*/ 539209 h 720278"/>
              <a:gd name="connsiteX160" fmla="*/ 45075 w 1237711"/>
              <a:gd name="connsiteY160" fmla="*/ 530155 h 720278"/>
              <a:gd name="connsiteX161" fmla="*/ 42057 w 1237711"/>
              <a:gd name="connsiteY161" fmla="*/ 521102 h 720278"/>
              <a:gd name="connsiteX162" fmla="*/ 36022 w 1237711"/>
              <a:gd name="connsiteY162" fmla="*/ 512048 h 720278"/>
              <a:gd name="connsiteX163" fmla="*/ 29986 w 1237711"/>
              <a:gd name="connsiteY163" fmla="*/ 496959 h 720278"/>
              <a:gd name="connsiteX164" fmla="*/ 23950 w 1237711"/>
              <a:gd name="connsiteY164" fmla="*/ 475834 h 720278"/>
              <a:gd name="connsiteX165" fmla="*/ 17915 w 1237711"/>
              <a:gd name="connsiteY165" fmla="*/ 463763 h 720278"/>
              <a:gd name="connsiteX166" fmla="*/ 11879 w 1237711"/>
              <a:gd name="connsiteY166" fmla="*/ 445656 h 720278"/>
              <a:gd name="connsiteX167" fmla="*/ 5843 w 1237711"/>
              <a:gd name="connsiteY167" fmla="*/ 430567 h 720278"/>
              <a:gd name="connsiteX168" fmla="*/ 5843 w 1237711"/>
              <a:gd name="connsiteY168" fmla="*/ 315890 h 720278"/>
              <a:gd name="connsiteX169" fmla="*/ 11879 w 1237711"/>
              <a:gd name="connsiteY169" fmla="*/ 279676 h 720278"/>
              <a:gd name="connsiteX170" fmla="*/ 17915 w 1237711"/>
              <a:gd name="connsiteY170" fmla="*/ 261569 h 720278"/>
              <a:gd name="connsiteX171" fmla="*/ 23950 w 1237711"/>
              <a:gd name="connsiteY171" fmla="*/ 228373 h 720278"/>
              <a:gd name="connsiteX172" fmla="*/ 26968 w 1237711"/>
              <a:gd name="connsiteY172" fmla="*/ 213284 h 720278"/>
              <a:gd name="connsiteX173" fmla="*/ 36022 w 1237711"/>
              <a:gd name="connsiteY173" fmla="*/ 192159 h 720278"/>
              <a:gd name="connsiteX174" fmla="*/ 42057 w 1237711"/>
              <a:gd name="connsiteY174" fmla="*/ 174052 h 720278"/>
              <a:gd name="connsiteX175" fmla="*/ 63182 w 1237711"/>
              <a:gd name="connsiteY175" fmla="*/ 161981 h 720278"/>
              <a:gd name="connsiteX176" fmla="*/ 81289 w 1237711"/>
              <a:gd name="connsiteY176" fmla="*/ 149910 h 720278"/>
              <a:gd name="connsiteX177" fmla="*/ 102414 w 1237711"/>
              <a:gd name="connsiteY177" fmla="*/ 143874 h 720278"/>
              <a:gd name="connsiteX178" fmla="*/ 135610 w 1237711"/>
              <a:gd name="connsiteY178" fmla="*/ 140856 h 720278"/>
              <a:gd name="connsiteX179" fmla="*/ 156735 w 1237711"/>
              <a:gd name="connsiteY179" fmla="*/ 137838 h 720278"/>
              <a:gd name="connsiteX180" fmla="*/ 165788 w 1237711"/>
              <a:gd name="connsiteY180" fmla="*/ 131803 h 720278"/>
              <a:gd name="connsiteX181" fmla="*/ 183895 w 1237711"/>
              <a:gd name="connsiteY181" fmla="*/ 116714 h 720278"/>
              <a:gd name="connsiteX182" fmla="*/ 202002 w 1237711"/>
              <a:gd name="connsiteY182" fmla="*/ 110678 h 720278"/>
              <a:gd name="connsiteX183" fmla="*/ 214073 w 1237711"/>
              <a:gd name="connsiteY183" fmla="*/ 92571 h 720278"/>
              <a:gd name="connsiteX184" fmla="*/ 238216 w 1237711"/>
              <a:gd name="connsiteY184" fmla="*/ 83518 h 72027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  <a:cxn ang="0">
                <a:pos x="connsiteX165" y="connsiteY165"/>
              </a:cxn>
              <a:cxn ang="0">
                <a:pos x="connsiteX166" y="connsiteY166"/>
              </a:cxn>
              <a:cxn ang="0">
                <a:pos x="connsiteX167" y="connsiteY167"/>
              </a:cxn>
              <a:cxn ang="0">
                <a:pos x="connsiteX168" y="connsiteY168"/>
              </a:cxn>
              <a:cxn ang="0">
                <a:pos x="connsiteX169" y="connsiteY169"/>
              </a:cxn>
              <a:cxn ang="0">
                <a:pos x="connsiteX170" y="connsiteY170"/>
              </a:cxn>
              <a:cxn ang="0">
                <a:pos x="connsiteX171" y="connsiteY171"/>
              </a:cxn>
              <a:cxn ang="0">
                <a:pos x="connsiteX172" y="connsiteY172"/>
              </a:cxn>
              <a:cxn ang="0">
                <a:pos x="connsiteX173" y="connsiteY173"/>
              </a:cxn>
              <a:cxn ang="0">
                <a:pos x="connsiteX174" y="connsiteY174"/>
              </a:cxn>
              <a:cxn ang="0">
                <a:pos x="connsiteX175" y="connsiteY175"/>
              </a:cxn>
              <a:cxn ang="0">
                <a:pos x="connsiteX176" y="connsiteY176"/>
              </a:cxn>
              <a:cxn ang="0">
                <a:pos x="connsiteX177" y="connsiteY177"/>
              </a:cxn>
              <a:cxn ang="0">
                <a:pos x="connsiteX178" y="connsiteY178"/>
              </a:cxn>
              <a:cxn ang="0">
                <a:pos x="connsiteX179" y="connsiteY179"/>
              </a:cxn>
              <a:cxn ang="0">
                <a:pos x="connsiteX180" y="connsiteY180"/>
              </a:cxn>
              <a:cxn ang="0">
                <a:pos x="connsiteX181" y="connsiteY181"/>
              </a:cxn>
              <a:cxn ang="0">
                <a:pos x="connsiteX182" y="connsiteY182"/>
              </a:cxn>
              <a:cxn ang="0">
                <a:pos x="connsiteX183" y="connsiteY183"/>
              </a:cxn>
              <a:cxn ang="0">
                <a:pos x="connsiteX184" y="connsiteY184"/>
              </a:cxn>
            </a:cxnLst>
            <a:rect l="l" t="t" r="r" b="b"/>
            <a:pathLst>
              <a:path w="1237711" h="720278">
                <a:moveTo>
                  <a:pt x="238216" y="83518"/>
                </a:moveTo>
                <a:cubicBezTo>
                  <a:pt x="243749" y="81506"/>
                  <a:pt x="244088" y="80500"/>
                  <a:pt x="247269" y="80500"/>
                </a:cubicBezTo>
                <a:cubicBezTo>
                  <a:pt x="250450" y="80500"/>
                  <a:pt x="253237" y="82747"/>
                  <a:pt x="256323" y="83518"/>
                </a:cubicBezTo>
                <a:cubicBezTo>
                  <a:pt x="261299" y="84762"/>
                  <a:pt x="266382" y="85529"/>
                  <a:pt x="271412" y="86535"/>
                </a:cubicBezTo>
                <a:cubicBezTo>
                  <a:pt x="273424" y="90559"/>
                  <a:pt x="275675" y="94472"/>
                  <a:pt x="277447" y="98607"/>
                </a:cubicBezTo>
                <a:cubicBezTo>
                  <a:pt x="283477" y="112677"/>
                  <a:pt x="281931" y="123785"/>
                  <a:pt x="283483" y="140856"/>
                </a:cubicBezTo>
                <a:cubicBezTo>
                  <a:pt x="282477" y="166005"/>
                  <a:pt x="281722" y="191165"/>
                  <a:pt x="280465" y="216302"/>
                </a:cubicBezTo>
                <a:cubicBezTo>
                  <a:pt x="280052" y="224560"/>
                  <a:pt x="277636" y="270751"/>
                  <a:pt x="274430" y="285712"/>
                </a:cubicBezTo>
                <a:cubicBezTo>
                  <a:pt x="273097" y="291933"/>
                  <a:pt x="270406" y="297783"/>
                  <a:pt x="268394" y="303819"/>
                </a:cubicBezTo>
                <a:cubicBezTo>
                  <a:pt x="266772" y="308685"/>
                  <a:pt x="266620" y="313932"/>
                  <a:pt x="265376" y="318908"/>
                </a:cubicBezTo>
                <a:cubicBezTo>
                  <a:pt x="264604" y="321994"/>
                  <a:pt x="263364" y="324943"/>
                  <a:pt x="262358" y="327961"/>
                </a:cubicBezTo>
                <a:cubicBezTo>
                  <a:pt x="268820" y="399044"/>
                  <a:pt x="258278" y="327795"/>
                  <a:pt x="277447" y="385300"/>
                </a:cubicBezTo>
                <a:cubicBezTo>
                  <a:pt x="279459" y="391336"/>
                  <a:pt x="277792" y="400562"/>
                  <a:pt x="283483" y="403407"/>
                </a:cubicBezTo>
                <a:cubicBezTo>
                  <a:pt x="290864" y="407097"/>
                  <a:pt x="296616" y="410684"/>
                  <a:pt x="304608" y="412460"/>
                </a:cubicBezTo>
                <a:cubicBezTo>
                  <a:pt x="310581" y="413787"/>
                  <a:pt x="316679" y="414472"/>
                  <a:pt x="322715" y="415478"/>
                </a:cubicBezTo>
                <a:cubicBezTo>
                  <a:pt x="330860" y="418193"/>
                  <a:pt x="334997" y="421373"/>
                  <a:pt x="343839" y="415478"/>
                </a:cubicBezTo>
                <a:cubicBezTo>
                  <a:pt x="346857" y="413466"/>
                  <a:pt x="347863" y="409443"/>
                  <a:pt x="349875" y="406425"/>
                </a:cubicBezTo>
                <a:cubicBezTo>
                  <a:pt x="355179" y="390514"/>
                  <a:pt x="349388" y="403388"/>
                  <a:pt x="361946" y="388318"/>
                </a:cubicBezTo>
                <a:cubicBezTo>
                  <a:pt x="364268" y="385532"/>
                  <a:pt x="366360" y="382508"/>
                  <a:pt x="367982" y="379264"/>
                </a:cubicBezTo>
                <a:cubicBezTo>
                  <a:pt x="374788" y="365654"/>
                  <a:pt x="366225" y="374131"/>
                  <a:pt x="377036" y="361157"/>
                </a:cubicBezTo>
                <a:cubicBezTo>
                  <a:pt x="389054" y="346735"/>
                  <a:pt x="382198" y="356855"/>
                  <a:pt x="395142" y="346068"/>
                </a:cubicBezTo>
                <a:cubicBezTo>
                  <a:pt x="398421" y="343336"/>
                  <a:pt x="401576" y="340384"/>
                  <a:pt x="404196" y="337015"/>
                </a:cubicBezTo>
                <a:cubicBezTo>
                  <a:pt x="408650" y="331289"/>
                  <a:pt x="416267" y="318908"/>
                  <a:pt x="416267" y="318908"/>
                </a:cubicBezTo>
                <a:cubicBezTo>
                  <a:pt x="417273" y="314884"/>
                  <a:pt x="416984" y="310287"/>
                  <a:pt x="419285" y="306836"/>
                </a:cubicBezTo>
                <a:cubicBezTo>
                  <a:pt x="423608" y="300351"/>
                  <a:pt x="431368" y="300795"/>
                  <a:pt x="437392" y="297783"/>
                </a:cubicBezTo>
                <a:cubicBezTo>
                  <a:pt x="440636" y="296161"/>
                  <a:pt x="443427" y="293759"/>
                  <a:pt x="446445" y="291747"/>
                </a:cubicBezTo>
                <a:cubicBezTo>
                  <a:pt x="452481" y="293759"/>
                  <a:pt x="463652" y="291485"/>
                  <a:pt x="464552" y="297783"/>
                </a:cubicBezTo>
                <a:cubicBezTo>
                  <a:pt x="472224" y="351485"/>
                  <a:pt x="463473" y="295406"/>
                  <a:pt x="470588" y="330979"/>
                </a:cubicBezTo>
                <a:cubicBezTo>
                  <a:pt x="471788" y="336979"/>
                  <a:pt x="471334" y="343405"/>
                  <a:pt x="473606" y="349086"/>
                </a:cubicBezTo>
                <a:cubicBezTo>
                  <a:pt x="479494" y="363807"/>
                  <a:pt x="482442" y="360488"/>
                  <a:pt x="494731" y="364175"/>
                </a:cubicBezTo>
                <a:cubicBezTo>
                  <a:pt x="500825" y="366003"/>
                  <a:pt x="512838" y="370211"/>
                  <a:pt x="512838" y="370211"/>
                </a:cubicBezTo>
                <a:cubicBezTo>
                  <a:pt x="527927" y="369205"/>
                  <a:pt x="543394" y="370696"/>
                  <a:pt x="558105" y="367193"/>
                </a:cubicBezTo>
                <a:cubicBezTo>
                  <a:pt x="565162" y="365513"/>
                  <a:pt x="576212" y="355122"/>
                  <a:pt x="576212" y="355122"/>
                </a:cubicBezTo>
                <a:cubicBezTo>
                  <a:pt x="577218" y="345062"/>
                  <a:pt x="577693" y="334935"/>
                  <a:pt x="579230" y="324943"/>
                </a:cubicBezTo>
                <a:cubicBezTo>
                  <a:pt x="579714" y="321799"/>
                  <a:pt x="580483" y="318537"/>
                  <a:pt x="582247" y="315890"/>
                </a:cubicBezTo>
                <a:cubicBezTo>
                  <a:pt x="584614" y="312339"/>
                  <a:pt x="588569" y="310115"/>
                  <a:pt x="591301" y="306836"/>
                </a:cubicBezTo>
                <a:cubicBezTo>
                  <a:pt x="600052" y="296336"/>
                  <a:pt x="594540" y="296163"/>
                  <a:pt x="609408" y="288729"/>
                </a:cubicBezTo>
                <a:cubicBezTo>
                  <a:pt x="613118" y="286874"/>
                  <a:pt x="617544" y="287023"/>
                  <a:pt x="621479" y="285712"/>
                </a:cubicBezTo>
                <a:cubicBezTo>
                  <a:pt x="636242" y="280791"/>
                  <a:pt x="634534" y="281032"/>
                  <a:pt x="645622" y="273640"/>
                </a:cubicBezTo>
                <a:cubicBezTo>
                  <a:pt x="647634" y="270622"/>
                  <a:pt x="648170" y="265583"/>
                  <a:pt x="651657" y="264587"/>
                </a:cubicBezTo>
                <a:cubicBezTo>
                  <a:pt x="666742" y="260277"/>
                  <a:pt x="666418" y="269022"/>
                  <a:pt x="672782" y="276658"/>
                </a:cubicBezTo>
                <a:cubicBezTo>
                  <a:pt x="675514" y="279937"/>
                  <a:pt x="678818" y="282694"/>
                  <a:pt x="681836" y="285712"/>
                </a:cubicBezTo>
                <a:cubicBezTo>
                  <a:pt x="683848" y="289736"/>
                  <a:pt x="685256" y="294122"/>
                  <a:pt x="687871" y="297783"/>
                </a:cubicBezTo>
                <a:cubicBezTo>
                  <a:pt x="693150" y="305174"/>
                  <a:pt x="698762" y="308061"/>
                  <a:pt x="705978" y="312872"/>
                </a:cubicBezTo>
                <a:cubicBezTo>
                  <a:pt x="706984" y="316896"/>
                  <a:pt x="707540" y="321060"/>
                  <a:pt x="708996" y="324943"/>
                </a:cubicBezTo>
                <a:cubicBezTo>
                  <a:pt x="713629" y="337297"/>
                  <a:pt x="716416" y="338130"/>
                  <a:pt x="724085" y="349086"/>
                </a:cubicBezTo>
                <a:cubicBezTo>
                  <a:pt x="728245" y="355029"/>
                  <a:pt x="732132" y="361157"/>
                  <a:pt x="736156" y="367193"/>
                </a:cubicBezTo>
                <a:cubicBezTo>
                  <a:pt x="738168" y="370211"/>
                  <a:pt x="739360" y="373980"/>
                  <a:pt x="742192" y="376246"/>
                </a:cubicBezTo>
                <a:cubicBezTo>
                  <a:pt x="747222" y="380270"/>
                  <a:pt x="752515" y="383985"/>
                  <a:pt x="757281" y="388318"/>
                </a:cubicBezTo>
                <a:cubicBezTo>
                  <a:pt x="781222" y="410083"/>
                  <a:pt x="765698" y="404003"/>
                  <a:pt x="787459" y="409442"/>
                </a:cubicBezTo>
                <a:cubicBezTo>
                  <a:pt x="796513" y="408436"/>
                  <a:pt x="806059" y="409538"/>
                  <a:pt x="814620" y="406425"/>
                </a:cubicBezTo>
                <a:cubicBezTo>
                  <a:pt x="818029" y="405186"/>
                  <a:pt x="818333" y="400157"/>
                  <a:pt x="820655" y="397371"/>
                </a:cubicBezTo>
                <a:cubicBezTo>
                  <a:pt x="823387" y="394092"/>
                  <a:pt x="826691" y="391336"/>
                  <a:pt x="829709" y="388318"/>
                </a:cubicBezTo>
                <a:cubicBezTo>
                  <a:pt x="828703" y="361157"/>
                  <a:pt x="828441" y="333959"/>
                  <a:pt x="826691" y="306836"/>
                </a:cubicBezTo>
                <a:cubicBezTo>
                  <a:pt x="826424" y="302697"/>
                  <a:pt x="824437" y="298841"/>
                  <a:pt x="823673" y="294765"/>
                </a:cubicBezTo>
                <a:cubicBezTo>
                  <a:pt x="821418" y="282737"/>
                  <a:pt x="821508" y="270161"/>
                  <a:pt x="817638" y="258551"/>
                </a:cubicBezTo>
                <a:cubicBezTo>
                  <a:pt x="810290" y="236509"/>
                  <a:pt x="813145" y="246616"/>
                  <a:pt x="808584" y="228373"/>
                </a:cubicBezTo>
                <a:cubicBezTo>
                  <a:pt x="810187" y="202723"/>
                  <a:pt x="800644" y="184374"/>
                  <a:pt x="820655" y="171034"/>
                </a:cubicBezTo>
                <a:cubicBezTo>
                  <a:pt x="823302" y="169269"/>
                  <a:pt x="826691" y="169023"/>
                  <a:pt x="829709" y="168017"/>
                </a:cubicBezTo>
                <a:cubicBezTo>
                  <a:pt x="846180" y="200963"/>
                  <a:pt x="824894" y="163377"/>
                  <a:pt x="844798" y="186124"/>
                </a:cubicBezTo>
                <a:cubicBezTo>
                  <a:pt x="844799" y="186125"/>
                  <a:pt x="859887" y="208757"/>
                  <a:pt x="862905" y="213284"/>
                </a:cubicBezTo>
                <a:lnTo>
                  <a:pt x="874976" y="231391"/>
                </a:lnTo>
                <a:lnTo>
                  <a:pt x="881012" y="240444"/>
                </a:lnTo>
                <a:cubicBezTo>
                  <a:pt x="888090" y="261678"/>
                  <a:pt x="878878" y="235464"/>
                  <a:pt x="890065" y="261569"/>
                </a:cubicBezTo>
                <a:cubicBezTo>
                  <a:pt x="891318" y="264493"/>
                  <a:pt x="890834" y="268374"/>
                  <a:pt x="893083" y="270623"/>
                </a:cubicBezTo>
                <a:cubicBezTo>
                  <a:pt x="897231" y="274771"/>
                  <a:pt x="903045" y="276827"/>
                  <a:pt x="908172" y="279676"/>
                </a:cubicBezTo>
                <a:cubicBezTo>
                  <a:pt x="912105" y="281861"/>
                  <a:pt x="916337" y="283480"/>
                  <a:pt x="920243" y="285712"/>
                </a:cubicBezTo>
                <a:cubicBezTo>
                  <a:pt x="936621" y="295070"/>
                  <a:pt x="921754" y="289233"/>
                  <a:pt x="938350" y="294765"/>
                </a:cubicBezTo>
                <a:cubicBezTo>
                  <a:pt x="958469" y="292753"/>
                  <a:pt x="979200" y="294049"/>
                  <a:pt x="998707" y="288729"/>
                </a:cubicBezTo>
                <a:cubicBezTo>
                  <a:pt x="1003047" y="287545"/>
                  <a:pt x="1003071" y="280835"/>
                  <a:pt x="1004742" y="276658"/>
                </a:cubicBezTo>
                <a:cubicBezTo>
                  <a:pt x="1007105" y="270751"/>
                  <a:pt x="1008766" y="264587"/>
                  <a:pt x="1010778" y="258551"/>
                </a:cubicBezTo>
                <a:lnTo>
                  <a:pt x="1013796" y="249498"/>
                </a:lnTo>
                <a:cubicBezTo>
                  <a:pt x="1012790" y="233403"/>
                  <a:pt x="1015668" y="216580"/>
                  <a:pt x="1010778" y="201213"/>
                </a:cubicBezTo>
                <a:cubicBezTo>
                  <a:pt x="1009266" y="196460"/>
                  <a:pt x="991632" y="181077"/>
                  <a:pt x="983618" y="177070"/>
                </a:cubicBezTo>
                <a:cubicBezTo>
                  <a:pt x="980773" y="175647"/>
                  <a:pt x="977345" y="175597"/>
                  <a:pt x="974564" y="174052"/>
                </a:cubicBezTo>
                <a:cubicBezTo>
                  <a:pt x="961785" y="166953"/>
                  <a:pt x="948138" y="157415"/>
                  <a:pt x="941368" y="143874"/>
                </a:cubicBezTo>
                <a:cubicBezTo>
                  <a:pt x="937761" y="136660"/>
                  <a:pt x="934926" y="127565"/>
                  <a:pt x="932315" y="119731"/>
                </a:cubicBezTo>
                <a:cubicBezTo>
                  <a:pt x="931309" y="112690"/>
                  <a:pt x="930569" y="105605"/>
                  <a:pt x="929297" y="98607"/>
                </a:cubicBezTo>
                <a:cubicBezTo>
                  <a:pt x="928555" y="94526"/>
                  <a:pt x="926082" y="90678"/>
                  <a:pt x="926279" y="86535"/>
                </a:cubicBezTo>
                <a:cubicBezTo>
                  <a:pt x="927098" y="69336"/>
                  <a:pt x="930303" y="52333"/>
                  <a:pt x="932315" y="35232"/>
                </a:cubicBezTo>
                <a:cubicBezTo>
                  <a:pt x="941368" y="36238"/>
                  <a:pt x="950371" y="37947"/>
                  <a:pt x="959475" y="38250"/>
                </a:cubicBezTo>
                <a:cubicBezTo>
                  <a:pt x="1120091" y="43604"/>
                  <a:pt x="1082430" y="0"/>
                  <a:pt x="1122438" y="53339"/>
                </a:cubicBezTo>
                <a:cubicBezTo>
                  <a:pt x="1123444" y="56357"/>
                  <a:pt x="1124581" y="59334"/>
                  <a:pt x="1125455" y="62393"/>
                </a:cubicBezTo>
                <a:cubicBezTo>
                  <a:pt x="1126594" y="66381"/>
                  <a:pt x="1126839" y="70652"/>
                  <a:pt x="1128473" y="74464"/>
                </a:cubicBezTo>
                <a:cubicBezTo>
                  <a:pt x="1129902" y="77798"/>
                  <a:pt x="1132887" y="80274"/>
                  <a:pt x="1134509" y="83518"/>
                </a:cubicBezTo>
                <a:cubicBezTo>
                  <a:pt x="1135932" y="86363"/>
                  <a:pt x="1136105" y="89726"/>
                  <a:pt x="1137527" y="92571"/>
                </a:cubicBezTo>
                <a:cubicBezTo>
                  <a:pt x="1143149" y="103816"/>
                  <a:pt x="1144268" y="100661"/>
                  <a:pt x="1152616" y="110678"/>
                </a:cubicBezTo>
                <a:cubicBezTo>
                  <a:pt x="1165192" y="125768"/>
                  <a:pt x="1151104" y="114700"/>
                  <a:pt x="1167705" y="125767"/>
                </a:cubicBezTo>
                <a:cubicBezTo>
                  <a:pt x="1188577" y="157080"/>
                  <a:pt x="1155187" y="110232"/>
                  <a:pt x="1185812" y="140856"/>
                </a:cubicBezTo>
                <a:cubicBezTo>
                  <a:pt x="1190941" y="145985"/>
                  <a:pt x="1197883" y="158963"/>
                  <a:pt x="1197883" y="158963"/>
                </a:cubicBezTo>
                <a:cubicBezTo>
                  <a:pt x="1205471" y="181728"/>
                  <a:pt x="1195233" y="153661"/>
                  <a:pt x="1206937" y="177070"/>
                </a:cubicBezTo>
                <a:cubicBezTo>
                  <a:pt x="1208360" y="179915"/>
                  <a:pt x="1208701" y="183200"/>
                  <a:pt x="1209954" y="186124"/>
                </a:cubicBezTo>
                <a:cubicBezTo>
                  <a:pt x="1211726" y="190259"/>
                  <a:pt x="1214410" y="193983"/>
                  <a:pt x="1215990" y="198195"/>
                </a:cubicBezTo>
                <a:cubicBezTo>
                  <a:pt x="1217446" y="202078"/>
                  <a:pt x="1217374" y="206454"/>
                  <a:pt x="1219008" y="210266"/>
                </a:cubicBezTo>
                <a:cubicBezTo>
                  <a:pt x="1220437" y="213600"/>
                  <a:pt x="1223031" y="216302"/>
                  <a:pt x="1225043" y="219320"/>
                </a:cubicBezTo>
                <a:lnTo>
                  <a:pt x="1231079" y="249498"/>
                </a:lnTo>
                <a:cubicBezTo>
                  <a:pt x="1236390" y="276054"/>
                  <a:pt x="1231241" y="259039"/>
                  <a:pt x="1237115" y="276658"/>
                </a:cubicBezTo>
                <a:cubicBezTo>
                  <a:pt x="1236006" y="304375"/>
                  <a:pt x="1237711" y="340368"/>
                  <a:pt x="1231079" y="370211"/>
                </a:cubicBezTo>
                <a:cubicBezTo>
                  <a:pt x="1228902" y="380007"/>
                  <a:pt x="1226282" y="381403"/>
                  <a:pt x="1222026" y="391335"/>
                </a:cubicBezTo>
                <a:cubicBezTo>
                  <a:pt x="1214531" y="408824"/>
                  <a:pt x="1224569" y="392048"/>
                  <a:pt x="1212972" y="409442"/>
                </a:cubicBezTo>
                <a:lnTo>
                  <a:pt x="1206937" y="427549"/>
                </a:lnTo>
                <a:cubicBezTo>
                  <a:pt x="1205931" y="430567"/>
                  <a:pt x="1205684" y="433956"/>
                  <a:pt x="1203919" y="436603"/>
                </a:cubicBezTo>
                <a:cubicBezTo>
                  <a:pt x="1201907" y="439621"/>
                  <a:pt x="1200205" y="442870"/>
                  <a:pt x="1197883" y="445656"/>
                </a:cubicBezTo>
                <a:cubicBezTo>
                  <a:pt x="1193015" y="451498"/>
                  <a:pt x="1183121" y="460127"/>
                  <a:pt x="1176758" y="463763"/>
                </a:cubicBezTo>
                <a:cubicBezTo>
                  <a:pt x="1173996" y="465341"/>
                  <a:pt x="1170550" y="465358"/>
                  <a:pt x="1167705" y="466781"/>
                </a:cubicBezTo>
                <a:cubicBezTo>
                  <a:pt x="1164461" y="468403"/>
                  <a:pt x="1161895" y="471195"/>
                  <a:pt x="1158651" y="472817"/>
                </a:cubicBezTo>
                <a:cubicBezTo>
                  <a:pt x="1155806" y="474239"/>
                  <a:pt x="1152522" y="474581"/>
                  <a:pt x="1149598" y="475834"/>
                </a:cubicBezTo>
                <a:cubicBezTo>
                  <a:pt x="1145463" y="477606"/>
                  <a:pt x="1141704" y="480199"/>
                  <a:pt x="1137527" y="481870"/>
                </a:cubicBezTo>
                <a:cubicBezTo>
                  <a:pt x="1131620" y="484233"/>
                  <a:pt x="1119420" y="487906"/>
                  <a:pt x="1119420" y="487906"/>
                </a:cubicBezTo>
                <a:cubicBezTo>
                  <a:pt x="1095879" y="511444"/>
                  <a:pt x="1126100" y="483134"/>
                  <a:pt x="1098295" y="502995"/>
                </a:cubicBezTo>
                <a:cubicBezTo>
                  <a:pt x="1094822" y="505476"/>
                  <a:pt x="1092792" y="509681"/>
                  <a:pt x="1089241" y="512048"/>
                </a:cubicBezTo>
                <a:cubicBezTo>
                  <a:pt x="1086594" y="513812"/>
                  <a:pt x="1083033" y="513643"/>
                  <a:pt x="1080188" y="515066"/>
                </a:cubicBezTo>
                <a:cubicBezTo>
                  <a:pt x="1068953" y="520684"/>
                  <a:pt x="1072089" y="521815"/>
                  <a:pt x="1062081" y="530155"/>
                </a:cubicBezTo>
                <a:cubicBezTo>
                  <a:pt x="1059295" y="532477"/>
                  <a:pt x="1055593" y="533626"/>
                  <a:pt x="1053028" y="536191"/>
                </a:cubicBezTo>
                <a:cubicBezTo>
                  <a:pt x="1049471" y="539748"/>
                  <a:pt x="1046858" y="544142"/>
                  <a:pt x="1043974" y="548262"/>
                </a:cubicBezTo>
                <a:cubicBezTo>
                  <a:pt x="1039814" y="554205"/>
                  <a:pt x="1037032" y="561240"/>
                  <a:pt x="1031903" y="566369"/>
                </a:cubicBezTo>
                <a:cubicBezTo>
                  <a:pt x="1025867" y="572405"/>
                  <a:pt x="1021894" y="581777"/>
                  <a:pt x="1013796" y="584476"/>
                </a:cubicBezTo>
                <a:cubicBezTo>
                  <a:pt x="1000807" y="588806"/>
                  <a:pt x="1007828" y="586722"/>
                  <a:pt x="992671" y="590512"/>
                </a:cubicBezTo>
                <a:cubicBezTo>
                  <a:pt x="972675" y="603842"/>
                  <a:pt x="995669" y="590516"/>
                  <a:pt x="956457" y="599565"/>
                </a:cubicBezTo>
                <a:cubicBezTo>
                  <a:pt x="952074" y="600577"/>
                  <a:pt x="948598" y="604021"/>
                  <a:pt x="944386" y="605601"/>
                </a:cubicBezTo>
                <a:cubicBezTo>
                  <a:pt x="940503" y="607057"/>
                  <a:pt x="936198" y="607163"/>
                  <a:pt x="932315" y="608619"/>
                </a:cubicBezTo>
                <a:cubicBezTo>
                  <a:pt x="928103" y="610199"/>
                  <a:pt x="924673" y="613872"/>
                  <a:pt x="920243" y="614654"/>
                </a:cubicBezTo>
                <a:cubicBezTo>
                  <a:pt x="907327" y="616933"/>
                  <a:pt x="894089" y="616666"/>
                  <a:pt x="881012" y="617672"/>
                </a:cubicBezTo>
                <a:cubicBezTo>
                  <a:pt x="843795" y="630078"/>
                  <a:pt x="869259" y="624026"/>
                  <a:pt x="802548" y="620690"/>
                </a:cubicBezTo>
                <a:cubicBezTo>
                  <a:pt x="799530" y="619684"/>
                  <a:pt x="796419" y="618925"/>
                  <a:pt x="793495" y="617672"/>
                </a:cubicBezTo>
                <a:cubicBezTo>
                  <a:pt x="789360" y="615900"/>
                  <a:pt x="785900" y="612084"/>
                  <a:pt x="781424" y="611636"/>
                </a:cubicBezTo>
                <a:cubicBezTo>
                  <a:pt x="775335" y="611027"/>
                  <a:pt x="769353" y="613648"/>
                  <a:pt x="763317" y="614654"/>
                </a:cubicBezTo>
                <a:cubicBezTo>
                  <a:pt x="761305" y="617672"/>
                  <a:pt x="760067" y="621386"/>
                  <a:pt x="757281" y="623708"/>
                </a:cubicBezTo>
                <a:cubicBezTo>
                  <a:pt x="749945" y="629821"/>
                  <a:pt x="741788" y="630290"/>
                  <a:pt x="733139" y="632761"/>
                </a:cubicBezTo>
                <a:cubicBezTo>
                  <a:pt x="730080" y="633635"/>
                  <a:pt x="727103" y="634773"/>
                  <a:pt x="724085" y="635779"/>
                </a:cubicBezTo>
                <a:cubicBezTo>
                  <a:pt x="721067" y="637791"/>
                  <a:pt x="717818" y="639493"/>
                  <a:pt x="715032" y="641815"/>
                </a:cubicBezTo>
                <a:cubicBezTo>
                  <a:pt x="711753" y="644547"/>
                  <a:pt x="709529" y="648501"/>
                  <a:pt x="705978" y="650868"/>
                </a:cubicBezTo>
                <a:cubicBezTo>
                  <a:pt x="703331" y="652632"/>
                  <a:pt x="699943" y="652880"/>
                  <a:pt x="696925" y="653886"/>
                </a:cubicBezTo>
                <a:cubicBezTo>
                  <a:pt x="692901" y="656904"/>
                  <a:pt x="689352" y="660690"/>
                  <a:pt x="684853" y="662939"/>
                </a:cubicBezTo>
                <a:cubicBezTo>
                  <a:pt x="681143" y="664794"/>
                  <a:pt x="676831" y="665057"/>
                  <a:pt x="672782" y="665957"/>
                </a:cubicBezTo>
                <a:cubicBezTo>
                  <a:pt x="649107" y="671219"/>
                  <a:pt x="651876" y="669423"/>
                  <a:pt x="618461" y="671993"/>
                </a:cubicBezTo>
                <a:cubicBezTo>
                  <a:pt x="577262" y="685724"/>
                  <a:pt x="619355" y="670746"/>
                  <a:pt x="588283" y="684064"/>
                </a:cubicBezTo>
                <a:cubicBezTo>
                  <a:pt x="585359" y="685317"/>
                  <a:pt x="582075" y="685659"/>
                  <a:pt x="579230" y="687082"/>
                </a:cubicBezTo>
                <a:cubicBezTo>
                  <a:pt x="561720" y="695837"/>
                  <a:pt x="579265" y="691218"/>
                  <a:pt x="558105" y="699153"/>
                </a:cubicBezTo>
                <a:cubicBezTo>
                  <a:pt x="554222" y="700609"/>
                  <a:pt x="549917" y="700715"/>
                  <a:pt x="546034" y="702171"/>
                </a:cubicBezTo>
                <a:cubicBezTo>
                  <a:pt x="541822" y="703751"/>
                  <a:pt x="538374" y="707325"/>
                  <a:pt x="533962" y="708207"/>
                </a:cubicBezTo>
                <a:cubicBezTo>
                  <a:pt x="518057" y="711388"/>
                  <a:pt x="485677" y="714242"/>
                  <a:pt x="485677" y="714242"/>
                </a:cubicBezTo>
                <a:cubicBezTo>
                  <a:pt x="481021" y="715406"/>
                  <a:pt x="462348" y="720278"/>
                  <a:pt x="458517" y="720278"/>
                </a:cubicBezTo>
                <a:cubicBezTo>
                  <a:pt x="439378" y="720278"/>
                  <a:pt x="420291" y="718266"/>
                  <a:pt x="401178" y="717260"/>
                </a:cubicBezTo>
                <a:cubicBezTo>
                  <a:pt x="347821" y="708367"/>
                  <a:pt x="414378" y="719660"/>
                  <a:pt x="367982" y="711225"/>
                </a:cubicBezTo>
                <a:cubicBezTo>
                  <a:pt x="361962" y="710131"/>
                  <a:pt x="355895" y="709302"/>
                  <a:pt x="349875" y="708207"/>
                </a:cubicBezTo>
                <a:cubicBezTo>
                  <a:pt x="344828" y="707289"/>
                  <a:pt x="339870" y="705867"/>
                  <a:pt x="334786" y="705189"/>
                </a:cubicBezTo>
                <a:cubicBezTo>
                  <a:pt x="324765" y="703853"/>
                  <a:pt x="314667" y="703177"/>
                  <a:pt x="304608" y="702171"/>
                </a:cubicBezTo>
                <a:cubicBezTo>
                  <a:pt x="265131" y="692301"/>
                  <a:pt x="309390" y="702171"/>
                  <a:pt x="214073" y="702171"/>
                </a:cubicBezTo>
                <a:cubicBezTo>
                  <a:pt x="199954" y="702171"/>
                  <a:pt x="185907" y="700159"/>
                  <a:pt x="171824" y="699153"/>
                </a:cubicBezTo>
                <a:cubicBezTo>
                  <a:pt x="168806" y="697141"/>
                  <a:pt x="165036" y="695950"/>
                  <a:pt x="162770" y="693118"/>
                </a:cubicBezTo>
                <a:cubicBezTo>
                  <a:pt x="160783" y="690634"/>
                  <a:pt x="161175" y="686909"/>
                  <a:pt x="159752" y="684064"/>
                </a:cubicBezTo>
                <a:cubicBezTo>
                  <a:pt x="145404" y="655367"/>
                  <a:pt x="163256" y="703625"/>
                  <a:pt x="147681" y="656904"/>
                </a:cubicBezTo>
                <a:cubicBezTo>
                  <a:pt x="145945" y="651697"/>
                  <a:pt x="132123" y="641978"/>
                  <a:pt x="126556" y="638797"/>
                </a:cubicBezTo>
                <a:cubicBezTo>
                  <a:pt x="122650" y="636565"/>
                  <a:pt x="117967" y="635610"/>
                  <a:pt x="114485" y="632761"/>
                </a:cubicBezTo>
                <a:cubicBezTo>
                  <a:pt x="110427" y="629441"/>
                  <a:pt x="91734" y="612504"/>
                  <a:pt x="87325" y="602583"/>
                </a:cubicBezTo>
                <a:cubicBezTo>
                  <a:pt x="75509" y="575997"/>
                  <a:pt x="88759" y="591946"/>
                  <a:pt x="72236" y="575423"/>
                </a:cubicBezTo>
                <a:cubicBezTo>
                  <a:pt x="71230" y="572405"/>
                  <a:pt x="70983" y="569016"/>
                  <a:pt x="69218" y="566369"/>
                </a:cubicBezTo>
                <a:cubicBezTo>
                  <a:pt x="55864" y="546340"/>
                  <a:pt x="64005" y="568016"/>
                  <a:pt x="54129" y="548262"/>
                </a:cubicBezTo>
                <a:cubicBezTo>
                  <a:pt x="52707" y="545417"/>
                  <a:pt x="52534" y="542054"/>
                  <a:pt x="51111" y="539209"/>
                </a:cubicBezTo>
                <a:cubicBezTo>
                  <a:pt x="49489" y="535965"/>
                  <a:pt x="46697" y="533399"/>
                  <a:pt x="45075" y="530155"/>
                </a:cubicBezTo>
                <a:cubicBezTo>
                  <a:pt x="43652" y="527310"/>
                  <a:pt x="43479" y="523947"/>
                  <a:pt x="42057" y="521102"/>
                </a:cubicBezTo>
                <a:cubicBezTo>
                  <a:pt x="40435" y="517858"/>
                  <a:pt x="37644" y="515292"/>
                  <a:pt x="36022" y="512048"/>
                </a:cubicBezTo>
                <a:cubicBezTo>
                  <a:pt x="33599" y="507203"/>
                  <a:pt x="31699" y="502098"/>
                  <a:pt x="29986" y="496959"/>
                </a:cubicBezTo>
                <a:cubicBezTo>
                  <a:pt x="26156" y="485470"/>
                  <a:pt x="28311" y="486009"/>
                  <a:pt x="23950" y="475834"/>
                </a:cubicBezTo>
                <a:cubicBezTo>
                  <a:pt x="22178" y="471699"/>
                  <a:pt x="19586" y="467940"/>
                  <a:pt x="17915" y="463763"/>
                </a:cubicBezTo>
                <a:cubicBezTo>
                  <a:pt x="15552" y="457856"/>
                  <a:pt x="13891" y="451692"/>
                  <a:pt x="11879" y="445656"/>
                </a:cubicBezTo>
                <a:cubicBezTo>
                  <a:pt x="10166" y="440517"/>
                  <a:pt x="7855" y="435597"/>
                  <a:pt x="5843" y="430567"/>
                </a:cubicBezTo>
                <a:cubicBezTo>
                  <a:pt x="0" y="377970"/>
                  <a:pt x="1240" y="401057"/>
                  <a:pt x="5843" y="315890"/>
                </a:cubicBezTo>
                <a:cubicBezTo>
                  <a:pt x="6501" y="303709"/>
                  <a:pt x="8364" y="291393"/>
                  <a:pt x="11879" y="279676"/>
                </a:cubicBezTo>
                <a:cubicBezTo>
                  <a:pt x="13707" y="273582"/>
                  <a:pt x="17915" y="261569"/>
                  <a:pt x="17915" y="261569"/>
                </a:cubicBezTo>
                <a:cubicBezTo>
                  <a:pt x="23145" y="224963"/>
                  <a:pt x="18261" y="253977"/>
                  <a:pt x="23950" y="228373"/>
                </a:cubicBezTo>
                <a:cubicBezTo>
                  <a:pt x="25063" y="223366"/>
                  <a:pt x="25724" y="218260"/>
                  <a:pt x="26968" y="213284"/>
                </a:cubicBezTo>
                <a:cubicBezTo>
                  <a:pt x="30207" y="200327"/>
                  <a:pt x="30262" y="206560"/>
                  <a:pt x="36022" y="192159"/>
                </a:cubicBezTo>
                <a:cubicBezTo>
                  <a:pt x="38385" y="186252"/>
                  <a:pt x="36967" y="177869"/>
                  <a:pt x="42057" y="174052"/>
                </a:cubicBezTo>
                <a:cubicBezTo>
                  <a:pt x="81664" y="144350"/>
                  <a:pt x="33553" y="178442"/>
                  <a:pt x="63182" y="161981"/>
                </a:cubicBezTo>
                <a:cubicBezTo>
                  <a:pt x="69523" y="158458"/>
                  <a:pt x="74252" y="151669"/>
                  <a:pt x="81289" y="149910"/>
                </a:cubicBezTo>
                <a:cubicBezTo>
                  <a:pt x="96446" y="146120"/>
                  <a:pt x="89425" y="148204"/>
                  <a:pt x="102414" y="143874"/>
                </a:cubicBezTo>
                <a:cubicBezTo>
                  <a:pt x="120541" y="131788"/>
                  <a:pt x="102667" y="140856"/>
                  <a:pt x="135610" y="140856"/>
                </a:cubicBezTo>
                <a:cubicBezTo>
                  <a:pt x="142723" y="140856"/>
                  <a:pt x="149693" y="138844"/>
                  <a:pt x="156735" y="137838"/>
                </a:cubicBezTo>
                <a:cubicBezTo>
                  <a:pt x="159753" y="135826"/>
                  <a:pt x="163002" y="134125"/>
                  <a:pt x="165788" y="131803"/>
                </a:cubicBezTo>
                <a:cubicBezTo>
                  <a:pt x="173915" y="125030"/>
                  <a:pt x="174256" y="120998"/>
                  <a:pt x="183895" y="116714"/>
                </a:cubicBezTo>
                <a:cubicBezTo>
                  <a:pt x="189709" y="114130"/>
                  <a:pt x="202002" y="110678"/>
                  <a:pt x="202002" y="110678"/>
                </a:cubicBezTo>
                <a:cubicBezTo>
                  <a:pt x="211351" y="101329"/>
                  <a:pt x="211161" y="104218"/>
                  <a:pt x="214073" y="92571"/>
                </a:cubicBezTo>
                <a:cubicBezTo>
                  <a:pt x="214317" y="91595"/>
                  <a:pt x="232683" y="85530"/>
                  <a:pt x="238216" y="83518"/>
                </a:cubicBezTo>
                <a:close/>
              </a:path>
            </a:pathLst>
          </a:custGeom>
          <a:noFill/>
          <a:ln w="222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23" name="手繪多邊形 122"/>
          <p:cNvSpPr/>
          <p:nvPr/>
        </p:nvSpPr>
        <p:spPr>
          <a:xfrm>
            <a:off x="5044790" y="3458679"/>
            <a:ext cx="1237711" cy="720278"/>
          </a:xfrm>
          <a:custGeom>
            <a:avLst/>
            <a:gdLst>
              <a:gd name="connsiteX0" fmla="*/ 238216 w 1237711"/>
              <a:gd name="connsiteY0" fmla="*/ 83518 h 720278"/>
              <a:gd name="connsiteX1" fmla="*/ 247269 w 1237711"/>
              <a:gd name="connsiteY1" fmla="*/ 80500 h 720278"/>
              <a:gd name="connsiteX2" fmla="*/ 256323 w 1237711"/>
              <a:gd name="connsiteY2" fmla="*/ 83518 h 720278"/>
              <a:gd name="connsiteX3" fmla="*/ 271412 w 1237711"/>
              <a:gd name="connsiteY3" fmla="*/ 86535 h 720278"/>
              <a:gd name="connsiteX4" fmla="*/ 277447 w 1237711"/>
              <a:gd name="connsiteY4" fmla="*/ 98607 h 720278"/>
              <a:gd name="connsiteX5" fmla="*/ 283483 w 1237711"/>
              <a:gd name="connsiteY5" fmla="*/ 140856 h 720278"/>
              <a:gd name="connsiteX6" fmla="*/ 280465 w 1237711"/>
              <a:gd name="connsiteY6" fmla="*/ 216302 h 720278"/>
              <a:gd name="connsiteX7" fmla="*/ 274430 w 1237711"/>
              <a:gd name="connsiteY7" fmla="*/ 285712 h 720278"/>
              <a:gd name="connsiteX8" fmla="*/ 268394 w 1237711"/>
              <a:gd name="connsiteY8" fmla="*/ 303819 h 720278"/>
              <a:gd name="connsiteX9" fmla="*/ 265376 w 1237711"/>
              <a:gd name="connsiteY9" fmla="*/ 318908 h 720278"/>
              <a:gd name="connsiteX10" fmla="*/ 262358 w 1237711"/>
              <a:gd name="connsiteY10" fmla="*/ 327961 h 720278"/>
              <a:gd name="connsiteX11" fmla="*/ 277447 w 1237711"/>
              <a:gd name="connsiteY11" fmla="*/ 385300 h 720278"/>
              <a:gd name="connsiteX12" fmla="*/ 283483 w 1237711"/>
              <a:gd name="connsiteY12" fmla="*/ 403407 h 720278"/>
              <a:gd name="connsiteX13" fmla="*/ 304608 w 1237711"/>
              <a:gd name="connsiteY13" fmla="*/ 412460 h 720278"/>
              <a:gd name="connsiteX14" fmla="*/ 322715 w 1237711"/>
              <a:gd name="connsiteY14" fmla="*/ 415478 h 720278"/>
              <a:gd name="connsiteX15" fmla="*/ 343839 w 1237711"/>
              <a:gd name="connsiteY15" fmla="*/ 415478 h 720278"/>
              <a:gd name="connsiteX16" fmla="*/ 349875 w 1237711"/>
              <a:gd name="connsiteY16" fmla="*/ 406425 h 720278"/>
              <a:gd name="connsiteX17" fmla="*/ 361946 w 1237711"/>
              <a:gd name="connsiteY17" fmla="*/ 388318 h 720278"/>
              <a:gd name="connsiteX18" fmla="*/ 367982 w 1237711"/>
              <a:gd name="connsiteY18" fmla="*/ 379264 h 720278"/>
              <a:gd name="connsiteX19" fmla="*/ 377036 w 1237711"/>
              <a:gd name="connsiteY19" fmla="*/ 361157 h 720278"/>
              <a:gd name="connsiteX20" fmla="*/ 395142 w 1237711"/>
              <a:gd name="connsiteY20" fmla="*/ 346068 h 720278"/>
              <a:gd name="connsiteX21" fmla="*/ 404196 w 1237711"/>
              <a:gd name="connsiteY21" fmla="*/ 337015 h 720278"/>
              <a:gd name="connsiteX22" fmla="*/ 416267 w 1237711"/>
              <a:gd name="connsiteY22" fmla="*/ 318908 h 720278"/>
              <a:gd name="connsiteX23" fmla="*/ 419285 w 1237711"/>
              <a:gd name="connsiteY23" fmla="*/ 306836 h 720278"/>
              <a:gd name="connsiteX24" fmla="*/ 437392 w 1237711"/>
              <a:gd name="connsiteY24" fmla="*/ 297783 h 720278"/>
              <a:gd name="connsiteX25" fmla="*/ 446445 w 1237711"/>
              <a:gd name="connsiteY25" fmla="*/ 291747 h 720278"/>
              <a:gd name="connsiteX26" fmla="*/ 464552 w 1237711"/>
              <a:gd name="connsiteY26" fmla="*/ 297783 h 720278"/>
              <a:gd name="connsiteX27" fmla="*/ 470588 w 1237711"/>
              <a:gd name="connsiteY27" fmla="*/ 330979 h 720278"/>
              <a:gd name="connsiteX28" fmla="*/ 473606 w 1237711"/>
              <a:gd name="connsiteY28" fmla="*/ 349086 h 720278"/>
              <a:gd name="connsiteX29" fmla="*/ 494731 w 1237711"/>
              <a:gd name="connsiteY29" fmla="*/ 364175 h 720278"/>
              <a:gd name="connsiteX30" fmla="*/ 512838 w 1237711"/>
              <a:gd name="connsiteY30" fmla="*/ 370211 h 720278"/>
              <a:gd name="connsiteX31" fmla="*/ 558105 w 1237711"/>
              <a:gd name="connsiteY31" fmla="*/ 367193 h 720278"/>
              <a:gd name="connsiteX32" fmla="*/ 576212 w 1237711"/>
              <a:gd name="connsiteY32" fmla="*/ 355122 h 720278"/>
              <a:gd name="connsiteX33" fmla="*/ 579230 w 1237711"/>
              <a:gd name="connsiteY33" fmla="*/ 324943 h 720278"/>
              <a:gd name="connsiteX34" fmla="*/ 582247 w 1237711"/>
              <a:gd name="connsiteY34" fmla="*/ 315890 h 720278"/>
              <a:gd name="connsiteX35" fmla="*/ 591301 w 1237711"/>
              <a:gd name="connsiteY35" fmla="*/ 306836 h 720278"/>
              <a:gd name="connsiteX36" fmla="*/ 609408 w 1237711"/>
              <a:gd name="connsiteY36" fmla="*/ 288729 h 720278"/>
              <a:gd name="connsiteX37" fmla="*/ 621479 w 1237711"/>
              <a:gd name="connsiteY37" fmla="*/ 285712 h 720278"/>
              <a:gd name="connsiteX38" fmla="*/ 645622 w 1237711"/>
              <a:gd name="connsiteY38" fmla="*/ 273640 h 720278"/>
              <a:gd name="connsiteX39" fmla="*/ 651657 w 1237711"/>
              <a:gd name="connsiteY39" fmla="*/ 264587 h 720278"/>
              <a:gd name="connsiteX40" fmla="*/ 672782 w 1237711"/>
              <a:gd name="connsiteY40" fmla="*/ 276658 h 720278"/>
              <a:gd name="connsiteX41" fmla="*/ 681836 w 1237711"/>
              <a:gd name="connsiteY41" fmla="*/ 285712 h 720278"/>
              <a:gd name="connsiteX42" fmla="*/ 687871 w 1237711"/>
              <a:gd name="connsiteY42" fmla="*/ 297783 h 720278"/>
              <a:gd name="connsiteX43" fmla="*/ 705978 w 1237711"/>
              <a:gd name="connsiteY43" fmla="*/ 312872 h 720278"/>
              <a:gd name="connsiteX44" fmla="*/ 708996 w 1237711"/>
              <a:gd name="connsiteY44" fmla="*/ 324943 h 720278"/>
              <a:gd name="connsiteX45" fmla="*/ 724085 w 1237711"/>
              <a:gd name="connsiteY45" fmla="*/ 349086 h 720278"/>
              <a:gd name="connsiteX46" fmla="*/ 736156 w 1237711"/>
              <a:gd name="connsiteY46" fmla="*/ 367193 h 720278"/>
              <a:gd name="connsiteX47" fmla="*/ 742192 w 1237711"/>
              <a:gd name="connsiteY47" fmla="*/ 376246 h 720278"/>
              <a:gd name="connsiteX48" fmla="*/ 757281 w 1237711"/>
              <a:gd name="connsiteY48" fmla="*/ 388318 h 720278"/>
              <a:gd name="connsiteX49" fmla="*/ 787459 w 1237711"/>
              <a:gd name="connsiteY49" fmla="*/ 409442 h 720278"/>
              <a:gd name="connsiteX50" fmla="*/ 814620 w 1237711"/>
              <a:gd name="connsiteY50" fmla="*/ 406425 h 720278"/>
              <a:gd name="connsiteX51" fmla="*/ 820655 w 1237711"/>
              <a:gd name="connsiteY51" fmla="*/ 397371 h 720278"/>
              <a:gd name="connsiteX52" fmla="*/ 829709 w 1237711"/>
              <a:gd name="connsiteY52" fmla="*/ 388318 h 720278"/>
              <a:gd name="connsiteX53" fmla="*/ 826691 w 1237711"/>
              <a:gd name="connsiteY53" fmla="*/ 306836 h 720278"/>
              <a:gd name="connsiteX54" fmla="*/ 823673 w 1237711"/>
              <a:gd name="connsiteY54" fmla="*/ 294765 h 720278"/>
              <a:gd name="connsiteX55" fmla="*/ 817638 w 1237711"/>
              <a:gd name="connsiteY55" fmla="*/ 258551 h 720278"/>
              <a:gd name="connsiteX56" fmla="*/ 808584 w 1237711"/>
              <a:gd name="connsiteY56" fmla="*/ 228373 h 720278"/>
              <a:gd name="connsiteX57" fmla="*/ 820655 w 1237711"/>
              <a:gd name="connsiteY57" fmla="*/ 171034 h 720278"/>
              <a:gd name="connsiteX58" fmla="*/ 829709 w 1237711"/>
              <a:gd name="connsiteY58" fmla="*/ 168017 h 720278"/>
              <a:gd name="connsiteX59" fmla="*/ 844798 w 1237711"/>
              <a:gd name="connsiteY59" fmla="*/ 186124 h 720278"/>
              <a:gd name="connsiteX60" fmla="*/ 862905 w 1237711"/>
              <a:gd name="connsiteY60" fmla="*/ 213284 h 720278"/>
              <a:gd name="connsiteX61" fmla="*/ 874976 w 1237711"/>
              <a:gd name="connsiteY61" fmla="*/ 231391 h 720278"/>
              <a:gd name="connsiteX62" fmla="*/ 881012 w 1237711"/>
              <a:gd name="connsiteY62" fmla="*/ 240444 h 720278"/>
              <a:gd name="connsiteX63" fmla="*/ 890065 w 1237711"/>
              <a:gd name="connsiteY63" fmla="*/ 261569 h 720278"/>
              <a:gd name="connsiteX64" fmla="*/ 893083 w 1237711"/>
              <a:gd name="connsiteY64" fmla="*/ 270623 h 720278"/>
              <a:gd name="connsiteX65" fmla="*/ 908172 w 1237711"/>
              <a:gd name="connsiteY65" fmla="*/ 279676 h 720278"/>
              <a:gd name="connsiteX66" fmla="*/ 920243 w 1237711"/>
              <a:gd name="connsiteY66" fmla="*/ 285712 h 720278"/>
              <a:gd name="connsiteX67" fmla="*/ 938350 w 1237711"/>
              <a:gd name="connsiteY67" fmla="*/ 294765 h 720278"/>
              <a:gd name="connsiteX68" fmla="*/ 998707 w 1237711"/>
              <a:gd name="connsiteY68" fmla="*/ 288729 h 720278"/>
              <a:gd name="connsiteX69" fmla="*/ 1004742 w 1237711"/>
              <a:gd name="connsiteY69" fmla="*/ 276658 h 720278"/>
              <a:gd name="connsiteX70" fmla="*/ 1010778 w 1237711"/>
              <a:gd name="connsiteY70" fmla="*/ 258551 h 720278"/>
              <a:gd name="connsiteX71" fmla="*/ 1013796 w 1237711"/>
              <a:gd name="connsiteY71" fmla="*/ 249498 h 720278"/>
              <a:gd name="connsiteX72" fmla="*/ 1010778 w 1237711"/>
              <a:gd name="connsiteY72" fmla="*/ 201213 h 720278"/>
              <a:gd name="connsiteX73" fmla="*/ 983618 w 1237711"/>
              <a:gd name="connsiteY73" fmla="*/ 177070 h 720278"/>
              <a:gd name="connsiteX74" fmla="*/ 974564 w 1237711"/>
              <a:gd name="connsiteY74" fmla="*/ 174052 h 720278"/>
              <a:gd name="connsiteX75" fmla="*/ 941368 w 1237711"/>
              <a:gd name="connsiteY75" fmla="*/ 143874 h 720278"/>
              <a:gd name="connsiteX76" fmla="*/ 932315 w 1237711"/>
              <a:gd name="connsiteY76" fmla="*/ 119731 h 720278"/>
              <a:gd name="connsiteX77" fmla="*/ 929297 w 1237711"/>
              <a:gd name="connsiteY77" fmla="*/ 98607 h 720278"/>
              <a:gd name="connsiteX78" fmla="*/ 926279 w 1237711"/>
              <a:gd name="connsiteY78" fmla="*/ 86535 h 720278"/>
              <a:gd name="connsiteX79" fmla="*/ 932315 w 1237711"/>
              <a:gd name="connsiteY79" fmla="*/ 35232 h 720278"/>
              <a:gd name="connsiteX80" fmla="*/ 959475 w 1237711"/>
              <a:gd name="connsiteY80" fmla="*/ 38250 h 720278"/>
              <a:gd name="connsiteX81" fmla="*/ 1122438 w 1237711"/>
              <a:gd name="connsiteY81" fmla="*/ 53339 h 720278"/>
              <a:gd name="connsiteX82" fmla="*/ 1125455 w 1237711"/>
              <a:gd name="connsiteY82" fmla="*/ 62393 h 720278"/>
              <a:gd name="connsiteX83" fmla="*/ 1128473 w 1237711"/>
              <a:gd name="connsiteY83" fmla="*/ 74464 h 720278"/>
              <a:gd name="connsiteX84" fmla="*/ 1134509 w 1237711"/>
              <a:gd name="connsiteY84" fmla="*/ 83518 h 720278"/>
              <a:gd name="connsiteX85" fmla="*/ 1137527 w 1237711"/>
              <a:gd name="connsiteY85" fmla="*/ 92571 h 720278"/>
              <a:gd name="connsiteX86" fmla="*/ 1152616 w 1237711"/>
              <a:gd name="connsiteY86" fmla="*/ 110678 h 720278"/>
              <a:gd name="connsiteX87" fmla="*/ 1167705 w 1237711"/>
              <a:gd name="connsiteY87" fmla="*/ 125767 h 720278"/>
              <a:gd name="connsiteX88" fmla="*/ 1185812 w 1237711"/>
              <a:gd name="connsiteY88" fmla="*/ 140856 h 720278"/>
              <a:gd name="connsiteX89" fmla="*/ 1197883 w 1237711"/>
              <a:gd name="connsiteY89" fmla="*/ 158963 h 720278"/>
              <a:gd name="connsiteX90" fmla="*/ 1206937 w 1237711"/>
              <a:gd name="connsiteY90" fmla="*/ 177070 h 720278"/>
              <a:gd name="connsiteX91" fmla="*/ 1209954 w 1237711"/>
              <a:gd name="connsiteY91" fmla="*/ 186124 h 720278"/>
              <a:gd name="connsiteX92" fmla="*/ 1215990 w 1237711"/>
              <a:gd name="connsiteY92" fmla="*/ 198195 h 720278"/>
              <a:gd name="connsiteX93" fmla="*/ 1219008 w 1237711"/>
              <a:gd name="connsiteY93" fmla="*/ 210266 h 720278"/>
              <a:gd name="connsiteX94" fmla="*/ 1225043 w 1237711"/>
              <a:gd name="connsiteY94" fmla="*/ 219320 h 720278"/>
              <a:gd name="connsiteX95" fmla="*/ 1231079 w 1237711"/>
              <a:gd name="connsiteY95" fmla="*/ 249498 h 720278"/>
              <a:gd name="connsiteX96" fmla="*/ 1237115 w 1237711"/>
              <a:gd name="connsiteY96" fmla="*/ 276658 h 720278"/>
              <a:gd name="connsiteX97" fmla="*/ 1231079 w 1237711"/>
              <a:gd name="connsiteY97" fmla="*/ 370211 h 720278"/>
              <a:gd name="connsiteX98" fmla="*/ 1222026 w 1237711"/>
              <a:gd name="connsiteY98" fmla="*/ 391335 h 720278"/>
              <a:gd name="connsiteX99" fmla="*/ 1212972 w 1237711"/>
              <a:gd name="connsiteY99" fmla="*/ 409442 h 720278"/>
              <a:gd name="connsiteX100" fmla="*/ 1206937 w 1237711"/>
              <a:gd name="connsiteY100" fmla="*/ 427549 h 720278"/>
              <a:gd name="connsiteX101" fmla="*/ 1203919 w 1237711"/>
              <a:gd name="connsiteY101" fmla="*/ 436603 h 720278"/>
              <a:gd name="connsiteX102" fmla="*/ 1197883 w 1237711"/>
              <a:gd name="connsiteY102" fmla="*/ 445656 h 720278"/>
              <a:gd name="connsiteX103" fmla="*/ 1176758 w 1237711"/>
              <a:gd name="connsiteY103" fmla="*/ 463763 h 720278"/>
              <a:gd name="connsiteX104" fmla="*/ 1167705 w 1237711"/>
              <a:gd name="connsiteY104" fmla="*/ 466781 h 720278"/>
              <a:gd name="connsiteX105" fmla="*/ 1158651 w 1237711"/>
              <a:gd name="connsiteY105" fmla="*/ 472817 h 720278"/>
              <a:gd name="connsiteX106" fmla="*/ 1149598 w 1237711"/>
              <a:gd name="connsiteY106" fmla="*/ 475834 h 720278"/>
              <a:gd name="connsiteX107" fmla="*/ 1137527 w 1237711"/>
              <a:gd name="connsiteY107" fmla="*/ 481870 h 720278"/>
              <a:gd name="connsiteX108" fmla="*/ 1119420 w 1237711"/>
              <a:gd name="connsiteY108" fmla="*/ 487906 h 720278"/>
              <a:gd name="connsiteX109" fmla="*/ 1098295 w 1237711"/>
              <a:gd name="connsiteY109" fmla="*/ 502995 h 720278"/>
              <a:gd name="connsiteX110" fmla="*/ 1089241 w 1237711"/>
              <a:gd name="connsiteY110" fmla="*/ 512048 h 720278"/>
              <a:gd name="connsiteX111" fmla="*/ 1080188 w 1237711"/>
              <a:gd name="connsiteY111" fmla="*/ 515066 h 720278"/>
              <a:gd name="connsiteX112" fmla="*/ 1062081 w 1237711"/>
              <a:gd name="connsiteY112" fmla="*/ 530155 h 720278"/>
              <a:gd name="connsiteX113" fmla="*/ 1053028 w 1237711"/>
              <a:gd name="connsiteY113" fmla="*/ 536191 h 720278"/>
              <a:gd name="connsiteX114" fmla="*/ 1043974 w 1237711"/>
              <a:gd name="connsiteY114" fmla="*/ 548262 h 720278"/>
              <a:gd name="connsiteX115" fmla="*/ 1031903 w 1237711"/>
              <a:gd name="connsiteY115" fmla="*/ 566369 h 720278"/>
              <a:gd name="connsiteX116" fmla="*/ 1013796 w 1237711"/>
              <a:gd name="connsiteY116" fmla="*/ 584476 h 720278"/>
              <a:gd name="connsiteX117" fmla="*/ 992671 w 1237711"/>
              <a:gd name="connsiteY117" fmla="*/ 590512 h 720278"/>
              <a:gd name="connsiteX118" fmla="*/ 956457 w 1237711"/>
              <a:gd name="connsiteY118" fmla="*/ 599565 h 720278"/>
              <a:gd name="connsiteX119" fmla="*/ 944386 w 1237711"/>
              <a:gd name="connsiteY119" fmla="*/ 605601 h 720278"/>
              <a:gd name="connsiteX120" fmla="*/ 932315 w 1237711"/>
              <a:gd name="connsiteY120" fmla="*/ 608619 h 720278"/>
              <a:gd name="connsiteX121" fmla="*/ 920243 w 1237711"/>
              <a:gd name="connsiteY121" fmla="*/ 614654 h 720278"/>
              <a:gd name="connsiteX122" fmla="*/ 881012 w 1237711"/>
              <a:gd name="connsiteY122" fmla="*/ 617672 h 720278"/>
              <a:gd name="connsiteX123" fmla="*/ 802548 w 1237711"/>
              <a:gd name="connsiteY123" fmla="*/ 620690 h 720278"/>
              <a:gd name="connsiteX124" fmla="*/ 793495 w 1237711"/>
              <a:gd name="connsiteY124" fmla="*/ 617672 h 720278"/>
              <a:gd name="connsiteX125" fmla="*/ 781424 w 1237711"/>
              <a:gd name="connsiteY125" fmla="*/ 611636 h 720278"/>
              <a:gd name="connsiteX126" fmla="*/ 763317 w 1237711"/>
              <a:gd name="connsiteY126" fmla="*/ 614654 h 720278"/>
              <a:gd name="connsiteX127" fmla="*/ 757281 w 1237711"/>
              <a:gd name="connsiteY127" fmla="*/ 623708 h 720278"/>
              <a:gd name="connsiteX128" fmla="*/ 733139 w 1237711"/>
              <a:gd name="connsiteY128" fmla="*/ 632761 h 720278"/>
              <a:gd name="connsiteX129" fmla="*/ 724085 w 1237711"/>
              <a:gd name="connsiteY129" fmla="*/ 635779 h 720278"/>
              <a:gd name="connsiteX130" fmla="*/ 715032 w 1237711"/>
              <a:gd name="connsiteY130" fmla="*/ 641815 h 720278"/>
              <a:gd name="connsiteX131" fmla="*/ 705978 w 1237711"/>
              <a:gd name="connsiteY131" fmla="*/ 650868 h 720278"/>
              <a:gd name="connsiteX132" fmla="*/ 696925 w 1237711"/>
              <a:gd name="connsiteY132" fmla="*/ 653886 h 720278"/>
              <a:gd name="connsiteX133" fmla="*/ 684853 w 1237711"/>
              <a:gd name="connsiteY133" fmla="*/ 662939 h 720278"/>
              <a:gd name="connsiteX134" fmla="*/ 672782 w 1237711"/>
              <a:gd name="connsiteY134" fmla="*/ 665957 h 720278"/>
              <a:gd name="connsiteX135" fmla="*/ 618461 w 1237711"/>
              <a:gd name="connsiteY135" fmla="*/ 671993 h 720278"/>
              <a:gd name="connsiteX136" fmla="*/ 588283 w 1237711"/>
              <a:gd name="connsiteY136" fmla="*/ 684064 h 720278"/>
              <a:gd name="connsiteX137" fmla="*/ 579230 w 1237711"/>
              <a:gd name="connsiteY137" fmla="*/ 687082 h 720278"/>
              <a:gd name="connsiteX138" fmla="*/ 558105 w 1237711"/>
              <a:gd name="connsiteY138" fmla="*/ 699153 h 720278"/>
              <a:gd name="connsiteX139" fmla="*/ 546034 w 1237711"/>
              <a:gd name="connsiteY139" fmla="*/ 702171 h 720278"/>
              <a:gd name="connsiteX140" fmla="*/ 533962 w 1237711"/>
              <a:gd name="connsiteY140" fmla="*/ 708207 h 720278"/>
              <a:gd name="connsiteX141" fmla="*/ 485677 w 1237711"/>
              <a:gd name="connsiteY141" fmla="*/ 714242 h 720278"/>
              <a:gd name="connsiteX142" fmla="*/ 458517 w 1237711"/>
              <a:gd name="connsiteY142" fmla="*/ 720278 h 720278"/>
              <a:gd name="connsiteX143" fmla="*/ 401178 w 1237711"/>
              <a:gd name="connsiteY143" fmla="*/ 717260 h 720278"/>
              <a:gd name="connsiteX144" fmla="*/ 367982 w 1237711"/>
              <a:gd name="connsiteY144" fmla="*/ 711225 h 720278"/>
              <a:gd name="connsiteX145" fmla="*/ 349875 w 1237711"/>
              <a:gd name="connsiteY145" fmla="*/ 708207 h 720278"/>
              <a:gd name="connsiteX146" fmla="*/ 334786 w 1237711"/>
              <a:gd name="connsiteY146" fmla="*/ 705189 h 720278"/>
              <a:gd name="connsiteX147" fmla="*/ 304608 w 1237711"/>
              <a:gd name="connsiteY147" fmla="*/ 702171 h 720278"/>
              <a:gd name="connsiteX148" fmla="*/ 214073 w 1237711"/>
              <a:gd name="connsiteY148" fmla="*/ 702171 h 720278"/>
              <a:gd name="connsiteX149" fmla="*/ 171824 w 1237711"/>
              <a:gd name="connsiteY149" fmla="*/ 699153 h 720278"/>
              <a:gd name="connsiteX150" fmla="*/ 162770 w 1237711"/>
              <a:gd name="connsiteY150" fmla="*/ 693118 h 720278"/>
              <a:gd name="connsiteX151" fmla="*/ 159752 w 1237711"/>
              <a:gd name="connsiteY151" fmla="*/ 684064 h 720278"/>
              <a:gd name="connsiteX152" fmla="*/ 147681 w 1237711"/>
              <a:gd name="connsiteY152" fmla="*/ 656904 h 720278"/>
              <a:gd name="connsiteX153" fmla="*/ 126556 w 1237711"/>
              <a:gd name="connsiteY153" fmla="*/ 638797 h 720278"/>
              <a:gd name="connsiteX154" fmla="*/ 114485 w 1237711"/>
              <a:gd name="connsiteY154" fmla="*/ 632761 h 720278"/>
              <a:gd name="connsiteX155" fmla="*/ 87325 w 1237711"/>
              <a:gd name="connsiteY155" fmla="*/ 602583 h 720278"/>
              <a:gd name="connsiteX156" fmla="*/ 72236 w 1237711"/>
              <a:gd name="connsiteY156" fmla="*/ 575423 h 720278"/>
              <a:gd name="connsiteX157" fmla="*/ 69218 w 1237711"/>
              <a:gd name="connsiteY157" fmla="*/ 566369 h 720278"/>
              <a:gd name="connsiteX158" fmla="*/ 54129 w 1237711"/>
              <a:gd name="connsiteY158" fmla="*/ 548262 h 720278"/>
              <a:gd name="connsiteX159" fmla="*/ 51111 w 1237711"/>
              <a:gd name="connsiteY159" fmla="*/ 539209 h 720278"/>
              <a:gd name="connsiteX160" fmla="*/ 45075 w 1237711"/>
              <a:gd name="connsiteY160" fmla="*/ 530155 h 720278"/>
              <a:gd name="connsiteX161" fmla="*/ 42057 w 1237711"/>
              <a:gd name="connsiteY161" fmla="*/ 521102 h 720278"/>
              <a:gd name="connsiteX162" fmla="*/ 36022 w 1237711"/>
              <a:gd name="connsiteY162" fmla="*/ 512048 h 720278"/>
              <a:gd name="connsiteX163" fmla="*/ 29986 w 1237711"/>
              <a:gd name="connsiteY163" fmla="*/ 496959 h 720278"/>
              <a:gd name="connsiteX164" fmla="*/ 23950 w 1237711"/>
              <a:gd name="connsiteY164" fmla="*/ 475834 h 720278"/>
              <a:gd name="connsiteX165" fmla="*/ 17915 w 1237711"/>
              <a:gd name="connsiteY165" fmla="*/ 463763 h 720278"/>
              <a:gd name="connsiteX166" fmla="*/ 11879 w 1237711"/>
              <a:gd name="connsiteY166" fmla="*/ 445656 h 720278"/>
              <a:gd name="connsiteX167" fmla="*/ 5843 w 1237711"/>
              <a:gd name="connsiteY167" fmla="*/ 430567 h 720278"/>
              <a:gd name="connsiteX168" fmla="*/ 5843 w 1237711"/>
              <a:gd name="connsiteY168" fmla="*/ 315890 h 720278"/>
              <a:gd name="connsiteX169" fmla="*/ 11879 w 1237711"/>
              <a:gd name="connsiteY169" fmla="*/ 279676 h 720278"/>
              <a:gd name="connsiteX170" fmla="*/ 17915 w 1237711"/>
              <a:gd name="connsiteY170" fmla="*/ 261569 h 720278"/>
              <a:gd name="connsiteX171" fmla="*/ 23950 w 1237711"/>
              <a:gd name="connsiteY171" fmla="*/ 228373 h 720278"/>
              <a:gd name="connsiteX172" fmla="*/ 26968 w 1237711"/>
              <a:gd name="connsiteY172" fmla="*/ 213284 h 720278"/>
              <a:gd name="connsiteX173" fmla="*/ 36022 w 1237711"/>
              <a:gd name="connsiteY173" fmla="*/ 192159 h 720278"/>
              <a:gd name="connsiteX174" fmla="*/ 42057 w 1237711"/>
              <a:gd name="connsiteY174" fmla="*/ 174052 h 720278"/>
              <a:gd name="connsiteX175" fmla="*/ 63182 w 1237711"/>
              <a:gd name="connsiteY175" fmla="*/ 161981 h 720278"/>
              <a:gd name="connsiteX176" fmla="*/ 81289 w 1237711"/>
              <a:gd name="connsiteY176" fmla="*/ 149910 h 720278"/>
              <a:gd name="connsiteX177" fmla="*/ 102414 w 1237711"/>
              <a:gd name="connsiteY177" fmla="*/ 143874 h 720278"/>
              <a:gd name="connsiteX178" fmla="*/ 135610 w 1237711"/>
              <a:gd name="connsiteY178" fmla="*/ 140856 h 720278"/>
              <a:gd name="connsiteX179" fmla="*/ 156735 w 1237711"/>
              <a:gd name="connsiteY179" fmla="*/ 137838 h 720278"/>
              <a:gd name="connsiteX180" fmla="*/ 165788 w 1237711"/>
              <a:gd name="connsiteY180" fmla="*/ 131803 h 720278"/>
              <a:gd name="connsiteX181" fmla="*/ 183895 w 1237711"/>
              <a:gd name="connsiteY181" fmla="*/ 116714 h 720278"/>
              <a:gd name="connsiteX182" fmla="*/ 202002 w 1237711"/>
              <a:gd name="connsiteY182" fmla="*/ 110678 h 720278"/>
              <a:gd name="connsiteX183" fmla="*/ 214073 w 1237711"/>
              <a:gd name="connsiteY183" fmla="*/ 92571 h 720278"/>
              <a:gd name="connsiteX184" fmla="*/ 238216 w 1237711"/>
              <a:gd name="connsiteY184" fmla="*/ 83518 h 72027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  <a:cxn ang="0">
                <a:pos x="connsiteX165" y="connsiteY165"/>
              </a:cxn>
              <a:cxn ang="0">
                <a:pos x="connsiteX166" y="connsiteY166"/>
              </a:cxn>
              <a:cxn ang="0">
                <a:pos x="connsiteX167" y="connsiteY167"/>
              </a:cxn>
              <a:cxn ang="0">
                <a:pos x="connsiteX168" y="connsiteY168"/>
              </a:cxn>
              <a:cxn ang="0">
                <a:pos x="connsiteX169" y="connsiteY169"/>
              </a:cxn>
              <a:cxn ang="0">
                <a:pos x="connsiteX170" y="connsiteY170"/>
              </a:cxn>
              <a:cxn ang="0">
                <a:pos x="connsiteX171" y="connsiteY171"/>
              </a:cxn>
              <a:cxn ang="0">
                <a:pos x="connsiteX172" y="connsiteY172"/>
              </a:cxn>
              <a:cxn ang="0">
                <a:pos x="connsiteX173" y="connsiteY173"/>
              </a:cxn>
              <a:cxn ang="0">
                <a:pos x="connsiteX174" y="connsiteY174"/>
              </a:cxn>
              <a:cxn ang="0">
                <a:pos x="connsiteX175" y="connsiteY175"/>
              </a:cxn>
              <a:cxn ang="0">
                <a:pos x="connsiteX176" y="connsiteY176"/>
              </a:cxn>
              <a:cxn ang="0">
                <a:pos x="connsiteX177" y="connsiteY177"/>
              </a:cxn>
              <a:cxn ang="0">
                <a:pos x="connsiteX178" y="connsiteY178"/>
              </a:cxn>
              <a:cxn ang="0">
                <a:pos x="connsiteX179" y="connsiteY179"/>
              </a:cxn>
              <a:cxn ang="0">
                <a:pos x="connsiteX180" y="connsiteY180"/>
              </a:cxn>
              <a:cxn ang="0">
                <a:pos x="connsiteX181" y="connsiteY181"/>
              </a:cxn>
              <a:cxn ang="0">
                <a:pos x="connsiteX182" y="connsiteY182"/>
              </a:cxn>
              <a:cxn ang="0">
                <a:pos x="connsiteX183" y="connsiteY183"/>
              </a:cxn>
              <a:cxn ang="0">
                <a:pos x="connsiteX184" y="connsiteY184"/>
              </a:cxn>
            </a:cxnLst>
            <a:rect l="l" t="t" r="r" b="b"/>
            <a:pathLst>
              <a:path w="1237711" h="720278">
                <a:moveTo>
                  <a:pt x="238216" y="83518"/>
                </a:moveTo>
                <a:cubicBezTo>
                  <a:pt x="243749" y="81506"/>
                  <a:pt x="244088" y="80500"/>
                  <a:pt x="247269" y="80500"/>
                </a:cubicBezTo>
                <a:cubicBezTo>
                  <a:pt x="250450" y="80500"/>
                  <a:pt x="253237" y="82747"/>
                  <a:pt x="256323" y="83518"/>
                </a:cubicBezTo>
                <a:cubicBezTo>
                  <a:pt x="261299" y="84762"/>
                  <a:pt x="266382" y="85529"/>
                  <a:pt x="271412" y="86535"/>
                </a:cubicBezTo>
                <a:cubicBezTo>
                  <a:pt x="273424" y="90559"/>
                  <a:pt x="275675" y="94472"/>
                  <a:pt x="277447" y="98607"/>
                </a:cubicBezTo>
                <a:cubicBezTo>
                  <a:pt x="283477" y="112677"/>
                  <a:pt x="281931" y="123785"/>
                  <a:pt x="283483" y="140856"/>
                </a:cubicBezTo>
                <a:cubicBezTo>
                  <a:pt x="282477" y="166005"/>
                  <a:pt x="281722" y="191165"/>
                  <a:pt x="280465" y="216302"/>
                </a:cubicBezTo>
                <a:cubicBezTo>
                  <a:pt x="280052" y="224560"/>
                  <a:pt x="277636" y="270751"/>
                  <a:pt x="274430" y="285712"/>
                </a:cubicBezTo>
                <a:cubicBezTo>
                  <a:pt x="273097" y="291933"/>
                  <a:pt x="270406" y="297783"/>
                  <a:pt x="268394" y="303819"/>
                </a:cubicBezTo>
                <a:cubicBezTo>
                  <a:pt x="266772" y="308685"/>
                  <a:pt x="266620" y="313932"/>
                  <a:pt x="265376" y="318908"/>
                </a:cubicBezTo>
                <a:cubicBezTo>
                  <a:pt x="264604" y="321994"/>
                  <a:pt x="263364" y="324943"/>
                  <a:pt x="262358" y="327961"/>
                </a:cubicBezTo>
                <a:cubicBezTo>
                  <a:pt x="268820" y="399044"/>
                  <a:pt x="258278" y="327795"/>
                  <a:pt x="277447" y="385300"/>
                </a:cubicBezTo>
                <a:cubicBezTo>
                  <a:pt x="279459" y="391336"/>
                  <a:pt x="277792" y="400562"/>
                  <a:pt x="283483" y="403407"/>
                </a:cubicBezTo>
                <a:cubicBezTo>
                  <a:pt x="290864" y="407097"/>
                  <a:pt x="296616" y="410684"/>
                  <a:pt x="304608" y="412460"/>
                </a:cubicBezTo>
                <a:cubicBezTo>
                  <a:pt x="310581" y="413787"/>
                  <a:pt x="316679" y="414472"/>
                  <a:pt x="322715" y="415478"/>
                </a:cubicBezTo>
                <a:cubicBezTo>
                  <a:pt x="330860" y="418193"/>
                  <a:pt x="334997" y="421373"/>
                  <a:pt x="343839" y="415478"/>
                </a:cubicBezTo>
                <a:cubicBezTo>
                  <a:pt x="346857" y="413466"/>
                  <a:pt x="347863" y="409443"/>
                  <a:pt x="349875" y="406425"/>
                </a:cubicBezTo>
                <a:cubicBezTo>
                  <a:pt x="355179" y="390514"/>
                  <a:pt x="349388" y="403388"/>
                  <a:pt x="361946" y="388318"/>
                </a:cubicBezTo>
                <a:cubicBezTo>
                  <a:pt x="364268" y="385532"/>
                  <a:pt x="366360" y="382508"/>
                  <a:pt x="367982" y="379264"/>
                </a:cubicBezTo>
                <a:cubicBezTo>
                  <a:pt x="374788" y="365654"/>
                  <a:pt x="366225" y="374131"/>
                  <a:pt x="377036" y="361157"/>
                </a:cubicBezTo>
                <a:cubicBezTo>
                  <a:pt x="389054" y="346735"/>
                  <a:pt x="382198" y="356855"/>
                  <a:pt x="395142" y="346068"/>
                </a:cubicBezTo>
                <a:cubicBezTo>
                  <a:pt x="398421" y="343336"/>
                  <a:pt x="401576" y="340384"/>
                  <a:pt x="404196" y="337015"/>
                </a:cubicBezTo>
                <a:cubicBezTo>
                  <a:pt x="408650" y="331289"/>
                  <a:pt x="416267" y="318908"/>
                  <a:pt x="416267" y="318908"/>
                </a:cubicBezTo>
                <a:cubicBezTo>
                  <a:pt x="417273" y="314884"/>
                  <a:pt x="416984" y="310287"/>
                  <a:pt x="419285" y="306836"/>
                </a:cubicBezTo>
                <a:cubicBezTo>
                  <a:pt x="423608" y="300351"/>
                  <a:pt x="431368" y="300795"/>
                  <a:pt x="437392" y="297783"/>
                </a:cubicBezTo>
                <a:cubicBezTo>
                  <a:pt x="440636" y="296161"/>
                  <a:pt x="443427" y="293759"/>
                  <a:pt x="446445" y="291747"/>
                </a:cubicBezTo>
                <a:cubicBezTo>
                  <a:pt x="452481" y="293759"/>
                  <a:pt x="463652" y="291485"/>
                  <a:pt x="464552" y="297783"/>
                </a:cubicBezTo>
                <a:cubicBezTo>
                  <a:pt x="472224" y="351485"/>
                  <a:pt x="463473" y="295406"/>
                  <a:pt x="470588" y="330979"/>
                </a:cubicBezTo>
                <a:cubicBezTo>
                  <a:pt x="471788" y="336979"/>
                  <a:pt x="471334" y="343405"/>
                  <a:pt x="473606" y="349086"/>
                </a:cubicBezTo>
                <a:cubicBezTo>
                  <a:pt x="479494" y="363807"/>
                  <a:pt x="482442" y="360488"/>
                  <a:pt x="494731" y="364175"/>
                </a:cubicBezTo>
                <a:cubicBezTo>
                  <a:pt x="500825" y="366003"/>
                  <a:pt x="512838" y="370211"/>
                  <a:pt x="512838" y="370211"/>
                </a:cubicBezTo>
                <a:cubicBezTo>
                  <a:pt x="527927" y="369205"/>
                  <a:pt x="543394" y="370696"/>
                  <a:pt x="558105" y="367193"/>
                </a:cubicBezTo>
                <a:cubicBezTo>
                  <a:pt x="565162" y="365513"/>
                  <a:pt x="576212" y="355122"/>
                  <a:pt x="576212" y="355122"/>
                </a:cubicBezTo>
                <a:cubicBezTo>
                  <a:pt x="577218" y="345062"/>
                  <a:pt x="577693" y="334935"/>
                  <a:pt x="579230" y="324943"/>
                </a:cubicBezTo>
                <a:cubicBezTo>
                  <a:pt x="579714" y="321799"/>
                  <a:pt x="580483" y="318537"/>
                  <a:pt x="582247" y="315890"/>
                </a:cubicBezTo>
                <a:cubicBezTo>
                  <a:pt x="584614" y="312339"/>
                  <a:pt x="588569" y="310115"/>
                  <a:pt x="591301" y="306836"/>
                </a:cubicBezTo>
                <a:cubicBezTo>
                  <a:pt x="600052" y="296336"/>
                  <a:pt x="594540" y="296163"/>
                  <a:pt x="609408" y="288729"/>
                </a:cubicBezTo>
                <a:cubicBezTo>
                  <a:pt x="613118" y="286874"/>
                  <a:pt x="617544" y="287023"/>
                  <a:pt x="621479" y="285712"/>
                </a:cubicBezTo>
                <a:cubicBezTo>
                  <a:pt x="636242" y="280791"/>
                  <a:pt x="634534" y="281032"/>
                  <a:pt x="645622" y="273640"/>
                </a:cubicBezTo>
                <a:cubicBezTo>
                  <a:pt x="647634" y="270622"/>
                  <a:pt x="648170" y="265583"/>
                  <a:pt x="651657" y="264587"/>
                </a:cubicBezTo>
                <a:cubicBezTo>
                  <a:pt x="666742" y="260277"/>
                  <a:pt x="666418" y="269022"/>
                  <a:pt x="672782" y="276658"/>
                </a:cubicBezTo>
                <a:cubicBezTo>
                  <a:pt x="675514" y="279937"/>
                  <a:pt x="678818" y="282694"/>
                  <a:pt x="681836" y="285712"/>
                </a:cubicBezTo>
                <a:cubicBezTo>
                  <a:pt x="683848" y="289736"/>
                  <a:pt x="685256" y="294122"/>
                  <a:pt x="687871" y="297783"/>
                </a:cubicBezTo>
                <a:cubicBezTo>
                  <a:pt x="693150" y="305174"/>
                  <a:pt x="698762" y="308061"/>
                  <a:pt x="705978" y="312872"/>
                </a:cubicBezTo>
                <a:cubicBezTo>
                  <a:pt x="706984" y="316896"/>
                  <a:pt x="707540" y="321060"/>
                  <a:pt x="708996" y="324943"/>
                </a:cubicBezTo>
                <a:cubicBezTo>
                  <a:pt x="713629" y="337297"/>
                  <a:pt x="716416" y="338130"/>
                  <a:pt x="724085" y="349086"/>
                </a:cubicBezTo>
                <a:cubicBezTo>
                  <a:pt x="728245" y="355029"/>
                  <a:pt x="732132" y="361157"/>
                  <a:pt x="736156" y="367193"/>
                </a:cubicBezTo>
                <a:cubicBezTo>
                  <a:pt x="738168" y="370211"/>
                  <a:pt x="739360" y="373980"/>
                  <a:pt x="742192" y="376246"/>
                </a:cubicBezTo>
                <a:cubicBezTo>
                  <a:pt x="747222" y="380270"/>
                  <a:pt x="752515" y="383985"/>
                  <a:pt x="757281" y="388318"/>
                </a:cubicBezTo>
                <a:cubicBezTo>
                  <a:pt x="781222" y="410083"/>
                  <a:pt x="765698" y="404003"/>
                  <a:pt x="787459" y="409442"/>
                </a:cubicBezTo>
                <a:cubicBezTo>
                  <a:pt x="796513" y="408436"/>
                  <a:pt x="806059" y="409538"/>
                  <a:pt x="814620" y="406425"/>
                </a:cubicBezTo>
                <a:cubicBezTo>
                  <a:pt x="818029" y="405186"/>
                  <a:pt x="818333" y="400157"/>
                  <a:pt x="820655" y="397371"/>
                </a:cubicBezTo>
                <a:cubicBezTo>
                  <a:pt x="823387" y="394092"/>
                  <a:pt x="826691" y="391336"/>
                  <a:pt x="829709" y="388318"/>
                </a:cubicBezTo>
                <a:cubicBezTo>
                  <a:pt x="828703" y="361157"/>
                  <a:pt x="828441" y="333959"/>
                  <a:pt x="826691" y="306836"/>
                </a:cubicBezTo>
                <a:cubicBezTo>
                  <a:pt x="826424" y="302697"/>
                  <a:pt x="824437" y="298841"/>
                  <a:pt x="823673" y="294765"/>
                </a:cubicBezTo>
                <a:cubicBezTo>
                  <a:pt x="821418" y="282737"/>
                  <a:pt x="821508" y="270161"/>
                  <a:pt x="817638" y="258551"/>
                </a:cubicBezTo>
                <a:cubicBezTo>
                  <a:pt x="810290" y="236509"/>
                  <a:pt x="813145" y="246616"/>
                  <a:pt x="808584" y="228373"/>
                </a:cubicBezTo>
                <a:cubicBezTo>
                  <a:pt x="810187" y="202723"/>
                  <a:pt x="800644" y="184374"/>
                  <a:pt x="820655" y="171034"/>
                </a:cubicBezTo>
                <a:cubicBezTo>
                  <a:pt x="823302" y="169269"/>
                  <a:pt x="826691" y="169023"/>
                  <a:pt x="829709" y="168017"/>
                </a:cubicBezTo>
                <a:cubicBezTo>
                  <a:pt x="846180" y="200963"/>
                  <a:pt x="824894" y="163377"/>
                  <a:pt x="844798" y="186124"/>
                </a:cubicBezTo>
                <a:cubicBezTo>
                  <a:pt x="844799" y="186125"/>
                  <a:pt x="859887" y="208757"/>
                  <a:pt x="862905" y="213284"/>
                </a:cubicBezTo>
                <a:lnTo>
                  <a:pt x="874976" y="231391"/>
                </a:lnTo>
                <a:lnTo>
                  <a:pt x="881012" y="240444"/>
                </a:lnTo>
                <a:cubicBezTo>
                  <a:pt x="888090" y="261678"/>
                  <a:pt x="878878" y="235464"/>
                  <a:pt x="890065" y="261569"/>
                </a:cubicBezTo>
                <a:cubicBezTo>
                  <a:pt x="891318" y="264493"/>
                  <a:pt x="890834" y="268374"/>
                  <a:pt x="893083" y="270623"/>
                </a:cubicBezTo>
                <a:cubicBezTo>
                  <a:pt x="897231" y="274771"/>
                  <a:pt x="903045" y="276827"/>
                  <a:pt x="908172" y="279676"/>
                </a:cubicBezTo>
                <a:cubicBezTo>
                  <a:pt x="912105" y="281861"/>
                  <a:pt x="916337" y="283480"/>
                  <a:pt x="920243" y="285712"/>
                </a:cubicBezTo>
                <a:cubicBezTo>
                  <a:pt x="936621" y="295070"/>
                  <a:pt x="921754" y="289233"/>
                  <a:pt x="938350" y="294765"/>
                </a:cubicBezTo>
                <a:cubicBezTo>
                  <a:pt x="958469" y="292753"/>
                  <a:pt x="979200" y="294049"/>
                  <a:pt x="998707" y="288729"/>
                </a:cubicBezTo>
                <a:cubicBezTo>
                  <a:pt x="1003047" y="287545"/>
                  <a:pt x="1003071" y="280835"/>
                  <a:pt x="1004742" y="276658"/>
                </a:cubicBezTo>
                <a:cubicBezTo>
                  <a:pt x="1007105" y="270751"/>
                  <a:pt x="1008766" y="264587"/>
                  <a:pt x="1010778" y="258551"/>
                </a:cubicBezTo>
                <a:lnTo>
                  <a:pt x="1013796" y="249498"/>
                </a:lnTo>
                <a:cubicBezTo>
                  <a:pt x="1012790" y="233403"/>
                  <a:pt x="1015668" y="216580"/>
                  <a:pt x="1010778" y="201213"/>
                </a:cubicBezTo>
                <a:cubicBezTo>
                  <a:pt x="1009266" y="196460"/>
                  <a:pt x="991632" y="181077"/>
                  <a:pt x="983618" y="177070"/>
                </a:cubicBezTo>
                <a:cubicBezTo>
                  <a:pt x="980773" y="175647"/>
                  <a:pt x="977345" y="175597"/>
                  <a:pt x="974564" y="174052"/>
                </a:cubicBezTo>
                <a:cubicBezTo>
                  <a:pt x="961785" y="166953"/>
                  <a:pt x="948138" y="157415"/>
                  <a:pt x="941368" y="143874"/>
                </a:cubicBezTo>
                <a:cubicBezTo>
                  <a:pt x="937761" y="136660"/>
                  <a:pt x="934926" y="127565"/>
                  <a:pt x="932315" y="119731"/>
                </a:cubicBezTo>
                <a:cubicBezTo>
                  <a:pt x="931309" y="112690"/>
                  <a:pt x="930569" y="105605"/>
                  <a:pt x="929297" y="98607"/>
                </a:cubicBezTo>
                <a:cubicBezTo>
                  <a:pt x="928555" y="94526"/>
                  <a:pt x="926082" y="90678"/>
                  <a:pt x="926279" y="86535"/>
                </a:cubicBezTo>
                <a:cubicBezTo>
                  <a:pt x="927098" y="69336"/>
                  <a:pt x="930303" y="52333"/>
                  <a:pt x="932315" y="35232"/>
                </a:cubicBezTo>
                <a:cubicBezTo>
                  <a:pt x="941368" y="36238"/>
                  <a:pt x="950371" y="37947"/>
                  <a:pt x="959475" y="38250"/>
                </a:cubicBezTo>
                <a:cubicBezTo>
                  <a:pt x="1120091" y="43604"/>
                  <a:pt x="1082430" y="0"/>
                  <a:pt x="1122438" y="53339"/>
                </a:cubicBezTo>
                <a:cubicBezTo>
                  <a:pt x="1123444" y="56357"/>
                  <a:pt x="1124581" y="59334"/>
                  <a:pt x="1125455" y="62393"/>
                </a:cubicBezTo>
                <a:cubicBezTo>
                  <a:pt x="1126594" y="66381"/>
                  <a:pt x="1126839" y="70652"/>
                  <a:pt x="1128473" y="74464"/>
                </a:cubicBezTo>
                <a:cubicBezTo>
                  <a:pt x="1129902" y="77798"/>
                  <a:pt x="1132887" y="80274"/>
                  <a:pt x="1134509" y="83518"/>
                </a:cubicBezTo>
                <a:cubicBezTo>
                  <a:pt x="1135932" y="86363"/>
                  <a:pt x="1136105" y="89726"/>
                  <a:pt x="1137527" y="92571"/>
                </a:cubicBezTo>
                <a:cubicBezTo>
                  <a:pt x="1143149" y="103816"/>
                  <a:pt x="1144268" y="100661"/>
                  <a:pt x="1152616" y="110678"/>
                </a:cubicBezTo>
                <a:cubicBezTo>
                  <a:pt x="1165192" y="125768"/>
                  <a:pt x="1151104" y="114700"/>
                  <a:pt x="1167705" y="125767"/>
                </a:cubicBezTo>
                <a:cubicBezTo>
                  <a:pt x="1188577" y="157080"/>
                  <a:pt x="1155187" y="110232"/>
                  <a:pt x="1185812" y="140856"/>
                </a:cubicBezTo>
                <a:cubicBezTo>
                  <a:pt x="1190941" y="145985"/>
                  <a:pt x="1197883" y="158963"/>
                  <a:pt x="1197883" y="158963"/>
                </a:cubicBezTo>
                <a:cubicBezTo>
                  <a:pt x="1205471" y="181728"/>
                  <a:pt x="1195233" y="153661"/>
                  <a:pt x="1206937" y="177070"/>
                </a:cubicBezTo>
                <a:cubicBezTo>
                  <a:pt x="1208360" y="179915"/>
                  <a:pt x="1208701" y="183200"/>
                  <a:pt x="1209954" y="186124"/>
                </a:cubicBezTo>
                <a:cubicBezTo>
                  <a:pt x="1211726" y="190259"/>
                  <a:pt x="1214410" y="193983"/>
                  <a:pt x="1215990" y="198195"/>
                </a:cubicBezTo>
                <a:cubicBezTo>
                  <a:pt x="1217446" y="202078"/>
                  <a:pt x="1217374" y="206454"/>
                  <a:pt x="1219008" y="210266"/>
                </a:cubicBezTo>
                <a:cubicBezTo>
                  <a:pt x="1220437" y="213600"/>
                  <a:pt x="1223031" y="216302"/>
                  <a:pt x="1225043" y="219320"/>
                </a:cubicBezTo>
                <a:lnTo>
                  <a:pt x="1231079" y="249498"/>
                </a:lnTo>
                <a:cubicBezTo>
                  <a:pt x="1236390" y="276054"/>
                  <a:pt x="1231241" y="259039"/>
                  <a:pt x="1237115" y="276658"/>
                </a:cubicBezTo>
                <a:cubicBezTo>
                  <a:pt x="1236006" y="304375"/>
                  <a:pt x="1237711" y="340368"/>
                  <a:pt x="1231079" y="370211"/>
                </a:cubicBezTo>
                <a:cubicBezTo>
                  <a:pt x="1228902" y="380007"/>
                  <a:pt x="1226282" y="381403"/>
                  <a:pt x="1222026" y="391335"/>
                </a:cubicBezTo>
                <a:cubicBezTo>
                  <a:pt x="1214531" y="408824"/>
                  <a:pt x="1224569" y="392048"/>
                  <a:pt x="1212972" y="409442"/>
                </a:cubicBezTo>
                <a:lnTo>
                  <a:pt x="1206937" y="427549"/>
                </a:lnTo>
                <a:cubicBezTo>
                  <a:pt x="1205931" y="430567"/>
                  <a:pt x="1205684" y="433956"/>
                  <a:pt x="1203919" y="436603"/>
                </a:cubicBezTo>
                <a:cubicBezTo>
                  <a:pt x="1201907" y="439621"/>
                  <a:pt x="1200205" y="442870"/>
                  <a:pt x="1197883" y="445656"/>
                </a:cubicBezTo>
                <a:cubicBezTo>
                  <a:pt x="1193015" y="451498"/>
                  <a:pt x="1183121" y="460127"/>
                  <a:pt x="1176758" y="463763"/>
                </a:cubicBezTo>
                <a:cubicBezTo>
                  <a:pt x="1173996" y="465341"/>
                  <a:pt x="1170550" y="465358"/>
                  <a:pt x="1167705" y="466781"/>
                </a:cubicBezTo>
                <a:cubicBezTo>
                  <a:pt x="1164461" y="468403"/>
                  <a:pt x="1161895" y="471195"/>
                  <a:pt x="1158651" y="472817"/>
                </a:cubicBezTo>
                <a:cubicBezTo>
                  <a:pt x="1155806" y="474239"/>
                  <a:pt x="1152522" y="474581"/>
                  <a:pt x="1149598" y="475834"/>
                </a:cubicBezTo>
                <a:cubicBezTo>
                  <a:pt x="1145463" y="477606"/>
                  <a:pt x="1141704" y="480199"/>
                  <a:pt x="1137527" y="481870"/>
                </a:cubicBezTo>
                <a:cubicBezTo>
                  <a:pt x="1131620" y="484233"/>
                  <a:pt x="1119420" y="487906"/>
                  <a:pt x="1119420" y="487906"/>
                </a:cubicBezTo>
                <a:cubicBezTo>
                  <a:pt x="1095879" y="511444"/>
                  <a:pt x="1126100" y="483134"/>
                  <a:pt x="1098295" y="502995"/>
                </a:cubicBezTo>
                <a:cubicBezTo>
                  <a:pt x="1094822" y="505476"/>
                  <a:pt x="1092792" y="509681"/>
                  <a:pt x="1089241" y="512048"/>
                </a:cubicBezTo>
                <a:cubicBezTo>
                  <a:pt x="1086594" y="513812"/>
                  <a:pt x="1083033" y="513643"/>
                  <a:pt x="1080188" y="515066"/>
                </a:cubicBezTo>
                <a:cubicBezTo>
                  <a:pt x="1068953" y="520684"/>
                  <a:pt x="1072089" y="521815"/>
                  <a:pt x="1062081" y="530155"/>
                </a:cubicBezTo>
                <a:cubicBezTo>
                  <a:pt x="1059295" y="532477"/>
                  <a:pt x="1055593" y="533626"/>
                  <a:pt x="1053028" y="536191"/>
                </a:cubicBezTo>
                <a:cubicBezTo>
                  <a:pt x="1049471" y="539748"/>
                  <a:pt x="1046858" y="544142"/>
                  <a:pt x="1043974" y="548262"/>
                </a:cubicBezTo>
                <a:cubicBezTo>
                  <a:pt x="1039814" y="554205"/>
                  <a:pt x="1037032" y="561240"/>
                  <a:pt x="1031903" y="566369"/>
                </a:cubicBezTo>
                <a:cubicBezTo>
                  <a:pt x="1025867" y="572405"/>
                  <a:pt x="1021894" y="581777"/>
                  <a:pt x="1013796" y="584476"/>
                </a:cubicBezTo>
                <a:cubicBezTo>
                  <a:pt x="1000807" y="588806"/>
                  <a:pt x="1007828" y="586722"/>
                  <a:pt x="992671" y="590512"/>
                </a:cubicBezTo>
                <a:cubicBezTo>
                  <a:pt x="972675" y="603842"/>
                  <a:pt x="995669" y="590516"/>
                  <a:pt x="956457" y="599565"/>
                </a:cubicBezTo>
                <a:cubicBezTo>
                  <a:pt x="952074" y="600577"/>
                  <a:pt x="948598" y="604021"/>
                  <a:pt x="944386" y="605601"/>
                </a:cubicBezTo>
                <a:cubicBezTo>
                  <a:pt x="940503" y="607057"/>
                  <a:pt x="936198" y="607163"/>
                  <a:pt x="932315" y="608619"/>
                </a:cubicBezTo>
                <a:cubicBezTo>
                  <a:pt x="928103" y="610199"/>
                  <a:pt x="924673" y="613872"/>
                  <a:pt x="920243" y="614654"/>
                </a:cubicBezTo>
                <a:cubicBezTo>
                  <a:pt x="907327" y="616933"/>
                  <a:pt x="894089" y="616666"/>
                  <a:pt x="881012" y="617672"/>
                </a:cubicBezTo>
                <a:cubicBezTo>
                  <a:pt x="843795" y="630078"/>
                  <a:pt x="869259" y="624026"/>
                  <a:pt x="802548" y="620690"/>
                </a:cubicBezTo>
                <a:cubicBezTo>
                  <a:pt x="799530" y="619684"/>
                  <a:pt x="796419" y="618925"/>
                  <a:pt x="793495" y="617672"/>
                </a:cubicBezTo>
                <a:cubicBezTo>
                  <a:pt x="789360" y="615900"/>
                  <a:pt x="785900" y="612084"/>
                  <a:pt x="781424" y="611636"/>
                </a:cubicBezTo>
                <a:cubicBezTo>
                  <a:pt x="775335" y="611027"/>
                  <a:pt x="769353" y="613648"/>
                  <a:pt x="763317" y="614654"/>
                </a:cubicBezTo>
                <a:cubicBezTo>
                  <a:pt x="761305" y="617672"/>
                  <a:pt x="760067" y="621386"/>
                  <a:pt x="757281" y="623708"/>
                </a:cubicBezTo>
                <a:cubicBezTo>
                  <a:pt x="749945" y="629821"/>
                  <a:pt x="741788" y="630290"/>
                  <a:pt x="733139" y="632761"/>
                </a:cubicBezTo>
                <a:cubicBezTo>
                  <a:pt x="730080" y="633635"/>
                  <a:pt x="727103" y="634773"/>
                  <a:pt x="724085" y="635779"/>
                </a:cubicBezTo>
                <a:cubicBezTo>
                  <a:pt x="721067" y="637791"/>
                  <a:pt x="717818" y="639493"/>
                  <a:pt x="715032" y="641815"/>
                </a:cubicBezTo>
                <a:cubicBezTo>
                  <a:pt x="711753" y="644547"/>
                  <a:pt x="709529" y="648501"/>
                  <a:pt x="705978" y="650868"/>
                </a:cubicBezTo>
                <a:cubicBezTo>
                  <a:pt x="703331" y="652632"/>
                  <a:pt x="699943" y="652880"/>
                  <a:pt x="696925" y="653886"/>
                </a:cubicBezTo>
                <a:cubicBezTo>
                  <a:pt x="692901" y="656904"/>
                  <a:pt x="689352" y="660690"/>
                  <a:pt x="684853" y="662939"/>
                </a:cubicBezTo>
                <a:cubicBezTo>
                  <a:pt x="681143" y="664794"/>
                  <a:pt x="676831" y="665057"/>
                  <a:pt x="672782" y="665957"/>
                </a:cubicBezTo>
                <a:cubicBezTo>
                  <a:pt x="649107" y="671219"/>
                  <a:pt x="651876" y="669423"/>
                  <a:pt x="618461" y="671993"/>
                </a:cubicBezTo>
                <a:cubicBezTo>
                  <a:pt x="577262" y="685724"/>
                  <a:pt x="619355" y="670746"/>
                  <a:pt x="588283" y="684064"/>
                </a:cubicBezTo>
                <a:cubicBezTo>
                  <a:pt x="585359" y="685317"/>
                  <a:pt x="582075" y="685659"/>
                  <a:pt x="579230" y="687082"/>
                </a:cubicBezTo>
                <a:cubicBezTo>
                  <a:pt x="561720" y="695837"/>
                  <a:pt x="579265" y="691218"/>
                  <a:pt x="558105" y="699153"/>
                </a:cubicBezTo>
                <a:cubicBezTo>
                  <a:pt x="554222" y="700609"/>
                  <a:pt x="549917" y="700715"/>
                  <a:pt x="546034" y="702171"/>
                </a:cubicBezTo>
                <a:cubicBezTo>
                  <a:pt x="541822" y="703751"/>
                  <a:pt x="538374" y="707325"/>
                  <a:pt x="533962" y="708207"/>
                </a:cubicBezTo>
                <a:cubicBezTo>
                  <a:pt x="518057" y="711388"/>
                  <a:pt x="485677" y="714242"/>
                  <a:pt x="485677" y="714242"/>
                </a:cubicBezTo>
                <a:cubicBezTo>
                  <a:pt x="481021" y="715406"/>
                  <a:pt x="462348" y="720278"/>
                  <a:pt x="458517" y="720278"/>
                </a:cubicBezTo>
                <a:cubicBezTo>
                  <a:pt x="439378" y="720278"/>
                  <a:pt x="420291" y="718266"/>
                  <a:pt x="401178" y="717260"/>
                </a:cubicBezTo>
                <a:cubicBezTo>
                  <a:pt x="347821" y="708367"/>
                  <a:pt x="414378" y="719660"/>
                  <a:pt x="367982" y="711225"/>
                </a:cubicBezTo>
                <a:cubicBezTo>
                  <a:pt x="361962" y="710131"/>
                  <a:pt x="355895" y="709302"/>
                  <a:pt x="349875" y="708207"/>
                </a:cubicBezTo>
                <a:cubicBezTo>
                  <a:pt x="344828" y="707289"/>
                  <a:pt x="339870" y="705867"/>
                  <a:pt x="334786" y="705189"/>
                </a:cubicBezTo>
                <a:cubicBezTo>
                  <a:pt x="324765" y="703853"/>
                  <a:pt x="314667" y="703177"/>
                  <a:pt x="304608" y="702171"/>
                </a:cubicBezTo>
                <a:cubicBezTo>
                  <a:pt x="265131" y="692301"/>
                  <a:pt x="309390" y="702171"/>
                  <a:pt x="214073" y="702171"/>
                </a:cubicBezTo>
                <a:cubicBezTo>
                  <a:pt x="199954" y="702171"/>
                  <a:pt x="185907" y="700159"/>
                  <a:pt x="171824" y="699153"/>
                </a:cubicBezTo>
                <a:cubicBezTo>
                  <a:pt x="168806" y="697141"/>
                  <a:pt x="165036" y="695950"/>
                  <a:pt x="162770" y="693118"/>
                </a:cubicBezTo>
                <a:cubicBezTo>
                  <a:pt x="160783" y="690634"/>
                  <a:pt x="161175" y="686909"/>
                  <a:pt x="159752" y="684064"/>
                </a:cubicBezTo>
                <a:cubicBezTo>
                  <a:pt x="145404" y="655367"/>
                  <a:pt x="163256" y="703625"/>
                  <a:pt x="147681" y="656904"/>
                </a:cubicBezTo>
                <a:cubicBezTo>
                  <a:pt x="145945" y="651697"/>
                  <a:pt x="132123" y="641978"/>
                  <a:pt x="126556" y="638797"/>
                </a:cubicBezTo>
                <a:cubicBezTo>
                  <a:pt x="122650" y="636565"/>
                  <a:pt x="117967" y="635610"/>
                  <a:pt x="114485" y="632761"/>
                </a:cubicBezTo>
                <a:cubicBezTo>
                  <a:pt x="110427" y="629441"/>
                  <a:pt x="91734" y="612504"/>
                  <a:pt x="87325" y="602583"/>
                </a:cubicBezTo>
                <a:cubicBezTo>
                  <a:pt x="75509" y="575997"/>
                  <a:pt x="88759" y="591946"/>
                  <a:pt x="72236" y="575423"/>
                </a:cubicBezTo>
                <a:cubicBezTo>
                  <a:pt x="71230" y="572405"/>
                  <a:pt x="70983" y="569016"/>
                  <a:pt x="69218" y="566369"/>
                </a:cubicBezTo>
                <a:cubicBezTo>
                  <a:pt x="55864" y="546340"/>
                  <a:pt x="64005" y="568016"/>
                  <a:pt x="54129" y="548262"/>
                </a:cubicBezTo>
                <a:cubicBezTo>
                  <a:pt x="52707" y="545417"/>
                  <a:pt x="52534" y="542054"/>
                  <a:pt x="51111" y="539209"/>
                </a:cubicBezTo>
                <a:cubicBezTo>
                  <a:pt x="49489" y="535965"/>
                  <a:pt x="46697" y="533399"/>
                  <a:pt x="45075" y="530155"/>
                </a:cubicBezTo>
                <a:cubicBezTo>
                  <a:pt x="43652" y="527310"/>
                  <a:pt x="43479" y="523947"/>
                  <a:pt x="42057" y="521102"/>
                </a:cubicBezTo>
                <a:cubicBezTo>
                  <a:pt x="40435" y="517858"/>
                  <a:pt x="37644" y="515292"/>
                  <a:pt x="36022" y="512048"/>
                </a:cubicBezTo>
                <a:cubicBezTo>
                  <a:pt x="33599" y="507203"/>
                  <a:pt x="31699" y="502098"/>
                  <a:pt x="29986" y="496959"/>
                </a:cubicBezTo>
                <a:cubicBezTo>
                  <a:pt x="26156" y="485470"/>
                  <a:pt x="28311" y="486009"/>
                  <a:pt x="23950" y="475834"/>
                </a:cubicBezTo>
                <a:cubicBezTo>
                  <a:pt x="22178" y="471699"/>
                  <a:pt x="19586" y="467940"/>
                  <a:pt x="17915" y="463763"/>
                </a:cubicBezTo>
                <a:cubicBezTo>
                  <a:pt x="15552" y="457856"/>
                  <a:pt x="13891" y="451692"/>
                  <a:pt x="11879" y="445656"/>
                </a:cubicBezTo>
                <a:cubicBezTo>
                  <a:pt x="10166" y="440517"/>
                  <a:pt x="7855" y="435597"/>
                  <a:pt x="5843" y="430567"/>
                </a:cubicBezTo>
                <a:cubicBezTo>
                  <a:pt x="0" y="377970"/>
                  <a:pt x="1240" y="401057"/>
                  <a:pt x="5843" y="315890"/>
                </a:cubicBezTo>
                <a:cubicBezTo>
                  <a:pt x="6501" y="303709"/>
                  <a:pt x="8364" y="291393"/>
                  <a:pt x="11879" y="279676"/>
                </a:cubicBezTo>
                <a:cubicBezTo>
                  <a:pt x="13707" y="273582"/>
                  <a:pt x="17915" y="261569"/>
                  <a:pt x="17915" y="261569"/>
                </a:cubicBezTo>
                <a:cubicBezTo>
                  <a:pt x="23145" y="224963"/>
                  <a:pt x="18261" y="253977"/>
                  <a:pt x="23950" y="228373"/>
                </a:cubicBezTo>
                <a:cubicBezTo>
                  <a:pt x="25063" y="223366"/>
                  <a:pt x="25724" y="218260"/>
                  <a:pt x="26968" y="213284"/>
                </a:cubicBezTo>
                <a:cubicBezTo>
                  <a:pt x="30207" y="200327"/>
                  <a:pt x="30262" y="206560"/>
                  <a:pt x="36022" y="192159"/>
                </a:cubicBezTo>
                <a:cubicBezTo>
                  <a:pt x="38385" y="186252"/>
                  <a:pt x="36967" y="177869"/>
                  <a:pt x="42057" y="174052"/>
                </a:cubicBezTo>
                <a:cubicBezTo>
                  <a:pt x="81664" y="144350"/>
                  <a:pt x="33553" y="178442"/>
                  <a:pt x="63182" y="161981"/>
                </a:cubicBezTo>
                <a:cubicBezTo>
                  <a:pt x="69523" y="158458"/>
                  <a:pt x="74252" y="151669"/>
                  <a:pt x="81289" y="149910"/>
                </a:cubicBezTo>
                <a:cubicBezTo>
                  <a:pt x="96446" y="146120"/>
                  <a:pt x="89425" y="148204"/>
                  <a:pt x="102414" y="143874"/>
                </a:cubicBezTo>
                <a:cubicBezTo>
                  <a:pt x="120541" y="131788"/>
                  <a:pt x="102667" y="140856"/>
                  <a:pt x="135610" y="140856"/>
                </a:cubicBezTo>
                <a:cubicBezTo>
                  <a:pt x="142723" y="140856"/>
                  <a:pt x="149693" y="138844"/>
                  <a:pt x="156735" y="137838"/>
                </a:cubicBezTo>
                <a:cubicBezTo>
                  <a:pt x="159753" y="135826"/>
                  <a:pt x="163002" y="134125"/>
                  <a:pt x="165788" y="131803"/>
                </a:cubicBezTo>
                <a:cubicBezTo>
                  <a:pt x="173915" y="125030"/>
                  <a:pt x="174256" y="120998"/>
                  <a:pt x="183895" y="116714"/>
                </a:cubicBezTo>
                <a:cubicBezTo>
                  <a:pt x="189709" y="114130"/>
                  <a:pt x="202002" y="110678"/>
                  <a:pt x="202002" y="110678"/>
                </a:cubicBezTo>
                <a:cubicBezTo>
                  <a:pt x="211351" y="101329"/>
                  <a:pt x="211161" y="104218"/>
                  <a:pt x="214073" y="92571"/>
                </a:cubicBezTo>
                <a:cubicBezTo>
                  <a:pt x="214317" y="91595"/>
                  <a:pt x="232683" y="85530"/>
                  <a:pt x="238216" y="83518"/>
                </a:cubicBezTo>
                <a:close/>
              </a:path>
            </a:pathLst>
          </a:custGeom>
          <a:noFill/>
          <a:ln w="222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24" name="手繪多邊形 123"/>
          <p:cNvSpPr/>
          <p:nvPr/>
        </p:nvSpPr>
        <p:spPr>
          <a:xfrm>
            <a:off x="2308425" y="2649373"/>
            <a:ext cx="1269094" cy="692526"/>
          </a:xfrm>
          <a:custGeom>
            <a:avLst/>
            <a:gdLst>
              <a:gd name="connsiteX0" fmla="*/ 221344 w 1269094"/>
              <a:gd name="connsiteY0" fmla="*/ 4388 h 692526"/>
              <a:gd name="connsiteX1" fmla="*/ 237219 w 1269094"/>
              <a:gd name="connsiteY1" fmla="*/ 1213 h 692526"/>
              <a:gd name="connsiteX2" fmla="*/ 262619 w 1269094"/>
              <a:gd name="connsiteY2" fmla="*/ 13913 h 692526"/>
              <a:gd name="connsiteX3" fmla="*/ 268969 w 1269094"/>
              <a:gd name="connsiteY3" fmla="*/ 23438 h 692526"/>
              <a:gd name="connsiteX4" fmla="*/ 275319 w 1269094"/>
              <a:gd name="connsiteY4" fmla="*/ 42488 h 692526"/>
              <a:gd name="connsiteX5" fmla="*/ 272144 w 1269094"/>
              <a:gd name="connsiteY5" fmla="*/ 71063 h 692526"/>
              <a:gd name="connsiteX6" fmla="*/ 262619 w 1269094"/>
              <a:gd name="connsiteY6" fmla="*/ 77413 h 692526"/>
              <a:gd name="connsiteX7" fmla="*/ 253094 w 1269094"/>
              <a:gd name="connsiteY7" fmla="*/ 80588 h 692526"/>
              <a:gd name="connsiteX8" fmla="*/ 205469 w 1269094"/>
              <a:gd name="connsiteY8" fmla="*/ 86938 h 692526"/>
              <a:gd name="connsiteX9" fmla="*/ 176894 w 1269094"/>
              <a:gd name="connsiteY9" fmla="*/ 99638 h 692526"/>
              <a:gd name="connsiteX10" fmla="*/ 164194 w 1269094"/>
              <a:gd name="connsiteY10" fmla="*/ 118688 h 692526"/>
              <a:gd name="connsiteX11" fmla="*/ 157844 w 1269094"/>
              <a:gd name="connsiteY11" fmla="*/ 128213 h 692526"/>
              <a:gd name="connsiteX12" fmla="*/ 148319 w 1269094"/>
              <a:gd name="connsiteY12" fmla="*/ 150438 h 692526"/>
              <a:gd name="connsiteX13" fmla="*/ 138794 w 1269094"/>
              <a:gd name="connsiteY13" fmla="*/ 182188 h 692526"/>
              <a:gd name="connsiteX14" fmla="*/ 141969 w 1269094"/>
              <a:gd name="connsiteY14" fmla="*/ 207588 h 692526"/>
              <a:gd name="connsiteX15" fmla="*/ 173719 w 1269094"/>
              <a:gd name="connsiteY15" fmla="*/ 217113 h 692526"/>
              <a:gd name="connsiteX16" fmla="*/ 202294 w 1269094"/>
              <a:gd name="connsiteY16" fmla="*/ 223463 h 692526"/>
              <a:gd name="connsiteX17" fmla="*/ 249919 w 1269094"/>
              <a:gd name="connsiteY17" fmla="*/ 220288 h 692526"/>
              <a:gd name="connsiteX18" fmla="*/ 272144 w 1269094"/>
              <a:gd name="connsiteY18" fmla="*/ 217113 h 692526"/>
              <a:gd name="connsiteX19" fmla="*/ 281669 w 1269094"/>
              <a:gd name="connsiteY19" fmla="*/ 213938 h 692526"/>
              <a:gd name="connsiteX20" fmla="*/ 300719 w 1269094"/>
              <a:gd name="connsiteY20" fmla="*/ 217113 h 692526"/>
              <a:gd name="connsiteX21" fmla="*/ 303894 w 1269094"/>
              <a:gd name="connsiteY21" fmla="*/ 229813 h 692526"/>
              <a:gd name="connsiteX22" fmla="*/ 319769 w 1269094"/>
              <a:gd name="connsiteY22" fmla="*/ 252038 h 692526"/>
              <a:gd name="connsiteX23" fmla="*/ 332469 w 1269094"/>
              <a:gd name="connsiteY23" fmla="*/ 280613 h 692526"/>
              <a:gd name="connsiteX24" fmla="*/ 332469 w 1269094"/>
              <a:gd name="connsiteY24" fmla="*/ 350463 h 692526"/>
              <a:gd name="connsiteX25" fmla="*/ 326119 w 1269094"/>
              <a:gd name="connsiteY25" fmla="*/ 363163 h 692526"/>
              <a:gd name="connsiteX26" fmla="*/ 319769 w 1269094"/>
              <a:gd name="connsiteY26" fmla="*/ 382213 h 692526"/>
              <a:gd name="connsiteX27" fmla="*/ 322944 w 1269094"/>
              <a:gd name="connsiteY27" fmla="*/ 391738 h 692526"/>
              <a:gd name="connsiteX28" fmla="*/ 376919 w 1269094"/>
              <a:gd name="connsiteY28" fmla="*/ 391738 h 692526"/>
              <a:gd name="connsiteX29" fmla="*/ 380094 w 1269094"/>
              <a:gd name="connsiteY29" fmla="*/ 382213 h 692526"/>
              <a:gd name="connsiteX30" fmla="*/ 399144 w 1269094"/>
              <a:gd name="connsiteY30" fmla="*/ 366338 h 692526"/>
              <a:gd name="connsiteX31" fmla="*/ 453119 w 1269094"/>
              <a:gd name="connsiteY31" fmla="*/ 369513 h 692526"/>
              <a:gd name="connsiteX32" fmla="*/ 472169 w 1269094"/>
              <a:gd name="connsiteY32" fmla="*/ 375863 h 692526"/>
              <a:gd name="connsiteX33" fmla="*/ 554719 w 1269094"/>
              <a:gd name="connsiteY33" fmla="*/ 372688 h 692526"/>
              <a:gd name="connsiteX34" fmla="*/ 557894 w 1269094"/>
              <a:gd name="connsiteY34" fmla="*/ 363163 h 692526"/>
              <a:gd name="connsiteX35" fmla="*/ 554719 w 1269094"/>
              <a:gd name="connsiteY35" fmla="*/ 328238 h 692526"/>
              <a:gd name="connsiteX36" fmla="*/ 545194 w 1269094"/>
              <a:gd name="connsiteY36" fmla="*/ 271088 h 692526"/>
              <a:gd name="connsiteX37" fmla="*/ 535669 w 1269094"/>
              <a:gd name="connsiteY37" fmla="*/ 264738 h 692526"/>
              <a:gd name="connsiteX38" fmla="*/ 538844 w 1269094"/>
              <a:gd name="connsiteY38" fmla="*/ 232988 h 692526"/>
              <a:gd name="connsiteX39" fmla="*/ 542019 w 1269094"/>
              <a:gd name="connsiteY39" fmla="*/ 223463 h 692526"/>
              <a:gd name="connsiteX40" fmla="*/ 567419 w 1269094"/>
              <a:gd name="connsiteY40" fmla="*/ 210763 h 692526"/>
              <a:gd name="connsiteX41" fmla="*/ 589644 w 1269094"/>
              <a:gd name="connsiteY41" fmla="*/ 201238 h 692526"/>
              <a:gd name="connsiteX42" fmla="*/ 605519 w 1269094"/>
              <a:gd name="connsiteY42" fmla="*/ 198063 h 692526"/>
              <a:gd name="connsiteX43" fmla="*/ 656319 w 1269094"/>
              <a:gd name="connsiteY43" fmla="*/ 201238 h 692526"/>
              <a:gd name="connsiteX44" fmla="*/ 697594 w 1269094"/>
              <a:gd name="connsiteY44" fmla="*/ 204413 h 692526"/>
              <a:gd name="connsiteX45" fmla="*/ 716644 w 1269094"/>
              <a:gd name="connsiteY45" fmla="*/ 217113 h 692526"/>
              <a:gd name="connsiteX46" fmla="*/ 738869 w 1269094"/>
              <a:gd name="connsiteY46" fmla="*/ 248863 h 692526"/>
              <a:gd name="connsiteX47" fmla="*/ 745219 w 1269094"/>
              <a:gd name="connsiteY47" fmla="*/ 267913 h 692526"/>
              <a:gd name="connsiteX48" fmla="*/ 748394 w 1269094"/>
              <a:gd name="connsiteY48" fmla="*/ 280613 h 692526"/>
              <a:gd name="connsiteX49" fmla="*/ 754744 w 1269094"/>
              <a:gd name="connsiteY49" fmla="*/ 290138 h 692526"/>
              <a:gd name="connsiteX50" fmla="*/ 757919 w 1269094"/>
              <a:gd name="connsiteY50" fmla="*/ 299663 h 692526"/>
              <a:gd name="connsiteX51" fmla="*/ 770619 w 1269094"/>
              <a:gd name="connsiteY51" fmla="*/ 318713 h 692526"/>
              <a:gd name="connsiteX52" fmla="*/ 776969 w 1269094"/>
              <a:gd name="connsiteY52" fmla="*/ 337763 h 692526"/>
              <a:gd name="connsiteX53" fmla="*/ 783319 w 1269094"/>
              <a:gd name="connsiteY53" fmla="*/ 347288 h 692526"/>
              <a:gd name="connsiteX54" fmla="*/ 786494 w 1269094"/>
              <a:gd name="connsiteY54" fmla="*/ 356813 h 692526"/>
              <a:gd name="connsiteX55" fmla="*/ 802369 w 1269094"/>
              <a:gd name="connsiteY55" fmla="*/ 375863 h 692526"/>
              <a:gd name="connsiteX56" fmla="*/ 811894 w 1269094"/>
              <a:gd name="connsiteY56" fmla="*/ 382213 h 692526"/>
              <a:gd name="connsiteX57" fmla="*/ 824594 w 1269094"/>
              <a:gd name="connsiteY57" fmla="*/ 385388 h 692526"/>
              <a:gd name="connsiteX58" fmla="*/ 875394 w 1269094"/>
              <a:gd name="connsiteY58" fmla="*/ 382213 h 692526"/>
              <a:gd name="connsiteX59" fmla="*/ 884919 w 1269094"/>
              <a:gd name="connsiteY59" fmla="*/ 375863 h 692526"/>
              <a:gd name="connsiteX60" fmla="*/ 903969 w 1269094"/>
              <a:gd name="connsiteY60" fmla="*/ 353638 h 692526"/>
              <a:gd name="connsiteX61" fmla="*/ 913494 w 1269094"/>
              <a:gd name="connsiteY61" fmla="*/ 334588 h 692526"/>
              <a:gd name="connsiteX62" fmla="*/ 919844 w 1269094"/>
              <a:gd name="connsiteY62" fmla="*/ 321888 h 692526"/>
              <a:gd name="connsiteX63" fmla="*/ 938894 w 1269094"/>
              <a:gd name="connsiteY63" fmla="*/ 315538 h 692526"/>
              <a:gd name="connsiteX64" fmla="*/ 948419 w 1269094"/>
              <a:gd name="connsiteY64" fmla="*/ 312363 h 692526"/>
              <a:gd name="connsiteX65" fmla="*/ 967469 w 1269094"/>
              <a:gd name="connsiteY65" fmla="*/ 306013 h 692526"/>
              <a:gd name="connsiteX66" fmla="*/ 976994 w 1269094"/>
              <a:gd name="connsiteY66" fmla="*/ 302838 h 692526"/>
              <a:gd name="connsiteX67" fmla="*/ 986519 w 1269094"/>
              <a:gd name="connsiteY67" fmla="*/ 296488 h 692526"/>
              <a:gd name="connsiteX68" fmla="*/ 999219 w 1269094"/>
              <a:gd name="connsiteY68" fmla="*/ 290138 h 692526"/>
              <a:gd name="connsiteX69" fmla="*/ 1011919 w 1269094"/>
              <a:gd name="connsiteY69" fmla="*/ 280613 h 692526"/>
              <a:gd name="connsiteX70" fmla="*/ 1034144 w 1269094"/>
              <a:gd name="connsiteY70" fmla="*/ 267913 h 692526"/>
              <a:gd name="connsiteX71" fmla="*/ 1053194 w 1269094"/>
              <a:gd name="connsiteY71" fmla="*/ 258388 h 692526"/>
              <a:gd name="connsiteX72" fmla="*/ 1075419 w 1269094"/>
              <a:gd name="connsiteY72" fmla="*/ 245688 h 692526"/>
              <a:gd name="connsiteX73" fmla="*/ 1084944 w 1269094"/>
              <a:gd name="connsiteY73" fmla="*/ 242513 h 692526"/>
              <a:gd name="connsiteX74" fmla="*/ 1126219 w 1269094"/>
              <a:gd name="connsiteY74" fmla="*/ 232988 h 692526"/>
              <a:gd name="connsiteX75" fmla="*/ 1145269 w 1269094"/>
              <a:gd name="connsiteY75" fmla="*/ 226638 h 692526"/>
              <a:gd name="connsiteX76" fmla="*/ 1177019 w 1269094"/>
              <a:gd name="connsiteY76" fmla="*/ 220288 h 692526"/>
              <a:gd name="connsiteX77" fmla="*/ 1259569 w 1269094"/>
              <a:gd name="connsiteY77" fmla="*/ 223463 h 692526"/>
              <a:gd name="connsiteX78" fmla="*/ 1269094 w 1269094"/>
              <a:gd name="connsiteY78" fmla="*/ 258388 h 692526"/>
              <a:gd name="connsiteX79" fmla="*/ 1265919 w 1269094"/>
              <a:gd name="connsiteY79" fmla="*/ 318713 h 692526"/>
              <a:gd name="connsiteX80" fmla="*/ 1262744 w 1269094"/>
              <a:gd name="connsiteY80" fmla="*/ 337763 h 692526"/>
              <a:gd name="connsiteX81" fmla="*/ 1256394 w 1269094"/>
              <a:gd name="connsiteY81" fmla="*/ 347288 h 692526"/>
              <a:gd name="connsiteX82" fmla="*/ 1250044 w 1269094"/>
              <a:gd name="connsiteY82" fmla="*/ 359988 h 692526"/>
              <a:gd name="connsiteX83" fmla="*/ 1243694 w 1269094"/>
              <a:gd name="connsiteY83" fmla="*/ 369513 h 692526"/>
              <a:gd name="connsiteX84" fmla="*/ 1237344 w 1269094"/>
              <a:gd name="connsiteY84" fmla="*/ 391738 h 692526"/>
              <a:gd name="connsiteX85" fmla="*/ 1230994 w 1269094"/>
              <a:gd name="connsiteY85" fmla="*/ 410788 h 692526"/>
              <a:gd name="connsiteX86" fmla="*/ 1221469 w 1269094"/>
              <a:gd name="connsiteY86" fmla="*/ 429838 h 692526"/>
              <a:gd name="connsiteX87" fmla="*/ 1208769 w 1269094"/>
              <a:gd name="connsiteY87" fmla="*/ 455238 h 692526"/>
              <a:gd name="connsiteX88" fmla="*/ 1199244 w 1269094"/>
              <a:gd name="connsiteY88" fmla="*/ 486988 h 692526"/>
              <a:gd name="connsiteX89" fmla="*/ 1196069 w 1269094"/>
              <a:gd name="connsiteY89" fmla="*/ 496513 h 692526"/>
              <a:gd name="connsiteX90" fmla="*/ 1189719 w 1269094"/>
              <a:gd name="connsiteY90" fmla="*/ 506038 h 692526"/>
              <a:gd name="connsiteX91" fmla="*/ 1186544 w 1269094"/>
              <a:gd name="connsiteY91" fmla="*/ 515563 h 692526"/>
              <a:gd name="connsiteX92" fmla="*/ 1170669 w 1269094"/>
              <a:gd name="connsiteY92" fmla="*/ 534613 h 692526"/>
              <a:gd name="connsiteX93" fmla="*/ 1148444 w 1269094"/>
              <a:gd name="connsiteY93" fmla="*/ 556838 h 692526"/>
              <a:gd name="connsiteX94" fmla="*/ 1119869 w 1269094"/>
              <a:gd name="connsiteY94" fmla="*/ 575888 h 692526"/>
              <a:gd name="connsiteX95" fmla="*/ 1110344 w 1269094"/>
              <a:gd name="connsiteY95" fmla="*/ 582238 h 692526"/>
              <a:gd name="connsiteX96" fmla="*/ 1100819 w 1269094"/>
              <a:gd name="connsiteY96" fmla="*/ 585413 h 692526"/>
              <a:gd name="connsiteX97" fmla="*/ 1072244 w 1269094"/>
              <a:gd name="connsiteY97" fmla="*/ 604463 h 692526"/>
              <a:gd name="connsiteX98" fmla="*/ 1059544 w 1269094"/>
              <a:gd name="connsiteY98" fmla="*/ 613988 h 692526"/>
              <a:gd name="connsiteX99" fmla="*/ 1040494 w 1269094"/>
              <a:gd name="connsiteY99" fmla="*/ 626688 h 692526"/>
              <a:gd name="connsiteX100" fmla="*/ 1030969 w 1269094"/>
              <a:gd name="connsiteY100" fmla="*/ 633038 h 692526"/>
              <a:gd name="connsiteX101" fmla="*/ 1021444 w 1269094"/>
              <a:gd name="connsiteY101" fmla="*/ 636213 h 692526"/>
              <a:gd name="connsiteX102" fmla="*/ 996044 w 1269094"/>
              <a:gd name="connsiteY102" fmla="*/ 648913 h 692526"/>
              <a:gd name="connsiteX103" fmla="*/ 976994 w 1269094"/>
              <a:gd name="connsiteY103" fmla="*/ 655263 h 692526"/>
              <a:gd name="connsiteX104" fmla="*/ 967469 w 1269094"/>
              <a:gd name="connsiteY104" fmla="*/ 658438 h 692526"/>
              <a:gd name="connsiteX105" fmla="*/ 957944 w 1269094"/>
              <a:gd name="connsiteY105" fmla="*/ 664788 h 692526"/>
              <a:gd name="connsiteX106" fmla="*/ 945244 w 1269094"/>
              <a:gd name="connsiteY106" fmla="*/ 667963 h 692526"/>
              <a:gd name="connsiteX107" fmla="*/ 935719 w 1269094"/>
              <a:gd name="connsiteY107" fmla="*/ 671138 h 692526"/>
              <a:gd name="connsiteX108" fmla="*/ 910319 w 1269094"/>
              <a:gd name="connsiteY108" fmla="*/ 677488 h 692526"/>
              <a:gd name="connsiteX109" fmla="*/ 900794 w 1269094"/>
              <a:gd name="connsiteY109" fmla="*/ 683838 h 692526"/>
              <a:gd name="connsiteX110" fmla="*/ 827769 w 1269094"/>
              <a:gd name="connsiteY110" fmla="*/ 683838 h 692526"/>
              <a:gd name="connsiteX111" fmla="*/ 780144 w 1269094"/>
              <a:gd name="connsiteY111" fmla="*/ 674313 h 692526"/>
              <a:gd name="connsiteX112" fmla="*/ 767444 w 1269094"/>
              <a:gd name="connsiteY112" fmla="*/ 671138 h 692526"/>
              <a:gd name="connsiteX113" fmla="*/ 707119 w 1269094"/>
              <a:gd name="connsiteY113" fmla="*/ 667963 h 692526"/>
              <a:gd name="connsiteX114" fmla="*/ 697594 w 1269094"/>
              <a:gd name="connsiteY114" fmla="*/ 661613 h 692526"/>
              <a:gd name="connsiteX115" fmla="*/ 678544 w 1269094"/>
              <a:gd name="connsiteY115" fmla="*/ 655263 h 692526"/>
              <a:gd name="connsiteX116" fmla="*/ 662669 w 1269094"/>
              <a:gd name="connsiteY116" fmla="*/ 652088 h 692526"/>
              <a:gd name="connsiteX117" fmla="*/ 643619 w 1269094"/>
              <a:gd name="connsiteY117" fmla="*/ 645738 h 692526"/>
              <a:gd name="connsiteX118" fmla="*/ 630919 w 1269094"/>
              <a:gd name="connsiteY118" fmla="*/ 642563 h 692526"/>
              <a:gd name="connsiteX119" fmla="*/ 602344 w 1269094"/>
              <a:gd name="connsiteY119" fmla="*/ 655263 h 692526"/>
              <a:gd name="connsiteX120" fmla="*/ 488044 w 1269094"/>
              <a:gd name="connsiteY120" fmla="*/ 648913 h 692526"/>
              <a:gd name="connsiteX121" fmla="*/ 475344 w 1269094"/>
              <a:gd name="connsiteY121" fmla="*/ 645738 h 692526"/>
              <a:gd name="connsiteX122" fmla="*/ 389619 w 1269094"/>
              <a:gd name="connsiteY122" fmla="*/ 642563 h 692526"/>
              <a:gd name="connsiteX123" fmla="*/ 370569 w 1269094"/>
              <a:gd name="connsiteY123" fmla="*/ 629863 h 692526"/>
              <a:gd name="connsiteX124" fmla="*/ 351519 w 1269094"/>
              <a:gd name="connsiteY124" fmla="*/ 620338 h 692526"/>
              <a:gd name="connsiteX125" fmla="*/ 341994 w 1269094"/>
              <a:gd name="connsiteY125" fmla="*/ 613988 h 692526"/>
              <a:gd name="connsiteX126" fmla="*/ 332469 w 1269094"/>
              <a:gd name="connsiteY126" fmla="*/ 610813 h 692526"/>
              <a:gd name="connsiteX127" fmla="*/ 294369 w 1269094"/>
              <a:gd name="connsiteY127" fmla="*/ 604463 h 692526"/>
              <a:gd name="connsiteX128" fmla="*/ 281669 w 1269094"/>
              <a:gd name="connsiteY128" fmla="*/ 601288 h 692526"/>
              <a:gd name="connsiteX129" fmla="*/ 265794 w 1269094"/>
              <a:gd name="connsiteY129" fmla="*/ 598113 h 692526"/>
              <a:gd name="connsiteX130" fmla="*/ 256269 w 1269094"/>
              <a:gd name="connsiteY130" fmla="*/ 591763 h 692526"/>
              <a:gd name="connsiteX131" fmla="*/ 243569 w 1269094"/>
              <a:gd name="connsiteY131" fmla="*/ 582238 h 692526"/>
              <a:gd name="connsiteX132" fmla="*/ 230869 w 1269094"/>
              <a:gd name="connsiteY132" fmla="*/ 579063 h 692526"/>
              <a:gd name="connsiteX133" fmla="*/ 221344 w 1269094"/>
              <a:gd name="connsiteY133" fmla="*/ 575888 h 692526"/>
              <a:gd name="connsiteX134" fmla="*/ 195944 w 1269094"/>
              <a:gd name="connsiteY134" fmla="*/ 563188 h 692526"/>
              <a:gd name="connsiteX135" fmla="*/ 176894 w 1269094"/>
              <a:gd name="connsiteY135" fmla="*/ 553663 h 692526"/>
              <a:gd name="connsiteX136" fmla="*/ 170544 w 1269094"/>
              <a:gd name="connsiteY136" fmla="*/ 544138 h 692526"/>
              <a:gd name="connsiteX137" fmla="*/ 148319 w 1269094"/>
              <a:gd name="connsiteY137" fmla="*/ 534613 h 692526"/>
              <a:gd name="connsiteX138" fmla="*/ 119744 w 1269094"/>
              <a:gd name="connsiteY138" fmla="*/ 509213 h 692526"/>
              <a:gd name="connsiteX139" fmla="*/ 107044 w 1269094"/>
              <a:gd name="connsiteY139" fmla="*/ 486988 h 692526"/>
              <a:gd name="connsiteX140" fmla="*/ 87994 w 1269094"/>
              <a:gd name="connsiteY140" fmla="*/ 458413 h 692526"/>
              <a:gd name="connsiteX141" fmla="*/ 81644 w 1269094"/>
              <a:gd name="connsiteY141" fmla="*/ 445713 h 692526"/>
              <a:gd name="connsiteX142" fmla="*/ 72119 w 1269094"/>
              <a:gd name="connsiteY142" fmla="*/ 401263 h 692526"/>
              <a:gd name="connsiteX143" fmla="*/ 68944 w 1269094"/>
              <a:gd name="connsiteY143" fmla="*/ 391738 h 692526"/>
              <a:gd name="connsiteX144" fmla="*/ 56244 w 1269094"/>
              <a:gd name="connsiteY144" fmla="*/ 372688 h 692526"/>
              <a:gd name="connsiteX145" fmla="*/ 49894 w 1269094"/>
              <a:gd name="connsiteY145" fmla="*/ 363163 h 692526"/>
              <a:gd name="connsiteX146" fmla="*/ 37194 w 1269094"/>
              <a:gd name="connsiteY146" fmla="*/ 340938 h 692526"/>
              <a:gd name="connsiteX147" fmla="*/ 27669 w 1269094"/>
              <a:gd name="connsiteY147" fmla="*/ 334588 h 692526"/>
              <a:gd name="connsiteX148" fmla="*/ 8619 w 1269094"/>
              <a:gd name="connsiteY148" fmla="*/ 318713 h 692526"/>
              <a:gd name="connsiteX149" fmla="*/ 2269 w 1269094"/>
              <a:gd name="connsiteY149" fmla="*/ 252038 h 692526"/>
              <a:gd name="connsiteX150" fmla="*/ 5444 w 1269094"/>
              <a:gd name="connsiteY150" fmla="*/ 191713 h 692526"/>
              <a:gd name="connsiteX151" fmla="*/ 18144 w 1269094"/>
              <a:gd name="connsiteY151" fmla="*/ 172663 h 692526"/>
              <a:gd name="connsiteX152" fmla="*/ 30844 w 1269094"/>
              <a:gd name="connsiteY152" fmla="*/ 150438 h 692526"/>
              <a:gd name="connsiteX153" fmla="*/ 40369 w 1269094"/>
              <a:gd name="connsiteY153" fmla="*/ 128213 h 692526"/>
              <a:gd name="connsiteX154" fmla="*/ 43544 w 1269094"/>
              <a:gd name="connsiteY154" fmla="*/ 115513 h 692526"/>
              <a:gd name="connsiteX155" fmla="*/ 49894 w 1269094"/>
              <a:gd name="connsiteY155" fmla="*/ 86938 h 692526"/>
              <a:gd name="connsiteX156" fmla="*/ 56244 w 1269094"/>
              <a:gd name="connsiteY156" fmla="*/ 67888 h 692526"/>
              <a:gd name="connsiteX157" fmla="*/ 72119 w 1269094"/>
              <a:gd name="connsiteY157" fmla="*/ 48838 h 692526"/>
              <a:gd name="connsiteX158" fmla="*/ 97519 w 1269094"/>
              <a:gd name="connsiteY158" fmla="*/ 45663 h 692526"/>
              <a:gd name="connsiteX159" fmla="*/ 107044 w 1269094"/>
              <a:gd name="connsiteY159" fmla="*/ 42488 h 692526"/>
              <a:gd name="connsiteX160" fmla="*/ 157844 w 1269094"/>
              <a:gd name="connsiteY160" fmla="*/ 36138 h 692526"/>
              <a:gd name="connsiteX161" fmla="*/ 186419 w 1269094"/>
              <a:gd name="connsiteY161" fmla="*/ 29788 h 692526"/>
              <a:gd name="connsiteX162" fmla="*/ 205469 w 1269094"/>
              <a:gd name="connsiteY162" fmla="*/ 26613 h 692526"/>
              <a:gd name="connsiteX163" fmla="*/ 218169 w 1269094"/>
              <a:gd name="connsiteY163" fmla="*/ 23438 h 692526"/>
              <a:gd name="connsiteX164" fmla="*/ 221344 w 1269094"/>
              <a:gd name="connsiteY164" fmla="*/ 4388 h 69252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</a:cxnLst>
            <a:rect l="l" t="t" r="r" b="b"/>
            <a:pathLst>
              <a:path w="1269094" h="692526">
                <a:moveTo>
                  <a:pt x="221344" y="4388"/>
                </a:moveTo>
                <a:cubicBezTo>
                  <a:pt x="224519" y="684"/>
                  <a:pt x="231961" y="0"/>
                  <a:pt x="237219" y="1213"/>
                </a:cubicBezTo>
                <a:cubicBezTo>
                  <a:pt x="246443" y="3342"/>
                  <a:pt x="262619" y="13913"/>
                  <a:pt x="262619" y="13913"/>
                </a:cubicBezTo>
                <a:cubicBezTo>
                  <a:pt x="264736" y="17088"/>
                  <a:pt x="267419" y="19951"/>
                  <a:pt x="268969" y="23438"/>
                </a:cubicBezTo>
                <a:cubicBezTo>
                  <a:pt x="271687" y="29555"/>
                  <a:pt x="275319" y="42488"/>
                  <a:pt x="275319" y="42488"/>
                </a:cubicBezTo>
                <a:cubicBezTo>
                  <a:pt x="274261" y="52013"/>
                  <a:pt x="275419" y="62056"/>
                  <a:pt x="272144" y="71063"/>
                </a:cubicBezTo>
                <a:cubicBezTo>
                  <a:pt x="270840" y="74649"/>
                  <a:pt x="266032" y="75706"/>
                  <a:pt x="262619" y="77413"/>
                </a:cubicBezTo>
                <a:cubicBezTo>
                  <a:pt x="259626" y="78910"/>
                  <a:pt x="256341" y="79776"/>
                  <a:pt x="253094" y="80588"/>
                </a:cubicBezTo>
                <a:cubicBezTo>
                  <a:pt x="235558" y="84972"/>
                  <a:pt x="225307" y="84954"/>
                  <a:pt x="205469" y="86938"/>
                </a:cubicBezTo>
                <a:cubicBezTo>
                  <a:pt x="182799" y="94495"/>
                  <a:pt x="191988" y="89575"/>
                  <a:pt x="176894" y="99638"/>
                </a:cubicBezTo>
                <a:lnTo>
                  <a:pt x="164194" y="118688"/>
                </a:lnTo>
                <a:cubicBezTo>
                  <a:pt x="162077" y="121863"/>
                  <a:pt x="159051" y="124593"/>
                  <a:pt x="157844" y="128213"/>
                </a:cubicBezTo>
                <a:cubicBezTo>
                  <a:pt x="147624" y="158874"/>
                  <a:pt x="164012" y="111204"/>
                  <a:pt x="148319" y="150438"/>
                </a:cubicBezTo>
                <a:cubicBezTo>
                  <a:pt x="143166" y="163321"/>
                  <a:pt x="141913" y="169713"/>
                  <a:pt x="138794" y="182188"/>
                </a:cubicBezTo>
                <a:cubicBezTo>
                  <a:pt x="139852" y="190655"/>
                  <a:pt x="138800" y="199666"/>
                  <a:pt x="141969" y="207588"/>
                </a:cubicBezTo>
                <a:cubicBezTo>
                  <a:pt x="145469" y="216339"/>
                  <a:pt x="171743" y="216831"/>
                  <a:pt x="173719" y="217113"/>
                </a:cubicBezTo>
                <a:cubicBezTo>
                  <a:pt x="183541" y="220387"/>
                  <a:pt x="191118" y="223463"/>
                  <a:pt x="202294" y="223463"/>
                </a:cubicBezTo>
                <a:cubicBezTo>
                  <a:pt x="218204" y="223463"/>
                  <a:pt x="234044" y="221346"/>
                  <a:pt x="249919" y="220288"/>
                </a:cubicBezTo>
                <a:cubicBezTo>
                  <a:pt x="257327" y="219230"/>
                  <a:pt x="264806" y="218581"/>
                  <a:pt x="272144" y="217113"/>
                </a:cubicBezTo>
                <a:cubicBezTo>
                  <a:pt x="275426" y="216457"/>
                  <a:pt x="278322" y="213938"/>
                  <a:pt x="281669" y="213938"/>
                </a:cubicBezTo>
                <a:cubicBezTo>
                  <a:pt x="288107" y="213938"/>
                  <a:pt x="294369" y="216055"/>
                  <a:pt x="300719" y="217113"/>
                </a:cubicBezTo>
                <a:cubicBezTo>
                  <a:pt x="301777" y="221346"/>
                  <a:pt x="301943" y="225910"/>
                  <a:pt x="303894" y="229813"/>
                </a:cubicBezTo>
                <a:cubicBezTo>
                  <a:pt x="308585" y="239195"/>
                  <a:pt x="315621" y="242704"/>
                  <a:pt x="319769" y="252038"/>
                </a:cubicBezTo>
                <a:cubicBezTo>
                  <a:pt x="334882" y="286043"/>
                  <a:pt x="318098" y="259057"/>
                  <a:pt x="332469" y="280613"/>
                </a:cubicBezTo>
                <a:cubicBezTo>
                  <a:pt x="338307" y="309804"/>
                  <a:pt x="338871" y="305650"/>
                  <a:pt x="332469" y="350463"/>
                </a:cubicBezTo>
                <a:cubicBezTo>
                  <a:pt x="331800" y="355148"/>
                  <a:pt x="327877" y="358769"/>
                  <a:pt x="326119" y="363163"/>
                </a:cubicBezTo>
                <a:cubicBezTo>
                  <a:pt x="323633" y="369378"/>
                  <a:pt x="319769" y="382213"/>
                  <a:pt x="319769" y="382213"/>
                </a:cubicBezTo>
                <a:cubicBezTo>
                  <a:pt x="320827" y="385388"/>
                  <a:pt x="319745" y="390754"/>
                  <a:pt x="322944" y="391738"/>
                </a:cubicBezTo>
                <a:cubicBezTo>
                  <a:pt x="347208" y="399204"/>
                  <a:pt x="356684" y="395785"/>
                  <a:pt x="376919" y="391738"/>
                </a:cubicBezTo>
                <a:cubicBezTo>
                  <a:pt x="377977" y="388563"/>
                  <a:pt x="378238" y="384998"/>
                  <a:pt x="380094" y="382213"/>
                </a:cubicBezTo>
                <a:cubicBezTo>
                  <a:pt x="384983" y="374879"/>
                  <a:pt x="392116" y="371024"/>
                  <a:pt x="399144" y="366338"/>
                </a:cubicBezTo>
                <a:cubicBezTo>
                  <a:pt x="417136" y="367396"/>
                  <a:pt x="435248" y="367182"/>
                  <a:pt x="453119" y="369513"/>
                </a:cubicBezTo>
                <a:cubicBezTo>
                  <a:pt x="459756" y="370379"/>
                  <a:pt x="472169" y="375863"/>
                  <a:pt x="472169" y="375863"/>
                </a:cubicBezTo>
                <a:cubicBezTo>
                  <a:pt x="499686" y="374805"/>
                  <a:pt x="527479" y="376724"/>
                  <a:pt x="554719" y="372688"/>
                </a:cubicBezTo>
                <a:cubicBezTo>
                  <a:pt x="558030" y="372198"/>
                  <a:pt x="557894" y="366510"/>
                  <a:pt x="557894" y="363163"/>
                </a:cubicBezTo>
                <a:cubicBezTo>
                  <a:pt x="557894" y="351473"/>
                  <a:pt x="555616" y="339893"/>
                  <a:pt x="554719" y="328238"/>
                </a:cubicBezTo>
                <a:cubicBezTo>
                  <a:pt x="553355" y="310507"/>
                  <a:pt x="559874" y="285768"/>
                  <a:pt x="545194" y="271088"/>
                </a:cubicBezTo>
                <a:cubicBezTo>
                  <a:pt x="542496" y="268390"/>
                  <a:pt x="538844" y="266855"/>
                  <a:pt x="535669" y="264738"/>
                </a:cubicBezTo>
                <a:cubicBezTo>
                  <a:pt x="536727" y="254155"/>
                  <a:pt x="537227" y="243500"/>
                  <a:pt x="538844" y="232988"/>
                </a:cubicBezTo>
                <a:cubicBezTo>
                  <a:pt x="539353" y="229680"/>
                  <a:pt x="540163" y="226248"/>
                  <a:pt x="542019" y="223463"/>
                </a:cubicBezTo>
                <a:cubicBezTo>
                  <a:pt x="550698" y="210444"/>
                  <a:pt x="552743" y="214432"/>
                  <a:pt x="567419" y="210763"/>
                </a:cubicBezTo>
                <a:cubicBezTo>
                  <a:pt x="589613" y="205215"/>
                  <a:pt x="562384" y="210325"/>
                  <a:pt x="589644" y="201238"/>
                </a:cubicBezTo>
                <a:cubicBezTo>
                  <a:pt x="594764" y="199531"/>
                  <a:pt x="600227" y="199121"/>
                  <a:pt x="605519" y="198063"/>
                </a:cubicBezTo>
                <a:lnTo>
                  <a:pt x="656319" y="201238"/>
                </a:lnTo>
                <a:cubicBezTo>
                  <a:pt x="670085" y="202187"/>
                  <a:pt x="684249" y="200901"/>
                  <a:pt x="697594" y="204413"/>
                </a:cubicBezTo>
                <a:cubicBezTo>
                  <a:pt x="704974" y="206355"/>
                  <a:pt x="716644" y="217113"/>
                  <a:pt x="716644" y="217113"/>
                </a:cubicBezTo>
                <a:cubicBezTo>
                  <a:pt x="720991" y="222909"/>
                  <a:pt x="737305" y="244172"/>
                  <a:pt x="738869" y="248863"/>
                </a:cubicBezTo>
                <a:lnTo>
                  <a:pt x="745219" y="267913"/>
                </a:lnTo>
                <a:cubicBezTo>
                  <a:pt x="746599" y="272053"/>
                  <a:pt x="746675" y="276602"/>
                  <a:pt x="748394" y="280613"/>
                </a:cubicBezTo>
                <a:cubicBezTo>
                  <a:pt x="749897" y="284120"/>
                  <a:pt x="753037" y="286725"/>
                  <a:pt x="754744" y="290138"/>
                </a:cubicBezTo>
                <a:cubicBezTo>
                  <a:pt x="756241" y="293131"/>
                  <a:pt x="756294" y="296737"/>
                  <a:pt x="757919" y="299663"/>
                </a:cubicBezTo>
                <a:cubicBezTo>
                  <a:pt x="761625" y="306334"/>
                  <a:pt x="766386" y="312363"/>
                  <a:pt x="770619" y="318713"/>
                </a:cubicBezTo>
                <a:cubicBezTo>
                  <a:pt x="774332" y="324282"/>
                  <a:pt x="774852" y="331413"/>
                  <a:pt x="776969" y="337763"/>
                </a:cubicBezTo>
                <a:cubicBezTo>
                  <a:pt x="778176" y="341383"/>
                  <a:pt x="781612" y="343875"/>
                  <a:pt x="783319" y="347288"/>
                </a:cubicBezTo>
                <a:cubicBezTo>
                  <a:pt x="784816" y="350281"/>
                  <a:pt x="784997" y="353820"/>
                  <a:pt x="786494" y="356813"/>
                </a:cubicBezTo>
                <a:cubicBezTo>
                  <a:pt x="790062" y="363949"/>
                  <a:pt x="796350" y="370847"/>
                  <a:pt x="802369" y="375863"/>
                </a:cubicBezTo>
                <a:cubicBezTo>
                  <a:pt x="805300" y="378306"/>
                  <a:pt x="808387" y="380710"/>
                  <a:pt x="811894" y="382213"/>
                </a:cubicBezTo>
                <a:cubicBezTo>
                  <a:pt x="815905" y="383932"/>
                  <a:pt x="820361" y="384330"/>
                  <a:pt x="824594" y="385388"/>
                </a:cubicBezTo>
                <a:cubicBezTo>
                  <a:pt x="841527" y="384330"/>
                  <a:pt x="858635" y="384859"/>
                  <a:pt x="875394" y="382213"/>
                </a:cubicBezTo>
                <a:cubicBezTo>
                  <a:pt x="879163" y="381618"/>
                  <a:pt x="881988" y="378306"/>
                  <a:pt x="884919" y="375863"/>
                </a:cubicBezTo>
                <a:cubicBezTo>
                  <a:pt x="893764" y="368493"/>
                  <a:pt x="896962" y="362981"/>
                  <a:pt x="903969" y="353638"/>
                </a:cubicBezTo>
                <a:cubicBezTo>
                  <a:pt x="909790" y="336174"/>
                  <a:pt x="903646" y="351822"/>
                  <a:pt x="913494" y="334588"/>
                </a:cubicBezTo>
                <a:cubicBezTo>
                  <a:pt x="915842" y="330479"/>
                  <a:pt x="916058" y="324728"/>
                  <a:pt x="919844" y="321888"/>
                </a:cubicBezTo>
                <a:cubicBezTo>
                  <a:pt x="925199" y="317872"/>
                  <a:pt x="932544" y="317655"/>
                  <a:pt x="938894" y="315538"/>
                </a:cubicBezTo>
                <a:lnTo>
                  <a:pt x="948419" y="312363"/>
                </a:lnTo>
                <a:lnTo>
                  <a:pt x="967469" y="306013"/>
                </a:lnTo>
                <a:lnTo>
                  <a:pt x="976994" y="302838"/>
                </a:lnTo>
                <a:cubicBezTo>
                  <a:pt x="980169" y="300721"/>
                  <a:pt x="983206" y="298381"/>
                  <a:pt x="986519" y="296488"/>
                </a:cubicBezTo>
                <a:cubicBezTo>
                  <a:pt x="990628" y="294140"/>
                  <a:pt x="995205" y="292646"/>
                  <a:pt x="999219" y="290138"/>
                </a:cubicBezTo>
                <a:cubicBezTo>
                  <a:pt x="1003706" y="287333"/>
                  <a:pt x="1007613" y="283689"/>
                  <a:pt x="1011919" y="280613"/>
                </a:cubicBezTo>
                <a:cubicBezTo>
                  <a:pt x="1027390" y="269562"/>
                  <a:pt x="1015541" y="278543"/>
                  <a:pt x="1034144" y="267913"/>
                </a:cubicBezTo>
                <a:cubicBezTo>
                  <a:pt x="1051378" y="258065"/>
                  <a:pt x="1035730" y="264209"/>
                  <a:pt x="1053194" y="258388"/>
                </a:cubicBezTo>
                <a:cubicBezTo>
                  <a:pt x="1062760" y="252011"/>
                  <a:pt x="1064140" y="250522"/>
                  <a:pt x="1075419" y="245688"/>
                </a:cubicBezTo>
                <a:cubicBezTo>
                  <a:pt x="1078495" y="244370"/>
                  <a:pt x="1081769" y="243571"/>
                  <a:pt x="1084944" y="242513"/>
                </a:cubicBezTo>
                <a:cubicBezTo>
                  <a:pt x="1105648" y="228711"/>
                  <a:pt x="1084181" y="240870"/>
                  <a:pt x="1126219" y="232988"/>
                </a:cubicBezTo>
                <a:cubicBezTo>
                  <a:pt x="1132798" y="231754"/>
                  <a:pt x="1138919" y="228755"/>
                  <a:pt x="1145269" y="226638"/>
                </a:cubicBezTo>
                <a:cubicBezTo>
                  <a:pt x="1154742" y="223480"/>
                  <a:pt x="1167640" y="221851"/>
                  <a:pt x="1177019" y="220288"/>
                </a:cubicBezTo>
                <a:cubicBezTo>
                  <a:pt x="1204536" y="221346"/>
                  <a:pt x="1232854" y="216784"/>
                  <a:pt x="1259569" y="223463"/>
                </a:cubicBezTo>
                <a:cubicBezTo>
                  <a:pt x="1262961" y="224311"/>
                  <a:pt x="1268367" y="254752"/>
                  <a:pt x="1269094" y="258388"/>
                </a:cubicBezTo>
                <a:cubicBezTo>
                  <a:pt x="1268036" y="278496"/>
                  <a:pt x="1267525" y="298641"/>
                  <a:pt x="1265919" y="318713"/>
                </a:cubicBezTo>
                <a:cubicBezTo>
                  <a:pt x="1265406" y="325130"/>
                  <a:pt x="1264780" y="331656"/>
                  <a:pt x="1262744" y="337763"/>
                </a:cubicBezTo>
                <a:cubicBezTo>
                  <a:pt x="1261537" y="341383"/>
                  <a:pt x="1258287" y="343975"/>
                  <a:pt x="1256394" y="347288"/>
                </a:cubicBezTo>
                <a:cubicBezTo>
                  <a:pt x="1254046" y="351397"/>
                  <a:pt x="1252392" y="355879"/>
                  <a:pt x="1250044" y="359988"/>
                </a:cubicBezTo>
                <a:cubicBezTo>
                  <a:pt x="1248151" y="363301"/>
                  <a:pt x="1245401" y="366100"/>
                  <a:pt x="1243694" y="369513"/>
                </a:cubicBezTo>
                <a:cubicBezTo>
                  <a:pt x="1241026" y="374848"/>
                  <a:pt x="1238870" y="386652"/>
                  <a:pt x="1237344" y="391738"/>
                </a:cubicBezTo>
                <a:cubicBezTo>
                  <a:pt x="1235421" y="398149"/>
                  <a:pt x="1234707" y="405219"/>
                  <a:pt x="1230994" y="410788"/>
                </a:cubicBezTo>
                <a:cubicBezTo>
                  <a:pt x="1217078" y="431662"/>
                  <a:pt x="1230858" y="409181"/>
                  <a:pt x="1221469" y="429838"/>
                </a:cubicBezTo>
                <a:cubicBezTo>
                  <a:pt x="1217552" y="438456"/>
                  <a:pt x="1211065" y="446055"/>
                  <a:pt x="1208769" y="455238"/>
                </a:cubicBezTo>
                <a:cubicBezTo>
                  <a:pt x="1203971" y="474432"/>
                  <a:pt x="1206974" y="463798"/>
                  <a:pt x="1199244" y="486988"/>
                </a:cubicBezTo>
                <a:cubicBezTo>
                  <a:pt x="1198186" y="490163"/>
                  <a:pt x="1197925" y="493728"/>
                  <a:pt x="1196069" y="496513"/>
                </a:cubicBezTo>
                <a:cubicBezTo>
                  <a:pt x="1193952" y="499688"/>
                  <a:pt x="1191426" y="502625"/>
                  <a:pt x="1189719" y="506038"/>
                </a:cubicBezTo>
                <a:cubicBezTo>
                  <a:pt x="1188222" y="509031"/>
                  <a:pt x="1188041" y="512570"/>
                  <a:pt x="1186544" y="515563"/>
                </a:cubicBezTo>
                <a:cubicBezTo>
                  <a:pt x="1182124" y="524404"/>
                  <a:pt x="1177691" y="527591"/>
                  <a:pt x="1170669" y="534613"/>
                </a:cubicBezTo>
                <a:cubicBezTo>
                  <a:pt x="1165081" y="551378"/>
                  <a:pt x="1170279" y="542282"/>
                  <a:pt x="1148444" y="556838"/>
                </a:cubicBezTo>
                <a:lnTo>
                  <a:pt x="1119869" y="575888"/>
                </a:lnTo>
                <a:cubicBezTo>
                  <a:pt x="1116694" y="578005"/>
                  <a:pt x="1113964" y="581031"/>
                  <a:pt x="1110344" y="582238"/>
                </a:cubicBezTo>
                <a:lnTo>
                  <a:pt x="1100819" y="585413"/>
                </a:lnTo>
                <a:lnTo>
                  <a:pt x="1072244" y="604463"/>
                </a:lnTo>
                <a:cubicBezTo>
                  <a:pt x="1067841" y="607398"/>
                  <a:pt x="1063879" y="610953"/>
                  <a:pt x="1059544" y="613988"/>
                </a:cubicBezTo>
                <a:cubicBezTo>
                  <a:pt x="1053292" y="618365"/>
                  <a:pt x="1046844" y="622455"/>
                  <a:pt x="1040494" y="626688"/>
                </a:cubicBezTo>
                <a:cubicBezTo>
                  <a:pt x="1037319" y="628805"/>
                  <a:pt x="1034589" y="631831"/>
                  <a:pt x="1030969" y="633038"/>
                </a:cubicBezTo>
                <a:lnTo>
                  <a:pt x="1021444" y="636213"/>
                </a:lnTo>
                <a:cubicBezTo>
                  <a:pt x="1002850" y="650158"/>
                  <a:pt x="1015859" y="642968"/>
                  <a:pt x="996044" y="648913"/>
                </a:cubicBezTo>
                <a:cubicBezTo>
                  <a:pt x="989633" y="650836"/>
                  <a:pt x="983344" y="653146"/>
                  <a:pt x="976994" y="655263"/>
                </a:cubicBezTo>
                <a:lnTo>
                  <a:pt x="967469" y="658438"/>
                </a:lnTo>
                <a:cubicBezTo>
                  <a:pt x="964294" y="660555"/>
                  <a:pt x="961451" y="663285"/>
                  <a:pt x="957944" y="664788"/>
                </a:cubicBezTo>
                <a:cubicBezTo>
                  <a:pt x="953933" y="666507"/>
                  <a:pt x="949440" y="666764"/>
                  <a:pt x="945244" y="667963"/>
                </a:cubicBezTo>
                <a:cubicBezTo>
                  <a:pt x="942026" y="668882"/>
                  <a:pt x="938966" y="670326"/>
                  <a:pt x="935719" y="671138"/>
                </a:cubicBezTo>
                <a:lnTo>
                  <a:pt x="910319" y="677488"/>
                </a:lnTo>
                <a:cubicBezTo>
                  <a:pt x="907144" y="679605"/>
                  <a:pt x="904301" y="682335"/>
                  <a:pt x="900794" y="683838"/>
                </a:cubicBezTo>
                <a:cubicBezTo>
                  <a:pt x="880521" y="692526"/>
                  <a:pt x="837251" y="684337"/>
                  <a:pt x="827769" y="683838"/>
                </a:cubicBezTo>
                <a:cubicBezTo>
                  <a:pt x="799627" y="674457"/>
                  <a:pt x="815372" y="678227"/>
                  <a:pt x="780144" y="674313"/>
                </a:cubicBezTo>
                <a:cubicBezTo>
                  <a:pt x="775911" y="673255"/>
                  <a:pt x="771791" y="671516"/>
                  <a:pt x="767444" y="671138"/>
                </a:cubicBezTo>
                <a:cubicBezTo>
                  <a:pt x="747384" y="669394"/>
                  <a:pt x="727071" y="670684"/>
                  <a:pt x="707119" y="667963"/>
                </a:cubicBezTo>
                <a:cubicBezTo>
                  <a:pt x="703338" y="667447"/>
                  <a:pt x="701081" y="663163"/>
                  <a:pt x="697594" y="661613"/>
                </a:cubicBezTo>
                <a:cubicBezTo>
                  <a:pt x="691477" y="658895"/>
                  <a:pt x="685108" y="656576"/>
                  <a:pt x="678544" y="655263"/>
                </a:cubicBezTo>
                <a:cubicBezTo>
                  <a:pt x="673252" y="654205"/>
                  <a:pt x="667875" y="653508"/>
                  <a:pt x="662669" y="652088"/>
                </a:cubicBezTo>
                <a:cubicBezTo>
                  <a:pt x="656211" y="650327"/>
                  <a:pt x="650113" y="647361"/>
                  <a:pt x="643619" y="645738"/>
                </a:cubicBezTo>
                <a:lnTo>
                  <a:pt x="630919" y="642563"/>
                </a:lnTo>
                <a:cubicBezTo>
                  <a:pt x="608249" y="650120"/>
                  <a:pt x="617438" y="645200"/>
                  <a:pt x="602344" y="655263"/>
                </a:cubicBezTo>
                <a:cubicBezTo>
                  <a:pt x="564244" y="653146"/>
                  <a:pt x="525063" y="658168"/>
                  <a:pt x="488044" y="648913"/>
                </a:cubicBezTo>
                <a:cubicBezTo>
                  <a:pt x="483811" y="647855"/>
                  <a:pt x="479699" y="646019"/>
                  <a:pt x="475344" y="645738"/>
                </a:cubicBezTo>
                <a:cubicBezTo>
                  <a:pt x="446809" y="643897"/>
                  <a:pt x="418194" y="643621"/>
                  <a:pt x="389619" y="642563"/>
                </a:cubicBezTo>
                <a:cubicBezTo>
                  <a:pt x="372880" y="636983"/>
                  <a:pt x="386424" y="643076"/>
                  <a:pt x="370569" y="629863"/>
                </a:cubicBezTo>
                <a:cubicBezTo>
                  <a:pt x="362363" y="623024"/>
                  <a:pt x="361065" y="623520"/>
                  <a:pt x="351519" y="620338"/>
                </a:cubicBezTo>
                <a:cubicBezTo>
                  <a:pt x="348344" y="618221"/>
                  <a:pt x="345407" y="615695"/>
                  <a:pt x="341994" y="613988"/>
                </a:cubicBezTo>
                <a:cubicBezTo>
                  <a:pt x="339001" y="612491"/>
                  <a:pt x="335687" y="611732"/>
                  <a:pt x="332469" y="610813"/>
                </a:cubicBezTo>
                <a:cubicBezTo>
                  <a:pt x="312463" y="605097"/>
                  <a:pt x="322198" y="609101"/>
                  <a:pt x="294369" y="604463"/>
                </a:cubicBezTo>
                <a:cubicBezTo>
                  <a:pt x="290065" y="603746"/>
                  <a:pt x="285929" y="602235"/>
                  <a:pt x="281669" y="601288"/>
                </a:cubicBezTo>
                <a:cubicBezTo>
                  <a:pt x="276401" y="600117"/>
                  <a:pt x="271086" y="599171"/>
                  <a:pt x="265794" y="598113"/>
                </a:cubicBezTo>
                <a:cubicBezTo>
                  <a:pt x="262619" y="595996"/>
                  <a:pt x="259374" y="593981"/>
                  <a:pt x="256269" y="591763"/>
                </a:cubicBezTo>
                <a:cubicBezTo>
                  <a:pt x="251963" y="588687"/>
                  <a:pt x="248302" y="584605"/>
                  <a:pt x="243569" y="582238"/>
                </a:cubicBezTo>
                <a:cubicBezTo>
                  <a:pt x="239666" y="580287"/>
                  <a:pt x="235065" y="580262"/>
                  <a:pt x="230869" y="579063"/>
                </a:cubicBezTo>
                <a:cubicBezTo>
                  <a:pt x="227651" y="578144"/>
                  <a:pt x="224391" y="577273"/>
                  <a:pt x="221344" y="575888"/>
                </a:cubicBezTo>
                <a:cubicBezTo>
                  <a:pt x="212726" y="571971"/>
                  <a:pt x="204411" y="567421"/>
                  <a:pt x="195944" y="563188"/>
                </a:cubicBezTo>
                <a:cubicBezTo>
                  <a:pt x="171325" y="550878"/>
                  <a:pt x="200835" y="561643"/>
                  <a:pt x="176894" y="553663"/>
                </a:cubicBezTo>
                <a:cubicBezTo>
                  <a:pt x="174777" y="550488"/>
                  <a:pt x="173719" y="546255"/>
                  <a:pt x="170544" y="544138"/>
                </a:cubicBezTo>
                <a:cubicBezTo>
                  <a:pt x="138433" y="522730"/>
                  <a:pt x="175212" y="558518"/>
                  <a:pt x="148319" y="534613"/>
                </a:cubicBezTo>
                <a:cubicBezTo>
                  <a:pt x="115697" y="505615"/>
                  <a:pt x="141362" y="523625"/>
                  <a:pt x="119744" y="509213"/>
                </a:cubicBezTo>
                <a:cubicBezTo>
                  <a:pt x="97778" y="476264"/>
                  <a:pt x="131214" y="527271"/>
                  <a:pt x="107044" y="486988"/>
                </a:cubicBezTo>
                <a:lnTo>
                  <a:pt x="87994" y="458413"/>
                </a:lnTo>
                <a:cubicBezTo>
                  <a:pt x="85369" y="454475"/>
                  <a:pt x="83761" y="449946"/>
                  <a:pt x="81644" y="445713"/>
                </a:cubicBezTo>
                <a:cubicBezTo>
                  <a:pt x="78980" y="429726"/>
                  <a:pt x="77393" y="417086"/>
                  <a:pt x="72119" y="401263"/>
                </a:cubicBezTo>
                <a:cubicBezTo>
                  <a:pt x="71061" y="398088"/>
                  <a:pt x="70569" y="394664"/>
                  <a:pt x="68944" y="391738"/>
                </a:cubicBezTo>
                <a:cubicBezTo>
                  <a:pt x="65238" y="385067"/>
                  <a:pt x="60477" y="379038"/>
                  <a:pt x="56244" y="372688"/>
                </a:cubicBezTo>
                <a:cubicBezTo>
                  <a:pt x="54127" y="369513"/>
                  <a:pt x="51601" y="366576"/>
                  <a:pt x="49894" y="363163"/>
                </a:cubicBezTo>
                <a:cubicBezTo>
                  <a:pt x="47404" y="358183"/>
                  <a:pt x="41682" y="345426"/>
                  <a:pt x="37194" y="340938"/>
                </a:cubicBezTo>
                <a:cubicBezTo>
                  <a:pt x="34496" y="338240"/>
                  <a:pt x="30600" y="337031"/>
                  <a:pt x="27669" y="334588"/>
                </a:cubicBezTo>
                <a:cubicBezTo>
                  <a:pt x="3223" y="314216"/>
                  <a:pt x="32268" y="334479"/>
                  <a:pt x="8619" y="318713"/>
                </a:cubicBezTo>
                <a:cubicBezTo>
                  <a:pt x="0" y="292856"/>
                  <a:pt x="2269" y="302448"/>
                  <a:pt x="2269" y="252038"/>
                </a:cubicBezTo>
                <a:cubicBezTo>
                  <a:pt x="2269" y="231902"/>
                  <a:pt x="1495" y="211458"/>
                  <a:pt x="5444" y="191713"/>
                </a:cubicBezTo>
                <a:cubicBezTo>
                  <a:pt x="6941" y="184229"/>
                  <a:pt x="14731" y="179489"/>
                  <a:pt x="18144" y="172663"/>
                </a:cubicBezTo>
                <a:cubicBezTo>
                  <a:pt x="26201" y="156550"/>
                  <a:pt x="21869" y="163901"/>
                  <a:pt x="30844" y="150438"/>
                </a:cubicBezTo>
                <a:cubicBezTo>
                  <a:pt x="39959" y="113977"/>
                  <a:pt x="27213" y="158910"/>
                  <a:pt x="40369" y="128213"/>
                </a:cubicBezTo>
                <a:cubicBezTo>
                  <a:pt x="42088" y="124202"/>
                  <a:pt x="42597" y="119773"/>
                  <a:pt x="43544" y="115513"/>
                </a:cubicBezTo>
                <a:cubicBezTo>
                  <a:pt x="46134" y="103860"/>
                  <a:pt x="46576" y="98000"/>
                  <a:pt x="49894" y="86938"/>
                </a:cubicBezTo>
                <a:cubicBezTo>
                  <a:pt x="51817" y="80527"/>
                  <a:pt x="52531" y="73457"/>
                  <a:pt x="56244" y="67888"/>
                </a:cubicBezTo>
                <a:cubicBezTo>
                  <a:pt x="59268" y="63353"/>
                  <a:pt x="66741" y="50794"/>
                  <a:pt x="72119" y="48838"/>
                </a:cubicBezTo>
                <a:cubicBezTo>
                  <a:pt x="80138" y="45922"/>
                  <a:pt x="89052" y="46721"/>
                  <a:pt x="97519" y="45663"/>
                </a:cubicBezTo>
                <a:cubicBezTo>
                  <a:pt x="100694" y="44605"/>
                  <a:pt x="103797" y="43300"/>
                  <a:pt x="107044" y="42488"/>
                </a:cubicBezTo>
                <a:cubicBezTo>
                  <a:pt x="125790" y="37802"/>
                  <a:pt x="136156" y="38110"/>
                  <a:pt x="157844" y="36138"/>
                </a:cubicBezTo>
                <a:cubicBezTo>
                  <a:pt x="171434" y="32741"/>
                  <a:pt x="171639" y="32475"/>
                  <a:pt x="186419" y="29788"/>
                </a:cubicBezTo>
                <a:cubicBezTo>
                  <a:pt x="192753" y="28636"/>
                  <a:pt x="199156" y="27876"/>
                  <a:pt x="205469" y="26613"/>
                </a:cubicBezTo>
                <a:cubicBezTo>
                  <a:pt x="209748" y="25757"/>
                  <a:pt x="213812" y="23680"/>
                  <a:pt x="218169" y="23438"/>
                </a:cubicBezTo>
                <a:cubicBezTo>
                  <a:pt x="232963" y="22616"/>
                  <a:pt x="218169" y="8092"/>
                  <a:pt x="221344" y="4388"/>
                </a:cubicBezTo>
                <a:close/>
              </a:path>
            </a:pathLst>
          </a:custGeom>
          <a:noFill/>
          <a:ln w="222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25" name="手繪多邊形 124"/>
          <p:cNvSpPr/>
          <p:nvPr/>
        </p:nvSpPr>
        <p:spPr>
          <a:xfrm>
            <a:off x="2320616" y="1699277"/>
            <a:ext cx="1269094" cy="692526"/>
          </a:xfrm>
          <a:custGeom>
            <a:avLst/>
            <a:gdLst>
              <a:gd name="connsiteX0" fmla="*/ 221344 w 1269094"/>
              <a:gd name="connsiteY0" fmla="*/ 4388 h 692526"/>
              <a:gd name="connsiteX1" fmla="*/ 237219 w 1269094"/>
              <a:gd name="connsiteY1" fmla="*/ 1213 h 692526"/>
              <a:gd name="connsiteX2" fmla="*/ 262619 w 1269094"/>
              <a:gd name="connsiteY2" fmla="*/ 13913 h 692526"/>
              <a:gd name="connsiteX3" fmla="*/ 268969 w 1269094"/>
              <a:gd name="connsiteY3" fmla="*/ 23438 h 692526"/>
              <a:gd name="connsiteX4" fmla="*/ 275319 w 1269094"/>
              <a:gd name="connsiteY4" fmla="*/ 42488 h 692526"/>
              <a:gd name="connsiteX5" fmla="*/ 272144 w 1269094"/>
              <a:gd name="connsiteY5" fmla="*/ 71063 h 692526"/>
              <a:gd name="connsiteX6" fmla="*/ 262619 w 1269094"/>
              <a:gd name="connsiteY6" fmla="*/ 77413 h 692526"/>
              <a:gd name="connsiteX7" fmla="*/ 253094 w 1269094"/>
              <a:gd name="connsiteY7" fmla="*/ 80588 h 692526"/>
              <a:gd name="connsiteX8" fmla="*/ 205469 w 1269094"/>
              <a:gd name="connsiteY8" fmla="*/ 86938 h 692526"/>
              <a:gd name="connsiteX9" fmla="*/ 176894 w 1269094"/>
              <a:gd name="connsiteY9" fmla="*/ 99638 h 692526"/>
              <a:gd name="connsiteX10" fmla="*/ 164194 w 1269094"/>
              <a:gd name="connsiteY10" fmla="*/ 118688 h 692526"/>
              <a:gd name="connsiteX11" fmla="*/ 157844 w 1269094"/>
              <a:gd name="connsiteY11" fmla="*/ 128213 h 692526"/>
              <a:gd name="connsiteX12" fmla="*/ 148319 w 1269094"/>
              <a:gd name="connsiteY12" fmla="*/ 150438 h 692526"/>
              <a:gd name="connsiteX13" fmla="*/ 138794 w 1269094"/>
              <a:gd name="connsiteY13" fmla="*/ 182188 h 692526"/>
              <a:gd name="connsiteX14" fmla="*/ 141969 w 1269094"/>
              <a:gd name="connsiteY14" fmla="*/ 207588 h 692526"/>
              <a:gd name="connsiteX15" fmla="*/ 173719 w 1269094"/>
              <a:gd name="connsiteY15" fmla="*/ 217113 h 692526"/>
              <a:gd name="connsiteX16" fmla="*/ 202294 w 1269094"/>
              <a:gd name="connsiteY16" fmla="*/ 223463 h 692526"/>
              <a:gd name="connsiteX17" fmla="*/ 249919 w 1269094"/>
              <a:gd name="connsiteY17" fmla="*/ 220288 h 692526"/>
              <a:gd name="connsiteX18" fmla="*/ 272144 w 1269094"/>
              <a:gd name="connsiteY18" fmla="*/ 217113 h 692526"/>
              <a:gd name="connsiteX19" fmla="*/ 281669 w 1269094"/>
              <a:gd name="connsiteY19" fmla="*/ 213938 h 692526"/>
              <a:gd name="connsiteX20" fmla="*/ 300719 w 1269094"/>
              <a:gd name="connsiteY20" fmla="*/ 217113 h 692526"/>
              <a:gd name="connsiteX21" fmla="*/ 303894 w 1269094"/>
              <a:gd name="connsiteY21" fmla="*/ 229813 h 692526"/>
              <a:gd name="connsiteX22" fmla="*/ 319769 w 1269094"/>
              <a:gd name="connsiteY22" fmla="*/ 252038 h 692526"/>
              <a:gd name="connsiteX23" fmla="*/ 332469 w 1269094"/>
              <a:gd name="connsiteY23" fmla="*/ 280613 h 692526"/>
              <a:gd name="connsiteX24" fmla="*/ 332469 w 1269094"/>
              <a:gd name="connsiteY24" fmla="*/ 350463 h 692526"/>
              <a:gd name="connsiteX25" fmla="*/ 326119 w 1269094"/>
              <a:gd name="connsiteY25" fmla="*/ 363163 h 692526"/>
              <a:gd name="connsiteX26" fmla="*/ 319769 w 1269094"/>
              <a:gd name="connsiteY26" fmla="*/ 382213 h 692526"/>
              <a:gd name="connsiteX27" fmla="*/ 322944 w 1269094"/>
              <a:gd name="connsiteY27" fmla="*/ 391738 h 692526"/>
              <a:gd name="connsiteX28" fmla="*/ 376919 w 1269094"/>
              <a:gd name="connsiteY28" fmla="*/ 391738 h 692526"/>
              <a:gd name="connsiteX29" fmla="*/ 380094 w 1269094"/>
              <a:gd name="connsiteY29" fmla="*/ 382213 h 692526"/>
              <a:gd name="connsiteX30" fmla="*/ 399144 w 1269094"/>
              <a:gd name="connsiteY30" fmla="*/ 366338 h 692526"/>
              <a:gd name="connsiteX31" fmla="*/ 453119 w 1269094"/>
              <a:gd name="connsiteY31" fmla="*/ 369513 h 692526"/>
              <a:gd name="connsiteX32" fmla="*/ 472169 w 1269094"/>
              <a:gd name="connsiteY32" fmla="*/ 375863 h 692526"/>
              <a:gd name="connsiteX33" fmla="*/ 554719 w 1269094"/>
              <a:gd name="connsiteY33" fmla="*/ 372688 h 692526"/>
              <a:gd name="connsiteX34" fmla="*/ 557894 w 1269094"/>
              <a:gd name="connsiteY34" fmla="*/ 363163 h 692526"/>
              <a:gd name="connsiteX35" fmla="*/ 554719 w 1269094"/>
              <a:gd name="connsiteY35" fmla="*/ 328238 h 692526"/>
              <a:gd name="connsiteX36" fmla="*/ 545194 w 1269094"/>
              <a:gd name="connsiteY36" fmla="*/ 271088 h 692526"/>
              <a:gd name="connsiteX37" fmla="*/ 535669 w 1269094"/>
              <a:gd name="connsiteY37" fmla="*/ 264738 h 692526"/>
              <a:gd name="connsiteX38" fmla="*/ 538844 w 1269094"/>
              <a:gd name="connsiteY38" fmla="*/ 232988 h 692526"/>
              <a:gd name="connsiteX39" fmla="*/ 542019 w 1269094"/>
              <a:gd name="connsiteY39" fmla="*/ 223463 h 692526"/>
              <a:gd name="connsiteX40" fmla="*/ 567419 w 1269094"/>
              <a:gd name="connsiteY40" fmla="*/ 210763 h 692526"/>
              <a:gd name="connsiteX41" fmla="*/ 589644 w 1269094"/>
              <a:gd name="connsiteY41" fmla="*/ 201238 h 692526"/>
              <a:gd name="connsiteX42" fmla="*/ 605519 w 1269094"/>
              <a:gd name="connsiteY42" fmla="*/ 198063 h 692526"/>
              <a:gd name="connsiteX43" fmla="*/ 656319 w 1269094"/>
              <a:gd name="connsiteY43" fmla="*/ 201238 h 692526"/>
              <a:gd name="connsiteX44" fmla="*/ 697594 w 1269094"/>
              <a:gd name="connsiteY44" fmla="*/ 204413 h 692526"/>
              <a:gd name="connsiteX45" fmla="*/ 716644 w 1269094"/>
              <a:gd name="connsiteY45" fmla="*/ 217113 h 692526"/>
              <a:gd name="connsiteX46" fmla="*/ 738869 w 1269094"/>
              <a:gd name="connsiteY46" fmla="*/ 248863 h 692526"/>
              <a:gd name="connsiteX47" fmla="*/ 745219 w 1269094"/>
              <a:gd name="connsiteY47" fmla="*/ 267913 h 692526"/>
              <a:gd name="connsiteX48" fmla="*/ 748394 w 1269094"/>
              <a:gd name="connsiteY48" fmla="*/ 280613 h 692526"/>
              <a:gd name="connsiteX49" fmla="*/ 754744 w 1269094"/>
              <a:gd name="connsiteY49" fmla="*/ 290138 h 692526"/>
              <a:gd name="connsiteX50" fmla="*/ 757919 w 1269094"/>
              <a:gd name="connsiteY50" fmla="*/ 299663 h 692526"/>
              <a:gd name="connsiteX51" fmla="*/ 770619 w 1269094"/>
              <a:gd name="connsiteY51" fmla="*/ 318713 h 692526"/>
              <a:gd name="connsiteX52" fmla="*/ 776969 w 1269094"/>
              <a:gd name="connsiteY52" fmla="*/ 337763 h 692526"/>
              <a:gd name="connsiteX53" fmla="*/ 783319 w 1269094"/>
              <a:gd name="connsiteY53" fmla="*/ 347288 h 692526"/>
              <a:gd name="connsiteX54" fmla="*/ 786494 w 1269094"/>
              <a:gd name="connsiteY54" fmla="*/ 356813 h 692526"/>
              <a:gd name="connsiteX55" fmla="*/ 802369 w 1269094"/>
              <a:gd name="connsiteY55" fmla="*/ 375863 h 692526"/>
              <a:gd name="connsiteX56" fmla="*/ 811894 w 1269094"/>
              <a:gd name="connsiteY56" fmla="*/ 382213 h 692526"/>
              <a:gd name="connsiteX57" fmla="*/ 824594 w 1269094"/>
              <a:gd name="connsiteY57" fmla="*/ 385388 h 692526"/>
              <a:gd name="connsiteX58" fmla="*/ 875394 w 1269094"/>
              <a:gd name="connsiteY58" fmla="*/ 382213 h 692526"/>
              <a:gd name="connsiteX59" fmla="*/ 884919 w 1269094"/>
              <a:gd name="connsiteY59" fmla="*/ 375863 h 692526"/>
              <a:gd name="connsiteX60" fmla="*/ 903969 w 1269094"/>
              <a:gd name="connsiteY60" fmla="*/ 353638 h 692526"/>
              <a:gd name="connsiteX61" fmla="*/ 913494 w 1269094"/>
              <a:gd name="connsiteY61" fmla="*/ 334588 h 692526"/>
              <a:gd name="connsiteX62" fmla="*/ 919844 w 1269094"/>
              <a:gd name="connsiteY62" fmla="*/ 321888 h 692526"/>
              <a:gd name="connsiteX63" fmla="*/ 938894 w 1269094"/>
              <a:gd name="connsiteY63" fmla="*/ 315538 h 692526"/>
              <a:gd name="connsiteX64" fmla="*/ 948419 w 1269094"/>
              <a:gd name="connsiteY64" fmla="*/ 312363 h 692526"/>
              <a:gd name="connsiteX65" fmla="*/ 967469 w 1269094"/>
              <a:gd name="connsiteY65" fmla="*/ 306013 h 692526"/>
              <a:gd name="connsiteX66" fmla="*/ 976994 w 1269094"/>
              <a:gd name="connsiteY66" fmla="*/ 302838 h 692526"/>
              <a:gd name="connsiteX67" fmla="*/ 986519 w 1269094"/>
              <a:gd name="connsiteY67" fmla="*/ 296488 h 692526"/>
              <a:gd name="connsiteX68" fmla="*/ 999219 w 1269094"/>
              <a:gd name="connsiteY68" fmla="*/ 290138 h 692526"/>
              <a:gd name="connsiteX69" fmla="*/ 1011919 w 1269094"/>
              <a:gd name="connsiteY69" fmla="*/ 280613 h 692526"/>
              <a:gd name="connsiteX70" fmla="*/ 1034144 w 1269094"/>
              <a:gd name="connsiteY70" fmla="*/ 267913 h 692526"/>
              <a:gd name="connsiteX71" fmla="*/ 1053194 w 1269094"/>
              <a:gd name="connsiteY71" fmla="*/ 258388 h 692526"/>
              <a:gd name="connsiteX72" fmla="*/ 1075419 w 1269094"/>
              <a:gd name="connsiteY72" fmla="*/ 245688 h 692526"/>
              <a:gd name="connsiteX73" fmla="*/ 1084944 w 1269094"/>
              <a:gd name="connsiteY73" fmla="*/ 242513 h 692526"/>
              <a:gd name="connsiteX74" fmla="*/ 1126219 w 1269094"/>
              <a:gd name="connsiteY74" fmla="*/ 232988 h 692526"/>
              <a:gd name="connsiteX75" fmla="*/ 1145269 w 1269094"/>
              <a:gd name="connsiteY75" fmla="*/ 226638 h 692526"/>
              <a:gd name="connsiteX76" fmla="*/ 1177019 w 1269094"/>
              <a:gd name="connsiteY76" fmla="*/ 220288 h 692526"/>
              <a:gd name="connsiteX77" fmla="*/ 1259569 w 1269094"/>
              <a:gd name="connsiteY77" fmla="*/ 223463 h 692526"/>
              <a:gd name="connsiteX78" fmla="*/ 1269094 w 1269094"/>
              <a:gd name="connsiteY78" fmla="*/ 258388 h 692526"/>
              <a:gd name="connsiteX79" fmla="*/ 1265919 w 1269094"/>
              <a:gd name="connsiteY79" fmla="*/ 318713 h 692526"/>
              <a:gd name="connsiteX80" fmla="*/ 1262744 w 1269094"/>
              <a:gd name="connsiteY80" fmla="*/ 337763 h 692526"/>
              <a:gd name="connsiteX81" fmla="*/ 1256394 w 1269094"/>
              <a:gd name="connsiteY81" fmla="*/ 347288 h 692526"/>
              <a:gd name="connsiteX82" fmla="*/ 1250044 w 1269094"/>
              <a:gd name="connsiteY82" fmla="*/ 359988 h 692526"/>
              <a:gd name="connsiteX83" fmla="*/ 1243694 w 1269094"/>
              <a:gd name="connsiteY83" fmla="*/ 369513 h 692526"/>
              <a:gd name="connsiteX84" fmla="*/ 1237344 w 1269094"/>
              <a:gd name="connsiteY84" fmla="*/ 391738 h 692526"/>
              <a:gd name="connsiteX85" fmla="*/ 1230994 w 1269094"/>
              <a:gd name="connsiteY85" fmla="*/ 410788 h 692526"/>
              <a:gd name="connsiteX86" fmla="*/ 1221469 w 1269094"/>
              <a:gd name="connsiteY86" fmla="*/ 429838 h 692526"/>
              <a:gd name="connsiteX87" fmla="*/ 1208769 w 1269094"/>
              <a:gd name="connsiteY87" fmla="*/ 455238 h 692526"/>
              <a:gd name="connsiteX88" fmla="*/ 1199244 w 1269094"/>
              <a:gd name="connsiteY88" fmla="*/ 486988 h 692526"/>
              <a:gd name="connsiteX89" fmla="*/ 1196069 w 1269094"/>
              <a:gd name="connsiteY89" fmla="*/ 496513 h 692526"/>
              <a:gd name="connsiteX90" fmla="*/ 1189719 w 1269094"/>
              <a:gd name="connsiteY90" fmla="*/ 506038 h 692526"/>
              <a:gd name="connsiteX91" fmla="*/ 1186544 w 1269094"/>
              <a:gd name="connsiteY91" fmla="*/ 515563 h 692526"/>
              <a:gd name="connsiteX92" fmla="*/ 1170669 w 1269094"/>
              <a:gd name="connsiteY92" fmla="*/ 534613 h 692526"/>
              <a:gd name="connsiteX93" fmla="*/ 1148444 w 1269094"/>
              <a:gd name="connsiteY93" fmla="*/ 556838 h 692526"/>
              <a:gd name="connsiteX94" fmla="*/ 1119869 w 1269094"/>
              <a:gd name="connsiteY94" fmla="*/ 575888 h 692526"/>
              <a:gd name="connsiteX95" fmla="*/ 1110344 w 1269094"/>
              <a:gd name="connsiteY95" fmla="*/ 582238 h 692526"/>
              <a:gd name="connsiteX96" fmla="*/ 1100819 w 1269094"/>
              <a:gd name="connsiteY96" fmla="*/ 585413 h 692526"/>
              <a:gd name="connsiteX97" fmla="*/ 1072244 w 1269094"/>
              <a:gd name="connsiteY97" fmla="*/ 604463 h 692526"/>
              <a:gd name="connsiteX98" fmla="*/ 1059544 w 1269094"/>
              <a:gd name="connsiteY98" fmla="*/ 613988 h 692526"/>
              <a:gd name="connsiteX99" fmla="*/ 1040494 w 1269094"/>
              <a:gd name="connsiteY99" fmla="*/ 626688 h 692526"/>
              <a:gd name="connsiteX100" fmla="*/ 1030969 w 1269094"/>
              <a:gd name="connsiteY100" fmla="*/ 633038 h 692526"/>
              <a:gd name="connsiteX101" fmla="*/ 1021444 w 1269094"/>
              <a:gd name="connsiteY101" fmla="*/ 636213 h 692526"/>
              <a:gd name="connsiteX102" fmla="*/ 996044 w 1269094"/>
              <a:gd name="connsiteY102" fmla="*/ 648913 h 692526"/>
              <a:gd name="connsiteX103" fmla="*/ 976994 w 1269094"/>
              <a:gd name="connsiteY103" fmla="*/ 655263 h 692526"/>
              <a:gd name="connsiteX104" fmla="*/ 967469 w 1269094"/>
              <a:gd name="connsiteY104" fmla="*/ 658438 h 692526"/>
              <a:gd name="connsiteX105" fmla="*/ 957944 w 1269094"/>
              <a:gd name="connsiteY105" fmla="*/ 664788 h 692526"/>
              <a:gd name="connsiteX106" fmla="*/ 945244 w 1269094"/>
              <a:gd name="connsiteY106" fmla="*/ 667963 h 692526"/>
              <a:gd name="connsiteX107" fmla="*/ 935719 w 1269094"/>
              <a:gd name="connsiteY107" fmla="*/ 671138 h 692526"/>
              <a:gd name="connsiteX108" fmla="*/ 910319 w 1269094"/>
              <a:gd name="connsiteY108" fmla="*/ 677488 h 692526"/>
              <a:gd name="connsiteX109" fmla="*/ 900794 w 1269094"/>
              <a:gd name="connsiteY109" fmla="*/ 683838 h 692526"/>
              <a:gd name="connsiteX110" fmla="*/ 827769 w 1269094"/>
              <a:gd name="connsiteY110" fmla="*/ 683838 h 692526"/>
              <a:gd name="connsiteX111" fmla="*/ 780144 w 1269094"/>
              <a:gd name="connsiteY111" fmla="*/ 674313 h 692526"/>
              <a:gd name="connsiteX112" fmla="*/ 767444 w 1269094"/>
              <a:gd name="connsiteY112" fmla="*/ 671138 h 692526"/>
              <a:gd name="connsiteX113" fmla="*/ 707119 w 1269094"/>
              <a:gd name="connsiteY113" fmla="*/ 667963 h 692526"/>
              <a:gd name="connsiteX114" fmla="*/ 697594 w 1269094"/>
              <a:gd name="connsiteY114" fmla="*/ 661613 h 692526"/>
              <a:gd name="connsiteX115" fmla="*/ 678544 w 1269094"/>
              <a:gd name="connsiteY115" fmla="*/ 655263 h 692526"/>
              <a:gd name="connsiteX116" fmla="*/ 662669 w 1269094"/>
              <a:gd name="connsiteY116" fmla="*/ 652088 h 692526"/>
              <a:gd name="connsiteX117" fmla="*/ 643619 w 1269094"/>
              <a:gd name="connsiteY117" fmla="*/ 645738 h 692526"/>
              <a:gd name="connsiteX118" fmla="*/ 630919 w 1269094"/>
              <a:gd name="connsiteY118" fmla="*/ 642563 h 692526"/>
              <a:gd name="connsiteX119" fmla="*/ 602344 w 1269094"/>
              <a:gd name="connsiteY119" fmla="*/ 655263 h 692526"/>
              <a:gd name="connsiteX120" fmla="*/ 488044 w 1269094"/>
              <a:gd name="connsiteY120" fmla="*/ 648913 h 692526"/>
              <a:gd name="connsiteX121" fmla="*/ 475344 w 1269094"/>
              <a:gd name="connsiteY121" fmla="*/ 645738 h 692526"/>
              <a:gd name="connsiteX122" fmla="*/ 389619 w 1269094"/>
              <a:gd name="connsiteY122" fmla="*/ 642563 h 692526"/>
              <a:gd name="connsiteX123" fmla="*/ 370569 w 1269094"/>
              <a:gd name="connsiteY123" fmla="*/ 629863 h 692526"/>
              <a:gd name="connsiteX124" fmla="*/ 351519 w 1269094"/>
              <a:gd name="connsiteY124" fmla="*/ 620338 h 692526"/>
              <a:gd name="connsiteX125" fmla="*/ 341994 w 1269094"/>
              <a:gd name="connsiteY125" fmla="*/ 613988 h 692526"/>
              <a:gd name="connsiteX126" fmla="*/ 332469 w 1269094"/>
              <a:gd name="connsiteY126" fmla="*/ 610813 h 692526"/>
              <a:gd name="connsiteX127" fmla="*/ 294369 w 1269094"/>
              <a:gd name="connsiteY127" fmla="*/ 604463 h 692526"/>
              <a:gd name="connsiteX128" fmla="*/ 281669 w 1269094"/>
              <a:gd name="connsiteY128" fmla="*/ 601288 h 692526"/>
              <a:gd name="connsiteX129" fmla="*/ 265794 w 1269094"/>
              <a:gd name="connsiteY129" fmla="*/ 598113 h 692526"/>
              <a:gd name="connsiteX130" fmla="*/ 256269 w 1269094"/>
              <a:gd name="connsiteY130" fmla="*/ 591763 h 692526"/>
              <a:gd name="connsiteX131" fmla="*/ 243569 w 1269094"/>
              <a:gd name="connsiteY131" fmla="*/ 582238 h 692526"/>
              <a:gd name="connsiteX132" fmla="*/ 230869 w 1269094"/>
              <a:gd name="connsiteY132" fmla="*/ 579063 h 692526"/>
              <a:gd name="connsiteX133" fmla="*/ 221344 w 1269094"/>
              <a:gd name="connsiteY133" fmla="*/ 575888 h 692526"/>
              <a:gd name="connsiteX134" fmla="*/ 195944 w 1269094"/>
              <a:gd name="connsiteY134" fmla="*/ 563188 h 692526"/>
              <a:gd name="connsiteX135" fmla="*/ 176894 w 1269094"/>
              <a:gd name="connsiteY135" fmla="*/ 553663 h 692526"/>
              <a:gd name="connsiteX136" fmla="*/ 170544 w 1269094"/>
              <a:gd name="connsiteY136" fmla="*/ 544138 h 692526"/>
              <a:gd name="connsiteX137" fmla="*/ 148319 w 1269094"/>
              <a:gd name="connsiteY137" fmla="*/ 534613 h 692526"/>
              <a:gd name="connsiteX138" fmla="*/ 119744 w 1269094"/>
              <a:gd name="connsiteY138" fmla="*/ 509213 h 692526"/>
              <a:gd name="connsiteX139" fmla="*/ 107044 w 1269094"/>
              <a:gd name="connsiteY139" fmla="*/ 486988 h 692526"/>
              <a:gd name="connsiteX140" fmla="*/ 87994 w 1269094"/>
              <a:gd name="connsiteY140" fmla="*/ 458413 h 692526"/>
              <a:gd name="connsiteX141" fmla="*/ 81644 w 1269094"/>
              <a:gd name="connsiteY141" fmla="*/ 445713 h 692526"/>
              <a:gd name="connsiteX142" fmla="*/ 72119 w 1269094"/>
              <a:gd name="connsiteY142" fmla="*/ 401263 h 692526"/>
              <a:gd name="connsiteX143" fmla="*/ 68944 w 1269094"/>
              <a:gd name="connsiteY143" fmla="*/ 391738 h 692526"/>
              <a:gd name="connsiteX144" fmla="*/ 56244 w 1269094"/>
              <a:gd name="connsiteY144" fmla="*/ 372688 h 692526"/>
              <a:gd name="connsiteX145" fmla="*/ 49894 w 1269094"/>
              <a:gd name="connsiteY145" fmla="*/ 363163 h 692526"/>
              <a:gd name="connsiteX146" fmla="*/ 37194 w 1269094"/>
              <a:gd name="connsiteY146" fmla="*/ 340938 h 692526"/>
              <a:gd name="connsiteX147" fmla="*/ 27669 w 1269094"/>
              <a:gd name="connsiteY147" fmla="*/ 334588 h 692526"/>
              <a:gd name="connsiteX148" fmla="*/ 8619 w 1269094"/>
              <a:gd name="connsiteY148" fmla="*/ 318713 h 692526"/>
              <a:gd name="connsiteX149" fmla="*/ 2269 w 1269094"/>
              <a:gd name="connsiteY149" fmla="*/ 252038 h 692526"/>
              <a:gd name="connsiteX150" fmla="*/ 5444 w 1269094"/>
              <a:gd name="connsiteY150" fmla="*/ 191713 h 692526"/>
              <a:gd name="connsiteX151" fmla="*/ 18144 w 1269094"/>
              <a:gd name="connsiteY151" fmla="*/ 172663 h 692526"/>
              <a:gd name="connsiteX152" fmla="*/ 30844 w 1269094"/>
              <a:gd name="connsiteY152" fmla="*/ 150438 h 692526"/>
              <a:gd name="connsiteX153" fmla="*/ 40369 w 1269094"/>
              <a:gd name="connsiteY153" fmla="*/ 128213 h 692526"/>
              <a:gd name="connsiteX154" fmla="*/ 43544 w 1269094"/>
              <a:gd name="connsiteY154" fmla="*/ 115513 h 692526"/>
              <a:gd name="connsiteX155" fmla="*/ 49894 w 1269094"/>
              <a:gd name="connsiteY155" fmla="*/ 86938 h 692526"/>
              <a:gd name="connsiteX156" fmla="*/ 56244 w 1269094"/>
              <a:gd name="connsiteY156" fmla="*/ 67888 h 692526"/>
              <a:gd name="connsiteX157" fmla="*/ 72119 w 1269094"/>
              <a:gd name="connsiteY157" fmla="*/ 48838 h 692526"/>
              <a:gd name="connsiteX158" fmla="*/ 97519 w 1269094"/>
              <a:gd name="connsiteY158" fmla="*/ 45663 h 692526"/>
              <a:gd name="connsiteX159" fmla="*/ 107044 w 1269094"/>
              <a:gd name="connsiteY159" fmla="*/ 42488 h 692526"/>
              <a:gd name="connsiteX160" fmla="*/ 157844 w 1269094"/>
              <a:gd name="connsiteY160" fmla="*/ 36138 h 692526"/>
              <a:gd name="connsiteX161" fmla="*/ 186419 w 1269094"/>
              <a:gd name="connsiteY161" fmla="*/ 29788 h 692526"/>
              <a:gd name="connsiteX162" fmla="*/ 205469 w 1269094"/>
              <a:gd name="connsiteY162" fmla="*/ 26613 h 692526"/>
              <a:gd name="connsiteX163" fmla="*/ 218169 w 1269094"/>
              <a:gd name="connsiteY163" fmla="*/ 23438 h 692526"/>
              <a:gd name="connsiteX164" fmla="*/ 221344 w 1269094"/>
              <a:gd name="connsiteY164" fmla="*/ 4388 h 69252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</a:cxnLst>
            <a:rect l="l" t="t" r="r" b="b"/>
            <a:pathLst>
              <a:path w="1269094" h="692526">
                <a:moveTo>
                  <a:pt x="221344" y="4388"/>
                </a:moveTo>
                <a:cubicBezTo>
                  <a:pt x="224519" y="684"/>
                  <a:pt x="231961" y="0"/>
                  <a:pt x="237219" y="1213"/>
                </a:cubicBezTo>
                <a:cubicBezTo>
                  <a:pt x="246443" y="3342"/>
                  <a:pt x="262619" y="13913"/>
                  <a:pt x="262619" y="13913"/>
                </a:cubicBezTo>
                <a:cubicBezTo>
                  <a:pt x="264736" y="17088"/>
                  <a:pt x="267419" y="19951"/>
                  <a:pt x="268969" y="23438"/>
                </a:cubicBezTo>
                <a:cubicBezTo>
                  <a:pt x="271687" y="29555"/>
                  <a:pt x="275319" y="42488"/>
                  <a:pt x="275319" y="42488"/>
                </a:cubicBezTo>
                <a:cubicBezTo>
                  <a:pt x="274261" y="52013"/>
                  <a:pt x="275419" y="62056"/>
                  <a:pt x="272144" y="71063"/>
                </a:cubicBezTo>
                <a:cubicBezTo>
                  <a:pt x="270840" y="74649"/>
                  <a:pt x="266032" y="75706"/>
                  <a:pt x="262619" y="77413"/>
                </a:cubicBezTo>
                <a:cubicBezTo>
                  <a:pt x="259626" y="78910"/>
                  <a:pt x="256341" y="79776"/>
                  <a:pt x="253094" y="80588"/>
                </a:cubicBezTo>
                <a:cubicBezTo>
                  <a:pt x="235558" y="84972"/>
                  <a:pt x="225307" y="84954"/>
                  <a:pt x="205469" y="86938"/>
                </a:cubicBezTo>
                <a:cubicBezTo>
                  <a:pt x="182799" y="94495"/>
                  <a:pt x="191988" y="89575"/>
                  <a:pt x="176894" y="99638"/>
                </a:cubicBezTo>
                <a:lnTo>
                  <a:pt x="164194" y="118688"/>
                </a:lnTo>
                <a:cubicBezTo>
                  <a:pt x="162077" y="121863"/>
                  <a:pt x="159051" y="124593"/>
                  <a:pt x="157844" y="128213"/>
                </a:cubicBezTo>
                <a:cubicBezTo>
                  <a:pt x="147624" y="158874"/>
                  <a:pt x="164012" y="111204"/>
                  <a:pt x="148319" y="150438"/>
                </a:cubicBezTo>
                <a:cubicBezTo>
                  <a:pt x="143166" y="163321"/>
                  <a:pt x="141913" y="169713"/>
                  <a:pt x="138794" y="182188"/>
                </a:cubicBezTo>
                <a:cubicBezTo>
                  <a:pt x="139852" y="190655"/>
                  <a:pt x="138800" y="199666"/>
                  <a:pt x="141969" y="207588"/>
                </a:cubicBezTo>
                <a:cubicBezTo>
                  <a:pt x="145469" y="216339"/>
                  <a:pt x="171743" y="216831"/>
                  <a:pt x="173719" y="217113"/>
                </a:cubicBezTo>
                <a:cubicBezTo>
                  <a:pt x="183541" y="220387"/>
                  <a:pt x="191118" y="223463"/>
                  <a:pt x="202294" y="223463"/>
                </a:cubicBezTo>
                <a:cubicBezTo>
                  <a:pt x="218204" y="223463"/>
                  <a:pt x="234044" y="221346"/>
                  <a:pt x="249919" y="220288"/>
                </a:cubicBezTo>
                <a:cubicBezTo>
                  <a:pt x="257327" y="219230"/>
                  <a:pt x="264806" y="218581"/>
                  <a:pt x="272144" y="217113"/>
                </a:cubicBezTo>
                <a:cubicBezTo>
                  <a:pt x="275426" y="216457"/>
                  <a:pt x="278322" y="213938"/>
                  <a:pt x="281669" y="213938"/>
                </a:cubicBezTo>
                <a:cubicBezTo>
                  <a:pt x="288107" y="213938"/>
                  <a:pt x="294369" y="216055"/>
                  <a:pt x="300719" y="217113"/>
                </a:cubicBezTo>
                <a:cubicBezTo>
                  <a:pt x="301777" y="221346"/>
                  <a:pt x="301943" y="225910"/>
                  <a:pt x="303894" y="229813"/>
                </a:cubicBezTo>
                <a:cubicBezTo>
                  <a:pt x="308585" y="239195"/>
                  <a:pt x="315621" y="242704"/>
                  <a:pt x="319769" y="252038"/>
                </a:cubicBezTo>
                <a:cubicBezTo>
                  <a:pt x="334882" y="286043"/>
                  <a:pt x="318098" y="259057"/>
                  <a:pt x="332469" y="280613"/>
                </a:cubicBezTo>
                <a:cubicBezTo>
                  <a:pt x="338307" y="309804"/>
                  <a:pt x="338871" y="305650"/>
                  <a:pt x="332469" y="350463"/>
                </a:cubicBezTo>
                <a:cubicBezTo>
                  <a:pt x="331800" y="355148"/>
                  <a:pt x="327877" y="358769"/>
                  <a:pt x="326119" y="363163"/>
                </a:cubicBezTo>
                <a:cubicBezTo>
                  <a:pt x="323633" y="369378"/>
                  <a:pt x="319769" y="382213"/>
                  <a:pt x="319769" y="382213"/>
                </a:cubicBezTo>
                <a:cubicBezTo>
                  <a:pt x="320827" y="385388"/>
                  <a:pt x="319745" y="390754"/>
                  <a:pt x="322944" y="391738"/>
                </a:cubicBezTo>
                <a:cubicBezTo>
                  <a:pt x="347208" y="399204"/>
                  <a:pt x="356684" y="395785"/>
                  <a:pt x="376919" y="391738"/>
                </a:cubicBezTo>
                <a:cubicBezTo>
                  <a:pt x="377977" y="388563"/>
                  <a:pt x="378238" y="384998"/>
                  <a:pt x="380094" y="382213"/>
                </a:cubicBezTo>
                <a:cubicBezTo>
                  <a:pt x="384983" y="374879"/>
                  <a:pt x="392116" y="371024"/>
                  <a:pt x="399144" y="366338"/>
                </a:cubicBezTo>
                <a:cubicBezTo>
                  <a:pt x="417136" y="367396"/>
                  <a:pt x="435248" y="367182"/>
                  <a:pt x="453119" y="369513"/>
                </a:cubicBezTo>
                <a:cubicBezTo>
                  <a:pt x="459756" y="370379"/>
                  <a:pt x="472169" y="375863"/>
                  <a:pt x="472169" y="375863"/>
                </a:cubicBezTo>
                <a:cubicBezTo>
                  <a:pt x="499686" y="374805"/>
                  <a:pt x="527479" y="376724"/>
                  <a:pt x="554719" y="372688"/>
                </a:cubicBezTo>
                <a:cubicBezTo>
                  <a:pt x="558030" y="372198"/>
                  <a:pt x="557894" y="366510"/>
                  <a:pt x="557894" y="363163"/>
                </a:cubicBezTo>
                <a:cubicBezTo>
                  <a:pt x="557894" y="351473"/>
                  <a:pt x="555616" y="339893"/>
                  <a:pt x="554719" y="328238"/>
                </a:cubicBezTo>
                <a:cubicBezTo>
                  <a:pt x="553355" y="310507"/>
                  <a:pt x="559874" y="285768"/>
                  <a:pt x="545194" y="271088"/>
                </a:cubicBezTo>
                <a:cubicBezTo>
                  <a:pt x="542496" y="268390"/>
                  <a:pt x="538844" y="266855"/>
                  <a:pt x="535669" y="264738"/>
                </a:cubicBezTo>
                <a:cubicBezTo>
                  <a:pt x="536727" y="254155"/>
                  <a:pt x="537227" y="243500"/>
                  <a:pt x="538844" y="232988"/>
                </a:cubicBezTo>
                <a:cubicBezTo>
                  <a:pt x="539353" y="229680"/>
                  <a:pt x="540163" y="226248"/>
                  <a:pt x="542019" y="223463"/>
                </a:cubicBezTo>
                <a:cubicBezTo>
                  <a:pt x="550698" y="210444"/>
                  <a:pt x="552743" y="214432"/>
                  <a:pt x="567419" y="210763"/>
                </a:cubicBezTo>
                <a:cubicBezTo>
                  <a:pt x="589613" y="205215"/>
                  <a:pt x="562384" y="210325"/>
                  <a:pt x="589644" y="201238"/>
                </a:cubicBezTo>
                <a:cubicBezTo>
                  <a:pt x="594764" y="199531"/>
                  <a:pt x="600227" y="199121"/>
                  <a:pt x="605519" y="198063"/>
                </a:cubicBezTo>
                <a:lnTo>
                  <a:pt x="656319" y="201238"/>
                </a:lnTo>
                <a:cubicBezTo>
                  <a:pt x="670085" y="202187"/>
                  <a:pt x="684249" y="200901"/>
                  <a:pt x="697594" y="204413"/>
                </a:cubicBezTo>
                <a:cubicBezTo>
                  <a:pt x="704974" y="206355"/>
                  <a:pt x="716644" y="217113"/>
                  <a:pt x="716644" y="217113"/>
                </a:cubicBezTo>
                <a:cubicBezTo>
                  <a:pt x="720991" y="222909"/>
                  <a:pt x="737305" y="244172"/>
                  <a:pt x="738869" y="248863"/>
                </a:cubicBezTo>
                <a:lnTo>
                  <a:pt x="745219" y="267913"/>
                </a:lnTo>
                <a:cubicBezTo>
                  <a:pt x="746599" y="272053"/>
                  <a:pt x="746675" y="276602"/>
                  <a:pt x="748394" y="280613"/>
                </a:cubicBezTo>
                <a:cubicBezTo>
                  <a:pt x="749897" y="284120"/>
                  <a:pt x="753037" y="286725"/>
                  <a:pt x="754744" y="290138"/>
                </a:cubicBezTo>
                <a:cubicBezTo>
                  <a:pt x="756241" y="293131"/>
                  <a:pt x="756294" y="296737"/>
                  <a:pt x="757919" y="299663"/>
                </a:cubicBezTo>
                <a:cubicBezTo>
                  <a:pt x="761625" y="306334"/>
                  <a:pt x="766386" y="312363"/>
                  <a:pt x="770619" y="318713"/>
                </a:cubicBezTo>
                <a:cubicBezTo>
                  <a:pt x="774332" y="324282"/>
                  <a:pt x="774852" y="331413"/>
                  <a:pt x="776969" y="337763"/>
                </a:cubicBezTo>
                <a:cubicBezTo>
                  <a:pt x="778176" y="341383"/>
                  <a:pt x="781612" y="343875"/>
                  <a:pt x="783319" y="347288"/>
                </a:cubicBezTo>
                <a:cubicBezTo>
                  <a:pt x="784816" y="350281"/>
                  <a:pt x="784997" y="353820"/>
                  <a:pt x="786494" y="356813"/>
                </a:cubicBezTo>
                <a:cubicBezTo>
                  <a:pt x="790062" y="363949"/>
                  <a:pt x="796350" y="370847"/>
                  <a:pt x="802369" y="375863"/>
                </a:cubicBezTo>
                <a:cubicBezTo>
                  <a:pt x="805300" y="378306"/>
                  <a:pt x="808387" y="380710"/>
                  <a:pt x="811894" y="382213"/>
                </a:cubicBezTo>
                <a:cubicBezTo>
                  <a:pt x="815905" y="383932"/>
                  <a:pt x="820361" y="384330"/>
                  <a:pt x="824594" y="385388"/>
                </a:cubicBezTo>
                <a:cubicBezTo>
                  <a:pt x="841527" y="384330"/>
                  <a:pt x="858635" y="384859"/>
                  <a:pt x="875394" y="382213"/>
                </a:cubicBezTo>
                <a:cubicBezTo>
                  <a:pt x="879163" y="381618"/>
                  <a:pt x="881988" y="378306"/>
                  <a:pt x="884919" y="375863"/>
                </a:cubicBezTo>
                <a:cubicBezTo>
                  <a:pt x="893764" y="368493"/>
                  <a:pt x="896962" y="362981"/>
                  <a:pt x="903969" y="353638"/>
                </a:cubicBezTo>
                <a:cubicBezTo>
                  <a:pt x="909790" y="336174"/>
                  <a:pt x="903646" y="351822"/>
                  <a:pt x="913494" y="334588"/>
                </a:cubicBezTo>
                <a:cubicBezTo>
                  <a:pt x="915842" y="330479"/>
                  <a:pt x="916058" y="324728"/>
                  <a:pt x="919844" y="321888"/>
                </a:cubicBezTo>
                <a:cubicBezTo>
                  <a:pt x="925199" y="317872"/>
                  <a:pt x="932544" y="317655"/>
                  <a:pt x="938894" y="315538"/>
                </a:cubicBezTo>
                <a:lnTo>
                  <a:pt x="948419" y="312363"/>
                </a:lnTo>
                <a:lnTo>
                  <a:pt x="967469" y="306013"/>
                </a:lnTo>
                <a:lnTo>
                  <a:pt x="976994" y="302838"/>
                </a:lnTo>
                <a:cubicBezTo>
                  <a:pt x="980169" y="300721"/>
                  <a:pt x="983206" y="298381"/>
                  <a:pt x="986519" y="296488"/>
                </a:cubicBezTo>
                <a:cubicBezTo>
                  <a:pt x="990628" y="294140"/>
                  <a:pt x="995205" y="292646"/>
                  <a:pt x="999219" y="290138"/>
                </a:cubicBezTo>
                <a:cubicBezTo>
                  <a:pt x="1003706" y="287333"/>
                  <a:pt x="1007613" y="283689"/>
                  <a:pt x="1011919" y="280613"/>
                </a:cubicBezTo>
                <a:cubicBezTo>
                  <a:pt x="1027390" y="269562"/>
                  <a:pt x="1015541" y="278543"/>
                  <a:pt x="1034144" y="267913"/>
                </a:cubicBezTo>
                <a:cubicBezTo>
                  <a:pt x="1051378" y="258065"/>
                  <a:pt x="1035730" y="264209"/>
                  <a:pt x="1053194" y="258388"/>
                </a:cubicBezTo>
                <a:cubicBezTo>
                  <a:pt x="1062760" y="252011"/>
                  <a:pt x="1064140" y="250522"/>
                  <a:pt x="1075419" y="245688"/>
                </a:cubicBezTo>
                <a:cubicBezTo>
                  <a:pt x="1078495" y="244370"/>
                  <a:pt x="1081769" y="243571"/>
                  <a:pt x="1084944" y="242513"/>
                </a:cubicBezTo>
                <a:cubicBezTo>
                  <a:pt x="1105648" y="228711"/>
                  <a:pt x="1084181" y="240870"/>
                  <a:pt x="1126219" y="232988"/>
                </a:cubicBezTo>
                <a:cubicBezTo>
                  <a:pt x="1132798" y="231754"/>
                  <a:pt x="1138919" y="228755"/>
                  <a:pt x="1145269" y="226638"/>
                </a:cubicBezTo>
                <a:cubicBezTo>
                  <a:pt x="1154742" y="223480"/>
                  <a:pt x="1167640" y="221851"/>
                  <a:pt x="1177019" y="220288"/>
                </a:cubicBezTo>
                <a:cubicBezTo>
                  <a:pt x="1204536" y="221346"/>
                  <a:pt x="1232854" y="216784"/>
                  <a:pt x="1259569" y="223463"/>
                </a:cubicBezTo>
                <a:cubicBezTo>
                  <a:pt x="1262961" y="224311"/>
                  <a:pt x="1268367" y="254752"/>
                  <a:pt x="1269094" y="258388"/>
                </a:cubicBezTo>
                <a:cubicBezTo>
                  <a:pt x="1268036" y="278496"/>
                  <a:pt x="1267525" y="298641"/>
                  <a:pt x="1265919" y="318713"/>
                </a:cubicBezTo>
                <a:cubicBezTo>
                  <a:pt x="1265406" y="325130"/>
                  <a:pt x="1264780" y="331656"/>
                  <a:pt x="1262744" y="337763"/>
                </a:cubicBezTo>
                <a:cubicBezTo>
                  <a:pt x="1261537" y="341383"/>
                  <a:pt x="1258287" y="343975"/>
                  <a:pt x="1256394" y="347288"/>
                </a:cubicBezTo>
                <a:cubicBezTo>
                  <a:pt x="1254046" y="351397"/>
                  <a:pt x="1252392" y="355879"/>
                  <a:pt x="1250044" y="359988"/>
                </a:cubicBezTo>
                <a:cubicBezTo>
                  <a:pt x="1248151" y="363301"/>
                  <a:pt x="1245401" y="366100"/>
                  <a:pt x="1243694" y="369513"/>
                </a:cubicBezTo>
                <a:cubicBezTo>
                  <a:pt x="1241026" y="374848"/>
                  <a:pt x="1238870" y="386652"/>
                  <a:pt x="1237344" y="391738"/>
                </a:cubicBezTo>
                <a:cubicBezTo>
                  <a:pt x="1235421" y="398149"/>
                  <a:pt x="1234707" y="405219"/>
                  <a:pt x="1230994" y="410788"/>
                </a:cubicBezTo>
                <a:cubicBezTo>
                  <a:pt x="1217078" y="431662"/>
                  <a:pt x="1230858" y="409181"/>
                  <a:pt x="1221469" y="429838"/>
                </a:cubicBezTo>
                <a:cubicBezTo>
                  <a:pt x="1217552" y="438456"/>
                  <a:pt x="1211065" y="446055"/>
                  <a:pt x="1208769" y="455238"/>
                </a:cubicBezTo>
                <a:cubicBezTo>
                  <a:pt x="1203971" y="474432"/>
                  <a:pt x="1206974" y="463798"/>
                  <a:pt x="1199244" y="486988"/>
                </a:cubicBezTo>
                <a:cubicBezTo>
                  <a:pt x="1198186" y="490163"/>
                  <a:pt x="1197925" y="493728"/>
                  <a:pt x="1196069" y="496513"/>
                </a:cubicBezTo>
                <a:cubicBezTo>
                  <a:pt x="1193952" y="499688"/>
                  <a:pt x="1191426" y="502625"/>
                  <a:pt x="1189719" y="506038"/>
                </a:cubicBezTo>
                <a:cubicBezTo>
                  <a:pt x="1188222" y="509031"/>
                  <a:pt x="1188041" y="512570"/>
                  <a:pt x="1186544" y="515563"/>
                </a:cubicBezTo>
                <a:cubicBezTo>
                  <a:pt x="1182124" y="524404"/>
                  <a:pt x="1177691" y="527591"/>
                  <a:pt x="1170669" y="534613"/>
                </a:cubicBezTo>
                <a:cubicBezTo>
                  <a:pt x="1165081" y="551378"/>
                  <a:pt x="1170279" y="542282"/>
                  <a:pt x="1148444" y="556838"/>
                </a:cubicBezTo>
                <a:lnTo>
                  <a:pt x="1119869" y="575888"/>
                </a:lnTo>
                <a:cubicBezTo>
                  <a:pt x="1116694" y="578005"/>
                  <a:pt x="1113964" y="581031"/>
                  <a:pt x="1110344" y="582238"/>
                </a:cubicBezTo>
                <a:lnTo>
                  <a:pt x="1100819" y="585413"/>
                </a:lnTo>
                <a:lnTo>
                  <a:pt x="1072244" y="604463"/>
                </a:lnTo>
                <a:cubicBezTo>
                  <a:pt x="1067841" y="607398"/>
                  <a:pt x="1063879" y="610953"/>
                  <a:pt x="1059544" y="613988"/>
                </a:cubicBezTo>
                <a:cubicBezTo>
                  <a:pt x="1053292" y="618365"/>
                  <a:pt x="1046844" y="622455"/>
                  <a:pt x="1040494" y="626688"/>
                </a:cubicBezTo>
                <a:cubicBezTo>
                  <a:pt x="1037319" y="628805"/>
                  <a:pt x="1034589" y="631831"/>
                  <a:pt x="1030969" y="633038"/>
                </a:cubicBezTo>
                <a:lnTo>
                  <a:pt x="1021444" y="636213"/>
                </a:lnTo>
                <a:cubicBezTo>
                  <a:pt x="1002850" y="650158"/>
                  <a:pt x="1015859" y="642968"/>
                  <a:pt x="996044" y="648913"/>
                </a:cubicBezTo>
                <a:cubicBezTo>
                  <a:pt x="989633" y="650836"/>
                  <a:pt x="983344" y="653146"/>
                  <a:pt x="976994" y="655263"/>
                </a:cubicBezTo>
                <a:lnTo>
                  <a:pt x="967469" y="658438"/>
                </a:lnTo>
                <a:cubicBezTo>
                  <a:pt x="964294" y="660555"/>
                  <a:pt x="961451" y="663285"/>
                  <a:pt x="957944" y="664788"/>
                </a:cubicBezTo>
                <a:cubicBezTo>
                  <a:pt x="953933" y="666507"/>
                  <a:pt x="949440" y="666764"/>
                  <a:pt x="945244" y="667963"/>
                </a:cubicBezTo>
                <a:cubicBezTo>
                  <a:pt x="942026" y="668882"/>
                  <a:pt x="938966" y="670326"/>
                  <a:pt x="935719" y="671138"/>
                </a:cubicBezTo>
                <a:lnTo>
                  <a:pt x="910319" y="677488"/>
                </a:lnTo>
                <a:cubicBezTo>
                  <a:pt x="907144" y="679605"/>
                  <a:pt x="904301" y="682335"/>
                  <a:pt x="900794" y="683838"/>
                </a:cubicBezTo>
                <a:cubicBezTo>
                  <a:pt x="880521" y="692526"/>
                  <a:pt x="837251" y="684337"/>
                  <a:pt x="827769" y="683838"/>
                </a:cubicBezTo>
                <a:cubicBezTo>
                  <a:pt x="799627" y="674457"/>
                  <a:pt x="815372" y="678227"/>
                  <a:pt x="780144" y="674313"/>
                </a:cubicBezTo>
                <a:cubicBezTo>
                  <a:pt x="775911" y="673255"/>
                  <a:pt x="771791" y="671516"/>
                  <a:pt x="767444" y="671138"/>
                </a:cubicBezTo>
                <a:cubicBezTo>
                  <a:pt x="747384" y="669394"/>
                  <a:pt x="727071" y="670684"/>
                  <a:pt x="707119" y="667963"/>
                </a:cubicBezTo>
                <a:cubicBezTo>
                  <a:pt x="703338" y="667447"/>
                  <a:pt x="701081" y="663163"/>
                  <a:pt x="697594" y="661613"/>
                </a:cubicBezTo>
                <a:cubicBezTo>
                  <a:pt x="691477" y="658895"/>
                  <a:pt x="685108" y="656576"/>
                  <a:pt x="678544" y="655263"/>
                </a:cubicBezTo>
                <a:cubicBezTo>
                  <a:pt x="673252" y="654205"/>
                  <a:pt x="667875" y="653508"/>
                  <a:pt x="662669" y="652088"/>
                </a:cubicBezTo>
                <a:cubicBezTo>
                  <a:pt x="656211" y="650327"/>
                  <a:pt x="650113" y="647361"/>
                  <a:pt x="643619" y="645738"/>
                </a:cubicBezTo>
                <a:lnTo>
                  <a:pt x="630919" y="642563"/>
                </a:lnTo>
                <a:cubicBezTo>
                  <a:pt x="608249" y="650120"/>
                  <a:pt x="617438" y="645200"/>
                  <a:pt x="602344" y="655263"/>
                </a:cubicBezTo>
                <a:cubicBezTo>
                  <a:pt x="564244" y="653146"/>
                  <a:pt x="525063" y="658168"/>
                  <a:pt x="488044" y="648913"/>
                </a:cubicBezTo>
                <a:cubicBezTo>
                  <a:pt x="483811" y="647855"/>
                  <a:pt x="479699" y="646019"/>
                  <a:pt x="475344" y="645738"/>
                </a:cubicBezTo>
                <a:cubicBezTo>
                  <a:pt x="446809" y="643897"/>
                  <a:pt x="418194" y="643621"/>
                  <a:pt x="389619" y="642563"/>
                </a:cubicBezTo>
                <a:cubicBezTo>
                  <a:pt x="372880" y="636983"/>
                  <a:pt x="386424" y="643076"/>
                  <a:pt x="370569" y="629863"/>
                </a:cubicBezTo>
                <a:cubicBezTo>
                  <a:pt x="362363" y="623024"/>
                  <a:pt x="361065" y="623520"/>
                  <a:pt x="351519" y="620338"/>
                </a:cubicBezTo>
                <a:cubicBezTo>
                  <a:pt x="348344" y="618221"/>
                  <a:pt x="345407" y="615695"/>
                  <a:pt x="341994" y="613988"/>
                </a:cubicBezTo>
                <a:cubicBezTo>
                  <a:pt x="339001" y="612491"/>
                  <a:pt x="335687" y="611732"/>
                  <a:pt x="332469" y="610813"/>
                </a:cubicBezTo>
                <a:cubicBezTo>
                  <a:pt x="312463" y="605097"/>
                  <a:pt x="322198" y="609101"/>
                  <a:pt x="294369" y="604463"/>
                </a:cubicBezTo>
                <a:cubicBezTo>
                  <a:pt x="290065" y="603746"/>
                  <a:pt x="285929" y="602235"/>
                  <a:pt x="281669" y="601288"/>
                </a:cubicBezTo>
                <a:cubicBezTo>
                  <a:pt x="276401" y="600117"/>
                  <a:pt x="271086" y="599171"/>
                  <a:pt x="265794" y="598113"/>
                </a:cubicBezTo>
                <a:cubicBezTo>
                  <a:pt x="262619" y="595996"/>
                  <a:pt x="259374" y="593981"/>
                  <a:pt x="256269" y="591763"/>
                </a:cubicBezTo>
                <a:cubicBezTo>
                  <a:pt x="251963" y="588687"/>
                  <a:pt x="248302" y="584605"/>
                  <a:pt x="243569" y="582238"/>
                </a:cubicBezTo>
                <a:cubicBezTo>
                  <a:pt x="239666" y="580287"/>
                  <a:pt x="235065" y="580262"/>
                  <a:pt x="230869" y="579063"/>
                </a:cubicBezTo>
                <a:cubicBezTo>
                  <a:pt x="227651" y="578144"/>
                  <a:pt x="224391" y="577273"/>
                  <a:pt x="221344" y="575888"/>
                </a:cubicBezTo>
                <a:cubicBezTo>
                  <a:pt x="212726" y="571971"/>
                  <a:pt x="204411" y="567421"/>
                  <a:pt x="195944" y="563188"/>
                </a:cubicBezTo>
                <a:cubicBezTo>
                  <a:pt x="171325" y="550878"/>
                  <a:pt x="200835" y="561643"/>
                  <a:pt x="176894" y="553663"/>
                </a:cubicBezTo>
                <a:cubicBezTo>
                  <a:pt x="174777" y="550488"/>
                  <a:pt x="173719" y="546255"/>
                  <a:pt x="170544" y="544138"/>
                </a:cubicBezTo>
                <a:cubicBezTo>
                  <a:pt x="138433" y="522730"/>
                  <a:pt x="175212" y="558518"/>
                  <a:pt x="148319" y="534613"/>
                </a:cubicBezTo>
                <a:cubicBezTo>
                  <a:pt x="115697" y="505615"/>
                  <a:pt x="141362" y="523625"/>
                  <a:pt x="119744" y="509213"/>
                </a:cubicBezTo>
                <a:cubicBezTo>
                  <a:pt x="97778" y="476264"/>
                  <a:pt x="131214" y="527271"/>
                  <a:pt x="107044" y="486988"/>
                </a:cubicBezTo>
                <a:lnTo>
                  <a:pt x="87994" y="458413"/>
                </a:lnTo>
                <a:cubicBezTo>
                  <a:pt x="85369" y="454475"/>
                  <a:pt x="83761" y="449946"/>
                  <a:pt x="81644" y="445713"/>
                </a:cubicBezTo>
                <a:cubicBezTo>
                  <a:pt x="78980" y="429726"/>
                  <a:pt x="77393" y="417086"/>
                  <a:pt x="72119" y="401263"/>
                </a:cubicBezTo>
                <a:cubicBezTo>
                  <a:pt x="71061" y="398088"/>
                  <a:pt x="70569" y="394664"/>
                  <a:pt x="68944" y="391738"/>
                </a:cubicBezTo>
                <a:cubicBezTo>
                  <a:pt x="65238" y="385067"/>
                  <a:pt x="60477" y="379038"/>
                  <a:pt x="56244" y="372688"/>
                </a:cubicBezTo>
                <a:cubicBezTo>
                  <a:pt x="54127" y="369513"/>
                  <a:pt x="51601" y="366576"/>
                  <a:pt x="49894" y="363163"/>
                </a:cubicBezTo>
                <a:cubicBezTo>
                  <a:pt x="47404" y="358183"/>
                  <a:pt x="41682" y="345426"/>
                  <a:pt x="37194" y="340938"/>
                </a:cubicBezTo>
                <a:cubicBezTo>
                  <a:pt x="34496" y="338240"/>
                  <a:pt x="30600" y="337031"/>
                  <a:pt x="27669" y="334588"/>
                </a:cubicBezTo>
                <a:cubicBezTo>
                  <a:pt x="3223" y="314216"/>
                  <a:pt x="32268" y="334479"/>
                  <a:pt x="8619" y="318713"/>
                </a:cubicBezTo>
                <a:cubicBezTo>
                  <a:pt x="0" y="292856"/>
                  <a:pt x="2269" y="302448"/>
                  <a:pt x="2269" y="252038"/>
                </a:cubicBezTo>
                <a:cubicBezTo>
                  <a:pt x="2269" y="231902"/>
                  <a:pt x="1495" y="211458"/>
                  <a:pt x="5444" y="191713"/>
                </a:cubicBezTo>
                <a:cubicBezTo>
                  <a:pt x="6941" y="184229"/>
                  <a:pt x="14731" y="179489"/>
                  <a:pt x="18144" y="172663"/>
                </a:cubicBezTo>
                <a:cubicBezTo>
                  <a:pt x="26201" y="156550"/>
                  <a:pt x="21869" y="163901"/>
                  <a:pt x="30844" y="150438"/>
                </a:cubicBezTo>
                <a:cubicBezTo>
                  <a:pt x="39959" y="113977"/>
                  <a:pt x="27213" y="158910"/>
                  <a:pt x="40369" y="128213"/>
                </a:cubicBezTo>
                <a:cubicBezTo>
                  <a:pt x="42088" y="124202"/>
                  <a:pt x="42597" y="119773"/>
                  <a:pt x="43544" y="115513"/>
                </a:cubicBezTo>
                <a:cubicBezTo>
                  <a:pt x="46134" y="103860"/>
                  <a:pt x="46576" y="98000"/>
                  <a:pt x="49894" y="86938"/>
                </a:cubicBezTo>
                <a:cubicBezTo>
                  <a:pt x="51817" y="80527"/>
                  <a:pt x="52531" y="73457"/>
                  <a:pt x="56244" y="67888"/>
                </a:cubicBezTo>
                <a:cubicBezTo>
                  <a:pt x="59268" y="63353"/>
                  <a:pt x="66741" y="50794"/>
                  <a:pt x="72119" y="48838"/>
                </a:cubicBezTo>
                <a:cubicBezTo>
                  <a:pt x="80138" y="45922"/>
                  <a:pt x="89052" y="46721"/>
                  <a:pt x="97519" y="45663"/>
                </a:cubicBezTo>
                <a:cubicBezTo>
                  <a:pt x="100694" y="44605"/>
                  <a:pt x="103797" y="43300"/>
                  <a:pt x="107044" y="42488"/>
                </a:cubicBezTo>
                <a:cubicBezTo>
                  <a:pt x="125790" y="37802"/>
                  <a:pt x="136156" y="38110"/>
                  <a:pt x="157844" y="36138"/>
                </a:cubicBezTo>
                <a:cubicBezTo>
                  <a:pt x="171434" y="32741"/>
                  <a:pt x="171639" y="32475"/>
                  <a:pt x="186419" y="29788"/>
                </a:cubicBezTo>
                <a:cubicBezTo>
                  <a:pt x="192753" y="28636"/>
                  <a:pt x="199156" y="27876"/>
                  <a:pt x="205469" y="26613"/>
                </a:cubicBezTo>
                <a:cubicBezTo>
                  <a:pt x="209748" y="25757"/>
                  <a:pt x="213812" y="23680"/>
                  <a:pt x="218169" y="23438"/>
                </a:cubicBezTo>
                <a:cubicBezTo>
                  <a:pt x="232963" y="22616"/>
                  <a:pt x="218169" y="8092"/>
                  <a:pt x="221344" y="4388"/>
                </a:cubicBezTo>
                <a:close/>
              </a:path>
            </a:pathLst>
          </a:custGeom>
          <a:noFill/>
          <a:ln w="222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26" name="手繪多邊形 125"/>
          <p:cNvSpPr/>
          <p:nvPr/>
        </p:nvSpPr>
        <p:spPr>
          <a:xfrm>
            <a:off x="2297756" y="3502113"/>
            <a:ext cx="1269094" cy="692526"/>
          </a:xfrm>
          <a:custGeom>
            <a:avLst/>
            <a:gdLst>
              <a:gd name="connsiteX0" fmla="*/ 221344 w 1269094"/>
              <a:gd name="connsiteY0" fmla="*/ 4388 h 692526"/>
              <a:gd name="connsiteX1" fmla="*/ 237219 w 1269094"/>
              <a:gd name="connsiteY1" fmla="*/ 1213 h 692526"/>
              <a:gd name="connsiteX2" fmla="*/ 262619 w 1269094"/>
              <a:gd name="connsiteY2" fmla="*/ 13913 h 692526"/>
              <a:gd name="connsiteX3" fmla="*/ 268969 w 1269094"/>
              <a:gd name="connsiteY3" fmla="*/ 23438 h 692526"/>
              <a:gd name="connsiteX4" fmla="*/ 275319 w 1269094"/>
              <a:gd name="connsiteY4" fmla="*/ 42488 h 692526"/>
              <a:gd name="connsiteX5" fmla="*/ 272144 w 1269094"/>
              <a:gd name="connsiteY5" fmla="*/ 71063 h 692526"/>
              <a:gd name="connsiteX6" fmla="*/ 262619 w 1269094"/>
              <a:gd name="connsiteY6" fmla="*/ 77413 h 692526"/>
              <a:gd name="connsiteX7" fmla="*/ 253094 w 1269094"/>
              <a:gd name="connsiteY7" fmla="*/ 80588 h 692526"/>
              <a:gd name="connsiteX8" fmla="*/ 205469 w 1269094"/>
              <a:gd name="connsiteY8" fmla="*/ 86938 h 692526"/>
              <a:gd name="connsiteX9" fmla="*/ 176894 w 1269094"/>
              <a:gd name="connsiteY9" fmla="*/ 99638 h 692526"/>
              <a:gd name="connsiteX10" fmla="*/ 164194 w 1269094"/>
              <a:gd name="connsiteY10" fmla="*/ 118688 h 692526"/>
              <a:gd name="connsiteX11" fmla="*/ 157844 w 1269094"/>
              <a:gd name="connsiteY11" fmla="*/ 128213 h 692526"/>
              <a:gd name="connsiteX12" fmla="*/ 148319 w 1269094"/>
              <a:gd name="connsiteY12" fmla="*/ 150438 h 692526"/>
              <a:gd name="connsiteX13" fmla="*/ 138794 w 1269094"/>
              <a:gd name="connsiteY13" fmla="*/ 182188 h 692526"/>
              <a:gd name="connsiteX14" fmla="*/ 141969 w 1269094"/>
              <a:gd name="connsiteY14" fmla="*/ 207588 h 692526"/>
              <a:gd name="connsiteX15" fmla="*/ 173719 w 1269094"/>
              <a:gd name="connsiteY15" fmla="*/ 217113 h 692526"/>
              <a:gd name="connsiteX16" fmla="*/ 202294 w 1269094"/>
              <a:gd name="connsiteY16" fmla="*/ 223463 h 692526"/>
              <a:gd name="connsiteX17" fmla="*/ 249919 w 1269094"/>
              <a:gd name="connsiteY17" fmla="*/ 220288 h 692526"/>
              <a:gd name="connsiteX18" fmla="*/ 272144 w 1269094"/>
              <a:gd name="connsiteY18" fmla="*/ 217113 h 692526"/>
              <a:gd name="connsiteX19" fmla="*/ 281669 w 1269094"/>
              <a:gd name="connsiteY19" fmla="*/ 213938 h 692526"/>
              <a:gd name="connsiteX20" fmla="*/ 300719 w 1269094"/>
              <a:gd name="connsiteY20" fmla="*/ 217113 h 692526"/>
              <a:gd name="connsiteX21" fmla="*/ 303894 w 1269094"/>
              <a:gd name="connsiteY21" fmla="*/ 229813 h 692526"/>
              <a:gd name="connsiteX22" fmla="*/ 319769 w 1269094"/>
              <a:gd name="connsiteY22" fmla="*/ 252038 h 692526"/>
              <a:gd name="connsiteX23" fmla="*/ 332469 w 1269094"/>
              <a:gd name="connsiteY23" fmla="*/ 280613 h 692526"/>
              <a:gd name="connsiteX24" fmla="*/ 332469 w 1269094"/>
              <a:gd name="connsiteY24" fmla="*/ 350463 h 692526"/>
              <a:gd name="connsiteX25" fmla="*/ 326119 w 1269094"/>
              <a:gd name="connsiteY25" fmla="*/ 363163 h 692526"/>
              <a:gd name="connsiteX26" fmla="*/ 319769 w 1269094"/>
              <a:gd name="connsiteY26" fmla="*/ 382213 h 692526"/>
              <a:gd name="connsiteX27" fmla="*/ 322944 w 1269094"/>
              <a:gd name="connsiteY27" fmla="*/ 391738 h 692526"/>
              <a:gd name="connsiteX28" fmla="*/ 376919 w 1269094"/>
              <a:gd name="connsiteY28" fmla="*/ 391738 h 692526"/>
              <a:gd name="connsiteX29" fmla="*/ 380094 w 1269094"/>
              <a:gd name="connsiteY29" fmla="*/ 382213 h 692526"/>
              <a:gd name="connsiteX30" fmla="*/ 399144 w 1269094"/>
              <a:gd name="connsiteY30" fmla="*/ 366338 h 692526"/>
              <a:gd name="connsiteX31" fmla="*/ 453119 w 1269094"/>
              <a:gd name="connsiteY31" fmla="*/ 369513 h 692526"/>
              <a:gd name="connsiteX32" fmla="*/ 472169 w 1269094"/>
              <a:gd name="connsiteY32" fmla="*/ 375863 h 692526"/>
              <a:gd name="connsiteX33" fmla="*/ 554719 w 1269094"/>
              <a:gd name="connsiteY33" fmla="*/ 372688 h 692526"/>
              <a:gd name="connsiteX34" fmla="*/ 557894 w 1269094"/>
              <a:gd name="connsiteY34" fmla="*/ 363163 h 692526"/>
              <a:gd name="connsiteX35" fmla="*/ 554719 w 1269094"/>
              <a:gd name="connsiteY35" fmla="*/ 328238 h 692526"/>
              <a:gd name="connsiteX36" fmla="*/ 545194 w 1269094"/>
              <a:gd name="connsiteY36" fmla="*/ 271088 h 692526"/>
              <a:gd name="connsiteX37" fmla="*/ 535669 w 1269094"/>
              <a:gd name="connsiteY37" fmla="*/ 264738 h 692526"/>
              <a:gd name="connsiteX38" fmla="*/ 538844 w 1269094"/>
              <a:gd name="connsiteY38" fmla="*/ 232988 h 692526"/>
              <a:gd name="connsiteX39" fmla="*/ 542019 w 1269094"/>
              <a:gd name="connsiteY39" fmla="*/ 223463 h 692526"/>
              <a:gd name="connsiteX40" fmla="*/ 567419 w 1269094"/>
              <a:gd name="connsiteY40" fmla="*/ 210763 h 692526"/>
              <a:gd name="connsiteX41" fmla="*/ 589644 w 1269094"/>
              <a:gd name="connsiteY41" fmla="*/ 201238 h 692526"/>
              <a:gd name="connsiteX42" fmla="*/ 605519 w 1269094"/>
              <a:gd name="connsiteY42" fmla="*/ 198063 h 692526"/>
              <a:gd name="connsiteX43" fmla="*/ 656319 w 1269094"/>
              <a:gd name="connsiteY43" fmla="*/ 201238 h 692526"/>
              <a:gd name="connsiteX44" fmla="*/ 697594 w 1269094"/>
              <a:gd name="connsiteY44" fmla="*/ 204413 h 692526"/>
              <a:gd name="connsiteX45" fmla="*/ 716644 w 1269094"/>
              <a:gd name="connsiteY45" fmla="*/ 217113 h 692526"/>
              <a:gd name="connsiteX46" fmla="*/ 738869 w 1269094"/>
              <a:gd name="connsiteY46" fmla="*/ 248863 h 692526"/>
              <a:gd name="connsiteX47" fmla="*/ 745219 w 1269094"/>
              <a:gd name="connsiteY47" fmla="*/ 267913 h 692526"/>
              <a:gd name="connsiteX48" fmla="*/ 748394 w 1269094"/>
              <a:gd name="connsiteY48" fmla="*/ 280613 h 692526"/>
              <a:gd name="connsiteX49" fmla="*/ 754744 w 1269094"/>
              <a:gd name="connsiteY49" fmla="*/ 290138 h 692526"/>
              <a:gd name="connsiteX50" fmla="*/ 757919 w 1269094"/>
              <a:gd name="connsiteY50" fmla="*/ 299663 h 692526"/>
              <a:gd name="connsiteX51" fmla="*/ 770619 w 1269094"/>
              <a:gd name="connsiteY51" fmla="*/ 318713 h 692526"/>
              <a:gd name="connsiteX52" fmla="*/ 776969 w 1269094"/>
              <a:gd name="connsiteY52" fmla="*/ 337763 h 692526"/>
              <a:gd name="connsiteX53" fmla="*/ 783319 w 1269094"/>
              <a:gd name="connsiteY53" fmla="*/ 347288 h 692526"/>
              <a:gd name="connsiteX54" fmla="*/ 786494 w 1269094"/>
              <a:gd name="connsiteY54" fmla="*/ 356813 h 692526"/>
              <a:gd name="connsiteX55" fmla="*/ 802369 w 1269094"/>
              <a:gd name="connsiteY55" fmla="*/ 375863 h 692526"/>
              <a:gd name="connsiteX56" fmla="*/ 811894 w 1269094"/>
              <a:gd name="connsiteY56" fmla="*/ 382213 h 692526"/>
              <a:gd name="connsiteX57" fmla="*/ 824594 w 1269094"/>
              <a:gd name="connsiteY57" fmla="*/ 385388 h 692526"/>
              <a:gd name="connsiteX58" fmla="*/ 875394 w 1269094"/>
              <a:gd name="connsiteY58" fmla="*/ 382213 h 692526"/>
              <a:gd name="connsiteX59" fmla="*/ 884919 w 1269094"/>
              <a:gd name="connsiteY59" fmla="*/ 375863 h 692526"/>
              <a:gd name="connsiteX60" fmla="*/ 903969 w 1269094"/>
              <a:gd name="connsiteY60" fmla="*/ 353638 h 692526"/>
              <a:gd name="connsiteX61" fmla="*/ 913494 w 1269094"/>
              <a:gd name="connsiteY61" fmla="*/ 334588 h 692526"/>
              <a:gd name="connsiteX62" fmla="*/ 919844 w 1269094"/>
              <a:gd name="connsiteY62" fmla="*/ 321888 h 692526"/>
              <a:gd name="connsiteX63" fmla="*/ 938894 w 1269094"/>
              <a:gd name="connsiteY63" fmla="*/ 315538 h 692526"/>
              <a:gd name="connsiteX64" fmla="*/ 948419 w 1269094"/>
              <a:gd name="connsiteY64" fmla="*/ 312363 h 692526"/>
              <a:gd name="connsiteX65" fmla="*/ 967469 w 1269094"/>
              <a:gd name="connsiteY65" fmla="*/ 306013 h 692526"/>
              <a:gd name="connsiteX66" fmla="*/ 976994 w 1269094"/>
              <a:gd name="connsiteY66" fmla="*/ 302838 h 692526"/>
              <a:gd name="connsiteX67" fmla="*/ 986519 w 1269094"/>
              <a:gd name="connsiteY67" fmla="*/ 296488 h 692526"/>
              <a:gd name="connsiteX68" fmla="*/ 999219 w 1269094"/>
              <a:gd name="connsiteY68" fmla="*/ 290138 h 692526"/>
              <a:gd name="connsiteX69" fmla="*/ 1011919 w 1269094"/>
              <a:gd name="connsiteY69" fmla="*/ 280613 h 692526"/>
              <a:gd name="connsiteX70" fmla="*/ 1034144 w 1269094"/>
              <a:gd name="connsiteY70" fmla="*/ 267913 h 692526"/>
              <a:gd name="connsiteX71" fmla="*/ 1053194 w 1269094"/>
              <a:gd name="connsiteY71" fmla="*/ 258388 h 692526"/>
              <a:gd name="connsiteX72" fmla="*/ 1075419 w 1269094"/>
              <a:gd name="connsiteY72" fmla="*/ 245688 h 692526"/>
              <a:gd name="connsiteX73" fmla="*/ 1084944 w 1269094"/>
              <a:gd name="connsiteY73" fmla="*/ 242513 h 692526"/>
              <a:gd name="connsiteX74" fmla="*/ 1126219 w 1269094"/>
              <a:gd name="connsiteY74" fmla="*/ 232988 h 692526"/>
              <a:gd name="connsiteX75" fmla="*/ 1145269 w 1269094"/>
              <a:gd name="connsiteY75" fmla="*/ 226638 h 692526"/>
              <a:gd name="connsiteX76" fmla="*/ 1177019 w 1269094"/>
              <a:gd name="connsiteY76" fmla="*/ 220288 h 692526"/>
              <a:gd name="connsiteX77" fmla="*/ 1259569 w 1269094"/>
              <a:gd name="connsiteY77" fmla="*/ 223463 h 692526"/>
              <a:gd name="connsiteX78" fmla="*/ 1269094 w 1269094"/>
              <a:gd name="connsiteY78" fmla="*/ 258388 h 692526"/>
              <a:gd name="connsiteX79" fmla="*/ 1265919 w 1269094"/>
              <a:gd name="connsiteY79" fmla="*/ 318713 h 692526"/>
              <a:gd name="connsiteX80" fmla="*/ 1262744 w 1269094"/>
              <a:gd name="connsiteY80" fmla="*/ 337763 h 692526"/>
              <a:gd name="connsiteX81" fmla="*/ 1256394 w 1269094"/>
              <a:gd name="connsiteY81" fmla="*/ 347288 h 692526"/>
              <a:gd name="connsiteX82" fmla="*/ 1250044 w 1269094"/>
              <a:gd name="connsiteY82" fmla="*/ 359988 h 692526"/>
              <a:gd name="connsiteX83" fmla="*/ 1243694 w 1269094"/>
              <a:gd name="connsiteY83" fmla="*/ 369513 h 692526"/>
              <a:gd name="connsiteX84" fmla="*/ 1237344 w 1269094"/>
              <a:gd name="connsiteY84" fmla="*/ 391738 h 692526"/>
              <a:gd name="connsiteX85" fmla="*/ 1230994 w 1269094"/>
              <a:gd name="connsiteY85" fmla="*/ 410788 h 692526"/>
              <a:gd name="connsiteX86" fmla="*/ 1221469 w 1269094"/>
              <a:gd name="connsiteY86" fmla="*/ 429838 h 692526"/>
              <a:gd name="connsiteX87" fmla="*/ 1208769 w 1269094"/>
              <a:gd name="connsiteY87" fmla="*/ 455238 h 692526"/>
              <a:gd name="connsiteX88" fmla="*/ 1199244 w 1269094"/>
              <a:gd name="connsiteY88" fmla="*/ 486988 h 692526"/>
              <a:gd name="connsiteX89" fmla="*/ 1196069 w 1269094"/>
              <a:gd name="connsiteY89" fmla="*/ 496513 h 692526"/>
              <a:gd name="connsiteX90" fmla="*/ 1189719 w 1269094"/>
              <a:gd name="connsiteY90" fmla="*/ 506038 h 692526"/>
              <a:gd name="connsiteX91" fmla="*/ 1186544 w 1269094"/>
              <a:gd name="connsiteY91" fmla="*/ 515563 h 692526"/>
              <a:gd name="connsiteX92" fmla="*/ 1170669 w 1269094"/>
              <a:gd name="connsiteY92" fmla="*/ 534613 h 692526"/>
              <a:gd name="connsiteX93" fmla="*/ 1148444 w 1269094"/>
              <a:gd name="connsiteY93" fmla="*/ 556838 h 692526"/>
              <a:gd name="connsiteX94" fmla="*/ 1119869 w 1269094"/>
              <a:gd name="connsiteY94" fmla="*/ 575888 h 692526"/>
              <a:gd name="connsiteX95" fmla="*/ 1110344 w 1269094"/>
              <a:gd name="connsiteY95" fmla="*/ 582238 h 692526"/>
              <a:gd name="connsiteX96" fmla="*/ 1100819 w 1269094"/>
              <a:gd name="connsiteY96" fmla="*/ 585413 h 692526"/>
              <a:gd name="connsiteX97" fmla="*/ 1072244 w 1269094"/>
              <a:gd name="connsiteY97" fmla="*/ 604463 h 692526"/>
              <a:gd name="connsiteX98" fmla="*/ 1059544 w 1269094"/>
              <a:gd name="connsiteY98" fmla="*/ 613988 h 692526"/>
              <a:gd name="connsiteX99" fmla="*/ 1040494 w 1269094"/>
              <a:gd name="connsiteY99" fmla="*/ 626688 h 692526"/>
              <a:gd name="connsiteX100" fmla="*/ 1030969 w 1269094"/>
              <a:gd name="connsiteY100" fmla="*/ 633038 h 692526"/>
              <a:gd name="connsiteX101" fmla="*/ 1021444 w 1269094"/>
              <a:gd name="connsiteY101" fmla="*/ 636213 h 692526"/>
              <a:gd name="connsiteX102" fmla="*/ 996044 w 1269094"/>
              <a:gd name="connsiteY102" fmla="*/ 648913 h 692526"/>
              <a:gd name="connsiteX103" fmla="*/ 976994 w 1269094"/>
              <a:gd name="connsiteY103" fmla="*/ 655263 h 692526"/>
              <a:gd name="connsiteX104" fmla="*/ 967469 w 1269094"/>
              <a:gd name="connsiteY104" fmla="*/ 658438 h 692526"/>
              <a:gd name="connsiteX105" fmla="*/ 957944 w 1269094"/>
              <a:gd name="connsiteY105" fmla="*/ 664788 h 692526"/>
              <a:gd name="connsiteX106" fmla="*/ 945244 w 1269094"/>
              <a:gd name="connsiteY106" fmla="*/ 667963 h 692526"/>
              <a:gd name="connsiteX107" fmla="*/ 935719 w 1269094"/>
              <a:gd name="connsiteY107" fmla="*/ 671138 h 692526"/>
              <a:gd name="connsiteX108" fmla="*/ 910319 w 1269094"/>
              <a:gd name="connsiteY108" fmla="*/ 677488 h 692526"/>
              <a:gd name="connsiteX109" fmla="*/ 900794 w 1269094"/>
              <a:gd name="connsiteY109" fmla="*/ 683838 h 692526"/>
              <a:gd name="connsiteX110" fmla="*/ 827769 w 1269094"/>
              <a:gd name="connsiteY110" fmla="*/ 683838 h 692526"/>
              <a:gd name="connsiteX111" fmla="*/ 780144 w 1269094"/>
              <a:gd name="connsiteY111" fmla="*/ 674313 h 692526"/>
              <a:gd name="connsiteX112" fmla="*/ 767444 w 1269094"/>
              <a:gd name="connsiteY112" fmla="*/ 671138 h 692526"/>
              <a:gd name="connsiteX113" fmla="*/ 707119 w 1269094"/>
              <a:gd name="connsiteY113" fmla="*/ 667963 h 692526"/>
              <a:gd name="connsiteX114" fmla="*/ 697594 w 1269094"/>
              <a:gd name="connsiteY114" fmla="*/ 661613 h 692526"/>
              <a:gd name="connsiteX115" fmla="*/ 678544 w 1269094"/>
              <a:gd name="connsiteY115" fmla="*/ 655263 h 692526"/>
              <a:gd name="connsiteX116" fmla="*/ 662669 w 1269094"/>
              <a:gd name="connsiteY116" fmla="*/ 652088 h 692526"/>
              <a:gd name="connsiteX117" fmla="*/ 643619 w 1269094"/>
              <a:gd name="connsiteY117" fmla="*/ 645738 h 692526"/>
              <a:gd name="connsiteX118" fmla="*/ 630919 w 1269094"/>
              <a:gd name="connsiteY118" fmla="*/ 642563 h 692526"/>
              <a:gd name="connsiteX119" fmla="*/ 602344 w 1269094"/>
              <a:gd name="connsiteY119" fmla="*/ 655263 h 692526"/>
              <a:gd name="connsiteX120" fmla="*/ 488044 w 1269094"/>
              <a:gd name="connsiteY120" fmla="*/ 648913 h 692526"/>
              <a:gd name="connsiteX121" fmla="*/ 475344 w 1269094"/>
              <a:gd name="connsiteY121" fmla="*/ 645738 h 692526"/>
              <a:gd name="connsiteX122" fmla="*/ 389619 w 1269094"/>
              <a:gd name="connsiteY122" fmla="*/ 642563 h 692526"/>
              <a:gd name="connsiteX123" fmla="*/ 370569 w 1269094"/>
              <a:gd name="connsiteY123" fmla="*/ 629863 h 692526"/>
              <a:gd name="connsiteX124" fmla="*/ 351519 w 1269094"/>
              <a:gd name="connsiteY124" fmla="*/ 620338 h 692526"/>
              <a:gd name="connsiteX125" fmla="*/ 341994 w 1269094"/>
              <a:gd name="connsiteY125" fmla="*/ 613988 h 692526"/>
              <a:gd name="connsiteX126" fmla="*/ 332469 w 1269094"/>
              <a:gd name="connsiteY126" fmla="*/ 610813 h 692526"/>
              <a:gd name="connsiteX127" fmla="*/ 294369 w 1269094"/>
              <a:gd name="connsiteY127" fmla="*/ 604463 h 692526"/>
              <a:gd name="connsiteX128" fmla="*/ 281669 w 1269094"/>
              <a:gd name="connsiteY128" fmla="*/ 601288 h 692526"/>
              <a:gd name="connsiteX129" fmla="*/ 265794 w 1269094"/>
              <a:gd name="connsiteY129" fmla="*/ 598113 h 692526"/>
              <a:gd name="connsiteX130" fmla="*/ 256269 w 1269094"/>
              <a:gd name="connsiteY130" fmla="*/ 591763 h 692526"/>
              <a:gd name="connsiteX131" fmla="*/ 243569 w 1269094"/>
              <a:gd name="connsiteY131" fmla="*/ 582238 h 692526"/>
              <a:gd name="connsiteX132" fmla="*/ 230869 w 1269094"/>
              <a:gd name="connsiteY132" fmla="*/ 579063 h 692526"/>
              <a:gd name="connsiteX133" fmla="*/ 221344 w 1269094"/>
              <a:gd name="connsiteY133" fmla="*/ 575888 h 692526"/>
              <a:gd name="connsiteX134" fmla="*/ 195944 w 1269094"/>
              <a:gd name="connsiteY134" fmla="*/ 563188 h 692526"/>
              <a:gd name="connsiteX135" fmla="*/ 176894 w 1269094"/>
              <a:gd name="connsiteY135" fmla="*/ 553663 h 692526"/>
              <a:gd name="connsiteX136" fmla="*/ 170544 w 1269094"/>
              <a:gd name="connsiteY136" fmla="*/ 544138 h 692526"/>
              <a:gd name="connsiteX137" fmla="*/ 148319 w 1269094"/>
              <a:gd name="connsiteY137" fmla="*/ 534613 h 692526"/>
              <a:gd name="connsiteX138" fmla="*/ 119744 w 1269094"/>
              <a:gd name="connsiteY138" fmla="*/ 509213 h 692526"/>
              <a:gd name="connsiteX139" fmla="*/ 107044 w 1269094"/>
              <a:gd name="connsiteY139" fmla="*/ 486988 h 692526"/>
              <a:gd name="connsiteX140" fmla="*/ 87994 w 1269094"/>
              <a:gd name="connsiteY140" fmla="*/ 458413 h 692526"/>
              <a:gd name="connsiteX141" fmla="*/ 81644 w 1269094"/>
              <a:gd name="connsiteY141" fmla="*/ 445713 h 692526"/>
              <a:gd name="connsiteX142" fmla="*/ 72119 w 1269094"/>
              <a:gd name="connsiteY142" fmla="*/ 401263 h 692526"/>
              <a:gd name="connsiteX143" fmla="*/ 68944 w 1269094"/>
              <a:gd name="connsiteY143" fmla="*/ 391738 h 692526"/>
              <a:gd name="connsiteX144" fmla="*/ 56244 w 1269094"/>
              <a:gd name="connsiteY144" fmla="*/ 372688 h 692526"/>
              <a:gd name="connsiteX145" fmla="*/ 49894 w 1269094"/>
              <a:gd name="connsiteY145" fmla="*/ 363163 h 692526"/>
              <a:gd name="connsiteX146" fmla="*/ 37194 w 1269094"/>
              <a:gd name="connsiteY146" fmla="*/ 340938 h 692526"/>
              <a:gd name="connsiteX147" fmla="*/ 27669 w 1269094"/>
              <a:gd name="connsiteY147" fmla="*/ 334588 h 692526"/>
              <a:gd name="connsiteX148" fmla="*/ 8619 w 1269094"/>
              <a:gd name="connsiteY148" fmla="*/ 318713 h 692526"/>
              <a:gd name="connsiteX149" fmla="*/ 2269 w 1269094"/>
              <a:gd name="connsiteY149" fmla="*/ 252038 h 692526"/>
              <a:gd name="connsiteX150" fmla="*/ 5444 w 1269094"/>
              <a:gd name="connsiteY150" fmla="*/ 191713 h 692526"/>
              <a:gd name="connsiteX151" fmla="*/ 18144 w 1269094"/>
              <a:gd name="connsiteY151" fmla="*/ 172663 h 692526"/>
              <a:gd name="connsiteX152" fmla="*/ 30844 w 1269094"/>
              <a:gd name="connsiteY152" fmla="*/ 150438 h 692526"/>
              <a:gd name="connsiteX153" fmla="*/ 40369 w 1269094"/>
              <a:gd name="connsiteY153" fmla="*/ 128213 h 692526"/>
              <a:gd name="connsiteX154" fmla="*/ 43544 w 1269094"/>
              <a:gd name="connsiteY154" fmla="*/ 115513 h 692526"/>
              <a:gd name="connsiteX155" fmla="*/ 49894 w 1269094"/>
              <a:gd name="connsiteY155" fmla="*/ 86938 h 692526"/>
              <a:gd name="connsiteX156" fmla="*/ 56244 w 1269094"/>
              <a:gd name="connsiteY156" fmla="*/ 67888 h 692526"/>
              <a:gd name="connsiteX157" fmla="*/ 72119 w 1269094"/>
              <a:gd name="connsiteY157" fmla="*/ 48838 h 692526"/>
              <a:gd name="connsiteX158" fmla="*/ 97519 w 1269094"/>
              <a:gd name="connsiteY158" fmla="*/ 45663 h 692526"/>
              <a:gd name="connsiteX159" fmla="*/ 107044 w 1269094"/>
              <a:gd name="connsiteY159" fmla="*/ 42488 h 692526"/>
              <a:gd name="connsiteX160" fmla="*/ 157844 w 1269094"/>
              <a:gd name="connsiteY160" fmla="*/ 36138 h 692526"/>
              <a:gd name="connsiteX161" fmla="*/ 186419 w 1269094"/>
              <a:gd name="connsiteY161" fmla="*/ 29788 h 692526"/>
              <a:gd name="connsiteX162" fmla="*/ 205469 w 1269094"/>
              <a:gd name="connsiteY162" fmla="*/ 26613 h 692526"/>
              <a:gd name="connsiteX163" fmla="*/ 218169 w 1269094"/>
              <a:gd name="connsiteY163" fmla="*/ 23438 h 692526"/>
              <a:gd name="connsiteX164" fmla="*/ 221344 w 1269094"/>
              <a:gd name="connsiteY164" fmla="*/ 4388 h 69252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</a:cxnLst>
            <a:rect l="l" t="t" r="r" b="b"/>
            <a:pathLst>
              <a:path w="1269094" h="692526">
                <a:moveTo>
                  <a:pt x="221344" y="4388"/>
                </a:moveTo>
                <a:cubicBezTo>
                  <a:pt x="224519" y="684"/>
                  <a:pt x="231961" y="0"/>
                  <a:pt x="237219" y="1213"/>
                </a:cubicBezTo>
                <a:cubicBezTo>
                  <a:pt x="246443" y="3342"/>
                  <a:pt x="262619" y="13913"/>
                  <a:pt x="262619" y="13913"/>
                </a:cubicBezTo>
                <a:cubicBezTo>
                  <a:pt x="264736" y="17088"/>
                  <a:pt x="267419" y="19951"/>
                  <a:pt x="268969" y="23438"/>
                </a:cubicBezTo>
                <a:cubicBezTo>
                  <a:pt x="271687" y="29555"/>
                  <a:pt x="275319" y="42488"/>
                  <a:pt x="275319" y="42488"/>
                </a:cubicBezTo>
                <a:cubicBezTo>
                  <a:pt x="274261" y="52013"/>
                  <a:pt x="275419" y="62056"/>
                  <a:pt x="272144" y="71063"/>
                </a:cubicBezTo>
                <a:cubicBezTo>
                  <a:pt x="270840" y="74649"/>
                  <a:pt x="266032" y="75706"/>
                  <a:pt x="262619" y="77413"/>
                </a:cubicBezTo>
                <a:cubicBezTo>
                  <a:pt x="259626" y="78910"/>
                  <a:pt x="256341" y="79776"/>
                  <a:pt x="253094" y="80588"/>
                </a:cubicBezTo>
                <a:cubicBezTo>
                  <a:pt x="235558" y="84972"/>
                  <a:pt x="225307" y="84954"/>
                  <a:pt x="205469" y="86938"/>
                </a:cubicBezTo>
                <a:cubicBezTo>
                  <a:pt x="182799" y="94495"/>
                  <a:pt x="191988" y="89575"/>
                  <a:pt x="176894" y="99638"/>
                </a:cubicBezTo>
                <a:lnTo>
                  <a:pt x="164194" y="118688"/>
                </a:lnTo>
                <a:cubicBezTo>
                  <a:pt x="162077" y="121863"/>
                  <a:pt x="159051" y="124593"/>
                  <a:pt x="157844" y="128213"/>
                </a:cubicBezTo>
                <a:cubicBezTo>
                  <a:pt x="147624" y="158874"/>
                  <a:pt x="164012" y="111204"/>
                  <a:pt x="148319" y="150438"/>
                </a:cubicBezTo>
                <a:cubicBezTo>
                  <a:pt x="143166" y="163321"/>
                  <a:pt x="141913" y="169713"/>
                  <a:pt x="138794" y="182188"/>
                </a:cubicBezTo>
                <a:cubicBezTo>
                  <a:pt x="139852" y="190655"/>
                  <a:pt x="138800" y="199666"/>
                  <a:pt x="141969" y="207588"/>
                </a:cubicBezTo>
                <a:cubicBezTo>
                  <a:pt x="145469" y="216339"/>
                  <a:pt x="171743" y="216831"/>
                  <a:pt x="173719" y="217113"/>
                </a:cubicBezTo>
                <a:cubicBezTo>
                  <a:pt x="183541" y="220387"/>
                  <a:pt x="191118" y="223463"/>
                  <a:pt x="202294" y="223463"/>
                </a:cubicBezTo>
                <a:cubicBezTo>
                  <a:pt x="218204" y="223463"/>
                  <a:pt x="234044" y="221346"/>
                  <a:pt x="249919" y="220288"/>
                </a:cubicBezTo>
                <a:cubicBezTo>
                  <a:pt x="257327" y="219230"/>
                  <a:pt x="264806" y="218581"/>
                  <a:pt x="272144" y="217113"/>
                </a:cubicBezTo>
                <a:cubicBezTo>
                  <a:pt x="275426" y="216457"/>
                  <a:pt x="278322" y="213938"/>
                  <a:pt x="281669" y="213938"/>
                </a:cubicBezTo>
                <a:cubicBezTo>
                  <a:pt x="288107" y="213938"/>
                  <a:pt x="294369" y="216055"/>
                  <a:pt x="300719" y="217113"/>
                </a:cubicBezTo>
                <a:cubicBezTo>
                  <a:pt x="301777" y="221346"/>
                  <a:pt x="301943" y="225910"/>
                  <a:pt x="303894" y="229813"/>
                </a:cubicBezTo>
                <a:cubicBezTo>
                  <a:pt x="308585" y="239195"/>
                  <a:pt x="315621" y="242704"/>
                  <a:pt x="319769" y="252038"/>
                </a:cubicBezTo>
                <a:cubicBezTo>
                  <a:pt x="334882" y="286043"/>
                  <a:pt x="318098" y="259057"/>
                  <a:pt x="332469" y="280613"/>
                </a:cubicBezTo>
                <a:cubicBezTo>
                  <a:pt x="338307" y="309804"/>
                  <a:pt x="338871" y="305650"/>
                  <a:pt x="332469" y="350463"/>
                </a:cubicBezTo>
                <a:cubicBezTo>
                  <a:pt x="331800" y="355148"/>
                  <a:pt x="327877" y="358769"/>
                  <a:pt x="326119" y="363163"/>
                </a:cubicBezTo>
                <a:cubicBezTo>
                  <a:pt x="323633" y="369378"/>
                  <a:pt x="319769" y="382213"/>
                  <a:pt x="319769" y="382213"/>
                </a:cubicBezTo>
                <a:cubicBezTo>
                  <a:pt x="320827" y="385388"/>
                  <a:pt x="319745" y="390754"/>
                  <a:pt x="322944" y="391738"/>
                </a:cubicBezTo>
                <a:cubicBezTo>
                  <a:pt x="347208" y="399204"/>
                  <a:pt x="356684" y="395785"/>
                  <a:pt x="376919" y="391738"/>
                </a:cubicBezTo>
                <a:cubicBezTo>
                  <a:pt x="377977" y="388563"/>
                  <a:pt x="378238" y="384998"/>
                  <a:pt x="380094" y="382213"/>
                </a:cubicBezTo>
                <a:cubicBezTo>
                  <a:pt x="384983" y="374879"/>
                  <a:pt x="392116" y="371024"/>
                  <a:pt x="399144" y="366338"/>
                </a:cubicBezTo>
                <a:cubicBezTo>
                  <a:pt x="417136" y="367396"/>
                  <a:pt x="435248" y="367182"/>
                  <a:pt x="453119" y="369513"/>
                </a:cubicBezTo>
                <a:cubicBezTo>
                  <a:pt x="459756" y="370379"/>
                  <a:pt x="472169" y="375863"/>
                  <a:pt x="472169" y="375863"/>
                </a:cubicBezTo>
                <a:cubicBezTo>
                  <a:pt x="499686" y="374805"/>
                  <a:pt x="527479" y="376724"/>
                  <a:pt x="554719" y="372688"/>
                </a:cubicBezTo>
                <a:cubicBezTo>
                  <a:pt x="558030" y="372198"/>
                  <a:pt x="557894" y="366510"/>
                  <a:pt x="557894" y="363163"/>
                </a:cubicBezTo>
                <a:cubicBezTo>
                  <a:pt x="557894" y="351473"/>
                  <a:pt x="555616" y="339893"/>
                  <a:pt x="554719" y="328238"/>
                </a:cubicBezTo>
                <a:cubicBezTo>
                  <a:pt x="553355" y="310507"/>
                  <a:pt x="559874" y="285768"/>
                  <a:pt x="545194" y="271088"/>
                </a:cubicBezTo>
                <a:cubicBezTo>
                  <a:pt x="542496" y="268390"/>
                  <a:pt x="538844" y="266855"/>
                  <a:pt x="535669" y="264738"/>
                </a:cubicBezTo>
                <a:cubicBezTo>
                  <a:pt x="536727" y="254155"/>
                  <a:pt x="537227" y="243500"/>
                  <a:pt x="538844" y="232988"/>
                </a:cubicBezTo>
                <a:cubicBezTo>
                  <a:pt x="539353" y="229680"/>
                  <a:pt x="540163" y="226248"/>
                  <a:pt x="542019" y="223463"/>
                </a:cubicBezTo>
                <a:cubicBezTo>
                  <a:pt x="550698" y="210444"/>
                  <a:pt x="552743" y="214432"/>
                  <a:pt x="567419" y="210763"/>
                </a:cubicBezTo>
                <a:cubicBezTo>
                  <a:pt x="589613" y="205215"/>
                  <a:pt x="562384" y="210325"/>
                  <a:pt x="589644" y="201238"/>
                </a:cubicBezTo>
                <a:cubicBezTo>
                  <a:pt x="594764" y="199531"/>
                  <a:pt x="600227" y="199121"/>
                  <a:pt x="605519" y="198063"/>
                </a:cubicBezTo>
                <a:lnTo>
                  <a:pt x="656319" y="201238"/>
                </a:lnTo>
                <a:cubicBezTo>
                  <a:pt x="670085" y="202187"/>
                  <a:pt x="684249" y="200901"/>
                  <a:pt x="697594" y="204413"/>
                </a:cubicBezTo>
                <a:cubicBezTo>
                  <a:pt x="704974" y="206355"/>
                  <a:pt x="716644" y="217113"/>
                  <a:pt x="716644" y="217113"/>
                </a:cubicBezTo>
                <a:cubicBezTo>
                  <a:pt x="720991" y="222909"/>
                  <a:pt x="737305" y="244172"/>
                  <a:pt x="738869" y="248863"/>
                </a:cubicBezTo>
                <a:lnTo>
                  <a:pt x="745219" y="267913"/>
                </a:lnTo>
                <a:cubicBezTo>
                  <a:pt x="746599" y="272053"/>
                  <a:pt x="746675" y="276602"/>
                  <a:pt x="748394" y="280613"/>
                </a:cubicBezTo>
                <a:cubicBezTo>
                  <a:pt x="749897" y="284120"/>
                  <a:pt x="753037" y="286725"/>
                  <a:pt x="754744" y="290138"/>
                </a:cubicBezTo>
                <a:cubicBezTo>
                  <a:pt x="756241" y="293131"/>
                  <a:pt x="756294" y="296737"/>
                  <a:pt x="757919" y="299663"/>
                </a:cubicBezTo>
                <a:cubicBezTo>
                  <a:pt x="761625" y="306334"/>
                  <a:pt x="766386" y="312363"/>
                  <a:pt x="770619" y="318713"/>
                </a:cubicBezTo>
                <a:cubicBezTo>
                  <a:pt x="774332" y="324282"/>
                  <a:pt x="774852" y="331413"/>
                  <a:pt x="776969" y="337763"/>
                </a:cubicBezTo>
                <a:cubicBezTo>
                  <a:pt x="778176" y="341383"/>
                  <a:pt x="781612" y="343875"/>
                  <a:pt x="783319" y="347288"/>
                </a:cubicBezTo>
                <a:cubicBezTo>
                  <a:pt x="784816" y="350281"/>
                  <a:pt x="784997" y="353820"/>
                  <a:pt x="786494" y="356813"/>
                </a:cubicBezTo>
                <a:cubicBezTo>
                  <a:pt x="790062" y="363949"/>
                  <a:pt x="796350" y="370847"/>
                  <a:pt x="802369" y="375863"/>
                </a:cubicBezTo>
                <a:cubicBezTo>
                  <a:pt x="805300" y="378306"/>
                  <a:pt x="808387" y="380710"/>
                  <a:pt x="811894" y="382213"/>
                </a:cubicBezTo>
                <a:cubicBezTo>
                  <a:pt x="815905" y="383932"/>
                  <a:pt x="820361" y="384330"/>
                  <a:pt x="824594" y="385388"/>
                </a:cubicBezTo>
                <a:cubicBezTo>
                  <a:pt x="841527" y="384330"/>
                  <a:pt x="858635" y="384859"/>
                  <a:pt x="875394" y="382213"/>
                </a:cubicBezTo>
                <a:cubicBezTo>
                  <a:pt x="879163" y="381618"/>
                  <a:pt x="881988" y="378306"/>
                  <a:pt x="884919" y="375863"/>
                </a:cubicBezTo>
                <a:cubicBezTo>
                  <a:pt x="893764" y="368493"/>
                  <a:pt x="896962" y="362981"/>
                  <a:pt x="903969" y="353638"/>
                </a:cubicBezTo>
                <a:cubicBezTo>
                  <a:pt x="909790" y="336174"/>
                  <a:pt x="903646" y="351822"/>
                  <a:pt x="913494" y="334588"/>
                </a:cubicBezTo>
                <a:cubicBezTo>
                  <a:pt x="915842" y="330479"/>
                  <a:pt x="916058" y="324728"/>
                  <a:pt x="919844" y="321888"/>
                </a:cubicBezTo>
                <a:cubicBezTo>
                  <a:pt x="925199" y="317872"/>
                  <a:pt x="932544" y="317655"/>
                  <a:pt x="938894" y="315538"/>
                </a:cubicBezTo>
                <a:lnTo>
                  <a:pt x="948419" y="312363"/>
                </a:lnTo>
                <a:lnTo>
                  <a:pt x="967469" y="306013"/>
                </a:lnTo>
                <a:lnTo>
                  <a:pt x="976994" y="302838"/>
                </a:lnTo>
                <a:cubicBezTo>
                  <a:pt x="980169" y="300721"/>
                  <a:pt x="983206" y="298381"/>
                  <a:pt x="986519" y="296488"/>
                </a:cubicBezTo>
                <a:cubicBezTo>
                  <a:pt x="990628" y="294140"/>
                  <a:pt x="995205" y="292646"/>
                  <a:pt x="999219" y="290138"/>
                </a:cubicBezTo>
                <a:cubicBezTo>
                  <a:pt x="1003706" y="287333"/>
                  <a:pt x="1007613" y="283689"/>
                  <a:pt x="1011919" y="280613"/>
                </a:cubicBezTo>
                <a:cubicBezTo>
                  <a:pt x="1027390" y="269562"/>
                  <a:pt x="1015541" y="278543"/>
                  <a:pt x="1034144" y="267913"/>
                </a:cubicBezTo>
                <a:cubicBezTo>
                  <a:pt x="1051378" y="258065"/>
                  <a:pt x="1035730" y="264209"/>
                  <a:pt x="1053194" y="258388"/>
                </a:cubicBezTo>
                <a:cubicBezTo>
                  <a:pt x="1062760" y="252011"/>
                  <a:pt x="1064140" y="250522"/>
                  <a:pt x="1075419" y="245688"/>
                </a:cubicBezTo>
                <a:cubicBezTo>
                  <a:pt x="1078495" y="244370"/>
                  <a:pt x="1081769" y="243571"/>
                  <a:pt x="1084944" y="242513"/>
                </a:cubicBezTo>
                <a:cubicBezTo>
                  <a:pt x="1105648" y="228711"/>
                  <a:pt x="1084181" y="240870"/>
                  <a:pt x="1126219" y="232988"/>
                </a:cubicBezTo>
                <a:cubicBezTo>
                  <a:pt x="1132798" y="231754"/>
                  <a:pt x="1138919" y="228755"/>
                  <a:pt x="1145269" y="226638"/>
                </a:cubicBezTo>
                <a:cubicBezTo>
                  <a:pt x="1154742" y="223480"/>
                  <a:pt x="1167640" y="221851"/>
                  <a:pt x="1177019" y="220288"/>
                </a:cubicBezTo>
                <a:cubicBezTo>
                  <a:pt x="1204536" y="221346"/>
                  <a:pt x="1232854" y="216784"/>
                  <a:pt x="1259569" y="223463"/>
                </a:cubicBezTo>
                <a:cubicBezTo>
                  <a:pt x="1262961" y="224311"/>
                  <a:pt x="1268367" y="254752"/>
                  <a:pt x="1269094" y="258388"/>
                </a:cubicBezTo>
                <a:cubicBezTo>
                  <a:pt x="1268036" y="278496"/>
                  <a:pt x="1267525" y="298641"/>
                  <a:pt x="1265919" y="318713"/>
                </a:cubicBezTo>
                <a:cubicBezTo>
                  <a:pt x="1265406" y="325130"/>
                  <a:pt x="1264780" y="331656"/>
                  <a:pt x="1262744" y="337763"/>
                </a:cubicBezTo>
                <a:cubicBezTo>
                  <a:pt x="1261537" y="341383"/>
                  <a:pt x="1258287" y="343975"/>
                  <a:pt x="1256394" y="347288"/>
                </a:cubicBezTo>
                <a:cubicBezTo>
                  <a:pt x="1254046" y="351397"/>
                  <a:pt x="1252392" y="355879"/>
                  <a:pt x="1250044" y="359988"/>
                </a:cubicBezTo>
                <a:cubicBezTo>
                  <a:pt x="1248151" y="363301"/>
                  <a:pt x="1245401" y="366100"/>
                  <a:pt x="1243694" y="369513"/>
                </a:cubicBezTo>
                <a:cubicBezTo>
                  <a:pt x="1241026" y="374848"/>
                  <a:pt x="1238870" y="386652"/>
                  <a:pt x="1237344" y="391738"/>
                </a:cubicBezTo>
                <a:cubicBezTo>
                  <a:pt x="1235421" y="398149"/>
                  <a:pt x="1234707" y="405219"/>
                  <a:pt x="1230994" y="410788"/>
                </a:cubicBezTo>
                <a:cubicBezTo>
                  <a:pt x="1217078" y="431662"/>
                  <a:pt x="1230858" y="409181"/>
                  <a:pt x="1221469" y="429838"/>
                </a:cubicBezTo>
                <a:cubicBezTo>
                  <a:pt x="1217552" y="438456"/>
                  <a:pt x="1211065" y="446055"/>
                  <a:pt x="1208769" y="455238"/>
                </a:cubicBezTo>
                <a:cubicBezTo>
                  <a:pt x="1203971" y="474432"/>
                  <a:pt x="1206974" y="463798"/>
                  <a:pt x="1199244" y="486988"/>
                </a:cubicBezTo>
                <a:cubicBezTo>
                  <a:pt x="1198186" y="490163"/>
                  <a:pt x="1197925" y="493728"/>
                  <a:pt x="1196069" y="496513"/>
                </a:cubicBezTo>
                <a:cubicBezTo>
                  <a:pt x="1193952" y="499688"/>
                  <a:pt x="1191426" y="502625"/>
                  <a:pt x="1189719" y="506038"/>
                </a:cubicBezTo>
                <a:cubicBezTo>
                  <a:pt x="1188222" y="509031"/>
                  <a:pt x="1188041" y="512570"/>
                  <a:pt x="1186544" y="515563"/>
                </a:cubicBezTo>
                <a:cubicBezTo>
                  <a:pt x="1182124" y="524404"/>
                  <a:pt x="1177691" y="527591"/>
                  <a:pt x="1170669" y="534613"/>
                </a:cubicBezTo>
                <a:cubicBezTo>
                  <a:pt x="1165081" y="551378"/>
                  <a:pt x="1170279" y="542282"/>
                  <a:pt x="1148444" y="556838"/>
                </a:cubicBezTo>
                <a:lnTo>
                  <a:pt x="1119869" y="575888"/>
                </a:lnTo>
                <a:cubicBezTo>
                  <a:pt x="1116694" y="578005"/>
                  <a:pt x="1113964" y="581031"/>
                  <a:pt x="1110344" y="582238"/>
                </a:cubicBezTo>
                <a:lnTo>
                  <a:pt x="1100819" y="585413"/>
                </a:lnTo>
                <a:lnTo>
                  <a:pt x="1072244" y="604463"/>
                </a:lnTo>
                <a:cubicBezTo>
                  <a:pt x="1067841" y="607398"/>
                  <a:pt x="1063879" y="610953"/>
                  <a:pt x="1059544" y="613988"/>
                </a:cubicBezTo>
                <a:cubicBezTo>
                  <a:pt x="1053292" y="618365"/>
                  <a:pt x="1046844" y="622455"/>
                  <a:pt x="1040494" y="626688"/>
                </a:cubicBezTo>
                <a:cubicBezTo>
                  <a:pt x="1037319" y="628805"/>
                  <a:pt x="1034589" y="631831"/>
                  <a:pt x="1030969" y="633038"/>
                </a:cubicBezTo>
                <a:lnTo>
                  <a:pt x="1021444" y="636213"/>
                </a:lnTo>
                <a:cubicBezTo>
                  <a:pt x="1002850" y="650158"/>
                  <a:pt x="1015859" y="642968"/>
                  <a:pt x="996044" y="648913"/>
                </a:cubicBezTo>
                <a:cubicBezTo>
                  <a:pt x="989633" y="650836"/>
                  <a:pt x="983344" y="653146"/>
                  <a:pt x="976994" y="655263"/>
                </a:cubicBezTo>
                <a:lnTo>
                  <a:pt x="967469" y="658438"/>
                </a:lnTo>
                <a:cubicBezTo>
                  <a:pt x="964294" y="660555"/>
                  <a:pt x="961451" y="663285"/>
                  <a:pt x="957944" y="664788"/>
                </a:cubicBezTo>
                <a:cubicBezTo>
                  <a:pt x="953933" y="666507"/>
                  <a:pt x="949440" y="666764"/>
                  <a:pt x="945244" y="667963"/>
                </a:cubicBezTo>
                <a:cubicBezTo>
                  <a:pt x="942026" y="668882"/>
                  <a:pt x="938966" y="670326"/>
                  <a:pt x="935719" y="671138"/>
                </a:cubicBezTo>
                <a:lnTo>
                  <a:pt x="910319" y="677488"/>
                </a:lnTo>
                <a:cubicBezTo>
                  <a:pt x="907144" y="679605"/>
                  <a:pt x="904301" y="682335"/>
                  <a:pt x="900794" y="683838"/>
                </a:cubicBezTo>
                <a:cubicBezTo>
                  <a:pt x="880521" y="692526"/>
                  <a:pt x="837251" y="684337"/>
                  <a:pt x="827769" y="683838"/>
                </a:cubicBezTo>
                <a:cubicBezTo>
                  <a:pt x="799627" y="674457"/>
                  <a:pt x="815372" y="678227"/>
                  <a:pt x="780144" y="674313"/>
                </a:cubicBezTo>
                <a:cubicBezTo>
                  <a:pt x="775911" y="673255"/>
                  <a:pt x="771791" y="671516"/>
                  <a:pt x="767444" y="671138"/>
                </a:cubicBezTo>
                <a:cubicBezTo>
                  <a:pt x="747384" y="669394"/>
                  <a:pt x="727071" y="670684"/>
                  <a:pt x="707119" y="667963"/>
                </a:cubicBezTo>
                <a:cubicBezTo>
                  <a:pt x="703338" y="667447"/>
                  <a:pt x="701081" y="663163"/>
                  <a:pt x="697594" y="661613"/>
                </a:cubicBezTo>
                <a:cubicBezTo>
                  <a:pt x="691477" y="658895"/>
                  <a:pt x="685108" y="656576"/>
                  <a:pt x="678544" y="655263"/>
                </a:cubicBezTo>
                <a:cubicBezTo>
                  <a:pt x="673252" y="654205"/>
                  <a:pt x="667875" y="653508"/>
                  <a:pt x="662669" y="652088"/>
                </a:cubicBezTo>
                <a:cubicBezTo>
                  <a:pt x="656211" y="650327"/>
                  <a:pt x="650113" y="647361"/>
                  <a:pt x="643619" y="645738"/>
                </a:cubicBezTo>
                <a:lnTo>
                  <a:pt x="630919" y="642563"/>
                </a:lnTo>
                <a:cubicBezTo>
                  <a:pt x="608249" y="650120"/>
                  <a:pt x="617438" y="645200"/>
                  <a:pt x="602344" y="655263"/>
                </a:cubicBezTo>
                <a:cubicBezTo>
                  <a:pt x="564244" y="653146"/>
                  <a:pt x="525063" y="658168"/>
                  <a:pt x="488044" y="648913"/>
                </a:cubicBezTo>
                <a:cubicBezTo>
                  <a:pt x="483811" y="647855"/>
                  <a:pt x="479699" y="646019"/>
                  <a:pt x="475344" y="645738"/>
                </a:cubicBezTo>
                <a:cubicBezTo>
                  <a:pt x="446809" y="643897"/>
                  <a:pt x="418194" y="643621"/>
                  <a:pt x="389619" y="642563"/>
                </a:cubicBezTo>
                <a:cubicBezTo>
                  <a:pt x="372880" y="636983"/>
                  <a:pt x="386424" y="643076"/>
                  <a:pt x="370569" y="629863"/>
                </a:cubicBezTo>
                <a:cubicBezTo>
                  <a:pt x="362363" y="623024"/>
                  <a:pt x="361065" y="623520"/>
                  <a:pt x="351519" y="620338"/>
                </a:cubicBezTo>
                <a:cubicBezTo>
                  <a:pt x="348344" y="618221"/>
                  <a:pt x="345407" y="615695"/>
                  <a:pt x="341994" y="613988"/>
                </a:cubicBezTo>
                <a:cubicBezTo>
                  <a:pt x="339001" y="612491"/>
                  <a:pt x="335687" y="611732"/>
                  <a:pt x="332469" y="610813"/>
                </a:cubicBezTo>
                <a:cubicBezTo>
                  <a:pt x="312463" y="605097"/>
                  <a:pt x="322198" y="609101"/>
                  <a:pt x="294369" y="604463"/>
                </a:cubicBezTo>
                <a:cubicBezTo>
                  <a:pt x="290065" y="603746"/>
                  <a:pt x="285929" y="602235"/>
                  <a:pt x="281669" y="601288"/>
                </a:cubicBezTo>
                <a:cubicBezTo>
                  <a:pt x="276401" y="600117"/>
                  <a:pt x="271086" y="599171"/>
                  <a:pt x="265794" y="598113"/>
                </a:cubicBezTo>
                <a:cubicBezTo>
                  <a:pt x="262619" y="595996"/>
                  <a:pt x="259374" y="593981"/>
                  <a:pt x="256269" y="591763"/>
                </a:cubicBezTo>
                <a:cubicBezTo>
                  <a:pt x="251963" y="588687"/>
                  <a:pt x="248302" y="584605"/>
                  <a:pt x="243569" y="582238"/>
                </a:cubicBezTo>
                <a:cubicBezTo>
                  <a:pt x="239666" y="580287"/>
                  <a:pt x="235065" y="580262"/>
                  <a:pt x="230869" y="579063"/>
                </a:cubicBezTo>
                <a:cubicBezTo>
                  <a:pt x="227651" y="578144"/>
                  <a:pt x="224391" y="577273"/>
                  <a:pt x="221344" y="575888"/>
                </a:cubicBezTo>
                <a:cubicBezTo>
                  <a:pt x="212726" y="571971"/>
                  <a:pt x="204411" y="567421"/>
                  <a:pt x="195944" y="563188"/>
                </a:cubicBezTo>
                <a:cubicBezTo>
                  <a:pt x="171325" y="550878"/>
                  <a:pt x="200835" y="561643"/>
                  <a:pt x="176894" y="553663"/>
                </a:cubicBezTo>
                <a:cubicBezTo>
                  <a:pt x="174777" y="550488"/>
                  <a:pt x="173719" y="546255"/>
                  <a:pt x="170544" y="544138"/>
                </a:cubicBezTo>
                <a:cubicBezTo>
                  <a:pt x="138433" y="522730"/>
                  <a:pt x="175212" y="558518"/>
                  <a:pt x="148319" y="534613"/>
                </a:cubicBezTo>
                <a:cubicBezTo>
                  <a:pt x="115697" y="505615"/>
                  <a:pt x="141362" y="523625"/>
                  <a:pt x="119744" y="509213"/>
                </a:cubicBezTo>
                <a:cubicBezTo>
                  <a:pt x="97778" y="476264"/>
                  <a:pt x="131214" y="527271"/>
                  <a:pt x="107044" y="486988"/>
                </a:cubicBezTo>
                <a:lnTo>
                  <a:pt x="87994" y="458413"/>
                </a:lnTo>
                <a:cubicBezTo>
                  <a:pt x="85369" y="454475"/>
                  <a:pt x="83761" y="449946"/>
                  <a:pt x="81644" y="445713"/>
                </a:cubicBezTo>
                <a:cubicBezTo>
                  <a:pt x="78980" y="429726"/>
                  <a:pt x="77393" y="417086"/>
                  <a:pt x="72119" y="401263"/>
                </a:cubicBezTo>
                <a:cubicBezTo>
                  <a:pt x="71061" y="398088"/>
                  <a:pt x="70569" y="394664"/>
                  <a:pt x="68944" y="391738"/>
                </a:cubicBezTo>
                <a:cubicBezTo>
                  <a:pt x="65238" y="385067"/>
                  <a:pt x="60477" y="379038"/>
                  <a:pt x="56244" y="372688"/>
                </a:cubicBezTo>
                <a:cubicBezTo>
                  <a:pt x="54127" y="369513"/>
                  <a:pt x="51601" y="366576"/>
                  <a:pt x="49894" y="363163"/>
                </a:cubicBezTo>
                <a:cubicBezTo>
                  <a:pt x="47404" y="358183"/>
                  <a:pt x="41682" y="345426"/>
                  <a:pt x="37194" y="340938"/>
                </a:cubicBezTo>
                <a:cubicBezTo>
                  <a:pt x="34496" y="338240"/>
                  <a:pt x="30600" y="337031"/>
                  <a:pt x="27669" y="334588"/>
                </a:cubicBezTo>
                <a:cubicBezTo>
                  <a:pt x="3223" y="314216"/>
                  <a:pt x="32268" y="334479"/>
                  <a:pt x="8619" y="318713"/>
                </a:cubicBezTo>
                <a:cubicBezTo>
                  <a:pt x="0" y="292856"/>
                  <a:pt x="2269" y="302448"/>
                  <a:pt x="2269" y="252038"/>
                </a:cubicBezTo>
                <a:cubicBezTo>
                  <a:pt x="2269" y="231902"/>
                  <a:pt x="1495" y="211458"/>
                  <a:pt x="5444" y="191713"/>
                </a:cubicBezTo>
                <a:cubicBezTo>
                  <a:pt x="6941" y="184229"/>
                  <a:pt x="14731" y="179489"/>
                  <a:pt x="18144" y="172663"/>
                </a:cubicBezTo>
                <a:cubicBezTo>
                  <a:pt x="26201" y="156550"/>
                  <a:pt x="21869" y="163901"/>
                  <a:pt x="30844" y="150438"/>
                </a:cubicBezTo>
                <a:cubicBezTo>
                  <a:pt x="39959" y="113977"/>
                  <a:pt x="27213" y="158910"/>
                  <a:pt x="40369" y="128213"/>
                </a:cubicBezTo>
                <a:cubicBezTo>
                  <a:pt x="42088" y="124202"/>
                  <a:pt x="42597" y="119773"/>
                  <a:pt x="43544" y="115513"/>
                </a:cubicBezTo>
                <a:cubicBezTo>
                  <a:pt x="46134" y="103860"/>
                  <a:pt x="46576" y="98000"/>
                  <a:pt x="49894" y="86938"/>
                </a:cubicBezTo>
                <a:cubicBezTo>
                  <a:pt x="51817" y="80527"/>
                  <a:pt x="52531" y="73457"/>
                  <a:pt x="56244" y="67888"/>
                </a:cubicBezTo>
                <a:cubicBezTo>
                  <a:pt x="59268" y="63353"/>
                  <a:pt x="66741" y="50794"/>
                  <a:pt x="72119" y="48838"/>
                </a:cubicBezTo>
                <a:cubicBezTo>
                  <a:pt x="80138" y="45922"/>
                  <a:pt x="89052" y="46721"/>
                  <a:pt x="97519" y="45663"/>
                </a:cubicBezTo>
                <a:cubicBezTo>
                  <a:pt x="100694" y="44605"/>
                  <a:pt x="103797" y="43300"/>
                  <a:pt x="107044" y="42488"/>
                </a:cubicBezTo>
                <a:cubicBezTo>
                  <a:pt x="125790" y="37802"/>
                  <a:pt x="136156" y="38110"/>
                  <a:pt x="157844" y="36138"/>
                </a:cubicBezTo>
                <a:cubicBezTo>
                  <a:pt x="171434" y="32741"/>
                  <a:pt x="171639" y="32475"/>
                  <a:pt x="186419" y="29788"/>
                </a:cubicBezTo>
                <a:cubicBezTo>
                  <a:pt x="192753" y="28636"/>
                  <a:pt x="199156" y="27876"/>
                  <a:pt x="205469" y="26613"/>
                </a:cubicBezTo>
                <a:cubicBezTo>
                  <a:pt x="209748" y="25757"/>
                  <a:pt x="213812" y="23680"/>
                  <a:pt x="218169" y="23438"/>
                </a:cubicBezTo>
                <a:cubicBezTo>
                  <a:pt x="232963" y="22616"/>
                  <a:pt x="218169" y="8092"/>
                  <a:pt x="221344" y="4388"/>
                </a:cubicBezTo>
                <a:close/>
              </a:path>
            </a:pathLst>
          </a:custGeom>
          <a:noFill/>
          <a:ln w="222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pic>
        <p:nvPicPr>
          <p:cNvPr id="127" name="Picture 2" descr="C:\Users\User\Desktop\Spinal cord injury20150621\DATA\全景\20140307\JM01P7-1Region002\2014-02-27 10-13-Region 002.jpg"/>
          <p:cNvPicPr preferRelativeResize="0">
            <a:picLocks noChangeArrowheads="1"/>
          </p:cNvPicPr>
          <p:nvPr/>
        </p:nvPicPr>
        <p:blipFill>
          <a:blip r:embed="rId14" cstate="print">
            <a:lum bright="13000" contrast="30000"/>
          </a:blip>
          <a:srcRect l="40451" t="45619" r="44293" b="40865"/>
          <a:stretch>
            <a:fillRect/>
          </a:stretch>
        </p:blipFill>
        <p:spPr bwMode="auto">
          <a:xfrm rot="16200000">
            <a:off x="2514997" y="4021422"/>
            <a:ext cx="874800" cy="1332000"/>
          </a:xfrm>
          <a:prstGeom prst="rect">
            <a:avLst/>
          </a:prstGeom>
          <a:noFill/>
        </p:spPr>
      </p:pic>
      <p:sp>
        <p:nvSpPr>
          <p:cNvPr id="128" name="矩形 127"/>
          <p:cNvSpPr/>
          <p:nvPr/>
        </p:nvSpPr>
        <p:spPr>
          <a:xfrm>
            <a:off x="2883917" y="3718173"/>
            <a:ext cx="146298" cy="155302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pic>
        <p:nvPicPr>
          <p:cNvPr id="129" name="Picture 4" descr="C:\Users\User\Desktop\Spinal cord injury20150621\DATA\全景\20140307\JM03P14Region013\2014-02-27 10-13-Region 013.jpg"/>
          <p:cNvPicPr preferRelativeResize="0">
            <a:picLocks noChangeArrowheads="1"/>
          </p:cNvPicPr>
          <p:nvPr/>
        </p:nvPicPr>
        <p:blipFill>
          <a:blip r:embed="rId15" cstate="print">
            <a:lum bright="18000" contrast="30000"/>
          </a:blip>
          <a:srcRect l="28939" t="63377" r="58382" b="22307"/>
          <a:stretch>
            <a:fillRect/>
          </a:stretch>
        </p:blipFill>
        <p:spPr bwMode="auto">
          <a:xfrm rot="16200000">
            <a:off x="3888879" y="4021423"/>
            <a:ext cx="874800" cy="1332000"/>
          </a:xfrm>
          <a:prstGeom prst="rect">
            <a:avLst/>
          </a:prstGeom>
          <a:noFill/>
        </p:spPr>
      </p:pic>
      <p:sp>
        <p:nvSpPr>
          <p:cNvPr id="130" name="矩形 129"/>
          <p:cNvSpPr/>
          <p:nvPr/>
        </p:nvSpPr>
        <p:spPr>
          <a:xfrm>
            <a:off x="4530328" y="3904878"/>
            <a:ext cx="146298" cy="155302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31" name="矩形 130"/>
          <p:cNvSpPr/>
          <p:nvPr/>
        </p:nvSpPr>
        <p:spPr>
          <a:xfrm>
            <a:off x="5733256" y="3846169"/>
            <a:ext cx="146298" cy="155302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pic>
        <p:nvPicPr>
          <p:cNvPr id="132" name="Picture 6" descr="C:\Users\User\Desktop\Spinal cord injury20150621\DATA\全景\20140307\JM04 P28 Region 017\2014-02-27 10-13-Region 017.jpg"/>
          <p:cNvPicPr preferRelativeResize="0">
            <a:picLocks noChangeArrowheads="1"/>
          </p:cNvPicPr>
          <p:nvPr/>
        </p:nvPicPr>
        <p:blipFill>
          <a:blip r:embed="rId16" cstate="print">
            <a:lum bright="25000" contrast="40000"/>
          </a:blip>
          <a:srcRect l="26825" t="49198" r="60879" b="40115"/>
          <a:stretch>
            <a:fillRect/>
          </a:stretch>
        </p:blipFill>
        <p:spPr bwMode="auto">
          <a:xfrm rot="16200000">
            <a:off x="5247010" y="4018941"/>
            <a:ext cx="874800" cy="1332000"/>
          </a:xfrm>
          <a:prstGeom prst="rect">
            <a:avLst/>
          </a:prstGeom>
          <a:noFill/>
        </p:spPr>
      </p:pic>
      <p:pic>
        <p:nvPicPr>
          <p:cNvPr id="133" name="Picture 7" descr="C:\Users\User\Desktop\Spinal cord injury20150621\DATA\全景\20140205\全景spinal cord\marge\2014-01-14 14-17-Region 002.jpg"/>
          <p:cNvPicPr preferRelativeResize="0">
            <a:picLocks noChangeArrowheads="1"/>
          </p:cNvPicPr>
          <p:nvPr/>
        </p:nvPicPr>
        <p:blipFill>
          <a:blip r:embed="rId17" cstate="print">
            <a:lum bright="30000" contrast="50000"/>
          </a:blip>
          <a:srcRect l="34295" t="56912" r="51382" b="29658"/>
          <a:stretch>
            <a:fillRect/>
          </a:stretch>
        </p:blipFill>
        <p:spPr bwMode="auto">
          <a:xfrm rot="16200000">
            <a:off x="1151260" y="4016460"/>
            <a:ext cx="874800" cy="1332000"/>
          </a:xfrm>
          <a:prstGeom prst="rect">
            <a:avLst/>
          </a:prstGeom>
          <a:noFill/>
        </p:spPr>
      </p:pic>
      <p:sp>
        <p:nvSpPr>
          <p:cNvPr id="134" name="矩形 133"/>
          <p:cNvSpPr/>
          <p:nvPr/>
        </p:nvSpPr>
        <p:spPr>
          <a:xfrm>
            <a:off x="1830535" y="3802137"/>
            <a:ext cx="146298" cy="155302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="" xmlns:p14="http://schemas.microsoft.com/office/powerpoint/2010/main" val="37873949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/>
          <p:cNvSpPr/>
          <p:nvPr/>
        </p:nvSpPr>
        <p:spPr>
          <a:xfrm>
            <a:off x="332656" y="6084168"/>
            <a:ext cx="626469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kumimoji="1" lang="en-US" altLang="zh-TW" sz="1200" b="1" dirty="0" smtClean="0">
                <a:latin typeface="Times New Roman" pitchFamily="18" charset="0"/>
                <a:ea typeface="標楷體" pitchFamily="65" charset="-120"/>
                <a:cs typeface="Times New Roman" pitchFamily="18" charset="0"/>
              </a:rPr>
              <a:t>Sup. Fig. </a:t>
            </a:r>
            <a:r>
              <a:rPr kumimoji="1" lang="en-US" altLang="zh-TW" sz="1200" b="1" dirty="0" smtClean="0">
                <a:latin typeface="Times New Roman" pitchFamily="18" charset="0"/>
                <a:ea typeface="標楷體" pitchFamily="65" charset="-120"/>
                <a:cs typeface="Times New Roman" pitchFamily="18" charset="0"/>
              </a:rPr>
              <a:t>2 </a:t>
            </a:r>
            <a:r>
              <a:rPr lang="en-US" altLang="zh-TW" sz="1200" dirty="0" err="1" smtClean="0">
                <a:latin typeface="Times New Roman" pitchFamily="18" charset="0"/>
                <a:cs typeface="Times New Roman" pitchFamily="18" charset="0"/>
              </a:rPr>
              <a:t>Immunostaining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demonstrates a regional heterogeneity in the expression of C/EBP</a:t>
            </a:r>
            <a:r>
              <a:rPr lang="el-GR" altLang="zh-TW" sz="1200" dirty="0" smtClean="0">
                <a:latin typeface="Times New Roman" pitchFamily="18" charset="0"/>
                <a:cs typeface="Times New Roman" pitchFamily="18" charset="0"/>
              </a:rPr>
              <a:t>δ 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altLang="zh-TW" sz="1200" dirty="0" err="1" smtClean="0">
                <a:latin typeface="Times New Roman" pitchFamily="18" charset="0"/>
                <a:cs typeface="Times New Roman" pitchFamily="18" charset="0"/>
              </a:rPr>
              <a:t>RhoA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 in injured wild-type mice. The </a:t>
            </a:r>
            <a:r>
              <a:rPr lang="en-US" altLang="zh-TW" sz="1200" dirty="0" err="1" smtClean="0">
                <a:latin typeface="Times New Roman" pitchFamily="18" charset="0"/>
                <a:cs typeface="Times New Roman" pitchFamily="18" charset="0"/>
              </a:rPr>
              <a:t>glial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 scar along the lesion border shows  stronger C/EBP </a:t>
            </a:r>
            <a:r>
              <a:rPr lang="el-GR" altLang="zh-TW" sz="1200" dirty="0" smtClean="0">
                <a:latin typeface="Times New Roman" pitchFamily="18" charset="0"/>
                <a:cs typeface="Times New Roman" pitchFamily="18" charset="0"/>
              </a:rPr>
              <a:t>δ 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and weaker </a:t>
            </a:r>
            <a:r>
              <a:rPr lang="en-US" altLang="zh-TW" sz="1200" dirty="0" err="1" smtClean="0">
                <a:latin typeface="Times New Roman" pitchFamily="18" charset="0"/>
                <a:cs typeface="Times New Roman" pitchFamily="18" charset="0"/>
              </a:rPr>
              <a:t>RhoA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 signals.  Compared  with  the lesion  border, the penumbral region exhibits weaker C/EBP </a:t>
            </a:r>
            <a:r>
              <a:rPr lang="el-GR" altLang="zh-TW" sz="1200" dirty="0" smtClean="0">
                <a:latin typeface="Times New Roman" pitchFamily="18" charset="0"/>
                <a:cs typeface="Times New Roman" pitchFamily="18" charset="0"/>
              </a:rPr>
              <a:t>δ 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and stronger </a:t>
            </a:r>
            <a:r>
              <a:rPr lang="en-US" altLang="zh-TW" sz="1200" dirty="0" err="1" smtClean="0">
                <a:latin typeface="Times New Roman" pitchFamily="18" charset="0"/>
                <a:cs typeface="Times New Roman" pitchFamily="18" charset="0"/>
              </a:rPr>
              <a:t>RhoA</a:t>
            </a:r>
            <a:r>
              <a:rPr lang="en-US" altLang="zh-TW" sz="1200" dirty="0" smtClean="0">
                <a:latin typeface="Times New Roman" pitchFamily="18" charset="0"/>
                <a:cs typeface="Times New Roman" pitchFamily="18" charset="0"/>
              </a:rPr>
              <a:t> signals.</a:t>
            </a:r>
          </a:p>
        </p:txBody>
      </p:sp>
      <p:grpSp>
        <p:nvGrpSpPr>
          <p:cNvPr id="13" name="群組 12"/>
          <p:cNvGrpSpPr/>
          <p:nvPr/>
        </p:nvGrpSpPr>
        <p:grpSpPr>
          <a:xfrm>
            <a:off x="1054095" y="1228348"/>
            <a:ext cx="4153029" cy="4550591"/>
            <a:chOff x="1054095" y="1228348"/>
            <a:chExt cx="4153029" cy="4550591"/>
          </a:xfrm>
        </p:grpSpPr>
        <p:pic>
          <p:nvPicPr>
            <p:cNvPr id="4" name="圖片 3"/>
            <p:cNvPicPr/>
            <p:nvPr/>
          </p:nvPicPr>
          <p:blipFill>
            <a:blip r:embed="rId2" cstate="print">
              <a:lum contrast="30000"/>
            </a:blip>
            <a:srcRect l="10062" t="14132"/>
            <a:stretch>
              <a:fillRect/>
            </a:stretch>
          </p:blipFill>
          <p:spPr bwMode="auto">
            <a:xfrm>
              <a:off x="1559790" y="1589945"/>
              <a:ext cx="3647334" cy="40041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" name="矩形 7"/>
            <p:cNvSpPr/>
            <p:nvPr/>
          </p:nvSpPr>
          <p:spPr>
            <a:xfrm>
              <a:off x="1612280" y="1228348"/>
              <a:ext cx="1765920" cy="36004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TW" sz="1600" b="1" dirty="0" smtClean="0">
                  <a:solidFill>
                    <a:srgbClr val="FF0000"/>
                  </a:solidFill>
                  <a:latin typeface="+mj-lt"/>
                  <a:cs typeface="Times New Roman" pitchFamily="18" charset="0"/>
                </a:rPr>
                <a:t>C/EBP</a:t>
              </a:r>
              <a:r>
                <a:rPr lang="el-GR" altLang="zh-TW" sz="1600" b="1" dirty="0" smtClean="0">
                  <a:solidFill>
                    <a:srgbClr val="FF0000"/>
                  </a:solidFill>
                  <a:latin typeface="+mj-lt"/>
                  <a:cs typeface="Times New Roman" pitchFamily="18" charset="0"/>
                </a:rPr>
                <a:t>δ</a:t>
              </a:r>
              <a:endParaRPr lang="en-US" altLang="zh-TW" sz="1600" b="1" dirty="0" smtClean="0">
                <a:solidFill>
                  <a:schemeClr val="bg1"/>
                </a:solidFill>
                <a:latin typeface="+mj-lt"/>
                <a:cs typeface="Times New Roman" pitchFamily="18" charset="0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>
              <a:off x="3430528" y="1228348"/>
              <a:ext cx="1705352" cy="36004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TW" sz="1600" b="1" dirty="0" err="1" smtClean="0">
                  <a:solidFill>
                    <a:srgbClr val="FF0000"/>
                  </a:solidFill>
                  <a:latin typeface="+mj-lt"/>
                  <a:cs typeface="Times New Roman" pitchFamily="18" charset="0"/>
                </a:rPr>
                <a:t>RhoA</a:t>
              </a:r>
              <a:endParaRPr lang="en-US" altLang="zh-TW" sz="1600" b="1" dirty="0" smtClean="0">
                <a:solidFill>
                  <a:schemeClr val="bg1"/>
                </a:solidFill>
                <a:latin typeface="+mj-lt"/>
                <a:cs typeface="Times New Roman" pitchFamily="18" charset="0"/>
              </a:endParaRPr>
            </a:p>
          </p:txBody>
        </p:sp>
        <p:sp>
          <p:nvSpPr>
            <p:cNvPr id="10" name="Text Box 3"/>
            <p:cNvSpPr txBox="1">
              <a:spLocks noChangeArrowheads="1"/>
            </p:cNvSpPr>
            <p:nvPr/>
          </p:nvSpPr>
          <p:spPr bwMode="auto">
            <a:xfrm rot="16200000">
              <a:off x="512995" y="2279233"/>
              <a:ext cx="1625600" cy="2893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>
                <a:lnSpc>
                  <a:spcPct val="80000"/>
                </a:lnSpc>
              </a:pPr>
              <a:r>
                <a:rPr lang="en-US" altLang="zh-TW" sz="1600" b="1" dirty="0">
                  <a:latin typeface="+mj-lt"/>
                  <a:ea typeface="新細明體" charset="-120"/>
                </a:rPr>
                <a:t>Lesion border</a:t>
              </a:r>
            </a:p>
          </p:txBody>
        </p:sp>
        <p:sp>
          <p:nvSpPr>
            <p:cNvPr id="11" name="Text Box 4"/>
            <p:cNvSpPr txBox="1">
              <a:spLocks noChangeArrowheads="1"/>
            </p:cNvSpPr>
            <p:nvPr/>
          </p:nvSpPr>
          <p:spPr bwMode="auto">
            <a:xfrm rot="16200000">
              <a:off x="690080" y="3547525"/>
              <a:ext cx="1214317" cy="4862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>
                <a:lnSpc>
                  <a:spcPct val="80000"/>
                </a:lnSpc>
              </a:pPr>
              <a:r>
                <a:rPr lang="en-US" altLang="zh-TW" sz="1600" b="1" dirty="0" smtClean="0">
                  <a:latin typeface="+mj-lt"/>
                  <a:ea typeface="新細明體" charset="-120"/>
                </a:rPr>
                <a:t>Penumbral</a:t>
              </a:r>
            </a:p>
            <a:p>
              <a:pPr algn="ctr">
                <a:lnSpc>
                  <a:spcPct val="80000"/>
                </a:lnSpc>
              </a:pPr>
              <a:r>
                <a:rPr lang="en-US" altLang="zh-TW" sz="1600" b="1" dirty="0" smtClean="0">
                  <a:latin typeface="+mj-lt"/>
                  <a:ea typeface="新細明體" charset="-120"/>
                </a:rPr>
                <a:t>region</a:t>
              </a:r>
              <a:endParaRPr lang="en-US" altLang="zh-TW" sz="1600" b="1" dirty="0">
                <a:latin typeface="+mj-lt"/>
                <a:ea typeface="新細明體" charset="-120"/>
              </a:endParaRPr>
            </a:p>
          </p:txBody>
        </p:sp>
        <p:sp>
          <p:nvSpPr>
            <p:cNvPr id="12" name="Text Box 5"/>
            <p:cNvSpPr txBox="1">
              <a:spLocks noChangeArrowheads="1"/>
            </p:cNvSpPr>
            <p:nvPr/>
          </p:nvSpPr>
          <p:spPr bwMode="auto">
            <a:xfrm rot="16200000">
              <a:off x="549754" y="4788310"/>
              <a:ext cx="1494971" cy="4862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algn="ctr">
                <a:lnSpc>
                  <a:spcPct val="80000"/>
                </a:lnSpc>
              </a:pPr>
              <a:r>
                <a:rPr lang="en-US" altLang="zh-TW" sz="1600" b="1" dirty="0">
                  <a:latin typeface="+mj-lt"/>
                  <a:ea typeface="新細明體" charset="-120"/>
                </a:rPr>
                <a:t>Less </a:t>
              </a:r>
              <a:r>
                <a:rPr lang="en-US" altLang="zh-TW" sz="1600" b="1" dirty="0" smtClean="0">
                  <a:latin typeface="+mj-lt"/>
                  <a:ea typeface="新細明體" charset="-120"/>
                </a:rPr>
                <a:t> injured </a:t>
              </a:r>
            </a:p>
            <a:p>
              <a:pPr algn="ctr">
                <a:lnSpc>
                  <a:spcPct val="80000"/>
                </a:lnSpc>
              </a:pPr>
              <a:r>
                <a:rPr lang="en-US" altLang="zh-TW" sz="1600" b="1" dirty="0" smtClean="0">
                  <a:latin typeface="+mj-lt"/>
                  <a:ea typeface="新細明體" charset="-120"/>
                </a:rPr>
                <a:t>tissue</a:t>
              </a:r>
              <a:endParaRPr lang="en-US" altLang="zh-TW" sz="1600" b="1" dirty="0">
                <a:latin typeface="+mj-lt"/>
                <a:ea typeface="新細明體" charset="-12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29</TotalTime>
  <Words>140</Words>
  <Application>Microsoft Office PowerPoint</Application>
  <PresentationFormat>如螢幕大小 (4:3)</PresentationFormat>
  <Paragraphs>16</Paragraphs>
  <Slides>2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2</vt:i4>
      </vt:variant>
    </vt:vector>
  </HeadingPairs>
  <TitlesOfParts>
    <vt:vector size="3" baseType="lpstr">
      <vt:lpstr>Office 佈景主題</vt:lpstr>
      <vt:lpstr>投影片 1</vt:lpstr>
      <vt:lpstr>投影片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User</cp:lastModifiedBy>
  <cp:revision>249</cp:revision>
  <dcterms:created xsi:type="dcterms:W3CDTF">2013-03-21T01:38:58Z</dcterms:created>
  <dcterms:modified xsi:type="dcterms:W3CDTF">2015-10-11T08:12:53Z</dcterms:modified>
</cp:coreProperties>
</file>